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6"/>
  </p:notesMasterIdLst>
  <p:sldIdLst>
    <p:sldId id="273" r:id="rId2"/>
    <p:sldId id="274" r:id="rId3"/>
    <p:sldId id="270" r:id="rId4"/>
    <p:sldId id="271" r:id="rId5"/>
    <p:sldId id="280" r:id="rId6"/>
    <p:sldId id="275" r:id="rId7"/>
    <p:sldId id="262" r:id="rId8"/>
    <p:sldId id="276" r:id="rId9"/>
    <p:sldId id="277" r:id="rId10"/>
    <p:sldId id="268" r:id="rId11"/>
    <p:sldId id="278" r:id="rId12"/>
    <p:sldId id="259" r:id="rId13"/>
    <p:sldId id="279" r:id="rId14"/>
    <p:sldId id="269" r:id="rId15"/>
  </p:sldIdLst>
  <p:sldSz cx="9906000" cy="6858000" type="A4"/>
  <p:notesSz cx="6864350" cy="9996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000099"/>
    <a:srgbClr val="0F870F"/>
    <a:srgbClr val="000080"/>
    <a:srgbClr val="D9D9D9"/>
    <a:srgbClr val="9CBE4A"/>
    <a:srgbClr val="C0C0C0"/>
    <a:srgbClr val="800000"/>
    <a:srgbClr val="800080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493" autoAdjust="0"/>
    <p:restoredTop sz="97425" autoAdjust="0"/>
  </p:normalViewPr>
  <p:slideViewPr>
    <p:cSldViewPr snapToGrid="0">
      <p:cViewPr varScale="1">
        <p:scale>
          <a:sx n="104" d="100"/>
          <a:sy n="104" d="100"/>
        </p:scale>
        <p:origin x="102" y="1296"/>
      </p:cViewPr>
      <p:guideLst/>
    </p:cSldViewPr>
  </p:slid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32.wmf"/></Relationships>
</file>

<file path=ppt/drawings/_rels/vmlDrawing1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4.wmf"/><Relationship Id="rId1" Type="http://schemas.openxmlformats.org/officeDocument/2006/relationships/image" Target="../media/image33.w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5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wmf"/><Relationship Id="rId2" Type="http://schemas.openxmlformats.org/officeDocument/2006/relationships/image" Target="../media/image14.wmf"/><Relationship Id="rId1" Type="http://schemas.openxmlformats.org/officeDocument/2006/relationships/image" Target="../media/image13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17.wmf"/><Relationship Id="rId1" Type="http://schemas.openxmlformats.org/officeDocument/2006/relationships/image" Target="../media/image16.w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w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21.wmf"/><Relationship Id="rId2" Type="http://schemas.openxmlformats.org/officeDocument/2006/relationships/image" Target="../media/image20.wmf"/><Relationship Id="rId1" Type="http://schemas.openxmlformats.org/officeDocument/2006/relationships/image" Target="../media/image19.wmf"/><Relationship Id="rId4" Type="http://schemas.openxmlformats.org/officeDocument/2006/relationships/image" Target="../media/image22.w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25.wmf"/><Relationship Id="rId2" Type="http://schemas.openxmlformats.org/officeDocument/2006/relationships/image" Target="../media/image24.wmf"/><Relationship Id="rId1" Type="http://schemas.openxmlformats.org/officeDocument/2006/relationships/image" Target="../media/image23.wmf"/><Relationship Id="rId4" Type="http://schemas.openxmlformats.org/officeDocument/2006/relationships/image" Target="../media/image26.wmf"/></Relationships>
</file>

<file path=ppt/drawings/_rels/vmlDrawing8.vml.rels><?xml version="1.0" encoding="UTF-8" standalone="yes"?>
<Relationships xmlns="http://schemas.openxmlformats.org/package/2006/relationships"><Relationship Id="rId3" Type="http://schemas.openxmlformats.org/officeDocument/2006/relationships/image" Target="../media/image29.wmf"/><Relationship Id="rId2" Type="http://schemas.openxmlformats.org/officeDocument/2006/relationships/image" Target="../media/image28.wmf"/><Relationship Id="rId1" Type="http://schemas.openxmlformats.org/officeDocument/2006/relationships/image" Target="../media/image27.wmf"/><Relationship Id="rId4" Type="http://schemas.openxmlformats.org/officeDocument/2006/relationships/image" Target="../media/image30.w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3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4551" cy="501561"/>
          </a:xfrm>
          <a:prstGeom prst="rect">
            <a:avLst/>
          </a:prstGeom>
        </p:spPr>
        <p:txBody>
          <a:bodyPr vert="horz" lIns="92181" tIns="46090" rIns="92181" bIns="4609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8211" y="0"/>
            <a:ext cx="2974551" cy="501561"/>
          </a:xfrm>
          <a:prstGeom prst="rect">
            <a:avLst/>
          </a:prstGeom>
        </p:spPr>
        <p:txBody>
          <a:bodyPr vert="horz" lIns="92181" tIns="46090" rIns="92181" bIns="46090" rtlCol="0"/>
          <a:lstStyle>
            <a:lvl1pPr algn="r">
              <a:defRPr sz="1200"/>
            </a:lvl1pPr>
          </a:lstStyle>
          <a:p>
            <a:fld id="{29A1FFB9-FDCE-4300-9C3C-F48B42172090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96950" y="1250950"/>
            <a:ext cx="4870450" cy="3371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81" tIns="46090" rIns="92181" bIns="4609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6436" y="4810810"/>
            <a:ext cx="5491480" cy="3936117"/>
          </a:xfrm>
          <a:prstGeom prst="rect">
            <a:avLst/>
          </a:prstGeom>
        </p:spPr>
        <p:txBody>
          <a:bodyPr vert="horz" lIns="92181" tIns="46090" rIns="92181" bIns="4609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94930"/>
            <a:ext cx="2974551" cy="501560"/>
          </a:xfrm>
          <a:prstGeom prst="rect">
            <a:avLst/>
          </a:prstGeom>
        </p:spPr>
        <p:txBody>
          <a:bodyPr vert="horz" lIns="92181" tIns="46090" rIns="92181" bIns="4609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8211" y="9494930"/>
            <a:ext cx="2974551" cy="501560"/>
          </a:xfrm>
          <a:prstGeom prst="rect">
            <a:avLst/>
          </a:prstGeom>
        </p:spPr>
        <p:txBody>
          <a:bodyPr vert="horz" lIns="92181" tIns="46090" rIns="92181" bIns="46090" rtlCol="0" anchor="b"/>
          <a:lstStyle>
            <a:lvl1pPr algn="r">
              <a:defRPr sz="1200"/>
            </a:lvl1pPr>
          </a:lstStyle>
          <a:p>
            <a:fld id="{ECA68AAA-FA76-4AD9-9301-B34853CA60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39602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7068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4697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3319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2358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8460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6362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7817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5134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0065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3212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4592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1E1608-B5DD-4255-95F2-20C5E03DA365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DF0F1-E231-485F-98CC-1837472B45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0404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4" Type="http://schemas.openxmlformats.org/officeDocument/2006/relationships/image" Target="../media/image31.w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4" Type="http://schemas.openxmlformats.org/officeDocument/2006/relationships/image" Target="../media/image32.w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6" Type="http://schemas.openxmlformats.org/officeDocument/2006/relationships/image" Target="../media/image34.wmf"/><Relationship Id="rId5" Type="http://schemas.openxmlformats.org/officeDocument/2006/relationships/oleObject" Target="../embeddings/oleObject29.bin"/><Relationship Id="rId4" Type="http://schemas.openxmlformats.org/officeDocument/2006/relationships/image" Target="../media/image33.w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2.vml"/><Relationship Id="rId4" Type="http://schemas.openxmlformats.org/officeDocument/2006/relationships/image" Target="../media/image35.wmf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7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wmf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4.w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13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7.wmf"/><Relationship Id="rId5" Type="http://schemas.openxmlformats.org/officeDocument/2006/relationships/oleObject" Target="../embeddings/oleObject12.bin"/><Relationship Id="rId4" Type="http://schemas.openxmlformats.org/officeDocument/2006/relationships/image" Target="../media/image16.w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18.w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wmf"/><Relationship Id="rId3" Type="http://schemas.openxmlformats.org/officeDocument/2006/relationships/oleObject" Target="../embeddings/oleObject14.bin"/><Relationship Id="rId7" Type="http://schemas.openxmlformats.org/officeDocument/2006/relationships/oleObject" Target="../embeddings/oleObject1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20.wmf"/><Relationship Id="rId5" Type="http://schemas.openxmlformats.org/officeDocument/2006/relationships/oleObject" Target="../embeddings/oleObject15.bin"/><Relationship Id="rId10" Type="http://schemas.openxmlformats.org/officeDocument/2006/relationships/image" Target="../media/image22.wmf"/><Relationship Id="rId4" Type="http://schemas.openxmlformats.org/officeDocument/2006/relationships/image" Target="../media/image19.wmf"/><Relationship Id="rId9" Type="http://schemas.openxmlformats.org/officeDocument/2006/relationships/oleObject" Target="../embeddings/oleObject17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wmf"/><Relationship Id="rId3" Type="http://schemas.openxmlformats.org/officeDocument/2006/relationships/oleObject" Target="../embeddings/oleObject18.bin"/><Relationship Id="rId7" Type="http://schemas.openxmlformats.org/officeDocument/2006/relationships/oleObject" Target="../embeddings/oleObject2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24.wmf"/><Relationship Id="rId5" Type="http://schemas.openxmlformats.org/officeDocument/2006/relationships/oleObject" Target="../embeddings/oleObject19.bin"/><Relationship Id="rId10" Type="http://schemas.openxmlformats.org/officeDocument/2006/relationships/image" Target="../media/image26.wmf"/><Relationship Id="rId4" Type="http://schemas.openxmlformats.org/officeDocument/2006/relationships/image" Target="../media/image23.wmf"/><Relationship Id="rId9" Type="http://schemas.openxmlformats.org/officeDocument/2006/relationships/oleObject" Target="../embeddings/oleObject21.bin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wmf"/><Relationship Id="rId3" Type="http://schemas.openxmlformats.org/officeDocument/2006/relationships/oleObject" Target="../embeddings/oleObject22.bin"/><Relationship Id="rId7" Type="http://schemas.openxmlformats.org/officeDocument/2006/relationships/oleObject" Target="../embeddings/oleObject2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28.wmf"/><Relationship Id="rId5" Type="http://schemas.openxmlformats.org/officeDocument/2006/relationships/oleObject" Target="../embeddings/oleObject23.bin"/><Relationship Id="rId10" Type="http://schemas.openxmlformats.org/officeDocument/2006/relationships/image" Target="../media/image30.wmf"/><Relationship Id="rId4" Type="http://schemas.openxmlformats.org/officeDocument/2006/relationships/image" Target="../media/image27.wmf"/><Relationship Id="rId9" Type="http://schemas.openxmlformats.org/officeDocument/2006/relationships/oleObject" Target="../embeddings/oleObject25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>
            <a:extLst>
              <a:ext uri="{FF2B5EF4-FFF2-40B4-BE49-F238E27FC236}">
                <a16:creationId xmlns:a16="http://schemas.microsoft.com/office/drawing/2014/main" id="{6D17C421-7210-42FD-824A-C4A113CDB52A}"/>
              </a:ext>
            </a:extLst>
          </p:cNvPr>
          <p:cNvSpPr/>
          <p:nvPr/>
        </p:nvSpPr>
        <p:spPr>
          <a:xfrm>
            <a:off x="0" y="2683"/>
            <a:ext cx="19175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4" name="개체 163">
            <a:extLst>
              <a:ext uri="{FF2B5EF4-FFF2-40B4-BE49-F238E27FC236}">
                <a16:creationId xmlns:a16="http://schemas.microsoft.com/office/drawing/2014/main" id="{0F1CA326-C69B-4138-BA6E-810D2CB083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752468"/>
              </p:ext>
            </p:extLst>
          </p:nvPr>
        </p:nvGraphicFramePr>
        <p:xfrm>
          <a:off x="2261870" y="244499"/>
          <a:ext cx="2404800" cy="1870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42" name="Graph" r:id="rId3" imgW="3291840" imgH="2560320" progId="Origin95.Graph">
                  <p:embed/>
                </p:oleObj>
              </mc:Choice>
              <mc:Fallback>
                <p:oleObj name="Graph" r:id="rId3" imgW="3291840" imgH="2560320" progId="Origin95.Graph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185BA899-D117-433A-885B-C6F415A503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61870" y="244499"/>
                        <a:ext cx="2404800" cy="1870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5" name="개체 164">
            <a:extLst>
              <a:ext uri="{FF2B5EF4-FFF2-40B4-BE49-F238E27FC236}">
                <a16:creationId xmlns:a16="http://schemas.microsoft.com/office/drawing/2014/main" id="{68931F30-1E70-43F2-BFD9-34F1907F41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1415444"/>
              </p:ext>
            </p:extLst>
          </p:nvPr>
        </p:nvGraphicFramePr>
        <p:xfrm>
          <a:off x="5242057" y="242987"/>
          <a:ext cx="2404800" cy="1870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43" name="Graph" r:id="rId5" imgW="3291840" imgH="2560320" progId="Origin95.Graph">
                  <p:embed/>
                </p:oleObj>
              </mc:Choice>
              <mc:Fallback>
                <p:oleObj name="Graph" r:id="rId5" imgW="3291840" imgH="2560320" progId="Origin95.Graph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47906B2A-04DB-47FA-B891-A1E01A9398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242057" y="242987"/>
                        <a:ext cx="2404800" cy="1870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6" name="개체 165">
            <a:extLst>
              <a:ext uri="{FF2B5EF4-FFF2-40B4-BE49-F238E27FC236}">
                <a16:creationId xmlns:a16="http://schemas.microsoft.com/office/drawing/2014/main" id="{40120C6C-2358-478B-A586-708727B215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7276672"/>
              </p:ext>
            </p:extLst>
          </p:nvPr>
        </p:nvGraphicFramePr>
        <p:xfrm>
          <a:off x="2262254" y="2428504"/>
          <a:ext cx="2404800" cy="1870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44" name="Graph" r:id="rId7" imgW="3291840" imgH="2560320" progId="Origin95.Graph">
                  <p:embed/>
                </p:oleObj>
              </mc:Choice>
              <mc:Fallback>
                <p:oleObj name="Graph" r:id="rId7" imgW="3291840" imgH="2560320" progId="Origin95.Graph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ECD8C1E3-0588-478E-A9E7-82CBDEEDCE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262254" y="2428504"/>
                        <a:ext cx="2404800" cy="1870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7" name="개체 166">
            <a:extLst>
              <a:ext uri="{FF2B5EF4-FFF2-40B4-BE49-F238E27FC236}">
                <a16:creationId xmlns:a16="http://schemas.microsoft.com/office/drawing/2014/main" id="{C0C30403-C077-4AD6-8512-81D4EBD628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9294461"/>
              </p:ext>
            </p:extLst>
          </p:nvPr>
        </p:nvGraphicFramePr>
        <p:xfrm>
          <a:off x="5242057" y="2434366"/>
          <a:ext cx="2404800" cy="1870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45" name="Graph" r:id="rId9" imgW="3291840" imgH="2560320" progId="Origin95.Graph">
                  <p:embed/>
                </p:oleObj>
              </mc:Choice>
              <mc:Fallback>
                <p:oleObj name="Graph" r:id="rId9" imgW="3291840" imgH="2560320" progId="Origin95.Graph">
                  <p:embed/>
                  <p:pic>
                    <p:nvPicPr>
                      <p:cNvPr id="10" name="개체 9">
                        <a:extLst>
                          <a:ext uri="{FF2B5EF4-FFF2-40B4-BE49-F238E27FC236}">
                            <a16:creationId xmlns:a16="http://schemas.microsoft.com/office/drawing/2014/main" id="{574087DB-6CD7-4BE7-99C6-26BD625B9B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242057" y="2434366"/>
                        <a:ext cx="2404800" cy="1870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8" name="개체 167">
            <a:extLst>
              <a:ext uri="{FF2B5EF4-FFF2-40B4-BE49-F238E27FC236}">
                <a16:creationId xmlns:a16="http://schemas.microsoft.com/office/drawing/2014/main" id="{D332B75D-26DD-4E4D-AE94-17A6AF5571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0766316"/>
              </p:ext>
            </p:extLst>
          </p:nvPr>
        </p:nvGraphicFramePr>
        <p:xfrm>
          <a:off x="2295849" y="4742568"/>
          <a:ext cx="2404800" cy="1870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46" name="Graph" r:id="rId11" imgW="3291840" imgH="2560320" progId="Origin95.Graph">
                  <p:embed/>
                </p:oleObj>
              </mc:Choice>
              <mc:Fallback>
                <p:oleObj name="Graph" r:id="rId11" imgW="3291840" imgH="2560320" progId="Origin95.Graph">
                  <p:embed/>
                  <p:pic>
                    <p:nvPicPr>
                      <p:cNvPr id="11" name="개체 10">
                        <a:extLst>
                          <a:ext uri="{FF2B5EF4-FFF2-40B4-BE49-F238E27FC236}">
                            <a16:creationId xmlns:a16="http://schemas.microsoft.com/office/drawing/2014/main" id="{D5ACC5B1-A3FD-4736-AFD7-7269A02717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295849" y="4742568"/>
                        <a:ext cx="2404800" cy="1870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9" name="개체 168">
            <a:extLst>
              <a:ext uri="{FF2B5EF4-FFF2-40B4-BE49-F238E27FC236}">
                <a16:creationId xmlns:a16="http://schemas.microsoft.com/office/drawing/2014/main" id="{D1448CDD-C292-483B-99D5-599392622C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2260461"/>
              </p:ext>
            </p:extLst>
          </p:nvPr>
        </p:nvGraphicFramePr>
        <p:xfrm>
          <a:off x="5287125" y="4742568"/>
          <a:ext cx="2404800" cy="1870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47" name="Graph" r:id="rId13" imgW="3291840" imgH="2560320" progId="Origin95.Graph">
                  <p:embed/>
                </p:oleObj>
              </mc:Choice>
              <mc:Fallback>
                <p:oleObj name="Graph" r:id="rId13" imgW="3291840" imgH="2560320" progId="Origin95.Graph">
                  <p:embed/>
                  <p:pic>
                    <p:nvPicPr>
                      <p:cNvPr id="13" name="개체 12">
                        <a:extLst>
                          <a:ext uri="{FF2B5EF4-FFF2-40B4-BE49-F238E27FC236}">
                            <a16:creationId xmlns:a16="http://schemas.microsoft.com/office/drawing/2014/main" id="{C2580887-A500-40FB-A5C4-F9E2201B2F4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287125" y="4742568"/>
                        <a:ext cx="2404800" cy="1870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0" name="TextBox 169">
            <a:extLst>
              <a:ext uri="{FF2B5EF4-FFF2-40B4-BE49-F238E27FC236}">
                <a16:creationId xmlns:a16="http://schemas.microsoft.com/office/drawing/2014/main" id="{F7BC86AE-B4CF-4F94-88DE-DA8EE92D6972}"/>
              </a:ext>
            </a:extLst>
          </p:cNvPr>
          <p:cNvSpPr txBox="1"/>
          <p:nvPr/>
        </p:nvSpPr>
        <p:spPr>
          <a:xfrm>
            <a:off x="1805832" y="25408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F13C601D-32CE-4925-A905-7D926F1A9FF5}"/>
              </a:ext>
            </a:extLst>
          </p:cNvPr>
          <p:cNvSpPr txBox="1"/>
          <p:nvPr/>
        </p:nvSpPr>
        <p:spPr>
          <a:xfrm>
            <a:off x="1805832" y="457329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8A1CFE09-1660-4F9F-B4B3-DC37E30CB70A}"/>
              </a:ext>
            </a:extLst>
          </p:cNvPr>
          <p:cNvSpPr txBox="1"/>
          <p:nvPr/>
        </p:nvSpPr>
        <p:spPr>
          <a:xfrm>
            <a:off x="1805832" y="227650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B6BE1607-781B-492D-9177-3B5664A2C275}"/>
              </a:ext>
            </a:extLst>
          </p:cNvPr>
          <p:cNvSpPr txBox="1"/>
          <p:nvPr/>
        </p:nvSpPr>
        <p:spPr>
          <a:xfrm>
            <a:off x="3021005" y="128152"/>
            <a:ext cx="1043555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-Glucose (0.3%)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0F9B72DF-2026-4552-BB3F-E55DCC5CE928}"/>
              </a:ext>
            </a:extLst>
          </p:cNvPr>
          <p:cNvSpPr txBox="1"/>
          <p:nvPr/>
        </p:nvSpPr>
        <p:spPr>
          <a:xfrm>
            <a:off x="6065074" y="127463"/>
            <a:ext cx="97142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uccinate (0.3%)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DA720E9A-2B5D-4404-B14C-0B93CE3FBB02}"/>
              </a:ext>
            </a:extLst>
          </p:cNvPr>
          <p:cNvSpPr txBox="1"/>
          <p:nvPr/>
        </p:nvSpPr>
        <p:spPr>
          <a:xfrm>
            <a:off x="3281914" y="2078907"/>
            <a:ext cx="477695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68F31490-F5A4-475F-8259-7C9767C72EAB}"/>
              </a:ext>
            </a:extLst>
          </p:cNvPr>
          <p:cNvSpPr txBox="1"/>
          <p:nvPr/>
        </p:nvSpPr>
        <p:spPr>
          <a:xfrm rot="16200000">
            <a:off x="1775765" y="1003707"/>
            <a:ext cx="75341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og(OD</a:t>
            </a:r>
            <a:r>
              <a:rPr lang="en-US" altLang="ko-KR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nm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022C4F28-B51A-4506-B9A5-32979439F70F}"/>
              </a:ext>
            </a:extLst>
          </p:cNvPr>
          <p:cNvSpPr txBox="1"/>
          <p:nvPr/>
        </p:nvSpPr>
        <p:spPr>
          <a:xfrm>
            <a:off x="6243208" y="2078906"/>
            <a:ext cx="477695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7110E730-DA97-4DC8-B386-CAD15460C57C}"/>
              </a:ext>
            </a:extLst>
          </p:cNvPr>
          <p:cNvSpPr txBox="1"/>
          <p:nvPr/>
        </p:nvSpPr>
        <p:spPr>
          <a:xfrm rot="16200000">
            <a:off x="4737058" y="1003706"/>
            <a:ext cx="75341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og(OD</a:t>
            </a:r>
            <a:r>
              <a:rPr lang="en-US" altLang="ko-KR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nm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4B68A7CB-7F8E-4236-BEAC-6E839890F1B5}"/>
              </a:ext>
            </a:extLst>
          </p:cNvPr>
          <p:cNvSpPr txBox="1"/>
          <p:nvPr/>
        </p:nvSpPr>
        <p:spPr>
          <a:xfrm>
            <a:off x="3281914" y="6626015"/>
            <a:ext cx="477695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F28C0A97-EA50-4C04-9F61-CE2D600F0534}"/>
              </a:ext>
            </a:extLst>
          </p:cNvPr>
          <p:cNvSpPr txBox="1"/>
          <p:nvPr/>
        </p:nvSpPr>
        <p:spPr>
          <a:xfrm rot="16200000">
            <a:off x="1775764" y="5550815"/>
            <a:ext cx="75341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og(OD</a:t>
            </a:r>
            <a:r>
              <a:rPr lang="en-US" altLang="ko-KR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nm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2F1AADD5-ADC3-423A-B635-E14A7F492322}"/>
              </a:ext>
            </a:extLst>
          </p:cNvPr>
          <p:cNvSpPr txBox="1"/>
          <p:nvPr/>
        </p:nvSpPr>
        <p:spPr>
          <a:xfrm>
            <a:off x="6243208" y="6626014"/>
            <a:ext cx="477695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1A5DD024-B21A-42A2-A798-6F8C20567C5E}"/>
              </a:ext>
            </a:extLst>
          </p:cNvPr>
          <p:cNvSpPr txBox="1"/>
          <p:nvPr/>
        </p:nvSpPr>
        <p:spPr>
          <a:xfrm rot="16200000">
            <a:off x="4737058" y="5550814"/>
            <a:ext cx="75341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og(OD</a:t>
            </a:r>
            <a:r>
              <a:rPr lang="en-US" altLang="ko-KR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nm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F686AC09-A7B3-41A7-9E28-0D05B648EE95}"/>
              </a:ext>
            </a:extLst>
          </p:cNvPr>
          <p:cNvSpPr txBox="1"/>
          <p:nvPr/>
        </p:nvSpPr>
        <p:spPr>
          <a:xfrm>
            <a:off x="3270694" y="4288728"/>
            <a:ext cx="477695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8810FE6A-9334-4854-9A73-55C3E422EBE4}"/>
              </a:ext>
            </a:extLst>
          </p:cNvPr>
          <p:cNvSpPr txBox="1"/>
          <p:nvPr/>
        </p:nvSpPr>
        <p:spPr>
          <a:xfrm rot="16200000">
            <a:off x="1764544" y="3213528"/>
            <a:ext cx="75341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og(OD</a:t>
            </a:r>
            <a:r>
              <a:rPr lang="en-US" altLang="ko-KR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nm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D153F94B-2347-4952-9E45-37D43EF6F213}"/>
              </a:ext>
            </a:extLst>
          </p:cNvPr>
          <p:cNvSpPr txBox="1"/>
          <p:nvPr/>
        </p:nvSpPr>
        <p:spPr>
          <a:xfrm>
            <a:off x="6231988" y="4288727"/>
            <a:ext cx="477695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DC7CBE7D-7372-4D7A-84D9-DC5343288E3B}"/>
              </a:ext>
            </a:extLst>
          </p:cNvPr>
          <p:cNvSpPr txBox="1"/>
          <p:nvPr/>
        </p:nvSpPr>
        <p:spPr>
          <a:xfrm rot="16200000">
            <a:off x="4725838" y="3213527"/>
            <a:ext cx="75341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og(OD</a:t>
            </a:r>
            <a:r>
              <a:rPr lang="en-US" altLang="ko-KR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nm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7" name="그룹 186">
            <a:extLst>
              <a:ext uri="{FF2B5EF4-FFF2-40B4-BE49-F238E27FC236}">
                <a16:creationId xmlns:a16="http://schemas.microsoft.com/office/drawing/2014/main" id="{C48D67F4-882E-47F7-B59B-39DF36C301F1}"/>
              </a:ext>
            </a:extLst>
          </p:cNvPr>
          <p:cNvGrpSpPr/>
          <p:nvPr/>
        </p:nvGrpSpPr>
        <p:grpSpPr>
          <a:xfrm>
            <a:off x="3765907" y="301874"/>
            <a:ext cx="805590" cy="276523"/>
            <a:chOff x="7385761" y="5311719"/>
            <a:chExt cx="805590" cy="276523"/>
          </a:xfrm>
        </p:grpSpPr>
        <p:grpSp>
          <p:nvGrpSpPr>
            <p:cNvPr id="188" name="그룹 187">
              <a:extLst>
                <a:ext uri="{FF2B5EF4-FFF2-40B4-BE49-F238E27FC236}">
                  <a16:creationId xmlns:a16="http://schemas.microsoft.com/office/drawing/2014/main" id="{247EEC7D-FD99-4C66-976D-70D4A4138AED}"/>
                </a:ext>
              </a:extLst>
            </p:cNvPr>
            <p:cNvGrpSpPr/>
            <p:nvPr/>
          </p:nvGrpSpPr>
          <p:grpSpPr>
            <a:xfrm>
              <a:off x="7385761" y="5311719"/>
              <a:ext cx="741469" cy="138499"/>
              <a:chOff x="7385761" y="5311719"/>
              <a:chExt cx="741469" cy="138499"/>
            </a:xfrm>
          </p:grpSpPr>
          <p:grpSp>
            <p:nvGrpSpPr>
              <p:cNvPr id="194" name="그룹 193">
                <a:extLst>
                  <a:ext uri="{FF2B5EF4-FFF2-40B4-BE49-F238E27FC236}">
                    <a16:creationId xmlns:a16="http://schemas.microsoft.com/office/drawing/2014/main" id="{B64D3C8A-F2D9-429D-80DA-06E6EFEB95C3}"/>
                  </a:ext>
                </a:extLst>
              </p:cNvPr>
              <p:cNvGrpSpPr/>
              <p:nvPr/>
            </p:nvGrpSpPr>
            <p:grpSpPr>
              <a:xfrm>
                <a:off x="7385761" y="5361262"/>
                <a:ext cx="180000" cy="54424"/>
                <a:chOff x="4252839" y="2312540"/>
                <a:chExt cx="180000" cy="54424"/>
              </a:xfrm>
            </p:grpSpPr>
            <p:cxnSp>
              <p:nvCxnSpPr>
                <p:cNvPr id="196" name="직선 연결선 195">
                  <a:extLst>
                    <a:ext uri="{FF2B5EF4-FFF2-40B4-BE49-F238E27FC236}">
                      <a16:creationId xmlns:a16="http://schemas.microsoft.com/office/drawing/2014/main" id="{E3522923-6C4E-4838-A9EE-3ACA7D3DCE8B}"/>
                    </a:ext>
                  </a:extLst>
                </p:cNvPr>
                <p:cNvCxnSpPr/>
                <p:nvPr/>
              </p:nvCxnSpPr>
              <p:spPr>
                <a:xfrm>
                  <a:off x="4252839" y="2339752"/>
                  <a:ext cx="180000" cy="0"/>
                </a:xfrm>
                <a:prstGeom prst="line">
                  <a:avLst/>
                </a:prstGeom>
                <a:ln cap="rnd">
                  <a:solidFill>
                    <a:srgbClr val="00008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7" name="직사각형 196">
                  <a:extLst>
                    <a:ext uri="{FF2B5EF4-FFF2-40B4-BE49-F238E27FC236}">
                      <a16:creationId xmlns:a16="http://schemas.microsoft.com/office/drawing/2014/main" id="{47DCAF8E-9CBC-44D0-8810-047B5740A107}"/>
                    </a:ext>
                  </a:extLst>
                </p:cNvPr>
                <p:cNvSpPr/>
                <p:nvPr/>
              </p:nvSpPr>
              <p:spPr>
                <a:xfrm>
                  <a:off x="4315627" y="2312540"/>
                  <a:ext cx="54424" cy="54424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rgbClr val="000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/>
                </a:p>
              </p:txBody>
            </p:sp>
          </p:grp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87B64B0B-2F48-4FCC-A7F4-F03C17B45828}"/>
                  </a:ext>
                </a:extLst>
              </p:cNvPr>
              <p:cNvSpPr txBox="1"/>
              <p:nvPr/>
            </p:nvSpPr>
            <p:spPr>
              <a:xfrm>
                <a:off x="7620681" y="5311719"/>
                <a:ext cx="506549" cy="1384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W25113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9" name="그룹 188">
              <a:extLst>
                <a:ext uri="{FF2B5EF4-FFF2-40B4-BE49-F238E27FC236}">
                  <a16:creationId xmlns:a16="http://schemas.microsoft.com/office/drawing/2014/main" id="{4545DED5-2E26-44C6-BED9-110B1513F4C3}"/>
                </a:ext>
              </a:extLst>
            </p:cNvPr>
            <p:cNvGrpSpPr/>
            <p:nvPr/>
          </p:nvGrpSpPr>
          <p:grpSpPr>
            <a:xfrm>
              <a:off x="7385761" y="5449743"/>
              <a:ext cx="805590" cy="138499"/>
              <a:chOff x="7385761" y="5497363"/>
              <a:chExt cx="805590" cy="138499"/>
            </a:xfrm>
          </p:grpSpPr>
          <p:grpSp>
            <p:nvGrpSpPr>
              <p:cNvPr id="190" name="그룹 189">
                <a:extLst>
                  <a:ext uri="{FF2B5EF4-FFF2-40B4-BE49-F238E27FC236}">
                    <a16:creationId xmlns:a16="http://schemas.microsoft.com/office/drawing/2014/main" id="{C580D5E3-43E8-4300-9C60-94D5384C4D43}"/>
                  </a:ext>
                </a:extLst>
              </p:cNvPr>
              <p:cNvGrpSpPr/>
              <p:nvPr/>
            </p:nvGrpSpPr>
            <p:grpSpPr>
              <a:xfrm>
                <a:off x="7385761" y="5536601"/>
                <a:ext cx="180000" cy="54424"/>
                <a:chOff x="4252839" y="2291106"/>
                <a:chExt cx="180000" cy="54424"/>
              </a:xfrm>
            </p:grpSpPr>
            <p:cxnSp>
              <p:nvCxnSpPr>
                <p:cNvPr id="192" name="직선 연결선 191">
                  <a:extLst>
                    <a:ext uri="{FF2B5EF4-FFF2-40B4-BE49-F238E27FC236}">
                      <a16:creationId xmlns:a16="http://schemas.microsoft.com/office/drawing/2014/main" id="{CC6CD1EE-DBB2-45A5-8616-06100E611823}"/>
                    </a:ext>
                  </a:extLst>
                </p:cNvPr>
                <p:cNvCxnSpPr/>
                <p:nvPr/>
              </p:nvCxnSpPr>
              <p:spPr>
                <a:xfrm>
                  <a:off x="4252839" y="2318318"/>
                  <a:ext cx="180000" cy="0"/>
                </a:xfrm>
                <a:prstGeom prst="line">
                  <a:avLst/>
                </a:prstGeom>
                <a:ln cap="rnd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3" name="타원 192">
                  <a:extLst>
                    <a:ext uri="{FF2B5EF4-FFF2-40B4-BE49-F238E27FC236}">
                      <a16:creationId xmlns:a16="http://schemas.microsoft.com/office/drawing/2014/main" id="{13C926FE-96B3-4F86-961E-8F936AA8C424}"/>
                    </a:ext>
                  </a:extLst>
                </p:cNvPr>
                <p:cNvSpPr/>
                <p:nvPr/>
              </p:nvSpPr>
              <p:spPr>
                <a:xfrm>
                  <a:off x="4315627" y="2291106"/>
                  <a:ext cx="54424" cy="54424"/>
                </a:xfrm>
                <a:prstGeom prst="ellipse">
                  <a:avLst/>
                </a:prstGeom>
                <a:solidFill>
                  <a:schemeClr val="bg1"/>
                </a:solidFill>
                <a:ln w="63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/>
                </a:p>
              </p:txBody>
            </p:sp>
          </p:grpSp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27403236-CA05-4ADB-BF13-D79B2A379A34}"/>
                  </a:ext>
                </a:extLst>
              </p:cNvPr>
              <p:cNvSpPr txBox="1"/>
              <p:nvPr/>
            </p:nvSpPr>
            <p:spPr>
              <a:xfrm>
                <a:off x="7620681" y="5497363"/>
                <a:ext cx="570670" cy="1384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L21(DE3)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98" name="그룹 197">
            <a:extLst>
              <a:ext uri="{FF2B5EF4-FFF2-40B4-BE49-F238E27FC236}">
                <a16:creationId xmlns:a16="http://schemas.microsoft.com/office/drawing/2014/main" id="{1767D51E-DBFC-4019-B6E6-404CFC193E8B}"/>
              </a:ext>
            </a:extLst>
          </p:cNvPr>
          <p:cNvGrpSpPr/>
          <p:nvPr/>
        </p:nvGrpSpPr>
        <p:grpSpPr>
          <a:xfrm>
            <a:off x="6709683" y="301636"/>
            <a:ext cx="805590" cy="276523"/>
            <a:chOff x="7385761" y="5311719"/>
            <a:chExt cx="805590" cy="276523"/>
          </a:xfrm>
        </p:grpSpPr>
        <p:grpSp>
          <p:nvGrpSpPr>
            <p:cNvPr id="199" name="그룹 198">
              <a:extLst>
                <a:ext uri="{FF2B5EF4-FFF2-40B4-BE49-F238E27FC236}">
                  <a16:creationId xmlns:a16="http://schemas.microsoft.com/office/drawing/2014/main" id="{0FF97254-725A-4A2E-A232-483680213B16}"/>
                </a:ext>
              </a:extLst>
            </p:cNvPr>
            <p:cNvGrpSpPr/>
            <p:nvPr/>
          </p:nvGrpSpPr>
          <p:grpSpPr>
            <a:xfrm>
              <a:off x="7385761" y="5311719"/>
              <a:ext cx="741469" cy="138499"/>
              <a:chOff x="7385761" y="5311719"/>
              <a:chExt cx="741469" cy="138499"/>
            </a:xfrm>
          </p:grpSpPr>
          <p:grpSp>
            <p:nvGrpSpPr>
              <p:cNvPr id="205" name="그룹 204">
                <a:extLst>
                  <a:ext uri="{FF2B5EF4-FFF2-40B4-BE49-F238E27FC236}">
                    <a16:creationId xmlns:a16="http://schemas.microsoft.com/office/drawing/2014/main" id="{DA1D0D1F-4E6A-48DD-8C33-06A523DCFB7A}"/>
                  </a:ext>
                </a:extLst>
              </p:cNvPr>
              <p:cNvGrpSpPr/>
              <p:nvPr/>
            </p:nvGrpSpPr>
            <p:grpSpPr>
              <a:xfrm>
                <a:off x="7385761" y="5361262"/>
                <a:ext cx="180000" cy="54424"/>
                <a:chOff x="4252839" y="2312540"/>
                <a:chExt cx="180000" cy="54424"/>
              </a:xfrm>
            </p:grpSpPr>
            <p:cxnSp>
              <p:nvCxnSpPr>
                <p:cNvPr id="207" name="직선 연결선 206">
                  <a:extLst>
                    <a:ext uri="{FF2B5EF4-FFF2-40B4-BE49-F238E27FC236}">
                      <a16:creationId xmlns:a16="http://schemas.microsoft.com/office/drawing/2014/main" id="{99A3CFFD-1A90-4041-8D77-81DF61DBC319}"/>
                    </a:ext>
                  </a:extLst>
                </p:cNvPr>
                <p:cNvCxnSpPr/>
                <p:nvPr/>
              </p:nvCxnSpPr>
              <p:spPr>
                <a:xfrm>
                  <a:off x="4252839" y="2339752"/>
                  <a:ext cx="180000" cy="0"/>
                </a:xfrm>
                <a:prstGeom prst="line">
                  <a:avLst/>
                </a:prstGeom>
                <a:ln cap="rnd">
                  <a:solidFill>
                    <a:srgbClr val="00008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8" name="직사각형 207">
                  <a:extLst>
                    <a:ext uri="{FF2B5EF4-FFF2-40B4-BE49-F238E27FC236}">
                      <a16:creationId xmlns:a16="http://schemas.microsoft.com/office/drawing/2014/main" id="{A51E754B-AC8B-4998-8B07-6575126D0149}"/>
                    </a:ext>
                  </a:extLst>
                </p:cNvPr>
                <p:cNvSpPr/>
                <p:nvPr/>
              </p:nvSpPr>
              <p:spPr>
                <a:xfrm>
                  <a:off x="4315627" y="2312540"/>
                  <a:ext cx="54424" cy="54424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rgbClr val="000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/>
                </a:p>
              </p:txBody>
            </p:sp>
          </p:grp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EC5C5103-57F8-4A60-B6DC-DF0AD47662AA}"/>
                  </a:ext>
                </a:extLst>
              </p:cNvPr>
              <p:cNvSpPr txBox="1"/>
              <p:nvPr/>
            </p:nvSpPr>
            <p:spPr>
              <a:xfrm>
                <a:off x="7620681" y="5311719"/>
                <a:ext cx="506549" cy="1384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W25113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0" name="그룹 199">
              <a:extLst>
                <a:ext uri="{FF2B5EF4-FFF2-40B4-BE49-F238E27FC236}">
                  <a16:creationId xmlns:a16="http://schemas.microsoft.com/office/drawing/2014/main" id="{9280D614-64BB-4F10-9CA1-55A68FBFEAAB}"/>
                </a:ext>
              </a:extLst>
            </p:cNvPr>
            <p:cNvGrpSpPr/>
            <p:nvPr/>
          </p:nvGrpSpPr>
          <p:grpSpPr>
            <a:xfrm>
              <a:off x="7385761" y="5449743"/>
              <a:ext cx="805590" cy="138499"/>
              <a:chOff x="7385761" y="5497363"/>
              <a:chExt cx="805590" cy="138499"/>
            </a:xfrm>
          </p:grpSpPr>
          <p:grpSp>
            <p:nvGrpSpPr>
              <p:cNvPr id="201" name="그룹 200">
                <a:extLst>
                  <a:ext uri="{FF2B5EF4-FFF2-40B4-BE49-F238E27FC236}">
                    <a16:creationId xmlns:a16="http://schemas.microsoft.com/office/drawing/2014/main" id="{FA774A9A-AF42-45E9-B9D4-4E24C739AA80}"/>
                  </a:ext>
                </a:extLst>
              </p:cNvPr>
              <p:cNvGrpSpPr/>
              <p:nvPr/>
            </p:nvGrpSpPr>
            <p:grpSpPr>
              <a:xfrm>
                <a:off x="7385761" y="5536601"/>
                <a:ext cx="180000" cy="54424"/>
                <a:chOff x="4252839" y="2291106"/>
                <a:chExt cx="180000" cy="54424"/>
              </a:xfrm>
            </p:grpSpPr>
            <p:cxnSp>
              <p:nvCxnSpPr>
                <p:cNvPr id="203" name="직선 연결선 202">
                  <a:extLst>
                    <a:ext uri="{FF2B5EF4-FFF2-40B4-BE49-F238E27FC236}">
                      <a16:creationId xmlns:a16="http://schemas.microsoft.com/office/drawing/2014/main" id="{BFD7EB41-8A42-4188-B7A6-A1A6C5225706}"/>
                    </a:ext>
                  </a:extLst>
                </p:cNvPr>
                <p:cNvCxnSpPr/>
                <p:nvPr/>
              </p:nvCxnSpPr>
              <p:spPr>
                <a:xfrm>
                  <a:off x="4252839" y="2318318"/>
                  <a:ext cx="180000" cy="0"/>
                </a:xfrm>
                <a:prstGeom prst="line">
                  <a:avLst/>
                </a:prstGeom>
                <a:ln cap="rnd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4" name="타원 203">
                  <a:extLst>
                    <a:ext uri="{FF2B5EF4-FFF2-40B4-BE49-F238E27FC236}">
                      <a16:creationId xmlns:a16="http://schemas.microsoft.com/office/drawing/2014/main" id="{43E10258-F2FD-4E59-B5AC-59BCB116D5EC}"/>
                    </a:ext>
                  </a:extLst>
                </p:cNvPr>
                <p:cNvSpPr/>
                <p:nvPr/>
              </p:nvSpPr>
              <p:spPr>
                <a:xfrm>
                  <a:off x="4315627" y="2291106"/>
                  <a:ext cx="54424" cy="54424"/>
                </a:xfrm>
                <a:prstGeom prst="ellipse">
                  <a:avLst/>
                </a:prstGeom>
                <a:solidFill>
                  <a:schemeClr val="bg1"/>
                </a:solidFill>
                <a:ln w="63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/>
                </a:p>
              </p:txBody>
            </p:sp>
          </p:grpSp>
          <p:sp>
            <p:nvSpPr>
              <p:cNvPr id="202" name="TextBox 201">
                <a:extLst>
                  <a:ext uri="{FF2B5EF4-FFF2-40B4-BE49-F238E27FC236}">
                    <a16:creationId xmlns:a16="http://schemas.microsoft.com/office/drawing/2014/main" id="{12B8278B-9806-4979-BC7C-42848DB050FC}"/>
                  </a:ext>
                </a:extLst>
              </p:cNvPr>
              <p:cNvSpPr txBox="1"/>
              <p:nvPr/>
            </p:nvSpPr>
            <p:spPr>
              <a:xfrm>
                <a:off x="7620681" y="5497363"/>
                <a:ext cx="570670" cy="1384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L21(DE3)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09" name="그룹 208">
            <a:extLst>
              <a:ext uri="{FF2B5EF4-FFF2-40B4-BE49-F238E27FC236}">
                <a16:creationId xmlns:a16="http://schemas.microsoft.com/office/drawing/2014/main" id="{F61C6AE4-BA7B-45C3-8BFE-A7BB96231AE0}"/>
              </a:ext>
            </a:extLst>
          </p:cNvPr>
          <p:cNvGrpSpPr/>
          <p:nvPr/>
        </p:nvGrpSpPr>
        <p:grpSpPr>
          <a:xfrm>
            <a:off x="3999739" y="2512118"/>
            <a:ext cx="741469" cy="276523"/>
            <a:chOff x="7385761" y="5311719"/>
            <a:chExt cx="741469" cy="276523"/>
          </a:xfrm>
        </p:grpSpPr>
        <p:grpSp>
          <p:nvGrpSpPr>
            <p:cNvPr id="210" name="그룹 209">
              <a:extLst>
                <a:ext uri="{FF2B5EF4-FFF2-40B4-BE49-F238E27FC236}">
                  <a16:creationId xmlns:a16="http://schemas.microsoft.com/office/drawing/2014/main" id="{A0E6A7D5-16DC-43E8-91CA-AC077A48FFFA}"/>
                </a:ext>
              </a:extLst>
            </p:cNvPr>
            <p:cNvGrpSpPr/>
            <p:nvPr/>
          </p:nvGrpSpPr>
          <p:grpSpPr>
            <a:xfrm>
              <a:off x="7385761" y="5311719"/>
              <a:ext cx="741469" cy="138499"/>
              <a:chOff x="7385761" y="5311719"/>
              <a:chExt cx="741469" cy="138499"/>
            </a:xfrm>
          </p:grpSpPr>
          <p:grpSp>
            <p:nvGrpSpPr>
              <p:cNvPr id="216" name="그룹 215">
                <a:extLst>
                  <a:ext uri="{FF2B5EF4-FFF2-40B4-BE49-F238E27FC236}">
                    <a16:creationId xmlns:a16="http://schemas.microsoft.com/office/drawing/2014/main" id="{7E996C34-E2E7-4787-AFA6-A41C2CD5A376}"/>
                  </a:ext>
                </a:extLst>
              </p:cNvPr>
              <p:cNvGrpSpPr/>
              <p:nvPr/>
            </p:nvGrpSpPr>
            <p:grpSpPr>
              <a:xfrm>
                <a:off x="7385761" y="5361262"/>
                <a:ext cx="180000" cy="54424"/>
                <a:chOff x="4252839" y="2312540"/>
                <a:chExt cx="180000" cy="54424"/>
              </a:xfrm>
            </p:grpSpPr>
            <p:cxnSp>
              <p:nvCxnSpPr>
                <p:cNvPr id="218" name="직선 연결선 217">
                  <a:extLst>
                    <a:ext uri="{FF2B5EF4-FFF2-40B4-BE49-F238E27FC236}">
                      <a16:creationId xmlns:a16="http://schemas.microsoft.com/office/drawing/2014/main" id="{3F632CEF-C32C-4CD7-8A60-74A389302EE0}"/>
                    </a:ext>
                  </a:extLst>
                </p:cNvPr>
                <p:cNvCxnSpPr/>
                <p:nvPr/>
              </p:nvCxnSpPr>
              <p:spPr>
                <a:xfrm>
                  <a:off x="4252839" y="2339752"/>
                  <a:ext cx="180000" cy="0"/>
                </a:xfrm>
                <a:prstGeom prst="line">
                  <a:avLst/>
                </a:prstGeom>
                <a:ln cap="rnd">
                  <a:solidFill>
                    <a:srgbClr val="00008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9" name="직사각형 218">
                  <a:extLst>
                    <a:ext uri="{FF2B5EF4-FFF2-40B4-BE49-F238E27FC236}">
                      <a16:creationId xmlns:a16="http://schemas.microsoft.com/office/drawing/2014/main" id="{B9BA43F2-D004-47A2-A052-F02968CDD88C}"/>
                    </a:ext>
                  </a:extLst>
                </p:cNvPr>
                <p:cNvSpPr/>
                <p:nvPr/>
              </p:nvSpPr>
              <p:spPr>
                <a:xfrm rot="2629078">
                  <a:off x="4315627" y="2312540"/>
                  <a:ext cx="54424" cy="54424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rgbClr val="000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/>
                </a:p>
              </p:txBody>
            </p:sp>
          </p:grpSp>
          <p:sp>
            <p:nvSpPr>
              <p:cNvPr id="217" name="TextBox 216">
                <a:extLst>
                  <a:ext uri="{FF2B5EF4-FFF2-40B4-BE49-F238E27FC236}">
                    <a16:creationId xmlns:a16="http://schemas.microsoft.com/office/drawing/2014/main" id="{014DBC8E-30F1-4049-AF54-7BAC90E13C8A}"/>
                  </a:ext>
                </a:extLst>
              </p:cNvPr>
              <p:cNvSpPr txBox="1"/>
              <p:nvPr/>
            </p:nvSpPr>
            <p:spPr>
              <a:xfrm>
                <a:off x="7620681" y="5311719"/>
                <a:ext cx="506549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B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1" name="그룹 210">
              <a:extLst>
                <a:ext uri="{FF2B5EF4-FFF2-40B4-BE49-F238E27FC236}">
                  <a16:creationId xmlns:a16="http://schemas.microsoft.com/office/drawing/2014/main" id="{6513D8E6-E18D-4CA9-87A9-6789FA688514}"/>
                </a:ext>
              </a:extLst>
            </p:cNvPr>
            <p:cNvGrpSpPr/>
            <p:nvPr/>
          </p:nvGrpSpPr>
          <p:grpSpPr>
            <a:xfrm>
              <a:off x="7385761" y="5449743"/>
              <a:ext cx="491400" cy="138499"/>
              <a:chOff x="7385761" y="5497363"/>
              <a:chExt cx="491400" cy="138499"/>
            </a:xfrm>
          </p:grpSpPr>
          <p:grpSp>
            <p:nvGrpSpPr>
              <p:cNvPr id="212" name="그룹 211">
                <a:extLst>
                  <a:ext uri="{FF2B5EF4-FFF2-40B4-BE49-F238E27FC236}">
                    <a16:creationId xmlns:a16="http://schemas.microsoft.com/office/drawing/2014/main" id="{6CC9F14B-AF3F-4475-9DCC-C271D459C2DE}"/>
                  </a:ext>
                </a:extLst>
              </p:cNvPr>
              <p:cNvGrpSpPr/>
              <p:nvPr/>
            </p:nvGrpSpPr>
            <p:grpSpPr>
              <a:xfrm>
                <a:off x="7385761" y="5536601"/>
                <a:ext cx="180000" cy="54424"/>
                <a:chOff x="4252839" y="2291106"/>
                <a:chExt cx="180000" cy="54424"/>
              </a:xfrm>
            </p:grpSpPr>
            <p:cxnSp>
              <p:nvCxnSpPr>
                <p:cNvPr id="214" name="직선 연결선 213">
                  <a:extLst>
                    <a:ext uri="{FF2B5EF4-FFF2-40B4-BE49-F238E27FC236}">
                      <a16:creationId xmlns:a16="http://schemas.microsoft.com/office/drawing/2014/main" id="{8D1CAAA8-C67C-4DC0-9410-75E6FB82720F}"/>
                    </a:ext>
                  </a:extLst>
                </p:cNvPr>
                <p:cNvCxnSpPr/>
                <p:nvPr/>
              </p:nvCxnSpPr>
              <p:spPr>
                <a:xfrm>
                  <a:off x="4252839" y="2318318"/>
                  <a:ext cx="180000" cy="0"/>
                </a:xfrm>
                <a:prstGeom prst="line">
                  <a:avLst/>
                </a:prstGeom>
                <a:ln cap="rnd">
                  <a:solidFill>
                    <a:srgbClr val="00008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5" name="타원 214">
                  <a:extLst>
                    <a:ext uri="{FF2B5EF4-FFF2-40B4-BE49-F238E27FC236}">
                      <a16:creationId xmlns:a16="http://schemas.microsoft.com/office/drawing/2014/main" id="{AA3F89AC-7FD0-479C-874D-075BB33C2350}"/>
                    </a:ext>
                  </a:extLst>
                </p:cNvPr>
                <p:cNvSpPr/>
                <p:nvPr/>
              </p:nvSpPr>
              <p:spPr>
                <a:xfrm>
                  <a:off x="4315627" y="2291106"/>
                  <a:ext cx="54424" cy="54424"/>
                </a:xfrm>
                <a:prstGeom prst="ellipse">
                  <a:avLst/>
                </a:prstGeom>
                <a:solidFill>
                  <a:schemeClr val="bg1"/>
                </a:solidFill>
                <a:ln w="6350">
                  <a:solidFill>
                    <a:srgbClr val="000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/>
                </a:p>
              </p:txBody>
            </p:sp>
          </p:grpSp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4942A6CF-2A20-4D4C-87C3-56CD9CD48AFB}"/>
                  </a:ext>
                </a:extLst>
              </p:cNvPr>
              <p:cNvSpPr txBox="1"/>
              <p:nvPr/>
            </p:nvSpPr>
            <p:spPr>
              <a:xfrm>
                <a:off x="7620681" y="5497363"/>
                <a:ext cx="256480" cy="1384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ucc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20" name="그룹 219">
            <a:extLst>
              <a:ext uri="{FF2B5EF4-FFF2-40B4-BE49-F238E27FC236}">
                <a16:creationId xmlns:a16="http://schemas.microsoft.com/office/drawing/2014/main" id="{4EA86E4C-CD65-4496-B3A2-AD69F2E3A4DB}"/>
              </a:ext>
            </a:extLst>
          </p:cNvPr>
          <p:cNvGrpSpPr/>
          <p:nvPr/>
        </p:nvGrpSpPr>
        <p:grpSpPr>
          <a:xfrm>
            <a:off x="6946207" y="2512118"/>
            <a:ext cx="741469" cy="276523"/>
            <a:chOff x="7385761" y="5311719"/>
            <a:chExt cx="741469" cy="276523"/>
          </a:xfrm>
        </p:grpSpPr>
        <p:grpSp>
          <p:nvGrpSpPr>
            <p:cNvPr id="221" name="그룹 220">
              <a:extLst>
                <a:ext uri="{FF2B5EF4-FFF2-40B4-BE49-F238E27FC236}">
                  <a16:creationId xmlns:a16="http://schemas.microsoft.com/office/drawing/2014/main" id="{0DEF606C-621B-435C-BEBA-6B5BE4EFE774}"/>
                </a:ext>
              </a:extLst>
            </p:cNvPr>
            <p:cNvGrpSpPr/>
            <p:nvPr/>
          </p:nvGrpSpPr>
          <p:grpSpPr>
            <a:xfrm>
              <a:off x="7385761" y="5311719"/>
              <a:ext cx="741469" cy="138499"/>
              <a:chOff x="7385761" y="5311719"/>
              <a:chExt cx="741469" cy="138499"/>
            </a:xfrm>
          </p:grpSpPr>
          <p:grpSp>
            <p:nvGrpSpPr>
              <p:cNvPr id="227" name="그룹 226">
                <a:extLst>
                  <a:ext uri="{FF2B5EF4-FFF2-40B4-BE49-F238E27FC236}">
                    <a16:creationId xmlns:a16="http://schemas.microsoft.com/office/drawing/2014/main" id="{885DC7C8-EB05-41A9-A77A-095EA0545E37}"/>
                  </a:ext>
                </a:extLst>
              </p:cNvPr>
              <p:cNvGrpSpPr/>
              <p:nvPr/>
            </p:nvGrpSpPr>
            <p:grpSpPr>
              <a:xfrm>
                <a:off x="7385761" y="5361262"/>
                <a:ext cx="180000" cy="54424"/>
                <a:chOff x="4252839" y="2312540"/>
                <a:chExt cx="180000" cy="54424"/>
              </a:xfrm>
            </p:grpSpPr>
            <p:cxnSp>
              <p:nvCxnSpPr>
                <p:cNvPr id="229" name="직선 연결선 228">
                  <a:extLst>
                    <a:ext uri="{FF2B5EF4-FFF2-40B4-BE49-F238E27FC236}">
                      <a16:creationId xmlns:a16="http://schemas.microsoft.com/office/drawing/2014/main" id="{F72A6B7B-F07B-43F4-9924-E8A974EF4FC7}"/>
                    </a:ext>
                  </a:extLst>
                </p:cNvPr>
                <p:cNvCxnSpPr/>
                <p:nvPr/>
              </p:nvCxnSpPr>
              <p:spPr>
                <a:xfrm>
                  <a:off x="4252839" y="2339752"/>
                  <a:ext cx="180000" cy="0"/>
                </a:xfrm>
                <a:prstGeom prst="line">
                  <a:avLst/>
                </a:prstGeom>
                <a:ln cap="rnd">
                  <a:solidFill>
                    <a:srgbClr val="00008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0" name="직사각형 229">
                  <a:extLst>
                    <a:ext uri="{FF2B5EF4-FFF2-40B4-BE49-F238E27FC236}">
                      <a16:creationId xmlns:a16="http://schemas.microsoft.com/office/drawing/2014/main" id="{4A504442-B363-4A9E-ABA3-B49A9CAE5714}"/>
                    </a:ext>
                  </a:extLst>
                </p:cNvPr>
                <p:cNvSpPr/>
                <p:nvPr/>
              </p:nvSpPr>
              <p:spPr>
                <a:xfrm rot="2629078">
                  <a:off x="4315627" y="2312540"/>
                  <a:ext cx="54424" cy="54424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rgbClr val="000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/>
                </a:p>
              </p:txBody>
            </p:sp>
          </p:grpSp>
          <p:sp>
            <p:nvSpPr>
              <p:cNvPr id="228" name="TextBox 227">
                <a:extLst>
                  <a:ext uri="{FF2B5EF4-FFF2-40B4-BE49-F238E27FC236}">
                    <a16:creationId xmlns:a16="http://schemas.microsoft.com/office/drawing/2014/main" id="{E578718F-7176-4C31-A1A2-A970C05249A8}"/>
                  </a:ext>
                </a:extLst>
              </p:cNvPr>
              <p:cNvSpPr txBox="1"/>
              <p:nvPr/>
            </p:nvSpPr>
            <p:spPr>
              <a:xfrm>
                <a:off x="7620681" y="5311719"/>
                <a:ext cx="506549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B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2" name="그룹 221">
              <a:extLst>
                <a:ext uri="{FF2B5EF4-FFF2-40B4-BE49-F238E27FC236}">
                  <a16:creationId xmlns:a16="http://schemas.microsoft.com/office/drawing/2014/main" id="{020C6D25-7CEC-4C47-982C-21C596A0CCA6}"/>
                </a:ext>
              </a:extLst>
            </p:cNvPr>
            <p:cNvGrpSpPr/>
            <p:nvPr/>
          </p:nvGrpSpPr>
          <p:grpSpPr>
            <a:xfrm>
              <a:off x="7385761" y="5449743"/>
              <a:ext cx="491400" cy="138499"/>
              <a:chOff x="7385761" y="5497363"/>
              <a:chExt cx="491400" cy="138499"/>
            </a:xfrm>
          </p:grpSpPr>
          <p:grpSp>
            <p:nvGrpSpPr>
              <p:cNvPr id="223" name="그룹 222">
                <a:extLst>
                  <a:ext uri="{FF2B5EF4-FFF2-40B4-BE49-F238E27FC236}">
                    <a16:creationId xmlns:a16="http://schemas.microsoft.com/office/drawing/2014/main" id="{DA22AB56-9247-4DC2-9C91-F1D944A6D9D4}"/>
                  </a:ext>
                </a:extLst>
              </p:cNvPr>
              <p:cNvGrpSpPr/>
              <p:nvPr/>
            </p:nvGrpSpPr>
            <p:grpSpPr>
              <a:xfrm>
                <a:off x="7385761" y="5536601"/>
                <a:ext cx="180000" cy="54424"/>
                <a:chOff x="4252839" y="2291106"/>
                <a:chExt cx="180000" cy="54424"/>
              </a:xfrm>
            </p:grpSpPr>
            <p:cxnSp>
              <p:nvCxnSpPr>
                <p:cNvPr id="225" name="직선 연결선 224">
                  <a:extLst>
                    <a:ext uri="{FF2B5EF4-FFF2-40B4-BE49-F238E27FC236}">
                      <a16:creationId xmlns:a16="http://schemas.microsoft.com/office/drawing/2014/main" id="{47357DEE-387A-409E-B850-D395CF586163}"/>
                    </a:ext>
                  </a:extLst>
                </p:cNvPr>
                <p:cNvCxnSpPr/>
                <p:nvPr/>
              </p:nvCxnSpPr>
              <p:spPr>
                <a:xfrm>
                  <a:off x="4252839" y="2318318"/>
                  <a:ext cx="180000" cy="0"/>
                </a:xfrm>
                <a:prstGeom prst="line">
                  <a:avLst/>
                </a:prstGeom>
                <a:ln cap="rnd">
                  <a:solidFill>
                    <a:srgbClr val="00008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6" name="타원 225">
                  <a:extLst>
                    <a:ext uri="{FF2B5EF4-FFF2-40B4-BE49-F238E27FC236}">
                      <a16:creationId xmlns:a16="http://schemas.microsoft.com/office/drawing/2014/main" id="{D6AB4F70-8C1A-43ED-9802-8AB89C877840}"/>
                    </a:ext>
                  </a:extLst>
                </p:cNvPr>
                <p:cNvSpPr/>
                <p:nvPr/>
              </p:nvSpPr>
              <p:spPr>
                <a:xfrm>
                  <a:off x="4315627" y="2291106"/>
                  <a:ext cx="54424" cy="54424"/>
                </a:xfrm>
                <a:prstGeom prst="ellipse">
                  <a:avLst/>
                </a:prstGeom>
                <a:solidFill>
                  <a:schemeClr val="bg1"/>
                </a:solidFill>
                <a:ln w="6350">
                  <a:solidFill>
                    <a:srgbClr val="000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/>
                </a:p>
              </p:txBody>
            </p:sp>
          </p:grpSp>
          <p:sp>
            <p:nvSpPr>
              <p:cNvPr id="224" name="TextBox 223">
                <a:extLst>
                  <a:ext uri="{FF2B5EF4-FFF2-40B4-BE49-F238E27FC236}">
                    <a16:creationId xmlns:a16="http://schemas.microsoft.com/office/drawing/2014/main" id="{6E601314-85F3-459F-AF19-9D587AED0580}"/>
                  </a:ext>
                </a:extLst>
              </p:cNvPr>
              <p:cNvSpPr txBox="1"/>
              <p:nvPr/>
            </p:nvSpPr>
            <p:spPr>
              <a:xfrm>
                <a:off x="7620681" y="5497363"/>
                <a:ext cx="256480" cy="1384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ucc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31" name="그룹 230">
            <a:extLst>
              <a:ext uri="{FF2B5EF4-FFF2-40B4-BE49-F238E27FC236}">
                <a16:creationId xmlns:a16="http://schemas.microsoft.com/office/drawing/2014/main" id="{B0C483C2-E130-4DB2-BA76-D989B9CE5548}"/>
              </a:ext>
            </a:extLst>
          </p:cNvPr>
          <p:cNvGrpSpPr/>
          <p:nvPr/>
        </p:nvGrpSpPr>
        <p:grpSpPr>
          <a:xfrm>
            <a:off x="4288331" y="4865885"/>
            <a:ext cx="243425" cy="795015"/>
            <a:chOff x="4286162" y="4868515"/>
            <a:chExt cx="243425" cy="795015"/>
          </a:xfrm>
        </p:grpSpPr>
        <p:grpSp>
          <p:nvGrpSpPr>
            <p:cNvPr id="232" name="그룹 231">
              <a:extLst>
                <a:ext uri="{FF2B5EF4-FFF2-40B4-BE49-F238E27FC236}">
                  <a16:creationId xmlns:a16="http://schemas.microsoft.com/office/drawing/2014/main" id="{05BB55A5-EBB4-4CAC-B2CF-36FA33D183A8}"/>
                </a:ext>
              </a:extLst>
            </p:cNvPr>
            <p:cNvGrpSpPr/>
            <p:nvPr/>
          </p:nvGrpSpPr>
          <p:grpSpPr>
            <a:xfrm>
              <a:off x="4286162" y="4894817"/>
              <a:ext cx="106933" cy="35398"/>
              <a:chOff x="1635238" y="2864169"/>
              <a:chExt cx="138112" cy="45719"/>
            </a:xfrm>
          </p:grpSpPr>
          <p:sp>
            <p:nvSpPr>
              <p:cNvPr id="270" name="직사각형 269">
                <a:extLst>
                  <a:ext uri="{FF2B5EF4-FFF2-40B4-BE49-F238E27FC236}">
                    <a16:creationId xmlns:a16="http://schemas.microsoft.com/office/drawing/2014/main" id="{6F6AF7DF-5432-4BB3-BB44-D12895DE9532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solidFill>
                <a:srgbClr val="FF0000"/>
              </a:solidFill>
              <a:ln w="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271" name="직선 연결선 270">
                <a:extLst>
                  <a:ext uri="{FF2B5EF4-FFF2-40B4-BE49-F238E27FC236}">
                    <a16:creationId xmlns:a16="http://schemas.microsoft.com/office/drawing/2014/main" id="{FB89EC0D-FBDF-4148-A94F-815F2A172712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ln w="31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3" name="그룹 232">
              <a:extLst>
                <a:ext uri="{FF2B5EF4-FFF2-40B4-BE49-F238E27FC236}">
                  <a16:creationId xmlns:a16="http://schemas.microsoft.com/office/drawing/2014/main" id="{7F5967E4-1403-4077-B106-AB89E8F1DB3F}"/>
                </a:ext>
              </a:extLst>
            </p:cNvPr>
            <p:cNvGrpSpPr/>
            <p:nvPr/>
          </p:nvGrpSpPr>
          <p:grpSpPr>
            <a:xfrm>
              <a:off x="4286162" y="5363657"/>
              <a:ext cx="106933" cy="35398"/>
              <a:chOff x="1635238" y="2976088"/>
              <a:chExt cx="138112" cy="45719"/>
            </a:xfrm>
          </p:grpSpPr>
          <p:cxnSp>
            <p:nvCxnSpPr>
              <p:cNvPr id="268" name="직선 연결선 267">
                <a:extLst>
                  <a:ext uri="{FF2B5EF4-FFF2-40B4-BE49-F238E27FC236}">
                    <a16:creationId xmlns:a16="http://schemas.microsoft.com/office/drawing/2014/main" id="{97511059-8B39-4ADA-97A7-3454E132F3A4}"/>
                  </a:ext>
                </a:extLst>
              </p:cNvPr>
              <p:cNvCxnSpPr/>
              <p:nvPr/>
            </p:nvCxnSpPr>
            <p:spPr>
              <a:xfrm>
                <a:off x="1635238" y="2998947"/>
                <a:ext cx="138112" cy="0"/>
              </a:xfrm>
              <a:prstGeom prst="line">
                <a:avLst/>
              </a:prstGeom>
              <a:ln w="31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9" name="직사각형 268">
                <a:extLst>
                  <a:ext uri="{FF2B5EF4-FFF2-40B4-BE49-F238E27FC236}">
                    <a16:creationId xmlns:a16="http://schemas.microsoft.com/office/drawing/2014/main" id="{23EE8379-C434-4A6D-AB1F-CF20709D33E1}"/>
                  </a:ext>
                </a:extLst>
              </p:cNvPr>
              <p:cNvSpPr/>
              <p:nvPr/>
            </p:nvSpPr>
            <p:spPr>
              <a:xfrm>
                <a:off x="1681435" y="2976088"/>
                <a:ext cx="45719" cy="45719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234" name="그룹 233">
              <a:extLst>
                <a:ext uri="{FF2B5EF4-FFF2-40B4-BE49-F238E27FC236}">
                  <a16:creationId xmlns:a16="http://schemas.microsoft.com/office/drawing/2014/main" id="{E7CCC82C-1FA1-4F19-A1D0-CD26B3FC5B74}"/>
                </a:ext>
              </a:extLst>
            </p:cNvPr>
            <p:cNvGrpSpPr/>
            <p:nvPr/>
          </p:nvGrpSpPr>
          <p:grpSpPr>
            <a:xfrm>
              <a:off x="4286162" y="4972957"/>
              <a:ext cx="106933" cy="35398"/>
              <a:chOff x="1635238" y="2864169"/>
              <a:chExt cx="138112" cy="45719"/>
            </a:xfrm>
          </p:grpSpPr>
          <p:sp>
            <p:nvSpPr>
              <p:cNvPr id="266" name="직사각형 265">
                <a:extLst>
                  <a:ext uri="{FF2B5EF4-FFF2-40B4-BE49-F238E27FC236}">
                    <a16:creationId xmlns:a16="http://schemas.microsoft.com/office/drawing/2014/main" id="{534466CD-9018-4087-BF2B-A6A4BE34831E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solidFill>
                <a:srgbClr val="FF8000"/>
              </a:solidFill>
              <a:ln w="0">
                <a:solidFill>
                  <a:srgbClr val="FF8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267" name="직선 연결선 266">
                <a:extLst>
                  <a:ext uri="{FF2B5EF4-FFF2-40B4-BE49-F238E27FC236}">
                    <a16:creationId xmlns:a16="http://schemas.microsoft.com/office/drawing/2014/main" id="{027C5EE7-C1C1-4985-94E2-7A353BB1C365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ln w="3175">
                <a:solidFill>
                  <a:srgbClr val="FF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5" name="그룹 234">
              <a:extLst>
                <a:ext uri="{FF2B5EF4-FFF2-40B4-BE49-F238E27FC236}">
                  <a16:creationId xmlns:a16="http://schemas.microsoft.com/office/drawing/2014/main" id="{6E4840A8-62C1-4846-AD90-55E5DC24B932}"/>
                </a:ext>
              </a:extLst>
            </p:cNvPr>
            <p:cNvGrpSpPr/>
            <p:nvPr/>
          </p:nvGrpSpPr>
          <p:grpSpPr>
            <a:xfrm>
              <a:off x="4286162" y="5051097"/>
              <a:ext cx="106933" cy="35398"/>
              <a:chOff x="1635238" y="2864169"/>
              <a:chExt cx="138112" cy="45719"/>
            </a:xfrm>
            <a:solidFill>
              <a:srgbClr val="008000"/>
            </a:solidFill>
          </p:grpSpPr>
          <p:sp>
            <p:nvSpPr>
              <p:cNvPr id="264" name="직사각형 263">
                <a:extLst>
                  <a:ext uri="{FF2B5EF4-FFF2-40B4-BE49-F238E27FC236}">
                    <a16:creationId xmlns:a16="http://schemas.microsoft.com/office/drawing/2014/main" id="{CA492F26-E13D-4EF9-A443-C595FC8DC8D3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grpFill/>
              <a:ln w="0">
                <a:solidFill>
                  <a:srgbClr val="008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265" name="직선 연결선 264">
                <a:extLst>
                  <a:ext uri="{FF2B5EF4-FFF2-40B4-BE49-F238E27FC236}">
                    <a16:creationId xmlns:a16="http://schemas.microsoft.com/office/drawing/2014/main" id="{D9FD75CB-E61A-4A88-90D3-18D8509CC345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grpFill/>
              <a:ln w="3175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6" name="그룹 235">
              <a:extLst>
                <a:ext uri="{FF2B5EF4-FFF2-40B4-BE49-F238E27FC236}">
                  <a16:creationId xmlns:a16="http://schemas.microsoft.com/office/drawing/2014/main" id="{88841CEA-C076-4788-89B8-854FDABC3DE8}"/>
                </a:ext>
              </a:extLst>
            </p:cNvPr>
            <p:cNvGrpSpPr/>
            <p:nvPr/>
          </p:nvGrpSpPr>
          <p:grpSpPr>
            <a:xfrm>
              <a:off x="4286162" y="5129237"/>
              <a:ext cx="106933" cy="35398"/>
              <a:chOff x="1635238" y="2864169"/>
              <a:chExt cx="138112" cy="45719"/>
            </a:xfrm>
            <a:solidFill>
              <a:srgbClr val="000080"/>
            </a:solidFill>
          </p:grpSpPr>
          <p:sp>
            <p:nvSpPr>
              <p:cNvPr id="262" name="직사각형 261">
                <a:extLst>
                  <a:ext uri="{FF2B5EF4-FFF2-40B4-BE49-F238E27FC236}">
                    <a16:creationId xmlns:a16="http://schemas.microsoft.com/office/drawing/2014/main" id="{2F268F10-2C7C-496E-BEBD-3DD4321F1119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grpFill/>
              <a:ln w="0">
                <a:solidFill>
                  <a:srgbClr val="000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263" name="직선 연결선 262">
                <a:extLst>
                  <a:ext uri="{FF2B5EF4-FFF2-40B4-BE49-F238E27FC236}">
                    <a16:creationId xmlns:a16="http://schemas.microsoft.com/office/drawing/2014/main" id="{634896FB-323B-4AE1-AD08-3BC595E2BF60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grpFill/>
              <a:ln w="3175">
                <a:solidFill>
                  <a:srgbClr val="00008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7" name="그룹 236">
              <a:extLst>
                <a:ext uri="{FF2B5EF4-FFF2-40B4-BE49-F238E27FC236}">
                  <a16:creationId xmlns:a16="http://schemas.microsoft.com/office/drawing/2014/main" id="{EAA9784A-1BF1-415F-96E4-1B76AF077EAF}"/>
                </a:ext>
              </a:extLst>
            </p:cNvPr>
            <p:cNvGrpSpPr/>
            <p:nvPr/>
          </p:nvGrpSpPr>
          <p:grpSpPr>
            <a:xfrm>
              <a:off x="4286162" y="5207377"/>
              <a:ext cx="106933" cy="35398"/>
              <a:chOff x="1635238" y="2864169"/>
              <a:chExt cx="138112" cy="45719"/>
            </a:xfrm>
            <a:solidFill>
              <a:srgbClr val="800080"/>
            </a:solidFill>
          </p:grpSpPr>
          <p:sp>
            <p:nvSpPr>
              <p:cNvPr id="260" name="직사각형 259">
                <a:extLst>
                  <a:ext uri="{FF2B5EF4-FFF2-40B4-BE49-F238E27FC236}">
                    <a16:creationId xmlns:a16="http://schemas.microsoft.com/office/drawing/2014/main" id="{39B1AD6C-00B0-4F6E-85E6-F2C5101127D5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grpFill/>
              <a:ln w="0">
                <a:solidFill>
                  <a:srgbClr val="800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261" name="직선 연결선 260">
                <a:extLst>
                  <a:ext uri="{FF2B5EF4-FFF2-40B4-BE49-F238E27FC236}">
                    <a16:creationId xmlns:a16="http://schemas.microsoft.com/office/drawing/2014/main" id="{C9BCED8E-418F-4B08-ABF3-EF27ED8F0399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grpFill/>
              <a:ln w="3175">
                <a:solidFill>
                  <a:srgbClr val="80008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8" name="그룹 237">
              <a:extLst>
                <a:ext uri="{FF2B5EF4-FFF2-40B4-BE49-F238E27FC236}">
                  <a16:creationId xmlns:a16="http://schemas.microsoft.com/office/drawing/2014/main" id="{B4BF8C85-E2BC-4AD5-BB5E-3B6CA15EC2B7}"/>
                </a:ext>
              </a:extLst>
            </p:cNvPr>
            <p:cNvGrpSpPr/>
            <p:nvPr/>
          </p:nvGrpSpPr>
          <p:grpSpPr>
            <a:xfrm>
              <a:off x="4286162" y="5285517"/>
              <a:ext cx="106933" cy="35398"/>
              <a:chOff x="1635238" y="2864169"/>
              <a:chExt cx="138112" cy="45719"/>
            </a:xfrm>
            <a:solidFill>
              <a:srgbClr val="800000"/>
            </a:solidFill>
          </p:grpSpPr>
          <p:sp>
            <p:nvSpPr>
              <p:cNvPr id="258" name="직사각형 257">
                <a:extLst>
                  <a:ext uri="{FF2B5EF4-FFF2-40B4-BE49-F238E27FC236}">
                    <a16:creationId xmlns:a16="http://schemas.microsoft.com/office/drawing/2014/main" id="{4473201B-3022-4664-A141-673CD44AA493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grpFill/>
              <a:ln w="0">
                <a:solidFill>
                  <a:srgbClr val="8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259" name="직선 연결선 258">
                <a:extLst>
                  <a:ext uri="{FF2B5EF4-FFF2-40B4-BE49-F238E27FC236}">
                    <a16:creationId xmlns:a16="http://schemas.microsoft.com/office/drawing/2014/main" id="{E6AC80D8-5C3E-40E9-88D1-74C5DB7F64DD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grpFill/>
              <a:ln w="3175">
                <a:solidFill>
                  <a:srgbClr val="8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9" name="그룹 238">
              <a:extLst>
                <a:ext uri="{FF2B5EF4-FFF2-40B4-BE49-F238E27FC236}">
                  <a16:creationId xmlns:a16="http://schemas.microsoft.com/office/drawing/2014/main" id="{4A680084-3FA6-4410-9B51-EA16ACA50243}"/>
                </a:ext>
              </a:extLst>
            </p:cNvPr>
            <p:cNvGrpSpPr/>
            <p:nvPr/>
          </p:nvGrpSpPr>
          <p:grpSpPr>
            <a:xfrm>
              <a:off x="4286162" y="5441797"/>
              <a:ext cx="106933" cy="35398"/>
              <a:chOff x="1635238" y="2976088"/>
              <a:chExt cx="138112" cy="45719"/>
            </a:xfrm>
          </p:grpSpPr>
          <p:cxnSp>
            <p:nvCxnSpPr>
              <p:cNvPr id="256" name="직선 연결선 255">
                <a:extLst>
                  <a:ext uri="{FF2B5EF4-FFF2-40B4-BE49-F238E27FC236}">
                    <a16:creationId xmlns:a16="http://schemas.microsoft.com/office/drawing/2014/main" id="{15EB29B2-34A8-494B-887E-9424CE8B50BA}"/>
                  </a:ext>
                </a:extLst>
              </p:cNvPr>
              <p:cNvCxnSpPr/>
              <p:nvPr/>
            </p:nvCxnSpPr>
            <p:spPr>
              <a:xfrm>
                <a:off x="1635238" y="2998947"/>
                <a:ext cx="138112" cy="0"/>
              </a:xfrm>
              <a:prstGeom prst="line">
                <a:avLst/>
              </a:prstGeom>
              <a:ln w="3175">
                <a:solidFill>
                  <a:srgbClr val="FF8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7" name="직사각형 256">
                <a:extLst>
                  <a:ext uri="{FF2B5EF4-FFF2-40B4-BE49-F238E27FC236}">
                    <a16:creationId xmlns:a16="http://schemas.microsoft.com/office/drawing/2014/main" id="{7D7E86D2-24BF-4466-9B54-DE9D613D0967}"/>
                  </a:ext>
                </a:extLst>
              </p:cNvPr>
              <p:cNvSpPr/>
              <p:nvPr/>
            </p:nvSpPr>
            <p:spPr>
              <a:xfrm>
                <a:off x="1681435" y="2976088"/>
                <a:ext cx="45719" cy="45719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rgbClr val="FF8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240" name="그룹 239">
              <a:extLst>
                <a:ext uri="{FF2B5EF4-FFF2-40B4-BE49-F238E27FC236}">
                  <a16:creationId xmlns:a16="http://schemas.microsoft.com/office/drawing/2014/main" id="{EEDC3672-6ECA-47EC-BF88-6AEEFE77E196}"/>
                </a:ext>
              </a:extLst>
            </p:cNvPr>
            <p:cNvGrpSpPr/>
            <p:nvPr/>
          </p:nvGrpSpPr>
          <p:grpSpPr>
            <a:xfrm>
              <a:off x="4286162" y="5519937"/>
              <a:ext cx="106933" cy="35398"/>
              <a:chOff x="1635238" y="2976088"/>
              <a:chExt cx="138112" cy="45719"/>
            </a:xfrm>
          </p:grpSpPr>
          <p:cxnSp>
            <p:nvCxnSpPr>
              <p:cNvPr id="254" name="직선 연결선 253">
                <a:extLst>
                  <a:ext uri="{FF2B5EF4-FFF2-40B4-BE49-F238E27FC236}">
                    <a16:creationId xmlns:a16="http://schemas.microsoft.com/office/drawing/2014/main" id="{8D2EE693-A34C-424C-8F4C-947FB22C713B}"/>
                  </a:ext>
                </a:extLst>
              </p:cNvPr>
              <p:cNvCxnSpPr/>
              <p:nvPr/>
            </p:nvCxnSpPr>
            <p:spPr>
              <a:xfrm>
                <a:off x="1635238" y="2998947"/>
                <a:ext cx="138112" cy="0"/>
              </a:xfrm>
              <a:prstGeom prst="line">
                <a:avLst/>
              </a:prstGeom>
              <a:ln w="3175">
                <a:solidFill>
                  <a:srgbClr val="008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5" name="직사각형 254">
                <a:extLst>
                  <a:ext uri="{FF2B5EF4-FFF2-40B4-BE49-F238E27FC236}">
                    <a16:creationId xmlns:a16="http://schemas.microsoft.com/office/drawing/2014/main" id="{AEC70B96-AF35-4CD2-B261-BC898D35D393}"/>
                  </a:ext>
                </a:extLst>
              </p:cNvPr>
              <p:cNvSpPr/>
              <p:nvPr/>
            </p:nvSpPr>
            <p:spPr>
              <a:xfrm>
                <a:off x="1681435" y="2976088"/>
                <a:ext cx="45719" cy="45719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rgbClr val="008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241" name="그룹 240">
              <a:extLst>
                <a:ext uri="{FF2B5EF4-FFF2-40B4-BE49-F238E27FC236}">
                  <a16:creationId xmlns:a16="http://schemas.microsoft.com/office/drawing/2014/main" id="{C8F849AE-96C8-49F9-AC5F-3A9FC475B8B3}"/>
                </a:ext>
              </a:extLst>
            </p:cNvPr>
            <p:cNvGrpSpPr/>
            <p:nvPr/>
          </p:nvGrpSpPr>
          <p:grpSpPr>
            <a:xfrm>
              <a:off x="4286162" y="5598077"/>
              <a:ext cx="106933" cy="35398"/>
              <a:chOff x="1635238" y="2976088"/>
              <a:chExt cx="138112" cy="45719"/>
            </a:xfrm>
          </p:grpSpPr>
          <p:cxnSp>
            <p:nvCxnSpPr>
              <p:cNvPr id="252" name="직선 연결선 251">
                <a:extLst>
                  <a:ext uri="{FF2B5EF4-FFF2-40B4-BE49-F238E27FC236}">
                    <a16:creationId xmlns:a16="http://schemas.microsoft.com/office/drawing/2014/main" id="{5B69D52F-0329-4F3D-9A20-99F1B5F35C96}"/>
                  </a:ext>
                </a:extLst>
              </p:cNvPr>
              <p:cNvCxnSpPr/>
              <p:nvPr/>
            </p:nvCxnSpPr>
            <p:spPr>
              <a:xfrm>
                <a:off x="1635238" y="2998947"/>
                <a:ext cx="138112" cy="0"/>
              </a:xfrm>
              <a:prstGeom prst="line">
                <a:avLst/>
              </a:prstGeom>
              <a:ln w="3175">
                <a:solidFill>
                  <a:srgbClr val="00008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3" name="직사각형 252">
                <a:extLst>
                  <a:ext uri="{FF2B5EF4-FFF2-40B4-BE49-F238E27FC236}">
                    <a16:creationId xmlns:a16="http://schemas.microsoft.com/office/drawing/2014/main" id="{5BF43758-178E-4A57-B214-E35AC8701497}"/>
                  </a:ext>
                </a:extLst>
              </p:cNvPr>
              <p:cNvSpPr/>
              <p:nvPr/>
            </p:nvSpPr>
            <p:spPr>
              <a:xfrm>
                <a:off x="1681435" y="2976088"/>
                <a:ext cx="45719" cy="45719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rgbClr val="000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2BAB2074-907F-4BB9-B349-9BCEE966C81F}"/>
                </a:ext>
              </a:extLst>
            </p:cNvPr>
            <p:cNvSpPr txBox="1"/>
            <p:nvPr/>
          </p:nvSpPr>
          <p:spPr>
            <a:xfrm>
              <a:off x="4414171" y="4868515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BC46BAC3-1F2A-46A2-A5C2-391E97ADC0BA}"/>
                </a:ext>
              </a:extLst>
            </p:cNvPr>
            <p:cNvSpPr txBox="1"/>
            <p:nvPr/>
          </p:nvSpPr>
          <p:spPr>
            <a:xfrm>
              <a:off x="4414171" y="4946591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249758A7-3236-4554-B029-639D5C0B251D}"/>
                </a:ext>
              </a:extLst>
            </p:cNvPr>
            <p:cNvSpPr txBox="1"/>
            <p:nvPr/>
          </p:nvSpPr>
          <p:spPr>
            <a:xfrm>
              <a:off x="4414171" y="5024667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EC8030E1-1C2A-49F1-8138-B4D067CB6D55}"/>
                </a:ext>
              </a:extLst>
            </p:cNvPr>
            <p:cNvSpPr txBox="1"/>
            <p:nvPr/>
          </p:nvSpPr>
          <p:spPr>
            <a:xfrm>
              <a:off x="4414171" y="5102743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2782BBD6-870B-4AAC-ADC2-421A801A396A}"/>
                </a:ext>
              </a:extLst>
            </p:cNvPr>
            <p:cNvSpPr txBox="1"/>
            <p:nvPr/>
          </p:nvSpPr>
          <p:spPr>
            <a:xfrm>
              <a:off x="4414171" y="5180819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5D4F0C84-1478-4287-80A6-9D9FCE577561}"/>
                </a:ext>
              </a:extLst>
            </p:cNvPr>
            <p:cNvSpPr txBox="1"/>
            <p:nvPr/>
          </p:nvSpPr>
          <p:spPr>
            <a:xfrm>
              <a:off x="4414171" y="5258895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47F09155-AD34-4F89-B3BB-12C131EA5230}"/>
                </a:ext>
              </a:extLst>
            </p:cNvPr>
            <p:cNvSpPr txBox="1"/>
            <p:nvPr/>
          </p:nvSpPr>
          <p:spPr>
            <a:xfrm>
              <a:off x="4414171" y="5336971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4F95A192-3841-49C6-82A7-18127420FC92}"/>
                </a:ext>
              </a:extLst>
            </p:cNvPr>
            <p:cNvSpPr txBox="1"/>
            <p:nvPr/>
          </p:nvSpPr>
          <p:spPr>
            <a:xfrm>
              <a:off x="4414171" y="5415047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750E9C2B-54E3-4D46-86F8-5CF9F5221B2A}"/>
                </a:ext>
              </a:extLst>
            </p:cNvPr>
            <p:cNvSpPr txBox="1"/>
            <p:nvPr/>
          </p:nvSpPr>
          <p:spPr>
            <a:xfrm>
              <a:off x="4414171" y="5493123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380400B2-C794-449E-BFC6-5210D1ED7153}"/>
                </a:ext>
              </a:extLst>
            </p:cNvPr>
            <p:cNvSpPr txBox="1"/>
            <p:nvPr/>
          </p:nvSpPr>
          <p:spPr>
            <a:xfrm>
              <a:off x="4414171" y="5571197"/>
              <a:ext cx="112211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2" name="TextBox 271">
            <a:extLst>
              <a:ext uri="{FF2B5EF4-FFF2-40B4-BE49-F238E27FC236}">
                <a16:creationId xmlns:a16="http://schemas.microsoft.com/office/drawing/2014/main" id="{64CF9170-89B3-4504-8A33-87F329081F89}"/>
              </a:ext>
            </a:extLst>
          </p:cNvPr>
          <p:cNvSpPr txBox="1"/>
          <p:nvPr/>
        </p:nvSpPr>
        <p:spPr>
          <a:xfrm>
            <a:off x="5696384" y="4649542"/>
            <a:ext cx="170880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L21(DE3) / Succinate (0.3%)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D3383713-396E-443B-BE59-CACF037FBB58}"/>
              </a:ext>
            </a:extLst>
          </p:cNvPr>
          <p:cNvSpPr txBox="1"/>
          <p:nvPr/>
        </p:nvSpPr>
        <p:spPr>
          <a:xfrm>
            <a:off x="5696384" y="2322754"/>
            <a:ext cx="170880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L21(DE3) / Succinate (0.3%)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F1C4EF02-C6C0-4B84-9031-809EB2D1D493}"/>
              </a:ext>
            </a:extLst>
          </p:cNvPr>
          <p:cNvSpPr txBox="1"/>
          <p:nvPr/>
        </p:nvSpPr>
        <p:spPr>
          <a:xfrm>
            <a:off x="2706815" y="2321322"/>
            <a:ext cx="1671932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W25113 / Succinate (0.3%)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4965BCB2-B8D8-4ACE-AF4C-2D5FB96F7C44}"/>
              </a:ext>
            </a:extLst>
          </p:cNvPr>
          <p:cNvSpPr txBox="1"/>
          <p:nvPr/>
        </p:nvSpPr>
        <p:spPr>
          <a:xfrm>
            <a:off x="2724450" y="4638337"/>
            <a:ext cx="1636666" cy="25648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W25113 / Succinate (0.3%)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6" name="그룹 275">
            <a:extLst>
              <a:ext uri="{FF2B5EF4-FFF2-40B4-BE49-F238E27FC236}">
                <a16:creationId xmlns:a16="http://schemas.microsoft.com/office/drawing/2014/main" id="{01BE44B1-F244-49F4-81AB-D906ACF377E0}"/>
              </a:ext>
            </a:extLst>
          </p:cNvPr>
          <p:cNvGrpSpPr/>
          <p:nvPr/>
        </p:nvGrpSpPr>
        <p:grpSpPr>
          <a:xfrm>
            <a:off x="5565236" y="4868015"/>
            <a:ext cx="243425" cy="795015"/>
            <a:chOff x="4286162" y="4868515"/>
            <a:chExt cx="243425" cy="795015"/>
          </a:xfrm>
        </p:grpSpPr>
        <p:grpSp>
          <p:nvGrpSpPr>
            <p:cNvPr id="277" name="그룹 276">
              <a:extLst>
                <a:ext uri="{FF2B5EF4-FFF2-40B4-BE49-F238E27FC236}">
                  <a16:creationId xmlns:a16="http://schemas.microsoft.com/office/drawing/2014/main" id="{FAE0CC25-1928-4208-82A1-2FF32A685FBD}"/>
                </a:ext>
              </a:extLst>
            </p:cNvPr>
            <p:cNvGrpSpPr/>
            <p:nvPr/>
          </p:nvGrpSpPr>
          <p:grpSpPr>
            <a:xfrm>
              <a:off x="4286162" y="4894817"/>
              <a:ext cx="106933" cy="35398"/>
              <a:chOff x="1635238" y="2864169"/>
              <a:chExt cx="138112" cy="45719"/>
            </a:xfrm>
          </p:grpSpPr>
          <p:sp>
            <p:nvSpPr>
              <p:cNvPr id="315" name="직사각형 314">
                <a:extLst>
                  <a:ext uri="{FF2B5EF4-FFF2-40B4-BE49-F238E27FC236}">
                    <a16:creationId xmlns:a16="http://schemas.microsoft.com/office/drawing/2014/main" id="{AC05B2BC-8054-4E1E-A46F-31CDC5BD95B0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solidFill>
                <a:srgbClr val="FF0000"/>
              </a:solidFill>
              <a:ln w="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316" name="직선 연결선 315">
                <a:extLst>
                  <a:ext uri="{FF2B5EF4-FFF2-40B4-BE49-F238E27FC236}">
                    <a16:creationId xmlns:a16="http://schemas.microsoft.com/office/drawing/2014/main" id="{17A5FA77-8336-4E80-8879-0F17D49A68AE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ln w="31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8" name="그룹 277">
              <a:extLst>
                <a:ext uri="{FF2B5EF4-FFF2-40B4-BE49-F238E27FC236}">
                  <a16:creationId xmlns:a16="http://schemas.microsoft.com/office/drawing/2014/main" id="{06F8927D-F63C-47CD-9EAF-8B9696FF439B}"/>
                </a:ext>
              </a:extLst>
            </p:cNvPr>
            <p:cNvGrpSpPr/>
            <p:nvPr/>
          </p:nvGrpSpPr>
          <p:grpSpPr>
            <a:xfrm>
              <a:off x="4286162" y="5363657"/>
              <a:ext cx="106933" cy="35398"/>
              <a:chOff x="1635238" y="2976088"/>
              <a:chExt cx="138112" cy="45719"/>
            </a:xfrm>
          </p:grpSpPr>
          <p:cxnSp>
            <p:nvCxnSpPr>
              <p:cNvPr id="313" name="직선 연결선 312">
                <a:extLst>
                  <a:ext uri="{FF2B5EF4-FFF2-40B4-BE49-F238E27FC236}">
                    <a16:creationId xmlns:a16="http://schemas.microsoft.com/office/drawing/2014/main" id="{A33144B1-182E-4930-B0D5-017AA656F7E1}"/>
                  </a:ext>
                </a:extLst>
              </p:cNvPr>
              <p:cNvCxnSpPr/>
              <p:nvPr/>
            </p:nvCxnSpPr>
            <p:spPr>
              <a:xfrm>
                <a:off x="1635238" y="2998947"/>
                <a:ext cx="138112" cy="0"/>
              </a:xfrm>
              <a:prstGeom prst="line">
                <a:avLst/>
              </a:prstGeom>
              <a:ln w="31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4" name="직사각형 313">
                <a:extLst>
                  <a:ext uri="{FF2B5EF4-FFF2-40B4-BE49-F238E27FC236}">
                    <a16:creationId xmlns:a16="http://schemas.microsoft.com/office/drawing/2014/main" id="{3AEA1FC6-1A61-4858-9903-1ADA904E02B1}"/>
                  </a:ext>
                </a:extLst>
              </p:cNvPr>
              <p:cNvSpPr/>
              <p:nvPr/>
            </p:nvSpPr>
            <p:spPr>
              <a:xfrm>
                <a:off x="1681435" y="2976088"/>
                <a:ext cx="45719" cy="45719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279" name="그룹 278">
              <a:extLst>
                <a:ext uri="{FF2B5EF4-FFF2-40B4-BE49-F238E27FC236}">
                  <a16:creationId xmlns:a16="http://schemas.microsoft.com/office/drawing/2014/main" id="{4278D2C6-CBAE-4EE6-AA79-36EFA546DE2A}"/>
                </a:ext>
              </a:extLst>
            </p:cNvPr>
            <p:cNvGrpSpPr/>
            <p:nvPr/>
          </p:nvGrpSpPr>
          <p:grpSpPr>
            <a:xfrm>
              <a:off x="4286162" y="4972957"/>
              <a:ext cx="106933" cy="35398"/>
              <a:chOff x="1635238" y="2864169"/>
              <a:chExt cx="138112" cy="45719"/>
            </a:xfrm>
          </p:grpSpPr>
          <p:sp>
            <p:nvSpPr>
              <p:cNvPr id="311" name="직사각형 310">
                <a:extLst>
                  <a:ext uri="{FF2B5EF4-FFF2-40B4-BE49-F238E27FC236}">
                    <a16:creationId xmlns:a16="http://schemas.microsoft.com/office/drawing/2014/main" id="{496E5956-4E6C-425C-A7DE-AD17C5EBC4C1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solidFill>
                <a:srgbClr val="FF8000"/>
              </a:solidFill>
              <a:ln w="0">
                <a:solidFill>
                  <a:srgbClr val="FF8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312" name="직선 연결선 311">
                <a:extLst>
                  <a:ext uri="{FF2B5EF4-FFF2-40B4-BE49-F238E27FC236}">
                    <a16:creationId xmlns:a16="http://schemas.microsoft.com/office/drawing/2014/main" id="{55AFCB05-AEE9-4990-AFEA-43BBD53C53F8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ln w="3175">
                <a:solidFill>
                  <a:srgbClr val="FF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0" name="그룹 279">
              <a:extLst>
                <a:ext uri="{FF2B5EF4-FFF2-40B4-BE49-F238E27FC236}">
                  <a16:creationId xmlns:a16="http://schemas.microsoft.com/office/drawing/2014/main" id="{B4B9BD8A-EA6D-4296-A2DD-94CB53544781}"/>
                </a:ext>
              </a:extLst>
            </p:cNvPr>
            <p:cNvGrpSpPr/>
            <p:nvPr/>
          </p:nvGrpSpPr>
          <p:grpSpPr>
            <a:xfrm>
              <a:off x="4286162" y="5051097"/>
              <a:ext cx="106933" cy="35398"/>
              <a:chOff x="1635238" y="2864169"/>
              <a:chExt cx="138112" cy="45719"/>
            </a:xfrm>
            <a:solidFill>
              <a:srgbClr val="008000"/>
            </a:solidFill>
          </p:grpSpPr>
          <p:sp>
            <p:nvSpPr>
              <p:cNvPr id="309" name="직사각형 308">
                <a:extLst>
                  <a:ext uri="{FF2B5EF4-FFF2-40B4-BE49-F238E27FC236}">
                    <a16:creationId xmlns:a16="http://schemas.microsoft.com/office/drawing/2014/main" id="{27F7B48C-2DBF-4744-8B61-F1790D42F8ED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grpFill/>
              <a:ln w="0">
                <a:solidFill>
                  <a:srgbClr val="008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310" name="직선 연결선 309">
                <a:extLst>
                  <a:ext uri="{FF2B5EF4-FFF2-40B4-BE49-F238E27FC236}">
                    <a16:creationId xmlns:a16="http://schemas.microsoft.com/office/drawing/2014/main" id="{CC761106-B80E-47D4-9876-1602D5BD9199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grpFill/>
              <a:ln w="3175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1" name="그룹 280">
              <a:extLst>
                <a:ext uri="{FF2B5EF4-FFF2-40B4-BE49-F238E27FC236}">
                  <a16:creationId xmlns:a16="http://schemas.microsoft.com/office/drawing/2014/main" id="{DA8C27A0-76BA-4A25-B4A3-9225898A1665}"/>
                </a:ext>
              </a:extLst>
            </p:cNvPr>
            <p:cNvGrpSpPr/>
            <p:nvPr/>
          </p:nvGrpSpPr>
          <p:grpSpPr>
            <a:xfrm>
              <a:off x="4286162" y="5129237"/>
              <a:ext cx="106933" cy="35398"/>
              <a:chOff x="1635238" y="2864169"/>
              <a:chExt cx="138112" cy="45719"/>
            </a:xfrm>
            <a:solidFill>
              <a:srgbClr val="000080"/>
            </a:solidFill>
          </p:grpSpPr>
          <p:sp>
            <p:nvSpPr>
              <p:cNvPr id="307" name="직사각형 306">
                <a:extLst>
                  <a:ext uri="{FF2B5EF4-FFF2-40B4-BE49-F238E27FC236}">
                    <a16:creationId xmlns:a16="http://schemas.microsoft.com/office/drawing/2014/main" id="{D4BE6F3C-440E-402E-AF86-DFE7F959D4C7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grpFill/>
              <a:ln w="0">
                <a:solidFill>
                  <a:srgbClr val="000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308" name="직선 연결선 307">
                <a:extLst>
                  <a:ext uri="{FF2B5EF4-FFF2-40B4-BE49-F238E27FC236}">
                    <a16:creationId xmlns:a16="http://schemas.microsoft.com/office/drawing/2014/main" id="{35BDC056-B211-4D8D-A199-04F4D463699F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grpFill/>
              <a:ln w="3175">
                <a:solidFill>
                  <a:srgbClr val="00008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2" name="그룹 281">
              <a:extLst>
                <a:ext uri="{FF2B5EF4-FFF2-40B4-BE49-F238E27FC236}">
                  <a16:creationId xmlns:a16="http://schemas.microsoft.com/office/drawing/2014/main" id="{ACC517F5-862F-47CC-8311-FFAF49716C80}"/>
                </a:ext>
              </a:extLst>
            </p:cNvPr>
            <p:cNvGrpSpPr/>
            <p:nvPr/>
          </p:nvGrpSpPr>
          <p:grpSpPr>
            <a:xfrm>
              <a:off x="4286162" y="5207377"/>
              <a:ext cx="106933" cy="35398"/>
              <a:chOff x="1635238" y="2864169"/>
              <a:chExt cx="138112" cy="45719"/>
            </a:xfrm>
            <a:solidFill>
              <a:srgbClr val="800080"/>
            </a:solidFill>
          </p:grpSpPr>
          <p:sp>
            <p:nvSpPr>
              <p:cNvPr id="305" name="직사각형 304">
                <a:extLst>
                  <a:ext uri="{FF2B5EF4-FFF2-40B4-BE49-F238E27FC236}">
                    <a16:creationId xmlns:a16="http://schemas.microsoft.com/office/drawing/2014/main" id="{876E9A75-A684-455D-A2BB-83DD3AA820C6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grpFill/>
              <a:ln w="0">
                <a:solidFill>
                  <a:srgbClr val="800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306" name="직선 연결선 305">
                <a:extLst>
                  <a:ext uri="{FF2B5EF4-FFF2-40B4-BE49-F238E27FC236}">
                    <a16:creationId xmlns:a16="http://schemas.microsoft.com/office/drawing/2014/main" id="{EBB86B19-36F6-4DFF-8750-337E9C83C390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grpFill/>
              <a:ln w="3175">
                <a:solidFill>
                  <a:srgbClr val="80008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3" name="그룹 282">
              <a:extLst>
                <a:ext uri="{FF2B5EF4-FFF2-40B4-BE49-F238E27FC236}">
                  <a16:creationId xmlns:a16="http://schemas.microsoft.com/office/drawing/2014/main" id="{359252F1-AA7F-41BF-BBED-F5DE913F36B3}"/>
                </a:ext>
              </a:extLst>
            </p:cNvPr>
            <p:cNvGrpSpPr/>
            <p:nvPr/>
          </p:nvGrpSpPr>
          <p:grpSpPr>
            <a:xfrm>
              <a:off x="4286162" y="5285517"/>
              <a:ext cx="106933" cy="35398"/>
              <a:chOff x="1635238" y="2864169"/>
              <a:chExt cx="138112" cy="45719"/>
            </a:xfrm>
            <a:solidFill>
              <a:srgbClr val="800000"/>
            </a:solidFill>
          </p:grpSpPr>
          <p:sp>
            <p:nvSpPr>
              <p:cNvPr id="303" name="직사각형 302">
                <a:extLst>
                  <a:ext uri="{FF2B5EF4-FFF2-40B4-BE49-F238E27FC236}">
                    <a16:creationId xmlns:a16="http://schemas.microsoft.com/office/drawing/2014/main" id="{A9ADDC50-2D04-46E5-A6D1-B38E095076D7}"/>
                  </a:ext>
                </a:extLst>
              </p:cNvPr>
              <p:cNvSpPr/>
              <p:nvPr/>
            </p:nvSpPr>
            <p:spPr>
              <a:xfrm>
                <a:off x="1681435" y="2864169"/>
                <a:ext cx="45719" cy="45719"/>
              </a:xfrm>
              <a:prstGeom prst="rect">
                <a:avLst/>
              </a:prstGeom>
              <a:grpFill/>
              <a:ln w="0">
                <a:solidFill>
                  <a:srgbClr val="8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304" name="직선 연결선 303">
                <a:extLst>
                  <a:ext uri="{FF2B5EF4-FFF2-40B4-BE49-F238E27FC236}">
                    <a16:creationId xmlns:a16="http://schemas.microsoft.com/office/drawing/2014/main" id="{B004CC13-3B85-4582-9494-3B42B7F52D32}"/>
                  </a:ext>
                </a:extLst>
              </p:cNvPr>
              <p:cNvCxnSpPr/>
              <p:nvPr/>
            </p:nvCxnSpPr>
            <p:spPr>
              <a:xfrm>
                <a:off x="1635238" y="2887981"/>
                <a:ext cx="138112" cy="0"/>
              </a:xfrm>
              <a:prstGeom prst="line">
                <a:avLst/>
              </a:prstGeom>
              <a:grpFill/>
              <a:ln w="3175">
                <a:solidFill>
                  <a:srgbClr val="8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4" name="그룹 283">
              <a:extLst>
                <a:ext uri="{FF2B5EF4-FFF2-40B4-BE49-F238E27FC236}">
                  <a16:creationId xmlns:a16="http://schemas.microsoft.com/office/drawing/2014/main" id="{36A35636-CEB1-45F0-81FB-A3905E8D7255}"/>
                </a:ext>
              </a:extLst>
            </p:cNvPr>
            <p:cNvGrpSpPr/>
            <p:nvPr/>
          </p:nvGrpSpPr>
          <p:grpSpPr>
            <a:xfrm>
              <a:off x="4286162" y="5441797"/>
              <a:ext cx="106933" cy="35398"/>
              <a:chOff x="1635238" y="2976088"/>
              <a:chExt cx="138112" cy="45719"/>
            </a:xfrm>
          </p:grpSpPr>
          <p:cxnSp>
            <p:nvCxnSpPr>
              <p:cNvPr id="301" name="직선 연결선 300">
                <a:extLst>
                  <a:ext uri="{FF2B5EF4-FFF2-40B4-BE49-F238E27FC236}">
                    <a16:creationId xmlns:a16="http://schemas.microsoft.com/office/drawing/2014/main" id="{C161FB92-C9B7-4D31-8A85-563EA7D8463F}"/>
                  </a:ext>
                </a:extLst>
              </p:cNvPr>
              <p:cNvCxnSpPr/>
              <p:nvPr/>
            </p:nvCxnSpPr>
            <p:spPr>
              <a:xfrm>
                <a:off x="1635238" y="2998947"/>
                <a:ext cx="138112" cy="0"/>
              </a:xfrm>
              <a:prstGeom prst="line">
                <a:avLst/>
              </a:prstGeom>
              <a:ln w="3175">
                <a:solidFill>
                  <a:srgbClr val="FF8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2" name="직사각형 301">
                <a:extLst>
                  <a:ext uri="{FF2B5EF4-FFF2-40B4-BE49-F238E27FC236}">
                    <a16:creationId xmlns:a16="http://schemas.microsoft.com/office/drawing/2014/main" id="{36E10815-9B4C-4370-8669-3883BFCC1833}"/>
                  </a:ext>
                </a:extLst>
              </p:cNvPr>
              <p:cNvSpPr/>
              <p:nvPr/>
            </p:nvSpPr>
            <p:spPr>
              <a:xfrm>
                <a:off x="1681435" y="2976088"/>
                <a:ext cx="45719" cy="45719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rgbClr val="FF8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285" name="그룹 284">
              <a:extLst>
                <a:ext uri="{FF2B5EF4-FFF2-40B4-BE49-F238E27FC236}">
                  <a16:creationId xmlns:a16="http://schemas.microsoft.com/office/drawing/2014/main" id="{4663160C-AE66-4106-A79D-DDBB6EA23EFB}"/>
                </a:ext>
              </a:extLst>
            </p:cNvPr>
            <p:cNvGrpSpPr/>
            <p:nvPr/>
          </p:nvGrpSpPr>
          <p:grpSpPr>
            <a:xfrm>
              <a:off x="4286162" y="5519937"/>
              <a:ext cx="106933" cy="35398"/>
              <a:chOff x="1635238" y="2976088"/>
              <a:chExt cx="138112" cy="45719"/>
            </a:xfrm>
          </p:grpSpPr>
          <p:cxnSp>
            <p:nvCxnSpPr>
              <p:cNvPr id="299" name="직선 연결선 298">
                <a:extLst>
                  <a:ext uri="{FF2B5EF4-FFF2-40B4-BE49-F238E27FC236}">
                    <a16:creationId xmlns:a16="http://schemas.microsoft.com/office/drawing/2014/main" id="{4ABB511E-AB9B-4A4A-A6D9-2D37D4D7FF70}"/>
                  </a:ext>
                </a:extLst>
              </p:cNvPr>
              <p:cNvCxnSpPr/>
              <p:nvPr/>
            </p:nvCxnSpPr>
            <p:spPr>
              <a:xfrm>
                <a:off x="1635238" y="2998947"/>
                <a:ext cx="138112" cy="0"/>
              </a:xfrm>
              <a:prstGeom prst="line">
                <a:avLst/>
              </a:prstGeom>
              <a:ln w="3175">
                <a:solidFill>
                  <a:srgbClr val="008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0" name="직사각형 299">
                <a:extLst>
                  <a:ext uri="{FF2B5EF4-FFF2-40B4-BE49-F238E27FC236}">
                    <a16:creationId xmlns:a16="http://schemas.microsoft.com/office/drawing/2014/main" id="{9680B48F-417E-4FE0-99FA-F24D9485567A}"/>
                  </a:ext>
                </a:extLst>
              </p:cNvPr>
              <p:cNvSpPr/>
              <p:nvPr/>
            </p:nvSpPr>
            <p:spPr>
              <a:xfrm>
                <a:off x="1681435" y="2976088"/>
                <a:ext cx="45719" cy="45719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rgbClr val="008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286" name="그룹 285">
              <a:extLst>
                <a:ext uri="{FF2B5EF4-FFF2-40B4-BE49-F238E27FC236}">
                  <a16:creationId xmlns:a16="http://schemas.microsoft.com/office/drawing/2014/main" id="{193C1A37-D506-49AC-9DDA-B013B3769726}"/>
                </a:ext>
              </a:extLst>
            </p:cNvPr>
            <p:cNvGrpSpPr/>
            <p:nvPr/>
          </p:nvGrpSpPr>
          <p:grpSpPr>
            <a:xfrm>
              <a:off x="4286162" y="5598077"/>
              <a:ext cx="106933" cy="35398"/>
              <a:chOff x="1635238" y="2976088"/>
              <a:chExt cx="138112" cy="45719"/>
            </a:xfrm>
          </p:grpSpPr>
          <p:cxnSp>
            <p:nvCxnSpPr>
              <p:cNvPr id="297" name="직선 연결선 296">
                <a:extLst>
                  <a:ext uri="{FF2B5EF4-FFF2-40B4-BE49-F238E27FC236}">
                    <a16:creationId xmlns:a16="http://schemas.microsoft.com/office/drawing/2014/main" id="{1C738B53-800E-438F-AD3B-B0006AAEDC5B}"/>
                  </a:ext>
                </a:extLst>
              </p:cNvPr>
              <p:cNvCxnSpPr/>
              <p:nvPr/>
            </p:nvCxnSpPr>
            <p:spPr>
              <a:xfrm>
                <a:off x="1635238" y="2998947"/>
                <a:ext cx="138112" cy="0"/>
              </a:xfrm>
              <a:prstGeom prst="line">
                <a:avLst/>
              </a:prstGeom>
              <a:ln w="3175">
                <a:solidFill>
                  <a:srgbClr val="00008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8" name="직사각형 297">
                <a:extLst>
                  <a:ext uri="{FF2B5EF4-FFF2-40B4-BE49-F238E27FC236}">
                    <a16:creationId xmlns:a16="http://schemas.microsoft.com/office/drawing/2014/main" id="{F991CEC2-C205-4D1C-A3BC-554576DBA309}"/>
                  </a:ext>
                </a:extLst>
              </p:cNvPr>
              <p:cNvSpPr/>
              <p:nvPr/>
            </p:nvSpPr>
            <p:spPr>
              <a:xfrm>
                <a:off x="1681435" y="2976088"/>
                <a:ext cx="45719" cy="45719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rgbClr val="000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8AF27364-D677-4C22-BEE0-85DA3996B466}"/>
                </a:ext>
              </a:extLst>
            </p:cNvPr>
            <p:cNvSpPr txBox="1"/>
            <p:nvPr/>
          </p:nvSpPr>
          <p:spPr>
            <a:xfrm>
              <a:off x="4414171" y="4868515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2E488BDA-E776-499B-A1C5-1818993B9B50}"/>
                </a:ext>
              </a:extLst>
            </p:cNvPr>
            <p:cNvSpPr txBox="1"/>
            <p:nvPr/>
          </p:nvSpPr>
          <p:spPr>
            <a:xfrm>
              <a:off x="4414171" y="4946591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0485C4FE-CB82-4550-ACAE-92634314F753}"/>
                </a:ext>
              </a:extLst>
            </p:cNvPr>
            <p:cNvSpPr txBox="1"/>
            <p:nvPr/>
          </p:nvSpPr>
          <p:spPr>
            <a:xfrm>
              <a:off x="4414171" y="5024667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8DB2507A-39FF-4002-BB88-666A465C114E}"/>
                </a:ext>
              </a:extLst>
            </p:cNvPr>
            <p:cNvSpPr txBox="1"/>
            <p:nvPr/>
          </p:nvSpPr>
          <p:spPr>
            <a:xfrm>
              <a:off x="4414171" y="5102743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F969FF46-12D9-4B66-9673-BA5FCA9C0C9E}"/>
                </a:ext>
              </a:extLst>
            </p:cNvPr>
            <p:cNvSpPr txBox="1"/>
            <p:nvPr/>
          </p:nvSpPr>
          <p:spPr>
            <a:xfrm>
              <a:off x="4414171" y="5180819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4F5B2B22-963C-4945-8179-9196B76CE20B}"/>
                </a:ext>
              </a:extLst>
            </p:cNvPr>
            <p:cNvSpPr txBox="1"/>
            <p:nvPr/>
          </p:nvSpPr>
          <p:spPr>
            <a:xfrm>
              <a:off x="4414171" y="5258895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51B5D729-5463-458B-AAB7-41203E23D024}"/>
                </a:ext>
              </a:extLst>
            </p:cNvPr>
            <p:cNvSpPr txBox="1"/>
            <p:nvPr/>
          </p:nvSpPr>
          <p:spPr>
            <a:xfrm>
              <a:off x="4414171" y="5336971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id="{5486CAB0-7C19-4A4E-B5B1-9BA785D957DC}"/>
                </a:ext>
              </a:extLst>
            </p:cNvPr>
            <p:cNvSpPr txBox="1"/>
            <p:nvPr/>
          </p:nvSpPr>
          <p:spPr>
            <a:xfrm>
              <a:off x="4414171" y="5415047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FC491D1C-FC08-432D-AE76-1447AEE5C58F}"/>
                </a:ext>
              </a:extLst>
            </p:cNvPr>
            <p:cNvSpPr txBox="1"/>
            <p:nvPr/>
          </p:nvSpPr>
          <p:spPr>
            <a:xfrm>
              <a:off x="4414171" y="5493123"/>
              <a:ext cx="115416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id="{4D00BA2F-452C-45F3-9F66-085EC43D1529}"/>
                </a:ext>
              </a:extLst>
            </p:cNvPr>
            <p:cNvSpPr txBox="1"/>
            <p:nvPr/>
          </p:nvSpPr>
          <p:spPr>
            <a:xfrm>
              <a:off x="4414171" y="5571197"/>
              <a:ext cx="112211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ko-KR" alt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7" name="TextBox 316">
            <a:extLst>
              <a:ext uri="{FF2B5EF4-FFF2-40B4-BE49-F238E27FC236}">
                <a16:creationId xmlns:a16="http://schemas.microsoft.com/office/drawing/2014/main" id="{B1C570DF-5917-4D29-9327-124CB4224AA7}"/>
              </a:ext>
            </a:extLst>
          </p:cNvPr>
          <p:cNvSpPr txBox="1"/>
          <p:nvPr/>
        </p:nvSpPr>
        <p:spPr>
          <a:xfrm>
            <a:off x="2885963" y="1125726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75</a:t>
            </a:r>
            <a:endParaRPr lang="ko-KR" altLang="en-US" sz="800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TextBox 317">
            <a:extLst>
              <a:ext uri="{FF2B5EF4-FFF2-40B4-BE49-F238E27FC236}">
                <a16:creationId xmlns:a16="http://schemas.microsoft.com/office/drawing/2014/main" id="{E8D10D68-434F-4EE5-AC2F-FB5464F58C7C}"/>
              </a:ext>
            </a:extLst>
          </p:cNvPr>
          <p:cNvSpPr txBox="1"/>
          <p:nvPr/>
        </p:nvSpPr>
        <p:spPr>
          <a:xfrm>
            <a:off x="2521992" y="901198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76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TextBox 318">
            <a:extLst>
              <a:ext uri="{FF2B5EF4-FFF2-40B4-BE49-F238E27FC236}">
                <a16:creationId xmlns:a16="http://schemas.microsoft.com/office/drawing/2014/main" id="{E4F9C80E-BC5F-4430-9ADD-C404BC04AEB5}"/>
              </a:ext>
            </a:extLst>
          </p:cNvPr>
          <p:cNvSpPr txBox="1"/>
          <p:nvPr/>
        </p:nvSpPr>
        <p:spPr>
          <a:xfrm>
            <a:off x="5532944" y="1126964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42</a:t>
            </a:r>
            <a:endParaRPr lang="ko-KR" altLang="en-US" sz="800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TextBox 319">
            <a:extLst>
              <a:ext uri="{FF2B5EF4-FFF2-40B4-BE49-F238E27FC236}">
                <a16:creationId xmlns:a16="http://schemas.microsoft.com/office/drawing/2014/main" id="{4C67DA97-5383-4662-9A4E-5DFF563525BA}"/>
              </a:ext>
            </a:extLst>
          </p:cNvPr>
          <p:cNvSpPr txBox="1"/>
          <p:nvPr/>
        </p:nvSpPr>
        <p:spPr>
          <a:xfrm>
            <a:off x="6451870" y="1390225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14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1" name="TextBox 320">
            <a:extLst>
              <a:ext uri="{FF2B5EF4-FFF2-40B4-BE49-F238E27FC236}">
                <a16:creationId xmlns:a16="http://schemas.microsoft.com/office/drawing/2014/main" id="{718EA62D-5EC3-432E-8D34-F7F7A870876E}"/>
              </a:ext>
            </a:extLst>
          </p:cNvPr>
          <p:cNvSpPr txBox="1"/>
          <p:nvPr/>
        </p:nvSpPr>
        <p:spPr>
          <a:xfrm>
            <a:off x="2521189" y="3149554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42</a:t>
            </a:r>
            <a:endParaRPr lang="ko-KR" altLang="en-US" sz="800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TextBox 321">
            <a:extLst>
              <a:ext uri="{FF2B5EF4-FFF2-40B4-BE49-F238E27FC236}">
                <a16:creationId xmlns:a16="http://schemas.microsoft.com/office/drawing/2014/main" id="{74577A45-994B-4FA8-9E73-1A40FCC59CFF}"/>
              </a:ext>
            </a:extLst>
          </p:cNvPr>
          <p:cNvSpPr txBox="1"/>
          <p:nvPr/>
        </p:nvSpPr>
        <p:spPr>
          <a:xfrm>
            <a:off x="3063355" y="3542575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45</a:t>
            </a:r>
            <a:endParaRPr lang="ko-KR" altLang="en-US" sz="800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TextBox 322">
            <a:extLst>
              <a:ext uri="{FF2B5EF4-FFF2-40B4-BE49-F238E27FC236}">
                <a16:creationId xmlns:a16="http://schemas.microsoft.com/office/drawing/2014/main" id="{2285B793-A7AB-4B91-87B4-E20A7C7E8266}"/>
              </a:ext>
            </a:extLst>
          </p:cNvPr>
          <p:cNvSpPr txBox="1"/>
          <p:nvPr/>
        </p:nvSpPr>
        <p:spPr>
          <a:xfrm>
            <a:off x="5826540" y="3403600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14</a:t>
            </a:r>
            <a:endParaRPr lang="ko-KR" altLang="en-US" sz="800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TextBox 323">
            <a:extLst>
              <a:ext uri="{FF2B5EF4-FFF2-40B4-BE49-F238E27FC236}">
                <a16:creationId xmlns:a16="http://schemas.microsoft.com/office/drawing/2014/main" id="{06A3EBB2-61C4-4F6B-BF7C-B7AAA4800FD4}"/>
              </a:ext>
            </a:extLst>
          </p:cNvPr>
          <p:cNvSpPr txBox="1"/>
          <p:nvPr/>
        </p:nvSpPr>
        <p:spPr>
          <a:xfrm>
            <a:off x="6546210" y="3536459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15</a:t>
            </a:r>
            <a:endParaRPr lang="ko-KR" altLang="en-US" sz="800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5" name="그룹 324">
            <a:extLst>
              <a:ext uri="{FF2B5EF4-FFF2-40B4-BE49-F238E27FC236}">
                <a16:creationId xmlns:a16="http://schemas.microsoft.com/office/drawing/2014/main" id="{04BB29E6-11EB-4171-95D1-AE05D1B34986}"/>
              </a:ext>
            </a:extLst>
          </p:cNvPr>
          <p:cNvGrpSpPr/>
          <p:nvPr/>
        </p:nvGrpSpPr>
        <p:grpSpPr>
          <a:xfrm>
            <a:off x="2231375" y="244499"/>
            <a:ext cx="204511" cy="1707837"/>
            <a:chOff x="2231375" y="244499"/>
            <a:chExt cx="204511" cy="1707837"/>
          </a:xfrm>
        </p:grpSpPr>
        <p:sp>
          <p:nvSpPr>
            <p:cNvPr id="326" name="TextBox 325">
              <a:extLst>
                <a:ext uri="{FF2B5EF4-FFF2-40B4-BE49-F238E27FC236}">
                  <a16:creationId xmlns:a16="http://schemas.microsoft.com/office/drawing/2014/main" id="{9ED075C0-390D-4B22-BD63-B84516275E43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TextBox 326">
              <a:extLst>
                <a:ext uri="{FF2B5EF4-FFF2-40B4-BE49-F238E27FC236}">
                  <a16:creationId xmlns:a16="http://schemas.microsoft.com/office/drawing/2014/main" id="{4D9DD9BB-2B09-44E6-84B1-96B65331783F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TextBox 327">
              <a:extLst>
                <a:ext uri="{FF2B5EF4-FFF2-40B4-BE49-F238E27FC236}">
                  <a16:creationId xmlns:a16="http://schemas.microsoft.com/office/drawing/2014/main" id="{9A3C628F-6A60-4794-8E62-337A5A37B2F0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9" name="TextBox 328">
              <a:extLst>
                <a:ext uri="{FF2B5EF4-FFF2-40B4-BE49-F238E27FC236}">
                  <a16:creationId xmlns:a16="http://schemas.microsoft.com/office/drawing/2014/main" id="{92D83BC7-67D5-4210-B22D-A3DEA66BB620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30" name="그룹 329">
            <a:extLst>
              <a:ext uri="{FF2B5EF4-FFF2-40B4-BE49-F238E27FC236}">
                <a16:creationId xmlns:a16="http://schemas.microsoft.com/office/drawing/2014/main" id="{DB9B7464-624E-4F46-AE91-29D7FBCB5612}"/>
              </a:ext>
            </a:extLst>
          </p:cNvPr>
          <p:cNvGrpSpPr/>
          <p:nvPr/>
        </p:nvGrpSpPr>
        <p:grpSpPr>
          <a:xfrm>
            <a:off x="5200866" y="244499"/>
            <a:ext cx="204511" cy="1707837"/>
            <a:chOff x="2231375" y="244499"/>
            <a:chExt cx="204511" cy="1707837"/>
          </a:xfrm>
        </p:grpSpPr>
        <p:sp>
          <p:nvSpPr>
            <p:cNvPr id="331" name="TextBox 330">
              <a:extLst>
                <a:ext uri="{FF2B5EF4-FFF2-40B4-BE49-F238E27FC236}">
                  <a16:creationId xmlns:a16="http://schemas.microsoft.com/office/drawing/2014/main" id="{E48420B9-25F0-4F78-8DC7-617412A34BCD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TextBox 331">
              <a:extLst>
                <a:ext uri="{FF2B5EF4-FFF2-40B4-BE49-F238E27FC236}">
                  <a16:creationId xmlns:a16="http://schemas.microsoft.com/office/drawing/2014/main" id="{ACCBB53E-88A2-4B6C-A22B-9C5433D316AE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TextBox 332">
              <a:extLst>
                <a:ext uri="{FF2B5EF4-FFF2-40B4-BE49-F238E27FC236}">
                  <a16:creationId xmlns:a16="http://schemas.microsoft.com/office/drawing/2014/main" id="{8A9D2250-EE79-4C6A-81D0-83A823144900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TextBox 333">
              <a:extLst>
                <a:ext uri="{FF2B5EF4-FFF2-40B4-BE49-F238E27FC236}">
                  <a16:creationId xmlns:a16="http://schemas.microsoft.com/office/drawing/2014/main" id="{2E04E20F-8B85-4ED9-B235-1A5363D749D9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35" name="그룹 334">
            <a:extLst>
              <a:ext uri="{FF2B5EF4-FFF2-40B4-BE49-F238E27FC236}">
                <a16:creationId xmlns:a16="http://schemas.microsoft.com/office/drawing/2014/main" id="{9D69B930-DB84-4B51-BCED-203641389609}"/>
              </a:ext>
            </a:extLst>
          </p:cNvPr>
          <p:cNvGrpSpPr/>
          <p:nvPr/>
        </p:nvGrpSpPr>
        <p:grpSpPr>
          <a:xfrm>
            <a:off x="2216948" y="2441530"/>
            <a:ext cx="204511" cy="1707837"/>
            <a:chOff x="2231375" y="244499"/>
            <a:chExt cx="204511" cy="1707837"/>
          </a:xfrm>
        </p:grpSpPr>
        <p:sp>
          <p:nvSpPr>
            <p:cNvPr id="336" name="TextBox 335">
              <a:extLst>
                <a:ext uri="{FF2B5EF4-FFF2-40B4-BE49-F238E27FC236}">
                  <a16:creationId xmlns:a16="http://schemas.microsoft.com/office/drawing/2014/main" id="{E92F867B-F885-409C-B179-A74625A88D7E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TextBox 336">
              <a:extLst>
                <a:ext uri="{FF2B5EF4-FFF2-40B4-BE49-F238E27FC236}">
                  <a16:creationId xmlns:a16="http://schemas.microsoft.com/office/drawing/2014/main" id="{A7F9231C-882D-4883-AB29-7F63207A3B9B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TextBox 337">
              <a:extLst>
                <a:ext uri="{FF2B5EF4-FFF2-40B4-BE49-F238E27FC236}">
                  <a16:creationId xmlns:a16="http://schemas.microsoft.com/office/drawing/2014/main" id="{1CCEFE06-6C01-4402-AC42-C65AA6562B9E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TextBox 338">
              <a:extLst>
                <a:ext uri="{FF2B5EF4-FFF2-40B4-BE49-F238E27FC236}">
                  <a16:creationId xmlns:a16="http://schemas.microsoft.com/office/drawing/2014/main" id="{72AD0B4D-3591-4A65-A064-DA044ABD00E5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0" name="그룹 339">
            <a:extLst>
              <a:ext uri="{FF2B5EF4-FFF2-40B4-BE49-F238E27FC236}">
                <a16:creationId xmlns:a16="http://schemas.microsoft.com/office/drawing/2014/main" id="{69850367-F33F-4133-A5E5-4A6FE9740210}"/>
              </a:ext>
            </a:extLst>
          </p:cNvPr>
          <p:cNvGrpSpPr/>
          <p:nvPr/>
        </p:nvGrpSpPr>
        <p:grpSpPr>
          <a:xfrm>
            <a:off x="5186439" y="2441530"/>
            <a:ext cx="204511" cy="1707837"/>
            <a:chOff x="2231375" y="244499"/>
            <a:chExt cx="204511" cy="1707837"/>
          </a:xfrm>
        </p:grpSpPr>
        <p:sp>
          <p:nvSpPr>
            <p:cNvPr id="341" name="TextBox 340">
              <a:extLst>
                <a:ext uri="{FF2B5EF4-FFF2-40B4-BE49-F238E27FC236}">
                  <a16:creationId xmlns:a16="http://schemas.microsoft.com/office/drawing/2014/main" id="{91BD33F0-8C58-4344-AC83-94F136FEFC8C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TextBox 341">
              <a:extLst>
                <a:ext uri="{FF2B5EF4-FFF2-40B4-BE49-F238E27FC236}">
                  <a16:creationId xmlns:a16="http://schemas.microsoft.com/office/drawing/2014/main" id="{03ED86C9-0898-420C-8916-57036B444FD9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TextBox 342">
              <a:extLst>
                <a:ext uri="{FF2B5EF4-FFF2-40B4-BE49-F238E27FC236}">
                  <a16:creationId xmlns:a16="http://schemas.microsoft.com/office/drawing/2014/main" id="{CD4F2852-F52D-4AC0-9D69-62C5197F9AAE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TextBox 343">
              <a:extLst>
                <a:ext uri="{FF2B5EF4-FFF2-40B4-BE49-F238E27FC236}">
                  <a16:creationId xmlns:a16="http://schemas.microsoft.com/office/drawing/2014/main" id="{07D14C08-08D6-4005-B59E-611EEEB65854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5" name="그룹 344">
            <a:extLst>
              <a:ext uri="{FF2B5EF4-FFF2-40B4-BE49-F238E27FC236}">
                <a16:creationId xmlns:a16="http://schemas.microsoft.com/office/drawing/2014/main" id="{527C1254-2032-4B72-B14C-B15C3EF1ED0E}"/>
              </a:ext>
            </a:extLst>
          </p:cNvPr>
          <p:cNvGrpSpPr/>
          <p:nvPr/>
        </p:nvGrpSpPr>
        <p:grpSpPr>
          <a:xfrm>
            <a:off x="2266169" y="4734361"/>
            <a:ext cx="204511" cy="1707837"/>
            <a:chOff x="2231375" y="244499"/>
            <a:chExt cx="204511" cy="1707837"/>
          </a:xfrm>
        </p:grpSpPr>
        <p:sp>
          <p:nvSpPr>
            <p:cNvPr id="346" name="TextBox 345">
              <a:extLst>
                <a:ext uri="{FF2B5EF4-FFF2-40B4-BE49-F238E27FC236}">
                  <a16:creationId xmlns:a16="http://schemas.microsoft.com/office/drawing/2014/main" id="{DCAAAB0D-9E4C-4042-B3B8-3C9C8182063C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TextBox 346">
              <a:extLst>
                <a:ext uri="{FF2B5EF4-FFF2-40B4-BE49-F238E27FC236}">
                  <a16:creationId xmlns:a16="http://schemas.microsoft.com/office/drawing/2014/main" id="{254BF945-1D09-4AC4-9C4F-FD87D291B9CD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" name="TextBox 347">
              <a:extLst>
                <a:ext uri="{FF2B5EF4-FFF2-40B4-BE49-F238E27FC236}">
                  <a16:creationId xmlns:a16="http://schemas.microsoft.com/office/drawing/2014/main" id="{AC883708-D5E6-40DD-BDB4-A82D98D1EB2F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" name="TextBox 348">
              <a:extLst>
                <a:ext uri="{FF2B5EF4-FFF2-40B4-BE49-F238E27FC236}">
                  <a16:creationId xmlns:a16="http://schemas.microsoft.com/office/drawing/2014/main" id="{03AA8287-DEBD-45CE-BDC3-8F978C75D80C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0" name="그룹 349">
            <a:extLst>
              <a:ext uri="{FF2B5EF4-FFF2-40B4-BE49-F238E27FC236}">
                <a16:creationId xmlns:a16="http://schemas.microsoft.com/office/drawing/2014/main" id="{6538EA43-D99A-4FEC-8BFC-A03F154C5183}"/>
              </a:ext>
            </a:extLst>
          </p:cNvPr>
          <p:cNvGrpSpPr/>
          <p:nvPr/>
        </p:nvGrpSpPr>
        <p:grpSpPr>
          <a:xfrm>
            <a:off x="5235660" y="4734361"/>
            <a:ext cx="204511" cy="1707837"/>
            <a:chOff x="2231375" y="244499"/>
            <a:chExt cx="204511" cy="1707837"/>
          </a:xfrm>
        </p:grpSpPr>
        <p:sp>
          <p:nvSpPr>
            <p:cNvPr id="351" name="TextBox 350">
              <a:extLst>
                <a:ext uri="{FF2B5EF4-FFF2-40B4-BE49-F238E27FC236}">
                  <a16:creationId xmlns:a16="http://schemas.microsoft.com/office/drawing/2014/main" id="{8B994AB2-65BC-49CC-A5B9-9579432471F4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" name="TextBox 351">
              <a:extLst>
                <a:ext uri="{FF2B5EF4-FFF2-40B4-BE49-F238E27FC236}">
                  <a16:creationId xmlns:a16="http://schemas.microsoft.com/office/drawing/2014/main" id="{522C3A11-468F-46B1-92ED-47E80E9EEDFD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" name="TextBox 352">
              <a:extLst>
                <a:ext uri="{FF2B5EF4-FFF2-40B4-BE49-F238E27FC236}">
                  <a16:creationId xmlns:a16="http://schemas.microsoft.com/office/drawing/2014/main" id="{8778A838-BBE2-4EBB-82A8-7D235A20E22C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" name="TextBox 353">
              <a:extLst>
                <a:ext uri="{FF2B5EF4-FFF2-40B4-BE49-F238E27FC236}">
                  <a16:creationId xmlns:a16="http://schemas.microsoft.com/office/drawing/2014/main" id="{78DC6C32-1FF8-4216-A719-E3F894999AD8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162311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815A7604-030A-4B37-ACF3-6452335F0F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8927139"/>
              </p:ext>
            </p:extLst>
          </p:nvPr>
        </p:nvGraphicFramePr>
        <p:xfrm>
          <a:off x="2102124" y="1570381"/>
          <a:ext cx="5768035" cy="21250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26" name="Graph" r:id="rId3" imgW="6949440" imgH="2560320" progId="Origin95.Graph">
                  <p:embed/>
                </p:oleObj>
              </mc:Choice>
              <mc:Fallback>
                <p:oleObj name="Graph" r:id="rId3" imgW="6949440" imgH="256032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02124" y="1570381"/>
                        <a:ext cx="5768035" cy="21250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1" name="TextBox 110">
            <a:extLst>
              <a:ext uri="{FF2B5EF4-FFF2-40B4-BE49-F238E27FC236}">
                <a16:creationId xmlns:a16="http://schemas.microsoft.com/office/drawing/2014/main" id="{22CBE702-FB92-43A8-B265-81DAFC10F623}"/>
              </a:ext>
            </a:extLst>
          </p:cNvPr>
          <p:cNvSpPr txBox="1"/>
          <p:nvPr/>
        </p:nvSpPr>
        <p:spPr>
          <a:xfrm>
            <a:off x="2990903" y="4946658"/>
            <a:ext cx="19845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Repeats of CGCCG (three times)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직사각형 222">
            <a:extLst>
              <a:ext uri="{FF2B5EF4-FFF2-40B4-BE49-F238E27FC236}">
                <a16:creationId xmlns:a16="http://schemas.microsoft.com/office/drawing/2014/main" id="{C9705AF1-1C3C-41FF-8C91-2B23A2865F1A}"/>
              </a:ext>
            </a:extLst>
          </p:cNvPr>
          <p:cNvSpPr/>
          <p:nvPr/>
        </p:nvSpPr>
        <p:spPr>
          <a:xfrm>
            <a:off x="7072253" y="4081249"/>
            <a:ext cx="720285" cy="323165"/>
          </a:xfrm>
          <a:prstGeom prst="rect">
            <a:avLst/>
          </a:prstGeom>
          <a:effectLst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Premature termination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0" name="그룹 329">
            <a:extLst>
              <a:ext uri="{FF2B5EF4-FFF2-40B4-BE49-F238E27FC236}">
                <a16:creationId xmlns:a16="http://schemas.microsoft.com/office/drawing/2014/main" id="{D5F93A31-60EA-41A5-97D4-584BA5A52D08}"/>
              </a:ext>
            </a:extLst>
          </p:cNvPr>
          <p:cNvGrpSpPr/>
          <p:nvPr/>
        </p:nvGrpSpPr>
        <p:grpSpPr>
          <a:xfrm>
            <a:off x="2668838" y="4583848"/>
            <a:ext cx="5246166" cy="444728"/>
            <a:chOff x="2351986" y="2781980"/>
            <a:chExt cx="5246166" cy="444728"/>
          </a:xfrm>
        </p:grpSpPr>
        <p:sp>
          <p:nvSpPr>
            <p:cNvPr id="325" name="직사각형 324">
              <a:extLst>
                <a:ext uri="{FF2B5EF4-FFF2-40B4-BE49-F238E27FC236}">
                  <a16:creationId xmlns:a16="http://schemas.microsoft.com/office/drawing/2014/main" id="{82345F29-F9EE-4686-AD2D-13D413BC5578}"/>
                </a:ext>
              </a:extLst>
            </p:cNvPr>
            <p:cNvSpPr/>
            <p:nvPr/>
          </p:nvSpPr>
          <p:spPr>
            <a:xfrm>
              <a:off x="3033654" y="3029595"/>
              <a:ext cx="1265313" cy="122492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grpSp>
          <p:nvGrpSpPr>
            <p:cNvPr id="226" name="그룹 225">
              <a:extLst>
                <a:ext uri="{FF2B5EF4-FFF2-40B4-BE49-F238E27FC236}">
                  <a16:creationId xmlns:a16="http://schemas.microsoft.com/office/drawing/2014/main" id="{FE223B32-E673-4A22-B775-6DC23A8172FB}"/>
                </a:ext>
              </a:extLst>
            </p:cNvPr>
            <p:cNvGrpSpPr/>
            <p:nvPr/>
          </p:nvGrpSpPr>
          <p:grpSpPr>
            <a:xfrm>
              <a:off x="2445164" y="2781980"/>
              <a:ext cx="5035638" cy="237852"/>
              <a:chOff x="2216409" y="4897417"/>
              <a:chExt cx="5035638" cy="237852"/>
            </a:xfrm>
          </p:grpSpPr>
          <p:grpSp>
            <p:nvGrpSpPr>
              <p:cNvPr id="62" name="그룹 61">
                <a:extLst>
                  <a:ext uri="{FF2B5EF4-FFF2-40B4-BE49-F238E27FC236}">
                    <a16:creationId xmlns:a16="http://schemas.microsoft.com/office/drawing/2014/main" id="{E13D6D59-4BAC-46D3-98FA-0E57BA4C6C6F}"/>
                  </a:ext>
                </a:extLst>
              </p:cNvPr>
              <p:cNvGrpSpPr/>
              <p:nvPr/>
            </p:nvGrpSpPr>
            <p:grpSpPr>
              <a:xfrm>
                <a:off x="2216409" y="5107967"/>
                <a:ext cx="5035638" cy="27302"/>
                <a:chOff x="2446250" y="3316314"/>
                <a:chExt cx="5035638" cy="27302"/>
              </a:xfrm>
            </p:grpSpPr>
            <p:cxnSp>
              <p:nvCxnSpPr>
                <p:cNvPr id="84" name="직선 연결선 83">
                  <a:extLst>
                    <a:ext uri="{FF2B5EF4-FFF2-40B4-BE49-F238E27FC236}">
                      <a16:creationId xmlns:a16="http://schemas.microsoft.com/office/drawing/2014/main" id="{6C2D4262-95F6-422C-95AD-1C16801CD991}"/>
                    </a:ext>
                  </a:extLst>
                </p:cNvPr>
                <p:cNvCxnSpPr/>
                <p:nvPr/>
              </p:nvCxnSpPr>
              <p:spPr>
                <a:xfrm>
                  <a:off x="2446250" y="3316314"/>
                  <a:ext cx="5035638" cy="0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직선 연결선 84">
                  <a:extLst>
                    <a:ext uri="{FF2B5EF4-FFF2-40B4-BE49-F238E27FC236}">
                      <a16:creationId xmlns:a16="http://schemas.microsoft.com/office/drawing/2014/main" id="{6EC3C063-099F-4B23-9E34-5754959D86E9}"/>
                    </a:ext>
                  </a:extLst>
                </p:cNvPr>
                <p:cNvCxnSpPr/>
                <p:nvPr/>
              </p:nvCxnSpPr>
              <p:spPr>
                <a:xfrm>
                  <a:off x="245135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직선 연결선 85">
                  <a:extLst>
                    <a:ext uri="{FF2B5EF4-FFF2-40B4-BE49-F238E27FC236}">
                      <a16:creationId xmlns:a16="http://schemas.microsoft.com/office/drawing/2014/main" id="{B821FC9F-22DE-4A7F-AF81-DA00827CAD41}"/>
                    </a:ext>
                  </a:extLst>
                </p:cNvPr>
                <p:cNvCxnSpPr/>
                <p:nvPr/>
              </p:nvCxnSpPr>
              <p:spPr>
                <a:xfrm>
                  <a:off x="270281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직선 연결선 86">
                  <a:extLst>
                    <a:ext uri="{FF2B5EF4-FFF2-40B4-BE49-F238E27FC236}">
                      <a16:creationId xmlns:a16="http://schemas.microsoft.com/office/drawing/2014/main" id="{BBFA3B56-8432-469E-9783-F4E24FF38EC3}"/>
                    </a:ext>
                  </a:extLst>
                </p:cNvPr>
                <p:cNvCxnSpPr/>
                <p:nvPr/>
              </p:nvCxnSpPr>
              <p:spPr>
                <a:xfrm>
                  <a:off x="295427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직선 연결선 87">
                  <a:extLst>
                    <a:ext uri="{FF2B5EF4-FFF2-40B4-BE49-F238E27FC236}">
                      <a16:creationId xmlns:a16="http://schemas.microsoft.com/office/drawing/2014/main" id="{7B657793-E12F-4026-A186-0323A43A479F}"/>
                    </a:ext>
                  </a:extLst>
                </p:cNvPr>
                <p:cNvCxnSpPr/>
                <p:nvPr/>
              </p:nvCxnSpPr>
              <p:spPr>
                <a:xfrm>
                  <a:off x="320573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직선 연결선 88">
                  <a:extLst>
                    <a:ext uri="{FF2B5EF4-FFF2-40B4-BE49-F238E27FC236}">
                      <a16:creationId xmlns:a16="http://schemas.microsoft.com/office/drawing/2014/main" id="{750292A4-379B-4AE1-9307-BEA977D748CF}"/>
                    </a:ext>
                  </a:extLst>
                </p:cNvPr>
                <p:cNvCxnSpPr/>
                <p:nvPr/>
              </p:nvCxnSpPr>
              <p:spPr>
                <a:xfrm>
                  <a:off x="345719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직선 연결선 89">
                  <a:extLst>
                    <a:ext uri="{FF2B5EF4-FFF2-40B4-BE49-F238E27FC236}">
                      <a16:creationId xmlns:a16="http://schemas.microsoft.com/office/drawing/2014/main" id="{A2C65494-BA91-44EF-84FC-150E8699E4EE}"/>
                    </a:ext>
                  </a:extLst>
                </p:cNvPr>
                <p:cNvCxnSpPr/>
                <p:nvPr/>
              </p:nvCxnSpPr>
              <p:spPr>
                <a:xfrm>
                  <a:off x="370865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직선 연결선 90">
                  <a:extLst>
                    <a:ext uri="{FF2B5EF4-FFF2-40B4-BE49-F238E27FC236}">
                      <a16:creationId xmlns:a16="http://schemas.microsoft.com/office/drawing/2014/main" id="{BB6D84B2-6C75-44EC-A8A3-A42C7B488D06}"/>
                    </a:ext>
                  </a:extLst>
                </p:cNvPr>
                <p:cNvCxnSpPr/>
                <p:nvPr/>
              </p:nvCxnSpPr>
              <p:spPr>
                <a:xfrm>
                  <a:off x="396011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직선 연결선 91">
                  <a:extLst>
                    <a:ext uri="{FF2B5EF4-FFF2-40B4-BE49-F238E27FC236}">
                      <a16:creationId xmlns:a16="http://schemas.microsoft.com/office/drawing/2014/main" id="{25658BA9-9E32-4835-8412-5ACB52775A9D}"/>
                    </a:ext>
                  </a:extLst>
                </p:cNvPr>
                <p:cNvCxnSpPr/>
                <p:nvPr/>
              </p:nvCxnSpPr>
              <p:spPr>
                <a:xfrm>
                  <a:off x="421157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직선 연결선 92">
                  <a:extLst>
                    <a:ext uri="{FF2B5EF4-FFF2-40B4-BE49-F238E27FC236}">
                      <a16:creationId xmlns:a16="http://schemas.microsoft.com/office/drawing/2014/main" id="{E92DA669-4D2E-4BE3-B62F-C61B89EFE7ED}"/>
                    </a:ext>
                  </a:extLst>
                </p:cNvPr>
                <p:cNvCxnSpPr/>
                <p:nvPr/>
              </p:nvCxnSpPr>
              <p:spPr>
                <a:xfrm>
                  <a:off x="446303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직선 연결선 93">
                  <a:extLst>
                    <a:ext uri="{FF2B5EF4-FFF2-40B4-BE49-F238E27FC236}">
                      <a16:creationId xmlns:a16="http://schemas.microsoft.com/office/drawing/2014/main" id="{88331C76-EFE4-4699-8854-7182C1278616}"/>
                    </a:ext>
                  </a:extLst>
                </p:cNvPr>
                <p:cNvCxnSpPr/>
                <p:nvPr/>
              </p:nvCxnSpPr>
              <p:spPr>
                <a:xfrm>
                  <a:off x="471449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직선 연결선 94">
                  <a:extLst>
                    <a:ext uri="{FF2B5EF4-FFF2-40B4-BE49-F238E27FC236}">
                      <a16:creationId xmlns:a16="http://schemas.microsoft.com/office/drawing/2014/main" id="{C96290AB-23A5-4917-A04F-2D882F44785A}"/>
                    </a:ext>
                  </a:extLst>
                </p:cNvPr>
                <p:cNvCxnSpPr/>
                <p:nvPr/>
              </p:nvCxnSpPr>
              <p:spPr>
                <a:xfrm>
                  <a:off x="496595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직선 연결선 95">
                  <a:extLst>
                    <a:ext uri="{FF2B5EF4-FFF2-40B4-BE49-F238E27FC236}">
                      <a16:creationId xmlns:a16="http://schemas.microsoft.com/office/drawing/2014/main" id="{63D5CBFD-6F86-4DB7-A9D0-F794CA02AF36}"/>
                    </a:ext>
                  </a:extLst>
                </p:cNvPr>
                <p:cNvCxnSpPr/>
                <p:nvPr/>
              </p:nvCxnSpPr>
              <p:spPr>
                <a:xfrm>
                  <a:off x="521741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직선 연결선 96">
                  <a:extLst>
                    <a:ext uri="{FF2B5EF4-FFF2-40B4-BE49-F238E27FC236}">
                      <a16:creationId xmlns:a16="http://schemas.microsoft.com/office/drawing/2014/main" id="{109D2182-8C94-4B9A-BD77-65929798B2E3}"/>
                    </a:ext>
                  </a:extLst>
                </p:cNvPr>
                <p:cNvCxnSpPr/>
                <p:nvPr/>
              </p:nvCxnSpPr>
              <p:spPr>
                <a:xfrm>
                  <a:off x="546887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직선 연결선 97">
                  <a:extLst>
                    <a:ext uri="{FF2B5EF4-FFF2-40B4-BE49-F238E27FC236}">
                      <a16:creationId xmlns:a16="http://schemas.microsoft.com/office/drawing/2014/main" id="{D9527BC4-99D6-44FC-8C20-3A9E69452112}"/>
                    </a:ext>
                  </a:extLst>
                </p:cNvPr>
                <p:cNvCxnSpPr/>
                <p:nvPr/>
              </p:nvCxnSpPr>
              <p:spPr>
                <a:xfrm>
                  <a:off x="572033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직선 연결선 98">
                  <a:extLst>
                    <a:ext uri="{FF2B5EF4-FFF2-40B4-BE49-F238E27FC236}">
                      <a16:creationId xmlns:a16="http://schemas.microsoft.com/office/drawing/2014/main" id="{70E8AD01-7625-4DB0-B25D-365228ED8336}"/>
                    </a:ext>
                  </a:extLst>
                </p:cNvPr>
                <p:cNvCxnSpPr/>
                <p:nvPr/>
              </p:nvCxnSpPr>
              <p:spPr>
                <a:xfrm>
                  <a:off x="597179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직선 연결선 99">
                  <a:extLst>
                    <a:ext uri="{FF2B5EF4-FFF2-40B4-BE49-F238E27FC236}">
                      <a16:creationId xmlns:a16="http://schemas.microsoft.com/office/drawing/2014/main" id="{69E14A60-2B89-4EE1-AD8C-749E37DB32B6}"/>
                    </a:ext>
                  </a:extLst>
                </p:cNvPr>
                <p:cNvCxnSpPr/>
                <p:nvPr/>
              </p:nvCxnSpPr>
              <p:spPr>
                <a:xfrm>
                  <a:off x="622325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직선 연결선 100">
                  <a:extLst>
                    <a:ext uri="{FF2B5EF4-FFF2-40B4-BE49-F238E27FC236}">
                      <a16:creationId xmlns:a16="http://schemas.microsoft.com/office/drawing/2014/main" id="{AB73E10C-CCBB-497E-B6EE-B2569C1D7D76}"/>
                    </a:ext>
                  </a:extLst>
                </p:cNvPr>
                <p:cNvCxnSpPr/>
                <p:nvPr/>
              </p:nvCxnSpPr>
              <p:spPr>
                <a:xfrm>
                  <a:off x="647471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직선 연결선 101">
                  <a:extLst>
                    <a:ext uri="{FF2B5EF4-FFF2-40B4-BE49-F238E27FC236}">
                      <a16:creationId xmlns:a16="http://schemas.microsoft.com/office/drawing/2014/main" id="{BA7BCEE3-8EB1-4726-A2B9-D6C536BDFAC2}"/>
                    </a:ext>
                  </a:extLst>
                </p:cNvPr>
                <p:cNvCxnSpPr/>
                <p:nvPr/>
              </p:nvCxnSpPr>
              <p:spPr>
                <a:xfrm>
                  <a:off x="672617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직선 연결선 102">
                  <a:extLst>
                    <a:ext uri="{FF2B5EF4-FFF2-40B4-BE49-F238E27FC236}">
                      <a16:creationId xmlns:a16="http://schemas.microsoft.com/office/drawing/2014/main" id="{FCD4731A-CB17-4CDA-851A-34809491CCCC}"/>
                    </a:ext>
                  </a:extLst>
                </p:cNvPr>
                <p:cNvCxnSpPr/>
                <p:nvPr/>
              </p:nvCxnSpPr>
              <p:spPr>
                <a:xfrm>
                  <a:off x="697763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직선 연결선 103">
                  <a:extLst>
                    <a:ext uri="{FF2B5EF4-FFF2-40B4-BE49-F238E27FC236}">
                      <a16:creationId xmlns:a16="http://schemas.microsoft.com/office/drawing/2014/main" id="{4D6B5E52-8CB4-4D6E-9D32-74EA4C8E5A0F}"/>
                    </a:ext>
                  </a:extLst>
                </p:cNvPr>
                <p:cNvCxnSpPr/>
                <p:nvPr/>
              </p:nvCxnSpPr>
              <p:spPr>
                <a:xfrm>
                  <a:off x="722909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직선 연결선 104">
                  <a:extLst>
                    <a:ext uri="{FF2B5EF4-FFF2-40B4-BE49-F238E27FC236}">
                      <a16:creationId xmlns:a16="http://schemas.microsoft.com/office/drawing/2014/main" id="{A110C4E2-9A55-4253-9EDA-FDE64BDCC240}"/>
                    </a:ext>
                  </a:extLst>
                </p:cNvPr>
                <p:cNvCxnSpPr/>
                <p:nvPr/>
              </p:nvCxnSpPr>
              <p:spPr>
                <a:xfrm>
                  <a:off x="7480551" y="3316314"/>
                  <a:ext cx="0" cy="27302"/>
                </a:xfrm>
                <a:prstGeom prst="line">
                  <a:avLst/>
                </a:prstGeom>
                <a:ln w="95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7A1E7EAA-017C-4D2C-ABB2-E7FF7EED587A}"/>
                  </a:ext>
                </a:extLst>
              </p:cNvPr>
              <p:cNvSpPr txBox="1"/>
              <p:nvPr/>
            </p:nvSpPr>
            <p:spPr>
              <a:xfrm>
                <a:off x="3023306" y="4977772"/>
                <a:ext cx="163506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rg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8865AA05-D8E3-42FD-B3CB-728ACED2880F}"/>
                  </a:ext>
                </a:extLst>
              </p:cNvPr>
              <p:cNvSpPr txBox="1"/>
              <p:nvPr/>
            </p:nvSpPr>
            <p:spPr>
              <a:xfrm>
                <a:off x="3274050" y="4977772"/>
                <a:ext cx="163506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rg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A5169C83-1273-4ADD-ADCA-84698A75D563}"/>
                  </a:ext>
                </a:extLst>
              </p:cNvPr>
              <p:cNvSpPr txBox="1"/>
              <p:nvPr/>
            </p:nvSpPr>
            <p:spPr>
              <a:xfrm>
                <a:off x="3524794" y="4977772"/>
                <a:ext cx="163506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la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E3C76832-7106-4396-A026-C3D5FFD3C309}"/>
                  </a:ext>
                </a:extLst>
              </p:cNvPr>
              <p:cNvSpPr txBox="1"/>
              <p:nvPr/>
            </p:nvSpPr>
            <p:spPr>
              <a:xfrm>
                <a:off x="3775539" y="4977772"/>
                <a:ext cx="163506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la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FE52B5AF-C8E2-4239-BE26-8917599ED111}"/>
                  </a:ext>
                </a:extLst>
              </p:cNvPr>
              <p:cNvSpPr txBox="1"/>
              <p:nvPr/>
            </p:nvSpPr>
            <p:spPr>
              <a:xfrm>
                <a:off x="4026284" y="4977772"/>
                <a:ext cx="163506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ro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390D495E-2EA0-41A2-9107-67A3769AB2F9}"/>
                  </a:ext>
                </a:extLst>
              </p:cNvPr>
              <p:cNvSpPr txBox="1"/>
              <p:nvPr/>
            </p:nvSpPr>
            <p:spPr>
              <a:xfrm>
                <a:off x="4277029" y="4977772"/>
                <a:ext cx="163506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ys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C74BDDF2-C2A2-43C5-9221-E2CC0096A207}"/>
                  </a:ext>
                </a:extLst>
              </p:cNvPr>
              <p:cNvSpPr txBox="1"/>
              <p:nvPr/>
            </p:nvSpPr>
            <p:spPr>
              <a:xfrm>
                <a:off x="4527774" y="4977772"/>
                <a:ext cx="163506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rg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4B1A126C-C977-4B7F-913C-246FA0B363C2}"/>
                  </a:ext>
                </a:extLst>
              </p:cNvPr>
              <p:cNvSpPr txBox="1"/>
              <p:nvPr/>
            </p:nvSpPr>
            <p:spPr>
              <a:xfrm>
                <a:off x="4778510" y="4977772"/>
                <a:ext cx="163506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eu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F4981999-EDDA-4E18-8FBC-6D4B7000469A}"/>
                  </a:ext>
                </a:extLst>
              </p:cNvPr>
              <p:cNvSpPr txBox="1"/>
              <p:nvPr/>
            </p:nvSpPr>
            <p:spPr>
              <a:xfrm>
                <a:off x="2271071" y="4977772"/>
                <a:ext cx="163506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ly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D3B55513-A75B-4506-A8D7-A689B0D632D2}"/>
                  </a:ext>
                </a:extLst>
              </p:cNvPr>
              <p:cNvSpPr txBox="1"/>
              <p:nvPr/>
            </p:nvSpPr>
            <p:spPr>
              <a:xfrm>
                <a:off x="2521816" y="4977772"/>
                <a:ext cx="163506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hr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1D0375FC-F122-42EF-9C47-D217654009F9}"/>
                  </a:ext>
                </a:extLst>
              </p:cNvPr>
              <p:cNvSpPr txBox="1"/>
              <p:nvPr/>
            </p:nvSpPr>
            <p:spPr>
              <a:xfrm>
                <a:off x="2772561" y="4977772"/>
                <a:ext cx="163506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ro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3AFE22B3-B7C9-407A-AFEF-C9F57EDE29DC}"/>
                  </a:ext>
                </a:extLst>
              </p:cNvPr>
              <p:cNvSpPr txBox="1"/>
              <p:nvPr/>
            </p:nvSpPr>
            <p:spPr>
              <a:xfrm>
                <a:off x="6025157" y="4982225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ly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5BD8BEB3-38DE-437A-BC04-3B9D0E646F5B}"/>
                  </a:ext>
                </a:extLst>
              </p:cNvPr>
              <p:cNvSpPr txBox="1"/>
              <p:nvPr/>
            </p:nvSpPr>
            <p:spPr>
              <a:xfrm>
                <a:off x="6275902" y="4982225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yr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A574D16C-79F0-4A4B-B3A3-827AFB0752EF}"/>
                  </a:ext>
                </a:extLst>
              </p:cNvPr>
              <p:cNvSpPr txBox="1"/>
              <p:nvPr/>
            </p:nvSpPr>
            <p:spPr>
              <a:xfrm>
                <a:off x="6526647" y="4982225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yr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E33FF19E-5E60-4ED6-BA2C-140FC48291E1}"/>
                  </a:ext>
                </a:extLst>
              </p:cNvPr>
              <p:cNvSpPr txBox="1"/>
              <p:nvPr/>
            </p:nvSpPr>
            <p:spPr>
              <a:xfrm>
                <a:off x="6750141" y="4969525"/>
                <a:ext cx="218009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b="1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Stop</a:t>
                </a:r>
                <a:endParaRPr lang="ko-KR" altLang="en-US" sz="700" b="1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091E15CB-4874-4C54-B349-C66BE265AAE6}"/>
                  </a:ext>
                </a:extLst>
              </p:cNvPr>
              <p:cNvSpPr txBox="1"/>
              <p:nvPr/>
            </p:nvSpPr>
            <p:spPr>
              <a:xfrm>
                <a:off x="5022177" y="4982225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rg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72231530-6FB1-4E48-8B95-D84E6D5D8E1C}"/>
                  </a:ext>
                </a:extLst>
              </p:cNvPr>
              <p:cNvSpPr txBox="1"/>
              <p:nvPr/>
            </p:nvSpPr>
            <p:spPr>
              <a:xfrm>
                <a:off x="5272922" y="4982225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eu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9844CA04-276D-4696-9022-934F18A8E46F}"/>
                  </a:ext>
                </a:extLst>
              </p:cNvPr>
              <p:cNvSpPr txBox="1"/>
              <p:nvPr/>
            </p:nvSpPr>
            <p:spPr>
              <a:xfrm>
                <a:off x="5523667" y="4982225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ys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A6A0EBD4-7719-463B-AFBE-FC1064EA4EDE}"/>
                  </a:ext>
                </a:extLst>
              </p:cNvPr>
              <p:cNvSpPr txBox="1"/>
              <p:nvPr/>
            </p:nvSpPr>
            <p:spPr>
              <a:xfrm>
                <a:off x="5774412" y="4982225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hr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F1411F41-7743-4534-8FF8-007A97FE2B92}"/>
                  </a:ext>
                </a:extLst>
              </p:cNvPr>
              <p:cNvSpPr txBox="1"/>
              <p:nvPr/>
            </p:nvSpPr>
            <p:spPr>
              <a:xfrm>
                <a:off x="6526646" y="4902310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303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95BC0FFC-CE14-4760-A957-F3738DCEFD63}"/>
                  </a:ext>
                </a:extLst>
              </p:cNvPr>
              <p:cNvSpPr txBox="1"/>
              <p:nvPr/>
            </p:nvSpPr>
            <p:spPr>
              <a:xfrm>
                <a:off x="2274624" y="4897417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287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</p:grpSp>
        <p:sp>
          <p:nvSpPr>
            <p:cNvPr id="225" name="직사각형 224">
              <a:extLst>
                <a:ext uri="{FF2B5EF4-FFF2-40B4-BE49-F238E27FC236}">
                  <a16:creationId xmlns:a16="http://schemas.microsoft.com/office/drawing/2014/main" id="{E1B8620F-2B31-4594-B4B0-58869C583C60}"/>
                </a:ext>
              </a:extLst>
            </p:cNvPr>
            <p:cNvSpPr/>
            <p:nvPr/>
          </p:nvSpPr>
          <p:spPr>
            <a:xfrm>
              <a:off x="2351986" y="2965098"/>
              <a:ext cx="5246166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11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GTACCCCGCGCCGCGCCGCGCCGAAGAGATTACGATTAAAGACCGGCTATTACTGATCA</a:t>
              </a:r>
            </a:p>
          </p:txBody>
        </p:sp>
      </p:grpSp>
      <p:grpSp>
        <p:nvGrpSpPr>
          <p:cNvPr id="329" name="그룹 328">
            <a:extLst>
              <a:ext uri="{FF2B5EF4-FFF2-40B4-BE49-F238E27FC236}">
                <a16:creationId xmlns:a16="http://schemas.microsoft.com/office/drawing/2014/main" id="{59B19070-D43B-43AB-885A-2A93076766ED}"/>
              </a:ext>
            </a:extLst>
          </p:cNvPr>
          <p:cNvGrpSpPr/>
          <p:nvPr/>
        </p:nvGrpSpPr>
        <p:grpSpPr>
          <a:xfrm>
            <a:off x="2668838" y="5133378"/>
            <a:ext cx="5246165" cy="438868"/>
            <a:chOff x="2351986" y="3253063"/>
            <a:chExt cx="5246165" cy="438868"/>
          </a:xfrm>
        </p:grpSpPr>
        <p:sp>
          <p:nvSpPr>
            <p:cNvPr id="326" name="직사각형 325">
              <a:extLst>
                <a:ext uri="{FF2B5EF4-FFF2-40B4-BE49-F238E27FC236}">
                  <a16:creationId xmlns:a16="http://schemas.microsoft.com/office/drawing/2014/main" id="{87E0BB33-CF9E-467C-B177-C9BB33B9AC75}"/>
                </a:ext>
              </a:extLst>
            </p:cNvPr>
            <p:cNvSpPr/>
            <p:nvPr/>
          </p:nvSpPr>
          <p:spPr>
            <a:xfrm>
              <a:off x="3033655" y="3500381"/>
              <a:ext cx="846196" cy="122492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27" name="직사각형 226">
              <a:extLst>
                <a:ext uri="{FF2B5EF4-FFF2-40B4-BE49-F238E27FC236}">
                  <a16:creationId xmlns:a16="http://schemas.microsoft.com/office/drawing/2014/main" id="{44BE9F21-9F74-4612-AB8E-D4924CD4530C}"/>
                </a:ext>
              </a:extLst>
            </p:cNvPr>
            <p:cNvSpPr/>
            <p:nvPr/>
          </p:nvSpPr>
          <p:spPr>
            <a:xfrm>
              <a:off x="2351986" y="3430321"/>
              <a:ext cx="5246165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11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GTACCCCGCGCCGCGCCGAAGAGATTACGATTAAAGACCGGCTATTACTGATCAACACC</a:t>
              </a:r>
            </a:p>
          </p:txBody>
        </p:sp>
        <p:grpSp>
          <p:nvGrpSpPr>
            <p:cNvPr id="276" name="그룹 275">
              <a:extLst>
                <a:ext uri="{FF2B5EF4-FFF2-40B4-BE49-F238E27FC236}">
                  <a16:creationId xmlns:a16="http://schemas.microsoft.com/office/drawing/2014/main" id="{8E02737F-0E9C-4655-A5F9-21A1E95A75AC}"/>
                </a:ext>
              </a:extLst>
            </p:cNvPr>
            <p:cNvGrpSpPr/>
            <p:nvPr/>
          </p:nvGrpSpPr>
          <p:grpSpPr>
            <a:xfrm>
              <a:off x="2445164" y="3253063"/>
              <a:ext cx="5035638" cy="237852"/>
              <a:chOff x="2452793" y="3253063"/>
              <a:chExt cx="5035638" cy="237852"/>
            </a:xfrm>
          </p:grpSpPr>
          <p:grpSp>
            <p:nvGrpSpPr>
              <p:cNvPr id="229" name="그룹 228">
                <a:extLst>
                  <a:ext uri="{FF2B5EF4-FFF2-40B4-BE49-F238E27FC236}">
                    <a16:creationId xmlns:a16="http://schemas.microsoft.com/office/drawing/2014/main" id="{BF3F5EFE-6053-4715-8CDC-E647D859C0CE}"/>
                  </a:ext>
                </a:extLst>
              </p:cNvPr>
              <p:cNvGrpSpPr/>
              <p:nvPr/>
            </p:nvGrpSpPr>
            <p:grpSpPr>
              <a:xfrm>
                <a:off x="2452793" y="3253063"/>
                <a:ext cx="5035638" cy="237852"/>
                <a:chOff x="2216409" y="4897417"/>
                <a:chExt cx="5035638" cy="237852"/>
              </a:xfrm>
            </p:grpSpPr>
            <p:grpSp>
              <p:nvGrpSpPr>
                <p:cNvPr id="230" name="그룹 229">
                  <a:extLst>
                    <a:ext uri="{FF2B5EF4-FFF2-40B4-BE49-F238E27FC236}">
                      <a16:creationId xmlns:a16="http://schemas.microsoft.com/office/drawing/2014/main" id="{DF71C35D-2F9A-4739-AF71-FC4F5FA57E9F}"/>
                    </a:ext>
                  </a:extLst>
                </p:cNvPr>
                <p:cNvGrpSpPr/>
                <p:nvPr/>
              </p:nvGrpSpPr>
              <p:grpSpPr>
                <a:xfrm>
                  <a:off x="2216409" y="5107967"/>
                  <a:ext cx="5035638" cy="27302"/>
                  <a:chOff x="2446250" y="3316314"/>
                  <a:chExt cx="5035638" cy="27302"/>
                </a:xfrm>
              </p:grpSpPr>
              <p:cxnSp>
                <p:nvCxnSpPr>
                  <p:cNvPr id="252" name="직선 연결선 251">
                    <a:extLst>
                      <a:ext uri="{FF2B5EF4-FFF2-40B4-BE49-F238E27FC236}">
                        <a16:creationId xmlns:a16="http://schemas.microsoft.com/office/drawing/2014/main" id="{2A2D57F2-3280-4E4D-B869-5A053159162F}"/>
                      </a:ext>
                    </a:extLst>
                  </p:cNvPr>
                  <p:cNvCxnSpPr/>
                  <p:nvPr/>
                </p:nvCxnSpPr>
                <p:spPr>
                  <a:xfrm>
                    <a:off x="2446250" y="3316314"/>
                    <a:ext cx="5035638" cy="0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3" name="직선 연결선 252">
                    <a:extLst>
                      <a:ext uri="{FF2B5EF4-FFF2-40B4-BE49-F238E27FC236}">
                        <a16:creationId xmlns:a16="http://schemas.microsoft.com/office/drawing/2014/main" id="{B7223EF8-EC86-4071-B780-F37FE7569E49}"/>
                      </a:ext>
                    </a:extLst>
                  </p:cNvPr>
                  <p:cNvCxnSpPr/>
                  <p:nvPr/>
                </p:nvCxnSpPr>
                <p:spPr>
                  <a:xfrm>
                    <a:off x="245135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4" name="직선 연결선 253">
                    <a:extLst>
                      <a:ext uri="{FF2B5EF4-FFF2-40B4-BE49-F238E27FC236}">
                        <a16:creationId xmlns:a16="http://schemas.microsoft.com/office/drawing/2014/main" id="{E21AA375-21E8-4587-B7AF-6211DDA305A6}"/>
                      </a:ext>
                    </a:extLst>
                  </p:cNvPr>
                  <p:cNvCxnSpPr/>
                  <p:nvPr/>
                </p:nvCxnSpPr>
                <p:spPr>
                  <a:xfrm>
                    <a:off x="270281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5" name="직선 연결선 254">
                    <a:extLst>
                      <a:ext uri="{FF2B5EF4-FFF2-40B4-BE49-F238E27FC236}">
                        <a16:creationId xmlns:a16="http://schemas.microsoft.com/office/drawing/2014/main" id="{DAFC83D8-EC83-4062-B134-3A6AACC5E82A}"/>
                      </a:ext>
                    </a:extLst>
                  </p:cNvPr>
                  <p:cNvCxnSpPr/>
                  <p:nvPr/>
                </p:nvCxnSpPr>
                <p:spPr>
                  <a:xfrm>
                    <a:off x="295427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6" name="직선 연결선 255">
                    <a:extLst>
                      <a:ext uri="{FF2B5EF4-FFF2-40B4-BE49-F238E27FC236}">
                        <a16:creationId xmlns:a16="http://schemas.microsoft.com/office/drawing/2014/main" id="{A5F9A3F1-B0B4-4CA6-B216-2EFE3354EFDD}"/>
                      </a:ext>
                    </a:extLst>
                  </p:cNvPr>
                  <p:cNvCxnSpPr/>
                  <p:nvPr/>
                </p:nvCxnSpPr>
                <p:spPr>
                  <a:xfrm>
                    <a:off x="320573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7" name="직선 연결선 256">
                    <a:extLst>
                      <a:ext uri="{FF2B5EF4-FFF2-40B4-BE49-F238E27FC236}">
                        <a16:creationId xmlns:a16="http://schemas.microsoft.com/office/drawing/2014/main" id="{20C0F347-C39E-4261-A3DA-8321D393A08E}"/>
                      </a:ext>
                    </a:extLst>
                  </p:cNvPr>
                  <p:cNvCxnSpPr/>
                  <p:nvPr/>
                </p:nvCxnSpPr>
                <p:spPr>
                  <a:xfrm>
                    <a:off x="345719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8" name="직선 연결선 257">
                    <a:extLst>
                      <a:ext uri="{FF2B5EF4-FFF2-40B4-BE49-F238E27FC236}">
                        <a16:creationId xmlns:a16="http://schemas.microsoft.com/office/drawing/2014/main" id="{DEEAE770-402E-4900-ABF1-4CA5F8FD0CA2}"/>
                      </a:ext>
                    </a:extLst>
                  </p:cNvPr>
                  <p:cNvCxnSpPr/>
                  <p:nvPr/>
                </p:nvCxnSpPr>
                <p:spPr>
                  <a:xfrm>
                    <a:off x="370865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9" name="직선 연결선 258">
                    <a:extLst>
                      <a:ext uri="{FF2B5EF4-FFF2-40B4-BE49-F238E27FC236}">
                        <a16:creationId xmlns:a16="http://schemas.microsoft.com/office/drawing/2014/main" id="{AE23E739-AEAC-4D24-8237-E3B824577C45}"/>
                      </a:ext>
                    </a:extLst>
                  </p:cNvPr>
                  <p:cNvCxnSpPr/>
                  <p:nvPr/>
                </p:nvCxnSpPr>
                <p:spPr>
                  <a:xfrm>
                    <a:off x="396011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0" name="직선 연결선 259">
                    <a:extLst>
                      <a:ext uri="{FF2B5EF4-FFF2-40B4-BE49-F238E27FC236}">
                        <a16:creationId xmlns:a16="http://schemas.microsoft.com/office/drawing/2014/main" id="{9D244D06-5FA7-4C48-93FC-3F9E566F7F9D}"/>
                      </a:ext>
                    </a:extLst>
                  </p:cNvPr>
                  <p:cNvCxnSpPr/>
                  <p:nvPr/>
                </p:nvCxnSpPr>
                <p:spPr>
                  <a:xfrm>
                    <a:off x="421157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1" name="직선 연결선 260">
                    <a:extLst>
                      <a:ext uri="{FF2B5EF4-FFF2-40B4-BE49-F238E27FC236}">
                        <a16:creationId xmlns:a16="http://schemas.microsoft.com/office/drawing/2014/main" id="{45257B93-2B72-433C-87EF-081D2C2AB205}"/>
                      </a:ext>
                    </a:extLst>
                  </p:cNvPr>
                  <p:cNvCxnSpPr/>
                  <p:nvPr/>
                </p:nvCxnSpPr>
                <p:spPr>
                  <a:xfrm>
                    <a:off x="446303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2" name="직선 연결선 261">
                    <a:extLst>
                      <a:ext uri="{FF2B5EF4-FFF2-40B4-BE49-F238E27FC236}">
                        <a16:creationId xmlns:a16="http://schemas.microsoft.com/office/drawing/2014/main" id="{334F477F-9BE3-4F2D-871A-5D6B66D6923F}"/>
                      </a:ext>
                    </a:extLst>
                  </p:cNvPr>
                  <p:cNvCxnSpPr/>
                  <p:nvPr/>
                </p:nvCxnSpPr>
                <p:spPr>
                  <a:xfrm>
                    <a:off x="471449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3" name="직선 연결선 262">
                    <a:extLst>
                      <a:ext uri="{FF2B5EF4-FFF2-40B4-BE49-F238E27FC236}">
                        <a16:creationId xmlns:a16="http://schemas.microsoft.com/office/drawing/2014/main" id="{C0D821CF-D1B9-4CDB-9B0A-1C442490705C}"/>
                      </a:ext>
                    </a:extLst>
                  </p:cNvPr>
                  <p:cNvCxnSpPr/>
                  <p:nvPr/>
                </p:nvCxnSpPr>
                <p:spPr>
                  <a:xfrm>
                    <a:off x="496595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4" name="직선 연결선 263">
                    <a:extLst>
                      <a:ext uri="{FF2B5EF4-FFF2-40B4-BE49-F238E27FC236}">
                        <a16:creationId xmlns:a16="http://schemas.microsoft.com/office/drawing/2014/main" id="{DCE11AF6-F1A7-49A4-9A94-A4DA932046A8}"/>
                      </a:ext>
                    </a:extLst>
                  </p:cNvPr>
                  <p:cNvCxnSpPr/>
                  <p:nvPr/>
                </p:nvCxnSpPr>
                <p:spPr>
                  <a:xfrm>
                    <a:off x="521741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5" name="직선 연결선 264">
                    <a:extLst>
                      <a:ext uri="{FF2B5EF4-FFF2-40B4-BE49-F238E27FC236}">
                        <a16:creationId xmlns:a16="http://schemas.microsoft.com/office/drawing/2014/main" id="{A832083A-873D-47E0-832E-075A1A50ECF8}"/>
                      </a:ext>
                    </a:extLst>
                  </p:cNvPr>
                  <p:cNvCxnSpPr/>
                  <p:nvPr/>
                </p:nvCxnSpPr>
                <p:spPr>
                  <a:xfrm>
                    <a:off x="546887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6" name="직선 연결선 265">
                    <a:extLst>
                      <a:ext uri="{FF2B5EF4-FFF2-40B4-BE49-F238E27FC236}">
                        <a16:creationId xmlns:a16="http://schemas.microsoft.com/office/drawing/2014/main" id="{8D31832D-AE80-40B1-8194-4B293AA317FB}"/>
                      </a:ext>
                    </a:extLst>
                  </p:cNvPr>
                  <p:cNvCxnSpPr/>
                  <p:nvPr/>
                </p:nvCxnSpPr>
                <p:spPr>
                  <a:xfrm>
                    <a:off x="572033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7" name="직선 연결선 266">
                    <a:extLst>
                      <a:ext uri="{FF2B5EF4-FFF2-40B4-BE49-F238E27FC236}">
                        <a16:creationId xmlns:a16="http://schemas.microsoft.com/office/drawing/2014/main" id="{E579214F-9295-48BE-9AC2-E6390558F5CA}"/>
                      </a:ext>
                    </a:extLst>
                  </p:cNvPr>
                  <p:cNvCxnSpPr/>
                  <p:nvPr/>
                </p:nvCxnSpPr>
                <p:spPr>
                  <a:xfrm>
                    <a:off x="597179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8" name="직선 연결선 267">
                    <a:extLst>
                      <a:ext uri="{FF2B5EF4-FFF2-40B4-BE49-F238E27FC236}">
                        <a16:creationId xmlns:a16="http://schemas.microsoft.com/office/drawing/2014/main" id="{47B9DF7E-A293-46AD-86AA-00BBB973E972}"/>
                      </a:ext>
                    </a:extLst>
                  </p:cNvPr>
                  <p:cNvCxnSpPr/>
                  <p:nvPr/>
                </p:nvCxnSpPr>
                <p:spPr>
                  <a:xfrm>
                    <a:off x="622325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9" name="직선 연결선 268">
                    <a:extLst>
                      <a:ext uri="{FF2B5EF4-FFF2-40B4-BE49-F238E27FC236}">
                        <a16:creationId xmlns:a16="http://schemas.microsoft.com/office/drawing/2014/main" id="{3BCB2026-03C2-4F52-B671-F803C2BDFDFC}"/>
                      </a:ext>
                    </a:extLst>
                  </p:cNvPr>
                  <p:cNvCxnSpPr/>
                  <p:nvPr/>
                </p:nvCxnSpPr>
                <p:spPr>
                  <a:xfrm>
                    <a:off x="647471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0" name="직선 연결선 269">
                    <a:extLst>
                      <a:ext uri="{FF2B5EF4-FFF2-40B4-BE49-F238E27FC236}">
                        <a16:creationId xmlns:a16="http://schemas.microsoft.com/office/drawing/2014/main" id="{D6FAC7AE-0A1E-4090-A299-D0AC65064550}"/>
                      </a:ext>
                    </a:extLst>
                  </p:cNvPr>
                  <p:cNvCxnSpPr/>
                  <p:nvPr/>
                </p:nvCxnSpPr>
                <p:spPr>
                  <a:xfrm>
                    <a:off x="672617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1" name="직선 연결선 270">
                    <a:extLst>
                      <a:ext uri="{FF2B5EF4-FFF2-40B4-BE49-F238E27FC236}">
                        <a16:creationId xmlns:a16="http://schemas.microsoft.com/office/drawing/2014/main" id="{D8B5F471-BAD2-4B83-A906-4408436FDA05}"/>
                      </a:ext>
                    </a:extLst>
                  </p:cNvPr>
                  <p:cNvCxnSpPr/>
                  <p:nvPr/>
                </p:nvCxnSpPr>
                <p:spPr>
                  <a:xfrm>
                    <a:off x="697763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2" name="직선 연결선 271">
                    <a:extLst>
                      <a:ext uri="{FF2B5EF4-FFF2-40B4-BE49-F238E27FC236}">
                        <a16:creationId xmlns:a16="http://schemas.microsoft.com/office/drawing/2014/main" id="{864B53CB-4AE5-443A-9B30-5F2B0938A404}"/>
                      </a:ext>
                    </a:extLst>
                  </p:cNvPr>
                  <p:cNvCxnSpPr/>
                  <p:nvPr/>
                </p:nvCxnSpPr>
                <p:spPr>
                  <a:xfrm>
                    <a:off x="722909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3" name="직선 연결선 272">
                    <a:extLst>
                      <a:ext uri="{FF2B5EF4-FFF2-40B4-BE49-F238E27FC236}">
                        <a16:creationId xmlns:a16="http://schemas.microsoft.com/office/drawing/2014/main" id="{AE519181-9C46-43E4-B9CD-DDDD96F9C079}"/>
                      </a:ext>
                    </a:extLst>
                  </p:cNvPr>
                  <p:cNvCxnSpPr/>
                  <p:nvPr/>
                </p:nvCxnSpPr>
                <p:spPr>
                  <a:xfrm>
                    <a:off x="748055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31" name="TextBox 230">
                  <a:extLst>
                    <a:ext uri="{FF2B5EF4-FFF2-40B4-BE49-F238E27FC236}">
                      <a16:creationId xmlns:a16="http://schemas.microsoft.com/office/drawing/2014/main" id="{BCFBE7BF-D938-4320-9BF3-32F1158337A9}"/>
                    </a:ext>
                  </a:extLst>
                </p:cNvPr>
                <p:cNvSpPr txBox="1"/>
                <p:nvPr/>
              </p:nvSpPr>
              <p:spPr>
                <a:xfrm>
                  <a:off x="3023306" y="4977772"/>
                  <a:ext cx="163506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rg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371A4068-4674-4DFF-9609-C2D00BF3AA25}"/>
                    </a:ext>
                  </a:extLst>
                </p:cNvPr>
                <p:cNvSpPr txBox="1"/>
                <p:nvPr/>
              </p:nvSpPr>
              <p:spPr>
                <a:xfrm>
                  <a:off x="3274050" y="4977772"/>
                  <a:ext cx="163506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rg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33" name="TextBox 232">
                  <a:extLst>
                    <a:ext uri="{FF2B5EF4-FFF2-40B4-BE49-F238E27FC236}">
                      <a16:creationId xmlns:a16="http://schemas.microsoft.com/office/drawing/2014/main" id="{F22D21EA-E7FA-4CEF-AABE-A26D22998C95}"/>
                    </a:ext>
                  </a:extLst>
                </p:cNvPr>
                <p:cNvSpPr txBox="1"/>
                <p:nvPr/>
              </p:nvSpPr>
              <p:spPr>
                <a:xfrm>
                  <a:off x="3524794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la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34" name="TextBox 233">
                  <a:extLst>
                    <a:ext uri="{FF2B5EF4-FFF2-40B4-BE49-F238E27FC236}">
                      <a16:creationId xmlns:a16="http://schemas.microsoft.com/office/drawing/2014/main" id="{FD21AB8E-E12D-4573-9EDA-D45DF1CA6B5C}"/>
                    </a:ext>
                  </a:extLst>
                </p:cNvPr>
                <p:cNvSpPr txBox="1"/>
                <p:nvPr/>
              </p:nvSpPr>
              <p:spPr>
                <a:xfrm>
                  <a:off x="3775539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lu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35" name="TextBox 234">
                  <a:extLst>
                    <a:ext uri="{FF2B5EF4-FFF2-40B4-BE49-F238E27FC236}">
                      <a16:creationId xmlns:a16="http://schemas.microsoft.com/office/drawing/2014/main" id="{C997C0A6-CF18-4CB9-A457-F0EBFCCB445F}"/>
                    </a:ext>
                  </a:extLst>
                </p:cNvPr>
                <p:cNvSpPr txBox="1"/>
                <p:nvPr/>
              </p:nvSpPr>
              <p:spPr>
                <a:xfrm>
                  <a:off x="4026284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lu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36" name="TextBox 235">
                  <a:extLst>
                    <a:ext uri="{FF2B5EF4-FFF2-40B4-BE49-F238E27FC236}">
                      <a16:creationId xmlns:a16="http://schemas.microsoft.com/office/drawing/2014/main" id="{43C3E0E2-5376-41EE-9A37-E34E04ECEC2C}"/>
                    </a:ext>
                  </a:extLst>
                </p:cNvPr>
                <p:cNvSpPr txBox="1"/>
                <p:nvPr/>
              </p:nvSpPr>
              <p:spPr>
                <a:xfrm>
                  <a:off x="4277029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Ile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37" name="TextBox 236">
                  <a:extLst>
                    <a:ext uri="{FF2B5EF4-FFF2-40B4-BE49-F238E27FC236}">
                      <a16:creationId xmlns:a16="http://schemas.microsoft.com/office/drawing/2014/main" id="{99D8B7E0-8E98-4E69-BE3C-73625222001F}"/>
                    </a:ext>
                  </a:extLst>
                </p:cNvPr>
                <p:cNvSpPr txBox="1"/>
                <p:nvPr/>
              </p:nvSpPr>
              <p:spPr>
                <a:xfrm>
                  <a:off x="4527774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hr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38" name="TextBox 237">
                  <a:extLst>
                    <a:ext uri="{FF2B5EF4-FFF2-40B4-BE49-F238E27FC236}">
                      <a16:creationId xmlns:a16="http://schemas.microsoft.com/office/drawing/2014/main" id="{66EEAD0A-B33A-44CF-B903-A86311EBAFEB}"/>
                    </a:ext>
                  </a:extLst>
                </p:cNvPr>
                <p:cNvSpPr txBox="1"/>
                <p:nvPr/>
              </p:nvSpPr>
              <p:spPr>
                <a:xfrm>
                  <a:off x="4778510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Ile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39" name="TextBox 238">
                  <a:extLst>
                    <a:ext uri="{FF2B5EF4-FFF2-40B4-BE49-F238E27FC236}">
                      <a16:creationId xmlns:a16="http://schemas.microsoft.com/office/drawing/2014/main" id="{C654B57F-0A4B-4FEF-A052-68E493ABB1E0}"/>
                    </a:ext>
                  </a:extLst>
                </p:cNvPr>
                <p:cNvSpPr txBox="1"/>
                <p:nvPr/>
              </p:nvSpPr>
              <p:spPr>
                <a:xfrm>
                  <a:off x="2271071" y="4977772"/>
                  <a:ext cx="163506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ly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40" name="TextBox 239">
                  <a:extLst>
                    <a:ext uri="{FF2B5EF4-FFF2-40B4-BE49-F238E27FC236}">
                      <a16:creationId xmlns:a16="http://schemas.microsoft.com/office/drawing/2014/main" id="{FF9E7474-7BDB-4B07-87AE-14C301DB21B2}"/>
                    </a:ext>
                  </a:extLst>
                </p:cNvPr>
                <p:cNvSpPr txBox="1"/>
                <p:nvPr/>
              </p:nvSpPr>
              <p:spPr>
                <a:xfrm>
                  <a:off x="2521816" y="4977772"/>
                  <a:ext cx="163506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hr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41" name="TextBox 240">
                  <a:extLst>
                    <a:ext uri="{FF2B5EF4-FFF2-40B4-BE49-F238E27FC236}">
                      <a16:creationId xmlns:a16="http://schemas.microsoft.com/office/drawing/2014/main" id="{73C1CB76-91DE-44EC-9594-F05FF8B43FAD}"/>
                    </a:ext>
                  </a:extLst>
                </p:cNvPr>
                <p:cNvSpPr txBox="1"/>
                <p:nvPr/>
              </p:nvSpPr>
              <p:spPr>
                <a:xfrm>
                  <a:off x="2772561" y="4977772"/>
                  <a:ext cx="163506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Pro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42" name="TextBox 241">
                  <a:extLst>
                    <a:ext uri="{FF2B5EF4-FFF2-40B4-BE49-F238E27FC236}">
                      <a16:creationId xmlns:a16="http://schemas.microsoft.com/office/drawing/2014/main" id="{9041C7C1-DF0C-4BEE-92E8-AF039739D2B4}"/>
                    </a:ext>
                  </a:extLst>
                </p:cNvPr>
                <p:cNvSpPr txBox="1"/>
                <p:nvPr/>
              </p:nvSpPr>
              <p:spPr>
                <a:xfrm>
                  <a:off x="6025157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Leu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43" name="TextBox 242">
                  <a:extLst>
                    <a:ext uri="{FF2B5EF4-FFF2-40B4-BE49-F238E27FC236}">
                      <a16:creationId xmlns:a16="http://schemas.microsoft.com/office/drawing/2014/main" id="{72429CB6-A5C8-4820-96E1-CA0EB05D590D}"/>
                    </a:ext>
                  </a:extLst>
                </p:cNvPr>
                <p:cNvSpPr txBox="1"/>
                <p:nvPr/>
              </p:nvSpPr>
              <p:spPr>
                <a:xfrm>
                  <a:off x="6275902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Leu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44" name="TextBox 243">
                  <a:extLst>
                    <a:ext uri="{FF2B5EF4-FFF2-40B4-BE49-F238E27FC236}">
                      <a16:creationId xmlns:a16="http://schemas.microsoft.com/office/drawing/2014/main" id="{4940CC72-DCD6-4686-BD95-2A814F4E2722}"/>
                    </a:ext>
                  </a:extLst>
                </p:cNvPr>
                <p:cNvSpPr txBox="1"/>
                <p:nvPr/>
              </p:nvSpPr>
              <p:spPr>
                <a:xfrm>
                  <a:off x="6526647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Ile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46" name="TextBox 245">
                  <a:extLst>
                    <a:ext uri="{FF2B5EF4-FFF2-40B4-BE49-F238E27FC236}">
                      <a16:creationId xmlns:a16="http://schemas.microsoft.com/office/drawing/2014/main" id="{8303FA70-C3AA-4C09-9EB3-9FF2E046EBF4}"/>
                    </a:ext>
                  </a:extLst>
                </p:cNvPr>
                <p:cNvSpPr txBox="1"/>
                <p:nvPr/>
              </p:nvSpPr>
              <p:spPr>
                <a:xfrm>
                  <a:off x="5022177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Lys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47" name="TextBox 246">
                  <a:extLst>
                    <a:ext uri="{FF2B5EF4-FFF2-40B4-BE49-F238E27FC236}">
                      <a16:creationId xmlns:a16="http://schemas.microsoft.com/office/drawing/2014/main" id="{BA412657-C5B3-4618-AAE6-B0C0BB5586AF}"/>
                    </a:ext>
                  </a:extLst>
                </p:cNvPr>
                <p:cNvSpPr txBox="1"/>
                <p:nvPr/>
              </p:nvSpPr>
              <p:spPr>
                <a:xfrm>
                  <a:off x="5272922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sp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48" name="TextBox 247">
                  <a:extLst>
                    <a:ext uri="{FF2B5EF4-FFF2-40B4-BE49-F238E27FC236}">
                      <a16:creationId xmlns:a16="http://schemas.microsoft.com/office/drawing/2014/main" id="{0190883C-361C-4E71-A900-B17388301B2F}"/>
                    </a:ext>
                  </a:extLst>
                </p:cNvPr>
                <p:cNvSpPr txBox="1"/>
                <p:nvPr/>
              </p:nvSpPr>
              <p:spPr>
                <a:xfrm>
                  <a:off x="5523667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rg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49" name="TextBox 248">
                  <a:extLst>
                    <a:ext uri="{FF2B5EF4-FFF2-40B4-BE49-F238E27FC236}">
                      <a16:creationId xmlns:a16="http://schemas.microsoft.com/office/drawing/2014/main" id="{9C3700E6-D077-4D4C-B13D-D678C658C72D}"/>
                    </a:ext>
                  </a:extLst>
                </p:cNvPr>
                <p:cNvSpPr txBox="1"/>
                <p:nvPr/>
              </p:nvSpPr>
              <p:spPr>
                <a:xfrm>
                  <a:off x="5774412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Leu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50" name="TextBox 249">
                  <a:extLst>
                    <a:ext uri="{FF2B5EF4-FFF2-40B4-BE49-F238E27FC236}">
                      <a16:creationId xmlns:a16="http://schemas.microsoft.com/office/drawing/2014/main" id="{F897CDB7-E5F0-4E1D-9D12-9E4B2F306A9C}"/>
                    </a:ext>
                  </a:extLst>
                </p:cNvPr>
                <p:cNvSpPr txBox="1"/>
                <p:nvPr/>
              </p:nvSpPr>
              <p:spPr>
                <a:xfrm>
                  <a:off x="7021049" y="4899886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305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51" name="TextBox 250">
                  <a:extLst>
                    <a:ext uri="{FF2B5EF4-FFF2-40B4-BE49-F238E27FC236}">
                      <a16:creationId xmlns:a16="http://schemas.microsoft.com/office/drawing/2014/main" id="{CA841909-581E-45F3-A3A6-548CCCA950CB}"/>
                    </a:ext>
                  </a:extLst>
                </p:cNvPr>
                <p:cNvSpPr txBox="1"/>
                <p:nvPr/>
              </p:nvSpPr>
              <p:spPr>
                <a:xfrm>
                  <a:off x="2274624" y="4897417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287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</p:grpSp>
          <p:sp>
            <p:nvSpPr>
              <p:cNvPr id="274" name="TextBox 273">
                <a:extLst>
                  <a:ext uri="{FF2B5EF4-FFF2-40B4-BE49-F238E27FC236}">
                    <a16:creationId xmlns:a16="http://schemas.microsoft.com/office/drawing/2014/main" id="{F64C6611-9183-4256-8229-677777C5D25F}"/>
                  </a:ext>
                </a:extLst>
              </p:cNvPr>
              <p:cNvSpPr txBox="1"/>
              <p:nvPr/>
            </p:nvSpPr>
            <p:spPr>
              <a:xfrm>
                <a:off x="7034369" y="3338608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sn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275" name="TextBox 274">
                <a:extLst>
                  <a:ext uri="{FF2B5EF4-FFF2-40B4-BE49-F238E27FC236}">
                    <a16:creationId xmlns:a16="http://schemas.microsoft.com/office/drawing/2014/main" id="{CFB081E5-CCE5-4B4F-8929-CF6D529732EB}"/>
                  </a:ext>
                </a:extLst>
              </p:cNvPr>
              <p:cNvSpPr txBox="1"/>
              <p:nvPr/>
            </p:nvSpPr>
            <p:spPr>
              <a:xfrm>
                <a:off x="7257433" y="3337871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hr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</p:grpSp>
      </p:grpSp>
      <p:grpSp>
        <p:nvGrpSpPr>
          <p:cNvPr id="9" name="그룹 8">
            <a:extLst>
              <a:ext uri="{FF2B5EF4-FFF2-40B4-BE49-F238E27FC236}">
                <a16:creationId xmlns:a16="http://schemas.microsoft.com/office/drawing/2014/main" id="{E9778E4B-4ECC-4042-9DA6-7423AA4DCDA9}"/>
              </a:ext>
            </a:extLst>
          </p:cNvPr>
          <p:cNvGrpSpPr/>
          <p:nvPr/>
        </p:nvGrpSpPr>
        <p:grpSpPr>
          <a:xfrm>
            <a:off x="2668838" y="5677048"/>
            <a:ext cx="5246164" cy="439186"/>
            <a:chOff x="2668838" y="5677048"/>
            <a:chExt cx="5246164" cy="439186"/>
          </a:xfrm>
        </p:grpSpPr>
        <p:sp>
          <p:nvSpPr>
            <p:cNvPr id="327" name="직사각형 326">
              <a:extLst>
                <a:ext uri="{FF2B5EF4-FFF2-40B4-BE49-F238E27FC236}">
                  <a16:creationId xmlns:a16="http://schemas.microsoft.com/office/drawing/2014/main" id="{0D72FEBC-52B3-4C59-9D84-FDCB48102AE0}"/>
                </a:ext>
              </a:extLst>
            </p:cNvPr>
            <p:cNvSpPr/>
            <p:nvPr/>
          </p:nvSpPr>
          <p:spPr>
            <a:xfrm>
              <a:off x="3349859" y="5927254"/>
              <a:ext cx="417279" cy="122492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28" name="직사각형 227">
              <a:extLst>
                <a:ext uri="{FF2B5EF4-FFF2-40B4-BE49-F238E27FC236}">
                  <a16:creationId xmlns:a16="http://schemas.microsoft.com/office/drawing/2014/main" id="{59CB52F8-12C0-4441-8B91-18D2FD44DFB1}"/>
                </a:ext>
              </a:extLst>
            </p:cNvPr>
            <p:cNvSpPr/>
            <p:nvPr/>
          </p:nvSpPr>
          <p:spPr>
            <a:xfrm>
              <a:off x="2668838" y="5854624"/>
              <a:ext cx="5246164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11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GTACCCCGCGCCGCGACGAAGAGATTACGATTAAAGACCGGCTATTACTGATCAACACC</a:t>
              </a:r>
            </a:p>
          </p:txBody>
        </p:sp>
        <p:grpSp>
          <p:nvGrpSpPr>
            <p:cNvPr id="277" name="그룹 276">
              <a:extLst>
                <a:ext uri="{FF2B5EF4-FFF2-40B4-BE49-F238E27FC236}">
                  <a16:creationId xmlns:a16="http://schemas.microsoft.com/office/drawing/2014/main" id="{7281BFCA-FD70-40F1-AB91-07FF01901B99}"/>
                </a:ext>
              </a:extLst>
            </p:cNvPr>
            <p:cNvGrpSpPr/>
            <p:nvPr/>
          </p:nvGrpSpPr>
          <p:grpSpPr>
            <a:xfrm>
              <a:off x="2762016" y="5677048"/>
              <a:ext cx="5035638" cy="237852"/>
              <a:chOff x="2452793" y="3253063"/>
              <a:chExt cx="5035638" cy="237852"/>
            </a:xfrm>
          </p:grpSpPr>
          <p:grpSp>
            <p:nvGrpSpPr>
              <p:cNvPr id="278" name="그룹 277">
                <a:extLst>
                  <a:ext uri="{FF2B5EF4-FFF2-40B4-BE49-F238E27FC236}">
                    <a16:creationId xmlns:a16="http://schemas.microsoft.com/office/drawing/2014/main" id="{AC05AB18-7BBE-43CE-8034-11943ED680A0}"/>
                  </a:ext>
                </a:extLst>
              </p:cNvPr>
              <p:cNvGrpSpPr/>
              <p:nvPr/>
            </p:nvGrpSpPr>
            <p:grpSpPr>
              <a:xfrm>
                <a:off x="2452793" y="3253063"/>
                <a:ext cx="5035638" cy="237852"/>
                <a:chOff x="2216409" y="4897417"/>
                <a:chExt cx="5035638" cy="237852"/>
              </a:xfrm>
            </p:grpSpPr>
            <p:grpSp>
              <p:nvGrpSpPr>
                <p:cNvPr id="281" name="그룹 280">
                  <a:extLst>
                    <a:ext uri="{FF2B5EF4-FFF2-40B4-BE49-F238E27FC236}">
                      <a16:creationId xmlns:a16="http://schemas.microsoft.com/office/drawing/2014/main" id="{722D23DA-2FB1-48C9-8386-8650986E6C2B}"/>
                    </a:ext>
                  </a:extLst>
                </p:cNvPr>
                <p:cNvGrpSpPr/>
                <p:nvPr/>
              </p:nvGrpSpPr>
              <p:grpSpPr>
                <a:xfrm>
                  <a:off x="2216409" y="5107967"/>
                  <a:ext cx="5035638" cy="27302"/>
                  <a:chOff x="2446250" y="3316314"/>
                  <a:chExt cx="5035638" cy="27302"/>
                </a:xfrm>
              </p:grpSpPr>
              <p:cxnSp>
                <p:nvCxnSpPr>
                  <p:cNvPr id="302" name="직선 연결선 301">
                    <a:extLst>
                      <a:ext uri="{FF2B5EF4-FFF2-40B4-BE49-F238E27FC236}">
                        <a16:creationId xmlns:a16="http://schemas.microsoft.com/office/drawing/2014/main" id="{16B53C01-5FEE-4F4F-AC5C-DC10B08F7E8A}"/>
                      </a:ext>
                    </a:extLst>
                  </p:cNvPr>
                  <p:cNvCxnSpPr/>
                  <p:nvPr/>
                </p:nvCxnSpPr>
                <p:spPr>
                  <a:xfrm>
                    <a:off x="2446250" y="3316314"/>
                    <a:ext cx="5035638" cy="0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3" name="직선 연결선 302">
                    <a:extLst>
                      <a:ext uri="{FF2B5EF4-FFF2-40B4-BE49-F238E27FC236}">
                        <a16:creationId xmlns:a16="http://schemas.microsoft.com/office/drawing/2014/main" id="{C55136DC-463D-4F72-9EA8-9BAEB0677671}"/>
                      </a:ext>
                    </a:extLst>
                  </p:cNvPr>
                  <p:cNvCxnSpPr/>
                  <p:nvPr/>
                </p:nvCxnSpPr>
                <p:spPr>
                  <a:xfrm>
                    <a:off x="245135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4" name="직선 연결선 303">
                    <a:extLst>
                      <a:ext uri="{FF2B5EF4-FFF2-40B4-BE49-F238E27FC236}">
                        <a16:creationId xmlns:a16="http://schemas.microsoft.com/office/drawing/2014/main" id="{DFA17A6F-A7A9-4A12-8470-B789B2A6C198}"/>
                      </a:ext>
                    </a:extLst>
                  </p:cNvPr>
                  <p:cNvCxnSpPr/>
                  <p:nvPr/>
                </p:nvCxnSpPr>
                <p:spPr>
                  <a:xfrm>
                    <a:off x="270281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5" name="직선 연결선 304">
                    <a:extLst>
                      <a:ext uri="{FF2B5EF4-FFF2-40B4-BE49-F238E27FC236}">
                        <a16:creationId xmlns:a16="http://schemas.microsoft.com/office/drawing/2014/main" id="{F9A151C5-B3CD-4A22-AA60-27F9B6A64A1D}"/>
                      </a:ext>
                    </a:extLst>
                  </p:cNvPr>
                  <p:cNvCxnSpPr/>
                  <p:nvPr/>
                </p:nvCxnSpPr>
                <p:spPr>
                  <a:xfrm>
                    <a:off x="295427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6" name="직선 연결선 305">
                    <a:extLst>
                      <a:ext uri="{FF2B5EF4-FFF2-40B4-BE49-F238E27FC236}">
                        <a16:creationId xmlns:a16="http://schemas.microsoft.com/office/drawing/2014/main" id="{20637540-D788-441A-A6C8-9AC0E5EC0515}"/>
                      </a:ext>
                    </a:extLst>
                  </p:cNvPr>
                  <p:cNvCxnSpPr/>
                  <p:nvPr/>
                </p:nvCxnSpPr>
                <p:spPr>
                  <a:xfrm>
                    <a:off x="320573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7" name="직선 연결선 306">
                    <a:extLst>
                      <a:ext uri="{FF2B5EF4-FFF2-40B4-BE49-F238E27FC236}">
                        <a16:creationId xmlns:a16="http://schemas.microsoft.com/office/drawing/2014/main" id="{F022ACA2-4DD5-4842-B586-4C2BDA3E4A7F}"/>
                      </a:ext>
                    </a:extLst>
                  </p:cNvPr>
                  <p:cNvCxnSpPr/>
                  <p:nvPr/>
                </p:nvCxnSpPr>
                <p:spPr>
                  <a:xfrm>
                    <a:off x="345719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8" name="직선 연결선 307">
                    <a:extLst>
                      <a:ext uri="{FF2B5EF4-FFF2-40B4-BE49-F238E27FC236}">
                        <a16:creationId xmlns:a16="http://schemas.microsoft.com/office/drawing/2014/main" id="{8A5AF5A1-CC1D-4DF0-9C08-63E1A5C7D7C8}"/>
                      </a:ext>
                    </a:extLst>
                  </p:cNvPr>
                  <p:cNvCxnSpPr/>
                  <p:nvPr/>
                </p:nvCxnSpPr>
                <p:spPr>
                  <a:xfrm>
                    <a:off x="370865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9" name="직선 연결선 308">
                    <a:extLst>
                      <a:ext uri="{FF2B5EF4-FFF2-40B4-BE49-F238E27FC236}">
                        <a16:creationId xmlns:a16="http://schemas.microsoft.com/office/drawing/2014/main" id="{66FC5B9A-92D6-4CF9-B5F3-0F7CECBD3EEA}"/>
                      </a:ext>
                    </a:extLst>
                  </p:cNvPr>
                  <p:cNvCxnSpPr/>
                  <p:nvPr/>
                </p:nvCxnSpPr>
                <p:spPr>
                  <a:xfrm>
                    <a:off x="396011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0" name="직선 연결선 309">
                    <a:extLst>
                      <a:ext uri="{FF2B5EF4-FFF2-40B4-BE49-F238E27FC236}">
                        <a16:creationId xmlns:a16="http://schemas.microsoft.com/office/drawing/2014/main" id="{A966B866-69D4-4871-B6A8-22DF4DC751FC}"/>
                      </a:ext>
                    </a:extLst>
                  </p:cNvPr>
                  <p:cNvCxnSpPr/>
                  <p:nvPr/>
                </p:nvCxnSpPr>
                <p:spPr>
                  <a:xfrm>
                    <a:off x="421157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1" name="직선 연결선 310">
                    <a:extLst>
                      <a:ext uri="{FF2B5EF4-FFF2-40B4-BE49-F238E27FC236}">
                        <a16:creationId xmlns:a16="http://schemas.microsoft.com/office/drawing/2014/main" id="{6A986BA1-51D6-42E3-9C68-DC22684729CA}"/>
                      </a:ext>
                    </a:extLst>
                  </p:cNvPr>
                  <p:cNvCxnSpPr/>
                  <p:nvPr/>
                </p:nvCxnSpPr>
                <p:spPr>
                  <a:xfrm>
                    <a:off x="446303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2" name="직선 연결선 311">
                    <a:extLst>
                      <a:ext uri="{FF2B5EF4-FFF2-40B4-BE49-F238E27FC236}">
                        <a16:creationId xmlns:a16="http://schemas.microsoft.com/office/drawing/2014/main" id="{E331E5AF-773C-4E3C-B937-568E4DAED175}"/>
                      </a:ext>
                    </a:extLst>
                  </p:cNvPr>
                  <p:cNvCxnSpPr/>
                  <p:nvPr/>
                </p:nvCxnSpPr>
                <p:spPr>
                  <a:xfrm>
                    <a:off x="471449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3" name="직선 연결선 312">
                    <a:extLst>
                      <a:ext uri="{FF2B5EF4-FFF2-40B4-BE49-F238E27FC236}">
                        <a16:creationId xmlns:a16="http://schemas.microsoft.com/office/drawing/2014/main" id="{6A3A97F5-577D-42F8-BC4C-72008D09AA86}"/>
                      </a:ext>
                    </a:extLst>
                  </p:cNvPr>
                  <p:cNvCxnSpPr/>
                  <p:nvPr/>
                </p:nvCxnSpPr>
                <p:spPr>
                  <a:xfrm>
                    <a:off x="496595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4" name="직선 연결선 313">
                    <a:extLst>
                      <a:ext uri="{FF2B5EF4-FFF2-40B4-BE49-F238E27FC236}">
                        <a16:creationId xmlns:a16="http://schemas.microsoft.com/office/drawing/2014/main" id="{89F5447D-BD4D-4256-9BB0-CA675C70B0D9}"/>
                      </a:ext>
                    </a:extLst>
                  </p:cNvPr>
                  <p:cNvCxnSpPr/>
                  <p:nvPr/>
                </p:nvCxnSpPr>
                <p:spPr>
                  <a:xfrm>
                    <a:off x="521741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5" name="직선 연결선 314">
                    <a:extLst>
                      <a:ext uri="{FF2B5EF4-FFF2-40B4-BE49-F238E27FC236}">
                        <a16:creationId xmlns:a16="http://schemas.microsoft.com/office/drawing/2014/main" id="{FA5ADC85-EF64-4459-8BC7-DC773A4E9396}"/>
                      </a:ext>
                    </a:extLst>
                  </p:cNvPr>
                  <p:cNvCxnSpPr/>
                  <p:nvPr/>
                </p:nvCxnSpPr>
                <p:spPr>
                  <a:xfrm>
                    <a:off x="546887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6" name="직선 연결선 315">
                    <a:extLst>
                      <a:ext uri="{FF2B5EF4-FFF2-40B4-BE49-F238E27FC236}">
                        <a16:creationId xmlns:a16="http://schemas.microsoft.com/office/drawing/2014/main" id="{AD96E391-42BA-4E63-ABC6-28B43DD4643F}"/>
                      </a:ext>
                    </a:extLst>
                  </p:cNvPr>
                  <p:cNvCxnSpPr/>
                  <p:nvPr/>
                </p:nvCxnSpPr>
                <p:spPr>
                  <a:xfrm>
                    <a:off x="572033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7" name="직선 연결선 316">
                    <a:extLst>
                      <a:ext uri="{FF2B5EF4-FFF2-40B4-BE49-F238E27FC236}">
                        <a16:creationId xmlns:a16="http://schemas.microsoft.com/office/drawing/2014/main" id="{48DB6045-50E0-4805-96A5-72011F591D24}"/>
                      </a:ext>
                    </a:extLst>
                  </p:cNvPr>
                  <p:cNvCxnSpPr/>
                  <p:nvPr/>
                </p:nvCxnSpPr>
                <p:spPr>
                  <a:xfrm>
                    <a:off x="597179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8" name="직선 연결선 317">
                    <a:extLst>
                      <a:ext uri="{FF2B5EF4-FFF2-40B4-BE49-F238E27FC236}">
                        <a16:creationId xmlns:a16="http://schemas.microsoft.com/office/drawing/2014/main" id="{5B7422F3-76CB-4009-90A6-E05ADC67ED6D}"/>
                      </a:ext>
                    </a:extLst>
                  </p:cNvPr>
                  <p:cNvCxnSpPr/>
                  <p:nvPr/>
                </p:nvCxnSpPr>
                <p:spPr>
                  <a:xfrm>
                    <a:off x="622325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9" name="직선 연결선 318">
                    <a:extLst>
                      <a:ext uri="{FF2B5EF4-FFF2-40B4-BE49-F238E27FC236}">
                        <a16:creationId xmlns:a16="http://schemas.microsoft.com/office/drawing/2014/main" id="{6A76D484-307A-4CA8-82EC-E0809B76FD97}"/>
                      </a:ext>
                    </a:extLst>
                  </p:cNvPr>
                  <p:cNvCxnSpPr/>
                  <p:nvPr/>
                </p:nvCxnSpPr>
                <p:spPr>
                  <a:xfrm>
                    <a:off x="647471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0" name="직선 연결선 319">
                    <a:extLst>
                      <a:ext uri="{FF2B5EF4-FFF2-40B4-BE49-F238E27FC236}">
                        <a16:creationId xmlns:a16="http://schemas.microsoft.com/office/drawing/2014/main" id="{42EC8DE9-4964-4B84-A5AF-7E714688A2F6}"/>
                      </a:ext>
                    </a:extLst>
                  </p:cNvPr>
                  <p:cNvCxnSpPr/>
                  <p:nvPr/>
                </p:nvCxnSpPr>
                <p:spPr>
                  <a:xfrm>
                    <a:off x="672617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1" name="직선 연결선 320">
                    <a:extLst>
                      <a:ext uri="{FF2B5EF4-FFF2-40B4-BE49-F238E27FC236}">
                        <a16:creationId xmlns:a16="http://schemas.microsoft.com/office/drawing/2014/main" id="{BC276892-6384-47AE-B3B9-1D0431BF4F6C}"/>
                      </a:ext>
                    </a:extLst>
                  </p:cNvPr>
                  <p:cNvCxnSpPr/>
                  <p:nvPr/>
                </p:nvCxnSpPr>
                <p:spPr>
                  <a:xfrm>
                    <a:off x="697763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2" name="직선 연결선 321">
                    <a:extLst>
                      <a:ext uri="{FF2B5EF4-FFF2-40B4-BE49-F238E27FC236}">
                        <a16:creationId xmlns:a16="http://schemas.microsoft.com/office/drawing/2014/main" id="{C9BFFD3C-44A0-47B6-835B-1EBE87A62814}"/>
                      </a:ext>
                    </a:extLst>
                  </p:cNvPr>
                  <p:cNvCxnSpPr/>
                  <p:nvPr/>
                </p:nvCxnSpPr>
                <p:spPr>
                  <a:xfrm>
                    <a:off x="722909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3" name="직선 연결선 322">
                    <a:extLst>
                      <a:ext uri="{FF2B5EF4-FFF2-40B4-BE49-F238E27FC236}">
                        <a16:creationId xmlns:a16="http://schemas.microsoft.com/office/drawing/2014/main" id="{B85AA54F-8BB1-43A7-8EB3-A343A1F458F5}"/>
                      </a:ext>
                    </a:extLst>
                  </p:cNvPr>
                  <p:cNvCxnSpPr/>
                  <p:nvPr/>
                </p:nvCxnSpPr>
                <p:spPr>
                  <a:xfrm>
                    <a:off x="7480551" y="3316314"/>
                    <a:ext cx="0" cy="27302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82" name="TextBox 281">
                  <a:extLst>
                    <a:ext uri="{FF2B5EF4-FFF2-40B4-BE49-F238E27FC236}">
                      <a16:creationId xmlns:a16="http://schemas.microsoft.com/office/drawing/2014/main" id="{76E97F0D-7945-4D8C-B870-6D57E49B5B89}"/>
                    </a:ext>
                  </a:extLst>
                </p:cNvPr>
                <p:cNvSpPr txBox="1"/>
                <p:nvPr/>
              </p:nvSpPr>
              <p:spPr>
                <a:xfrm>
                  <a:off x="3023306" y="4977772"/>
                  <a:ext cx="163506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rg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83" name="TextBox 282">
                  <a:extLst>
                    <a:ext uri="{FF2B5EF4-FFF2-40B4-BE49-F238E27FC236}">
                      <a16:creationId xmlns:a16="http://schemas.microsoft.com/office/drawing/2014/main" id="{32BEF388-E39A-4E78-92C7-DC673CD95A38}"/>
                    </a:ext>
                  </a:extLst>
                </p:cNvPr>
                <p:cNvSpPr txBox="1"/>
                <p:nvPr/>
              </p:nvSpPr>
              <p:spPr>
                <a:xfrm>
                  <a:off x="3274050" y="4977772"/>
                  <a:ext cx="163506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rg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84" name="TextBox 283">
                  <a:extLst>
                    <a:ext uri="{FF2B5EF4-FFF2-40B4-BE49-F238E27FC236}">
                      <a16:creationId xmlns:a16="http://schemas.microsoft.com/office/drawing/2014/main" id="{30EFB51E-1ADD-4581-A4B1-36607641DDFE}"/>
                    </a:ext>
                  </a:extLst>
                </p:cNvPr>
                <p:cNvSpPr txBox="1"/>
                <p:nvPr/>
              </p:nvSpPr>
              <p:spPr>
                <a:xfrm>
                  <a:off x="3524794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sp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85" name="TextBox 284">
                  <a:extLst>
                    <a:ext uri="{FF2B5EF4-FFF2-40B4-BE49-F238E27FC236}">
                      <a16:creationId xmlns:a16="http://schemas.microsoft.com/office/drawing/2014/main" id="{118C544B-6DD2-424A-9F12-BAC7B18BB31C}"/>
                    </a:ext>
                  </a:extLst>
                </p:cNvPr>
                <p:cNvSpPr txBox="1"/>
                <p:nvPr/>
              </p:nvSpPr>
              <p:spPr>
                <a:xfrm>
                  <a:off x="3775539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lu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86" name="TextBox 285">
                  <a:extLst>
                    <a:ext uri="{FF2B5EF4-FFF2-40B4-BE49-F238E27FC236}">
                      <a16:creationId xmlns:a16="http://schemas.microsoft.com/office/drawing/2014/main" id="{FD83824C-C5FD-4E5B-907D-47AF641D2F14}"/>
                    </a:ext>
                  </a:extLst>
                </p:cNvPr>
                <p:cNvSpPr txBox="1"/>
                <p:nvPr/>
              </p:nvSpPr>
              <p:spPr>
                <a:xfrm>
                  <a:off x="4026284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lu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87" name="TextBox 286">
                  <a:extLst>
                    <a:ext uri="{FF2B5EF4-FFF2-40B4-BE49-F238E27FC236}">
                      <a16:creationId xmlns:a16="http://schemas.microsoft.com/office/drawing/2014/main" id="{DD0645CE-8224-46FF-97F5-68BB8BC6371A}"/>
                    </a:ext>
                  </a:extLst>
                </p:cNvPr>
                <p:cNvSpPr txBox="1"/>
                <p:nvPr/>
              </p:nvSpPr>
              <p:spPr>
                <a:xfrm>
                  <a:off x="4277029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Ile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88" name="TextBox 287">
                  <a:extLst>
                    <a:ext uri="{FF2B5EF4-FFF2-40B4-BE49-F238E27FC236}">
                      <a16:creationId xmlns:a16="http://schemas.microsoft.com/office/drawing/2014/main" id="{B849765B-267F-4277-8806-A4BA25388568}"/>
                    </a:ext>
                  </a:extLst>
                </p:cNvPr>
                <p:cNvSpPr txBox="1"/>
                <p:nvPr/>
              </p:nvSpPr>
              <p:spPr>
                <a:xfrm>
                  <a:off x="4527774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hr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89" name="TextBox 288">
                  <a:extLst>
                    <a:ext uri="{FF2B5EF4-FFF2-40B4-BE49-F238E27FC236}">
                      <a16:creationId xmlns:a16="http://schemas.microsoft.com/office/drawing/2014/main" id="{A6F1A1A1-63E5-4589-AF5B-C9446871F3B2}"/>
                    </a:ext>
                  </a:extLst>
                </p:cNvPr>
                <p:cNvSpPr txBox="1"/>
                <p:nvPr/>
              </p:nvSpPr>
              <p:spPr>
                <a:xfrm>
                  <a:off x="4778510" y="4977772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Ile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90" name="TextBox 289">
                  <a:extLst>
                    <a:ext uri="{FF2B5EF4-FFF2-40B4-BE49-F238E27FC236}">
                      <a16:creationId xmlns:a16="http://schemas.microsoft.com/office/drawing/2014/main" id="{C6D9DDE0-6FC6-4031-BA8D-B9A73470D7D1}"/>
                    </a:ext>
                  </a:extLst>
                </p:cNvPr>
                <p:cNvSpPr txBox="1"/>
                <p:nvPr/>
              </p:nvSpPr>
              <p:spPr>
                <a:xfrm>
                  <a:off x="2271071" y="4977772"/>
                  <a:ext cx="163506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ly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91" name="TextBox 290">
                  <a:extLst>
                    <a:ext uri="{FF2B5EF4-FFF2-40B4-BE49-F238E27FC236}">
                      <a16:creationId xmlns:a16="http://schemas.microsoft.com/office/drawing/2014/main" id="{0C49C5CE-E613-4C9F-A790-14AF80E7A85B}"/>
                    </a:ext>
                  </a:extLst>
                </p:cNvPr>
                <p:cNvSpPr txBox="1"/>
                <p:nvPr/>
              </p:nvSpPr>
              <p:spPr>
                <a:xfrm>
                  <a:off x="2521816" y="4977772"/>
                  <a:ext cx="163506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hr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92" name="TextBox 291">
                  <a:extLst>
                    <a:ext uri="{FF2B5EF4-FFF2-40B4-BE49-F238E27FC236}">
                      <a16:creationId xmlns:a16="http://schemas.microsoft.com/office/drawing/2014/main" id="{08CEF19C-E5C5-4E4A-B419-09C38EB4C836}"/>
                    </a:ext>
                  </a:extLst>
                </p:cNvPr>
                <p:cNvSpPr txBox="1"/>
                <p:nvPr/>
              </p:nvSpPr>
              <p:spPr>
                <a:xfrm>
                  <a:off x="2772561" y="4977772"/>
                  <a:ext cx="163506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Pro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93" name="TextBox 292">
                  <a:extLst>
                    <a:ext uri="{FF2B5EF4-FFF2-40B4-BE49-F238E27FC236}">
                      <a16:creationId xmlns:a16="http://schemas.microsoft.com/office/drawing/2014/main" id="{4DEB972C-B5F5-4F1E-ACFB-6536EC3546BB}"/>
                    </a:ext>
                  </a:extLst>
                </p:cNvPr>
                <p:cNvSpPr txBox="1"/>
                <p:nvPr/>
              </p:nvSpPr>
              <p:spPr>
                <a:xfrm>
                  <a:off x="6025157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Leu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94" name="TextBox 293">
                  <a:extLst>
                    <a:ext uri="{FF2B5EF4-FFF2-40B4-BE49-F238E27FC236}">
                      <a16:creationId xmlns:a16="http://schemas.microsoft.com/office/drawing/2014/main" id="{C8B711D4-F0AE-4C89-8898-020405AE09BD}"/>
                    </a:ext>
                  </a:extLst>
                </p:cNvPr>
                <p:cNvSpPr txBox="1"/>
                <p:nvPr/>
              </p:nvSpPr>
              <p:spPr>
                <a:xfrm>
                  <a:off x="6275902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Leu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95" name="TextBox 294">
                  <a:extLst>
                    <a:ext uri="{FF2B5EF4-FFF2-40B4-BE49-F238E27FC236}">
                      <a16:creationId xmlns:a16="http://schemas.microsoft.com/office/drawing/2014/main" id="{9E33E855-C304-447E-935A-DF3F61EFF5C5}"/>
                    </a:ext>
                  </a:extLst>
                </p:cNvPr>
                <p:cNvSpPr txBox="1"/>
                <p:nvPr/>
              </p:nvSpPr>
              <p:spPr>
                <a:xfrm>
                  <a:off x="6526647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Ile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96" name="TextBox 295">
                  <a:extLst>
                    <a:ext uri="{FF2B5EF4-FFF2-40B4-BE49-F238E27FC236}">
                      <a16:creationId xmlns:a16="http://schemas.microsoft.com/office/drawing/2014/main" id="{ED79502C-F7D4-4334-89B4-A236A65C96C3}"/>
                    </a:ext>
                  </a:extLst>
                </p:cNvPr>
                <p:cNvSpPr txBox="1"/>
                <p:nvPr/>
              </p:nvSpPr>
              <p:spPr>
                <a:xfrm>
                  <a:off x="5022177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Lys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97" name="TextBox 296">
                  <a:extLst>
                    <a:ext uri="{FF2B5EF4-FFF2-40B4-BE49-F238E27FC236}">
                      <a16:creationId xmlns:a16="http://schemas.microsoft.com/office/drawing/2014/main" id="{25414103-C050-420D-80A4-28CB00C2B28E}"/>
                    </a:ext>
                  </a:extLst>
                </p:cNvPr>
                <p:cNvSpPr txBox="1"/>
                <p:nvPr/>
              </p:nvSpPr>
              <p:spPr>
                <a:xfrm>
                  <a:off x="5272922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sp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98" name="TextBox 297">
                  <a:extLst>
                    <a:ext uri="{FF2B5EF4-FFF2-40B4-BE49-F238E27FC236}">
                      <a16:creationId xmlns:a16="http://schemas.microsoft.com/office/drawing/2014/main" id="{5A3C66FB-59CE-48FF-A8C9-F445544838C3}"/>
                    </a:ext>
                  </a:extLst>
                </p:cNvPr>
                <p:cNvSpPr txBox="1"/>
                <p:nvPr/>
              </p:nvSpPr>
              <p:spPr>
                <a:xfrm>
                  <a:off x="5523667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 err="1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rg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99" name="TextBox 298">
                  <a:extLst>
                    <a:ext uri="{FF2B5EF4-FFF2-40B4-BE49-F238E27FC236}">
                      <a16:creationId xmlns:a16="http://schemas.microsoft.com/office/drawing/2014/main" id="{F64E9C90-41FC-4F53-80CE-803C64950AEA}"/>
                    </a:ext>
                  </a:extLst>
                </p:cNvPr>
                <p:cNvSpPr txBox="1"/>
                <p:nvPr/>
              </p:nvSpPr>
              <p:spPr>
                <a:xfrm>
                  <a:off x="5774412" y="4982225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Leu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300" name="TextBox 299">
                  <a:extLst>
                    <a:ext uri="{FF2B5EF4-FFF2-40B4-BE49-F238E27FC236}">
                      <a16:creationId xmlns:a16="http://schemas.microsoft.com/office/drawing/2014/main" id="{1639CC0D-D6BB-44F5-9375-7B9F5BE3BE79}"/>
                    </a:ext>
                  </a:extLst>
                </p:cNvPr>
                <p:cNvSpPr txBox="1"/>
                <p:nvPr/>
              </p:nvSpPr>
              <p:spPr>
                <a:xfrm>
                  <a:off x="7021049" y="4899886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305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301" name="TextBox 300">
                  <a:extLst>
                    <a:ext uri="{FF2B5EF4-FFF2-40B4-BE49-F238E27FC236}">
                      <a16:creationId xmlns:a16="http://schemas.microsoft.com/office/drawing/2014/main" id="{8706C583-7A2B-4100-9FB0-6B147507B333}"/>
                    </a:ext>
                  </a:extLst>
                </p:cNvPr>
                <p:cNvSpPr txBox="1"/>
                <p:nvPr/>
              </p:nvSpPr>
              <p:spPr>
                <a:xfrm>
                  <a:off x="2274624" y="4897417"/>
                  <a:ext cx="163507" cy="10772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700" dirty="0">
                      <a:solidFill>
                        <a:srgbClr val="0033CC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287</a:t>
                  </a:r>
                  <a:endParaRPr lang="ko-KR" altLang="en-US" sz="700" dirty="0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</p:grpSp>
          <p:sp>
            <p:nvSpPr>
              <p:cNvPr id="279" name="TextBox 278">
                <a:extLst>
                  <a:ext uri="{FF2B5EF4-FFF2-40B4-BE49-F238E27FC236}">
                    <a16:creationId xmlns:a16="http://schemas.microsoft.com/office/drawing/2014/main" id="{A1F422AE-A9BF-43D7-AF41-350893DE36E6}"/>
                  </a:ext>
                </a:extLst>
              </p:cNvPr>
              <p:cNvSpPr txBox="1"/>
              <p:nvPr/>
            </p:nvSpPr>
            <p:spPr>
              <a:xfrm>
                <a:off x="7034369" y="3338608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sn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280" name="TextBox 279">
                <a:extLst>
                  <a:ext uri="{FF2B5EF4-FFF2-40B4-BE49-F238E27FC236}">
                    <a16:creationId xmlns:a16="http://schemas.microsoft.com/office/drawing/2014/main" id="{B6A4CBDD-3705-4BF7-8109-33B06B053031}"/>
                  </a:ext>
                </a:extLst>
              </p:cNvPr>
              <p:cNvSpPr txBox="1"/>
              <p:nvPr/>
            </p:nvSpPr>
            <p:spPr>
              <a:xfrm>
                <a:off x="7257433" y="3337871"/>
                <a:ext cx="163507" cy="10772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700" dirty="0" err="1">
                    <a:solidFill>
                      <a:srgbClr val="0033CC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hr</a:t>
                </a:r>
                <a:endParaRPr lang="ko-KR" altLang="en-US" sz="700" dirty="0">
                  <a:solidFill>
                    <a:srgbClr val="0033CC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</p:grpSp>
      </p:grpSp>
      <p:cxnSp>
        <p:nvCxnSpPr>
          <p:cNvPr id="324" name="직선 화살표 연결선 323">
            <a:extLst>
              <a:ext uri="{FF2B5EF4-FFF2-40B4-BE49-F238E27FC236}">
                <a16:creationId xmlns:a16="http://schemas.microsoft.com/office/drawing/2014/main" id="{7E55DF79-3713-4498-B747-7CE8DC4013EE}"/>
              </a:ext>
            </a:extLst>
          </p:cNvPr>
          <p:cNvCxnSpPr/>
          <p:nvPr/>
        </p:nvCxnSpPr>
        <p:spPr>
          <a:xfrm>
            <a:off x="7402931" y="4439432"/>
            <a:ext cx="1821" cy="171608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1" name="TextBox 330">
            <a:extLst>
              <a:ext uri="{FF2B5EF4-FFF2-40B4-BE49-F238E27FC236}">
                <a16:creationId xmlns:a16="http://schemas.microsoft.com/office/drawing/2014/main" id="{4325BCBD-AED1-4489-B82D-332FEF6A80C7}"/>
              </a:ext>
            </a:extLst>
          </p:cNvPr>
          <p:cNvSpPr txBox="1"/>
          <p:nvPr/>
        </p:nvSpPr>
        <p:spPr>
          <a:xfrm>
            <a:off x="3188597" y="5488101"/>
            <a:ext cx="1199046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Repeats (two times)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직사각형 331">
            <a:extLst>
              <a:ext uri="{FF2B5EF4-FFF2-40B4-BE49-F238E27FC236}">
                <a16:creationId xmlns:a16="http://schemas.microsoft.com/office/drawing/2014/main" id="{298C2980-AE5A-45AF-823F-137D5996EE40}"/>
              </a:ext>
            </a:extLst>
          </p:cNvPr>
          <p:cNvSpPr/>
          <p:nvPr/>
        </p:nvSpPr>
        <p:spPr>
          <a:xfrm>
            <a:off x="1899248" y="4794398"/>
            <a:ext cx="899674" cy="16927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ko-KR" sz="1100" dirty="0">
                <a:latin typeface="Courier New" panose="02070309020205020404" pitchFamily="49" charset="0"/>
                <a:cs typeface="Courier New" panose="02070309020205020404" pitchFamily="49" charset="0"/>
              </a:rPr>
              <a:t>HK567   :</a:t>
            </a:r>
          </a:p>
        </p:txBody>
      </p:sp>
      <p:sp>
        <p:nvSpPr>
          <p:cNvPr id="333" name="직사각형 332">
            <a:extLst>
              <a:ext uri="{FF2B5EF4-FFF2-40B4-BE49-F238E27FC236}">
                <a16:creationId xmlns:a16="http://schemas.microsoft.com/office/drawing/2014/main" id="{BEDF9768-31C9-4061-9B71-B80E8D6A2A73}"/>
              </a:ext>
            </a:extLst>
          </p:cNvPr>
          <p:cNvSpPr/>
          <p:nvPr/>
        </p:nvSpPr>
        <p:spPr>
          <a:xfrm>
            <a:off x="1897377" y="5343928"/>
            <a:ext cx="877914" cy="16927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ko-KR" sz="1100" dirty="0">
                <a:latin typeface="Courier New" panose="02070309020205020404" pitchFamily="49" charset="0"/>
                <a:cs typeface="Courier New" panose="02070309020205020404" pitchFamily="49" charset="0"/>
              </a:rPr>
              <a:t>HK569   :</a:t>
            </a:r>
          </a:p>
        </p:txBody>
      </p:sp>
      <p:sp>
        <p:nvSpPr>
          <p:cNvPr id="334" name="직사각형 333">
            <a:extLst>
              <a:ext uri="{FF2B5EF4-FFF2-40B4-BE49-F238E27FC236}">
                <a16:creationId xmlns:a16="http://schemas.microsoft.com/office/drawing/2014/main" id="{4F13BAFB-FAD5-4E12-A5D9-262C7B6E0E5B}"/>
              </a:ext>
            </a:extLst>
          </p:cNvPr>
          <p:cNvSpPr/>
          <p:nvPr/>
        </p:nvSpPr>
        <p:spPr>
          <a:xfrm>
            <a:off x="1894898" y="5901249"/>
            <a:ext cx="764633" cy="1692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ko-KR" sz="1100" dirty="0">
                <a:latin typeface="Courier New" panose="02070309020205020404" pitchFamily="49" charset="0"/>
                <a:cs typeface="Courier New" panose="02070309020205020404" pitchFamily="49" charset="0"/>
              </a:rPr>
              <a:t>BW25113 :</a:t>
            </a:r>
            <a:endParaRPr lang="ko-KR" altLang="en-US" sz="11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C2A6B905-75FA-4A9B-9C83-E5E02AD18B54}"/>
              </a:ext>
            </a:extLst>
          </p:cNvPr>
          <p:cNvSpPr txBox="1"/>
          <p:nvPr/>
        </p:nvSpPr>
        <p:spPr>
          <a:xfrm>
            <a:off x="1683787" y="389074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CC8F7248-FA2D-460B-B1C9-8333E148041A}"/>
              </a:ext>
            </a:extLst>
          </p:cNvPr>
          <p:cNvSpPr txBox="1"/>
          <p:nvPr/>
        </p:nvSpPr>
        <p:spPr>
          <a:xfrm>
            <a:off x="1683787" y="126138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1" name="그룹 350">
            <a:extLst>
              <a:ext uri="{FF2B5EF4-FFF2-40B4-BE49-F238E27FC236}">
                <a16:creationId xmlns:a16="http://schemas.microsoft.com/office/drawing/2014/main" id="{705FBB3D-0073-494F-A656-F6575DCADED6}"/>
              </a:ext>
            </a:extLst>
          </p:cNvPr>
          <p:cNvGrpSpPr/>
          <p:nvPr/>
        </p:nvGrpSpPr>
        <p:grpSpPr>
          <a:xfrm>
            <a:off x="1906143" y="1947734"/>
            <a:ext cx="1896448" cy="1809623"/>
            <a:chOff x="468717" y="1896660"/>
            <a:chExt cx="1896448" cy="1809623"/>
          </a:xfrm>
        </p:grpSpPr>
        <p:sp>
          <p:nvSpPr>
            <p:cNvPr id="352" name="TextBox 351">
              <a:extLst>
                <a:ext uri="{FF2B5EF4-FFF2-40B4-BE49-F238E27FC236}">
                  <a16:creationId xmlns:a16="http://schemas.microsoft.com/office/drawing/2014/main" id="{4AB91140-3383-4534-BE19-4622C67CC10D}"/>
                </a:ext>
              </a:extLst>
            </p:cNvPr>
            <p:cNvSpPr txBox="1"/>
            <p:nvPr/>
          </p:nvSpPr>
          <p:spPr>
            <a:xfrm>
              <a:off x="1887470" y="3552395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" name="TextBox 352">
              <a:extLst>
                <a:ext uri="{FF2B5EF4-FFF2-40B4-BE49-F238E27FC236}">
                  <a16:creationId xmlns:a16="http://schemas.microsoft.com/office/drawing/2014/main" id="{AD908577-E800-4856-BF15-43A4E6DB8473}"/>
                </a:ext>
              </a:extLst>
            </p:cNvPr>
            <p:cNvSpPr txBox="1"/>
            <p:nvPr/>
          </p:nvSpPr>
          <p:spPr>
            <a:xfrm rot="16200000">
              <a:off x="-62679" y="2428056"/>
              <a:ext cx="121668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ell growth 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4" name="TextBox 353">
            <a:extLst>
              <a:ext uri="{FF2B5EF4-FFF2-40B4-BE49-F238E27FC236}">
                <a16:creationId xmlns:a16="http://schemas.microsoft.com/office/drawing/2014/main" id="{3A14B50C-3E20-4FEE-AB18-5EBF35512C6E}"/>
              </a:ext>
            </a:extLst>
          </p:cNvPr>
          <p:cNvSpPr txBox="1"/>
          <p:nvPr/>
        </p:nvSpPr>
        <p:spPr>
          <a:xfrm>
            <a:off x="4357603" y="1399811"/>
            <a:ext cx="12570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ccinate (0.3%)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TextBox 354">
            <a:extLst>
              <a:ext uri="{FF2B5EF4-FFF2-40B4-BE49-F238E27FC236}">
                <a16:creationId xmlns:a16="http://schemas.microsoft.com/office/drawing/2014/main" id="{91C65C74-0BA9-44EE-8146-3465DB4C5125}"/>
              </a:ext>
            </a:extLst>
          </p:cNvPr>
          <p:cNvSpPr txBox="1"/>
          <p:nvPr/>
        </p:nvSpPr>
        <p:spPr>
          <a:xfrm>
            <a:off x="3254724" y="2649434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29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TextBox 355">
            <a:extLst>
              <a:ext uri="{FF2B5EF4-FFF2-40B4-BE49-F238E27FC236}">
                <a16:creationId xmlns:a16="http://schemas.microsoft.com/office/drawing/2014/main" id="{B60BC353-1F79-4F75-B983-BB2510B4B0AE}"/>
              </a:ext>
            </a:extLst>
          </p:cNvPr>
          <p:cNvSpPr txBox="1"/>
          <p:nvPr/>
        </p:nvSpPr>
        <p:spPr>
          <a:xfrm>
            <a:off x="5030257" y="3035449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04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직사각형 356">
            <a:extLst>
              <a:ext uri="{FF2B5EF4-FFF2-40B4-BE49-F238E27FC236}">
                <a16:creationId xmlns:a16="http://schemas.microsoft.com/office/drawing/2014/main" id="{C27F732D-8BA8-436C-AA38-124587989977}"/>
              </a:ext>
            </a:extLst>
          </p:cNvPr>
          <p:cNvSpPr/>
          <p:nvPr/>
        </p:nvSpPr>
        <p:spPr>
          <a:xfrm>
            <a:off x="0" y="2683"/>
            <a:ext cx="200247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0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D5D42D07-FB09-46A3-93F2-07A4B6249E30}"/>
              </a:ext>
            </a:extLst>
          </p:cNvPr>
          <p:cNvSpPr txBox="1"/>
          <p:nvPr/>
        </p:nvSpPr>
        <p:spPr>
          <a:xfrm>
            <a:off x="2638621" y="2649434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7</a:t>
            </a:r>
            <a:endParaRPr lang="ko-KR" altLang="en-US" sz="8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id="{7D18DA6B-06B6-45DA-AAA9-E65CC662DECA}"/>
              </a:ext>
            </a:extLst>
          </p:cNvPr>
          <p:cNvGrpSpPr/>
          <p:nvPr/>
        </p:nvGrpSpPr>
        <p:grpSpPr>
          <a:xfrm>
            <a:off x="5324117" y="1719793"/>
            <a:ext cx="2106441" cy="417963"/>
            <a:chOff x="3986881" y="1687658"/>
            <a:chExt cx="2106441" cy="417963"/>
          </a:xfrm>
        </p:grpSpPr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94432D16-974B-4747-8E04-68090405C6E6}"/>
                </a:ext>
              </a:extLst>
            </p:cNvPr>
            <p:cNvGrpSpPr/>
            <p:nvPr/>
          </p:nvGrpSpPr>
          <p:grpSpPr>
            <a:xfrm>
              <a:off x="3986881" y="1741237"/>
              <a:ext cx="180000" cy="54424"/>
              <a:chOff x="3986881" y="1741237"/>
              <a:chExt cx="180000" cy="54424"/>
            </a:xfrm>
          </p:grpSpPr>
          <p:cxnSp>
            <p:nvCxnSpPr>
              <p:cNvPr id="340" name="직선 연결선 339">
                <a:extLst>
                  <a:ext uri="{FF2B5EF4-FFF2-40B4-BE49-F238E27FC236}">
                    <a16:creationId xmlns:a16="http://schemas.microsoft.com/office/drawing/2014/main" id="{87DFB4D4-604E-470B-A5EF-D780BBFF4D1C}"/>
                  </a:ext>
                </a:extLst>
              </p:cNvPr>
              <p:cNvCxnSpPr/>
              <p:nvPr/>
            </p:nvCxnSpPr>
            <p:spPr>
              <a:xfrm>
                <a:off x="3986881" y="1768449"/>
                <a:ext cx="180000" cy="0"/>
              </a:xfrm>
              <a:prstGeom prst="line">
                <a:avLst/>
              </a:prstGeom>
              <a:ln w="9525" cap="rnd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1" name="타원 340">
                <a:extLst>
                  <a:ext uri="{FF2B5EF4-FFF2-40B4-BE49-F238E27FC236}">
                    <a16:creationId xmlns:a16="http://schemas.microsoft.com/office/drawing/2014/main" id="{DA9D59C3-491E-416E-9C36-2262A9656DD3}"/>
                  </a:ext>
                </a:extLst>
              </p:cNvPr>
              <p:cNvSpPr/>
              <p:nvPr/>
            </p:nvSpPr>
            <p:spPr>
              <a:xfrm>
                <a:off x="4049669" y="1741237"/>
                <a:ext cx="54424" cy="54424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grpSp>
          <p:nvGrpSpPr>
            <p:cNvPr id="6" name="그룹 5">
              <a:extLst>
                <a:ext uri="{FF2B5EF4-FFF2-40B4-BE49-F238E27FC236}">
                  <a16:creationId xmlns:a16="http://schemas.microsoft.com/office/drawing/2014/main" id="{FD7ABE12-96BD-4F2E-94E2-9A9BD5FD2417}"/>
                </a:ext>
              </a:extLst>
            </p:cNvPr>
            <p:cNvGrpSpPr/>
            <p:nvPr/>
          </p:nvGrpSpPr>
          <p:grpSpPr>
            <a:xfrm>
              <a:off x="3986881" y="1877318"/>
              <a:ext cx="180000" cy="54424"/>
              <a:chOff x="3989455" y="1877318"/>
              <a:chExt cx="180000" cy="54424"/>
            </a:xfrm>
          </p:grpSpPr>
          <p:cxnSp>
            <p:nvCxnSpPr>
              <p:cNvPr id="342" name="직선 연결선 341">
                <a:extLst>
                  <a:ext uri="{FF2B5EF4-FFF2-40B4-BE49-F238E27FC236}">
                    <a16:creationId xmlns:a16="http://schemas.microsoft.com/office/drawing/2014/main" id="{DC6921EE-DDA3-4D94-BEA4-37525C8685D3}"/>
                  </a:ext>
                </a:extLst>
              </p:cNvPr>
              <p:cNvCxnSpPr/>
              <p:nvPr/>
            </p:nvCxnSpPr>
            <p:spPr>
              <a:xfrm>
                <a:off x="3989455" y="1904530"/>
                <a:ext cx="180000" cy="0"/>
              </a:xfrm>
              <a:prstGeom prst="line">
                <a:avLst/>
              </a:prstGeom>
              <a:ln w="9525" cap="rnd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3" name="이등변 삼각형 342">
                <a:extLst>
                  <a:ext uri="{FF2B5EF4-FFF2-40B4-BE49-F238E27FC236}">
                    <a16:creationId xmlns:a16="http://schemas.microsoft.com/office/drawing/2014/main" id="{07E25764-76C6-4485-BC9D-1D64B91068C1}"/>
                  </a:ext>
                </a:extLst>
              </p:cNvPr>
              <p:cNvSpPr/>
              <p:nvPr/>
            </p:nvSpPr>
            <p:spPr>
              <a:xfrm>
                <a:off x="4052243" y="1877318"/>
                <a:ext cx="54424" cy="5442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rgbClr val="008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sp>
          <p:nvSpPr>
            <p:cNvPr id="344" name="TextBox 343">
              <a:extLst>
                <a:ext uri="{FF2B5EF4-FFF2-40B4-BE49-F238E27FC236}">
                  <a16:creationId xmlns:a16="http://schemas.microsoft.com/office/drawing/2014/main" id="{2CB6C179-E4D1-4343-9AD0-E2D9CE7F9C0C}"/>
                </a:ext>
              </a:extLst>
            </p:cNvPr>
            <p:cNvSpPr txBox="1"/>
            <p:nvPr/>
          </p:nvSpPr>
          <p:spPr>
            <a:xfrm>
              <a:off x="4201779" y="1827390"/>
              <a:ext cx="1891543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K569 (BL21(DE3), </a:t>
              </a:r>
              <a:r>
                <a:rPr lang="el-GR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gtP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n-US" altLang="ko-KR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dcuS</a:t>
              </a:r>
              <a:r>
                <a:rPr lang="en-US" altLang="ko-KR" sz="900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TextBox 344">
              <a:extLst>
                <a:ext uri="{FF2B5EF4-FFF2-40B4-BE49-F238E27FC236}">
                  <a16:creationId xmlns:a16="http://schemas.microsoft.com/office/drawing/2014/main" id="{D39E788C-01A0-4DCD-9F50-4AE1A8D128B5}"/>
                </a:ext>
              </a:extLst>
            </p:cNvPr>
            <p:cNvSpPr txBox="1"/>
            <p:nvPr/>
          </p:nvSpPr>
          <p:spPr>
            <a:xfrm>
              <a:off x="4201779" y="1687658"/>
              <a:ext cx="140423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K567 (BL21(DE3), </a:t>
              </a:r>
              <a:r>
                <a:rPr lang="el-GR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gtP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그룹 6">
              <a:extLst>
                <a:ext uri="{FF2B5EF4-FFF2-40B4-BE49-F238E27FC236}">
                  <a16:creationId xmlns:a16="http://schemas.microsoft.com/office/drawing/2014/main" id="{AD957813-738A-4A30-B465-A139AC0E0362}"/>
                </a:ext>
              </a:extLst>
            </p:cNvPr>
            <p:cNvGrpSpPr/>
            <p:nvPr/>
          </p:nvGrpSpPr>
          <p:grpSpPr>
            <a:xfrm>
              <a:off x="3986881" y="2011177"/>
              <a:ext cx="180000" cy="54424"/>
              <a:chOff x="3994260" y="2011177"/>
              <a:chExt cx="180000" cy="54424"/>
            </a:xfrm>
          </p:grpSpPr>
          <p:cxnSp>
            <p:nvCxnSpPr>
              <p:cNvPr id="178" name="직선 연결선 177">
                <a:extLst>
                  <a:ext uri="{FF2B5EF4-FFF2-40B4-BE49-F238E27FC236}">
                    <a16:creationId xmlns:a16="http://schemas.microsoft.com/office/drawing/2014/main" id="{C570FF98-A1BA-4CA1-87DC-BD4303A28813}"/>
                  </a:ext>
                </a:extLst>
              </p:cNvPr>
              <p:cNvCxnSpPr/>
              <p:nvPr/>
            </p:nvCxnSpPr>
            <p:spPr>
              <a:xfrm>
                <a:off x="3994260" y="2038389"/>
                <a:ext cx="180000" cy="0"/>
              </a:xfrm>
              <a:prstGeom prst="line">
                <a:avLst/>
              </a:prstGeom>
              <a:ln w="9525" cap="rnd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9" name="직사각형 178">
                <a:extLst>
                  <a:ext uri="{FF2B5EF4-FFF2-40B4-BE49-F238E27FC236}">
                    <a16:creationId xmlns:a16="http://schemas.microsoft.com/office/drawing/2014/main" id="{B6BAEBA2-EA6B-4A06-9D40-D4F48C3541B5}"/>
                  </a:ext>
                </a:extLst>
              </p:cNvPr>
              <p:cNvSpPr/>
              <p:nvPr/>
            </p:nvSpPr>
            <p:spPr>
              <a:xfrm>
                <a:off x="4057048" y="2011177"/>
                <a:ext cx="54424" cy="54424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D69397BA-EE76-456E-BC99-DB8072A75263}"/>
                </a:ext>
              </a:extLst>
            </p:cNvPr>
            <p:cNvSpPr txBox="1"/>
            <p:nvPr/>
          </p:nvSpPr>
          <p:spPr>
            <a:xfrm>
              <a:off x="4201779" y="1967122"/>
              <a:ext cx="1689565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K565 (BL21(DE3), </a:t>
              </a:r>
              <a:r>
                <a:rPr lang="el-GR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gtP</a:t>
              </a:r>
              <a:r>
                <a:rPr lang="en-US" altLang="ko-KR" sz="900" baseline="300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(-8CT)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)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7298879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87EDDC3E-7972-4BCE-8B05-D407ED1924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4475438"/>
              </p:ext>
            </p:extLst>
          </p:nvPr>
        </p:nvGraphicFramePr>
        <p:xfrm>
          <a:off x="2070140" y="1578208"/>
          <a:ext cx="5832000" cy="21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64" name="Graph" r:id="rId3" imgW="6949440" imgH="2560320" progId="Origin95.Graph">
                  <p:embed/>
                </p:oleObj>
              </mc:Choice>
              <mc:Fallback>
                <p:oleObj name="Graph" r:id="rId3" imgW="6949440" imgH="2560320" progId="Origin95.Graph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018B59FA-DB33-4DC5-9E7E-9143E6937A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70140" y="1578208"/>
                        <a:ext cx="5832000" cy="21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그룹 3">
            <a:extLst>
              <a:ext uri="{FF2B5EF4-FFF2-40B4-BE49-F238E27FC236}">
                <a16:creationId xmlns:a16="http://schemas.microsoft.com/office/drawing/2014/main" id="{D0611F53-DB2E-4EFE-87CE-5B399B9F381B}"/>
              </a:ext>
            </a:extLst>
          </p:cNvPr>
          <p:cNvGrpSpPr/>
          <p:nvPr/>
        </p:nvGrpSpPr>
        <p:grpSpPr>
          <a:xfrm>
            <a:off x="1906143" y="2179368"/>
            <a:ext cx="3444715" cy="1653107"/>
            <a:chOff x="468717" y="2128294"/>
            <a:chExt cx="3444715" cy="1653107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750E02B-F7DF-4ABE-880D-27C0D61B4738}"/>
                </a:ext>
              </a:extLst>
            </p:cNvPr>
            <p:cNvSpPr txBox="1"/>
            <p:nvPr/>
          </p:nvSpPr>
          <p:spPr>
            <a:xfrm>
              <a:off x="3435737" y="3627513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059A77D-1E8A-417F-87C3-FB2B93976807}"/>
                </a:ext>
              </a:extLst>
            </p:cNvPr>
            <p:cNvSpPr txBox="1"/>
            <p:nvPr/>
          </p:nvSpPr>
          <p:spPr>
            <a:xfrm rot="16200000">
              <a:off x="168955" y="2428056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4B1C4220-2363-4BB8-A409-A627D917AE22}"/>
              </a:ext>
            </a:extLst>
          </p:cNvPr>
          <p:cNvSpPr txBox="1"/>
          <p:nvPr/>
        </p:nvSpPr>
        <p:spPr>
          <a:xfrm>
            <a:off x="4357603" y="1399811"/>
            <a:ext cx="12570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ccinate (0.3%)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7085D59-1E8A-484B-9E1D-BD91ED1AECBA}"/>
              </a:ext>
            </a:extLst>
          </p:cNvPr>
          <p:cNvSpPr txBox="1"/>
          <p:nvPr/>
        </p:nvSpPr>
        <p:spPr>
          <a:xfrm>
            <a:off x="3254724" y="2649434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29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ED699A0-AA84-471B-931F-379C5657988A}"/>
              </a:ext>
            </a:extLst>
          </p:cNvPr>
          <p:cNvSpPr txBox="1"/>
          <p:nvPr/>
        </p:nvSpPr>
        <p:spPr>
          <a:xfrm>
            <a:off x="5030257" y="3035449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04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D780E6-73EE-4265-9D16-9FFD714E4180}"/>
              </a:ext>
            </a:extLst>
          </p:cNvPr>
          <p:cNvSpPr txBox="1"/>
          <p:nvPr/>
        </p:nvSpPr>
        <p:spPr>
          <a:xfrm>
            <a:off x="2638621" y="2649434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7</a:t>
            </a:r>
            <a:endParaRPr lang="ko-KR" altLang="en-US" sz="8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3B3C8BAB-3DBF-47CE-AFBD-5B402D1CBED2}"/>
              </a:ext>
            </a:extLst>
          </p:cNvPr>
          <p:cNvGrpSpPr/>
          <p:nvPr/>
        </p:nvGrpSpPr>
        <p:grpSpPr>
          <a:xfrm>
            <a:off x="5324117" y="1719793"/>
            <a:ext cx="2106441" cy="417963"/>
            <a:chOff x="3986881" y="1687658"/>
            <a:chExt cx="2106441" cy="417963"/>
          </a:xfrm>
        </p:grpSpPr>
        <p:grpSp>
          <p:nvGrpSpPr>
            <p:cNvPr id="12" name="그룹 11">
              <a:extLst>
                <a:ext uri="{FF2B5EF4-FFF2-40B4-BE49-F238E27FC236}">
                  <a16:creationId xmlns:a16="http://schemas.microsoft.com/office/drawing/2014/main" id="{24313B23-FBE0-47CE-9B07-DC26C7426B46}"/>
                </a:ext>
              </a:extLst>
            </p:cNvPr>
            <p:cNvGrpSpPr/>
            <p:nvPr/>
          </p:nvGrpSpPr>
          <p:grpSpPr>
            <a:xfrm>
              <a:off x="3986881" y="1741237"/>
              <a:ext cx="180000" cy="54424"/>
              <a:chOff x="3986881" y="1741237"/>
              <a:chExt cx="180000" cy="54424"/>
            </a:xfrm>
          </p:grpSpPr>
          <p:cxnSp>
            <p:nvCxnSpPr>
              <p:cNvPr id="22" name="직선 연결선 21">
                <a:extLst>
                  <a:ext uri="{FF2B5EF4-FFF2-40B4-BE49-F238E27FC236}">
                    <a16:creationId xmlns:a16="http://schemas.microsoft.com/office/drawing/2014/main" id="{8723F967-E6B6-4877-972F-585A23BF9BEE}"/>
                  </a:ext>
                </a:extLst>
              </p:cNvPr>
              <p:cNvCxnSpPr/>
              <p:nvPr/>
            </p:nvCxnSpPr>
            <p:spPr>
              <a:xfrm>
                <a:off x="3986881" y="1768449"/>
                <a:ext cx="180000" cy="0"/>
              </a:xfrm>
              <a:prstGeom prst="line">
                <a:avLst/>
              </a:prstGeom>
              <a:ln w="9525" cap="rnd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타원 22">
                <a:extLst>
                  <a:ext uri="{FF2B5EF4-FFF2-40B4-BE49-F238E27FC236}">
                    <a16:creationId xmlns:a16="http://schemas.microsoft.com/office/drawing/2014/main" id="{873C93EE-4BFF-4412-89DD-85C6BD6D9C7F}"/>
                  </a:ext>
                </a:extLst>
              </p:cNvPr>
              <p:cNvSpPr/>
              <p:nvPr/>
            </p:nvSpPr>
            <p:spPr>
              <a:xfrm>
                <a:off x="4049669" y="1741237"/>
                <a:ext cx="54424" cy="54424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grpSp>
          <p:nvGrpSpPr>
            <p:cNvPr id="13" name="그룹 12">
              <a:extLst>
                <a:ext uri="{FF2B5EF4-FFF2-40B4-BE49-F238E27FC236}">
                  <a16:creationId xmlns:a16="http://schemas.microsoft.com/office/drawing/2014/main" id="{943D63B2-89E8-49A1-84E6-293D0F27230E}"/>
                </a:ext>
              </a:extLst>
            </p:cNvPr>
            <p:cNvGrpSpPr/>
            <p:nvPr/>
          </p:nvGrpSpPr>
          <p:grpSpPr>
            <a:xfrm>
              <a:off x="3986881" y="1877318"/>
              <a:ext cx="180000" cy="54424"/>
              <a:chOff x="3989455" y="1877318"/>
              <a:chExt cx="180000" cy="54424"/>
            </a:xfrm>
          </p:grpSpPr>
          <p:cxnSp>
            <p:nvCxnSpPr>
              <p:cNvPr id="20" name="직선 연결선 19">
                <a:extLst>
                  <a:ext uri="{FF2B5EF4-FFF2-40B4-BE49-F238E27FC236}">
                    <a16:creationId xmlns:a16="http://schemas.microsoft.com/office/drawing/2014/main" id="{196CA611-BDAE-4EED-A85A-3D1EF439CF63}"/>
                  </a:ext>
                </a:extLst>
              </p:cNvPr>
              <p:cNvCxnSpPr/>
              <p:nvPr/>
            </p:nvCxnSpPr>
            <p:spPr>
              <a:xfrm>
                <a:off x="3989455" y="1904530"/>
                <a:ext cx="180000" cy="0"/>
              </a:xfrm>
              <a:prstGeom prst="line">
                <a:avLst/>
              </a:prstGeom>
              <a:ln w="9525" cap="rnd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이등변 삼각형 20">
                <a:extLst>
                  <a:ext uri="{FF2B5EF4-FFF2-40B4-BE49-F238E27FC236}">
                    <a16:creationId xmlns:a16="http://schemas.microsoft.com/office/drawing/2014/main" id="{500C73CC-01DD-450E-A335-24343C96F975}"/>
                  </a:ext>
                </a:extLst>
              </p:cNvPr>
              <p:cNvSpPr/>
              <p:nvPr/>
            </p:nvSpPr>
            <p:spPr>
              <a:xfrm>
                <a:off x="4052243" y="1877318"/>
                <a:ext cx="54424" cy="5442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rgbClr val="008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04CCD97-546B-4325-B0EE-DDF7081D1109}"/>
                </a:ext>
              </a:extLst>
            </p:cNvPr>
            <p:cNvSpPr txBox="1"/>
            <p:nvPr/>
          </p:nvSpPr>
          <p:spPr>
            <a:xfrm>
              <a:off x="4201779" y="1827390"/>
              <a:ext cx="1891543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K569 (BL21(DE3), </a:t>
              </a:r>
              <a:r>
                <a:rPr lang="el-GR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gtP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n-US" altLang="ko-KR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dcuS</a:t>
              </a:r>
              <a:r>
                <a:rPr lang="en-US" altLang="ko-KR" sz="900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4965711-1EAA-48C9-BCDA-357A3B50C658}"/>
                </a:ext>
              </a:extLst>
            </p:cNvPr>
            <p:cNvSpPr txBox="1"/>
            <p:nvPr/>
          </p:nvSpPr>
          <p:spPr>
            <a:xfrm>
              <a:off x="4201779" y="1687658"/>
              <a:ext cx="140423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K567 (BL21(DE3), </a:t>
              </a:r>
              <a:r>
                <a:rPr lang="el-GR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gtP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" name="그룹 15">
              <a:extLst>
                <a:ext uri="{FF2B5EF4-FFF2-40B4-BE49-F238E27FC236}">
                  <a16:creationId xmlns:a16="http://schemas.microsoft.com/office/drawing/2014/main" id="{85F3C143-034A-4C8C-8EDC-57CF23D9AB0E}"/>
                </a:ext>
              </a:extLst>
            </p:cNvPr>
            <p:cNvGrpSpPr/>
            <p:nvPr/>
          </p:nvGrpSpPr>
          <p:grpSpPr>
            <a:xfrm>
              <a:off x="3986881" y="2011177"/>
              <a:ext cx="180000" cy="54424"/>
              <a:chOff x="3994260" y="2011177"/>
              <a:chExt cx="180000" cy="54424"/>
            </a:xfrm>
          </p:grpSpPr>
          <p:cxnSp>
            <p:nvCxnSpPr>
              <p:cNvPr id="18" name="직선 연결선 17">
                <a:extLst>
                  <a:ext uri="{FF2B5EF4-FFF2-40B4-BE49-F238E27FC236}">
                    <a16:creationId xmlns:a16="http://schemas.microsoft.com/office/drawing/2014/main" id="{D8FC9506-D6F7-4CCD-846C-0D9CF7E63970}"/>
                  </a:ext>
                </a:extLst>
              </p:cNvPr>
              <p:cNvCxnSpPr/>
              <p:nvPr/>
            </p:nvCxnSpPr>
            <p:spPr>
              <a:xfrm>
                <a:off x="3994260" y="2038389"/>
                <a:ext cx="180000" cy="0"/>
              </a:xfrm>
              <a:prstGeom prst="line">
                <a:avLst/>
              </a:prstGeom>
              <a:ln w="9525" cap="rnd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직사각형 18">
                <a:extLst>
                  <a:ext uri="{FF2B5EF4-FFF2-40B4-BE49-F238E27FC236}">
                    <a16:creationId xmlns:a16="http://schemas.microsoft.com/office/drawing/2014/main" id="{7B22E15B-6E2F-4A5A-9FFA-7D1888B50BFD}"/>
                  </a:ext>
                </a:extLst>
              </p:cNvPr>
              <p:cNvSpPr/>
              <p:nvPr/>
            </p:nvSpPr>
            <p:spPr>
              <a:xfrm>
                <a:off x="4057048" y="2011177"/>
                <a:ext cx="54424" cy="54424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05390DF-0D6B-4D6A-862C-249314A94CD5}"/>
                </a:ext>
              </a:extLst>
            </p:cNvPr>
            <p:cNvSpPr txBox="1"/>
            <p:nvPr/>
          </p:nvSpPr>
          <p:spPr>
            <a:xfrm>
              <a:off x="4201779" y="1967122"/>
              <a:ext cx="1689565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K565 (BL21(DE3), </a:t>
              </a:r>
              <a:r>
                <a:rPr lang="el-GR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gtP</a:t>
              </a:r>
              <a:r>
                <a:rPr lang="en-US" altLang="ko-KR" sz="900" baseline="300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(-8CT)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)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A755A348-EC27-4744-9711-40A5AB9AE3D9}"/>
              </a:ext>
            </a:extLst>
          </p:cNvPr>
          <p:cNvGrpSpPr/>
          <p:nvPr/>
        </p:nvGrpSpPr>
        <p:grpSpPr>
          <a:xfrm>
            <a:off x="2048116" y="1578507"/>
            <a:ext cx="224420" cy="1986223"/>
            <a:chOff x="2231375" y="244499"/>
            <a:chExt cx="224420" cy="1723225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93505B5-3B53-4567-A4EC-3267551CB8AC}"/>
                </a:ext>
              </a:extLst>
            </p:cNvPr>
            <p:cNvSpPr txBox="1"/>
            <p:nvPr/>
          </p:nvSpPr>
          <p:spPr>
            <a:xfrm>
              <a:off x="2306043" y="244499"/>
              <a:ext cx="12824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9308D77-B596-4A44-91EF-A9C1E894DFC4}"/>
                </a:ext>
              </a:extLst>
            </p:cNvPr>
            <p:cNvSpPr txBox="1"/>
            <p:nvPr/>
          </p:nvSpPr>
          <p:spPr>
            <a:xfrm>
              <a:off x="2368425" y="778087"/>
              <a:ext cx="641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6BA9562-5559-4973-B69D-3DB49D3947D5}"/>
                </a:ext>
              </a:extLst>
            </p:cNvPr>
            <p:cNvSpPr txBox="1"/>
            <p:nvPr/>
          </p:nvSpPr>
          <p:spPr>
            <a:xfrm>
              <a:off x="2291616" y="1310912"/>
              <a:ext cx="16030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4CF0636-DDC5-4501-BE36-95037C20B347}"/>
                </a:ext>
              </a:extLst>
            </p:cNvPr>
            <p:cNvSpPr txBox="1"/>
            <p:nvPr/>
          </p:nvSpPr>
          <p:spPr>
            <a:xfrm>
              <a:off x="2231375" y="1829225"/>
              <a:ext cx="2244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256E4834-CAF1-4137-8BAA-AF0C2AF438D3}"/>
              </a:ext>
            </a:extLst>
          </p:cNvPr>
          <p:cNvSpPr/>
          <p:nvPr/>
        </p:nvSpPr>
        <p:spPr>
          <a:xfrm>
            <a:off x="0" y="2683"/>
            <a:ext cx="200247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1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44999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>
            <a:extLst>
              <a:ext uri="{FF2B5EF4-FFF2-40B4-BE49-F238E27FC236}">
                <a16:creationId xmlns:a16="http://schemas.microsoft.com/office/drawing/2014/main" id="{4D274288-91B6-48F9-9DED-88403DF67607}"/>
              </a:ext>
            </a:extLst>
          </p:cNvPr>
          <p:cNvSpPr/>
          <p:nvPr/>
        </p:nvSpPr>
        <p:spPr>
          <a:xfrm>
            <a:off x="0" y="2683"/>
            <a:ext cx="200247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2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직선 연결선 3">
            <a:extLst>
              <a:ext uri="{FF2B5EF4-FFF2-40B4-BE49-F238E27FC236}">
                <a16:creationId xmlns:a16="http://schemas.microsoft.com/office/drawing/2014/main" id="{422D83EB-693B-4D86-9B59-63EC4D884F36}"/>
              </a:ext>
            </a:extLst>
          </p:cNvPr>
          <p:cNvCxnSpPr>
            <a:cxnSpLocks/>
          </p:cNvCxnSpPr>
          <p:nvPr/>
        </p:nvCxnSpPr>
        <p:spPr>
          <a:xfrm>
            <a:off x="5221873" y="1627181"/>
            <a:ext cx="1677906" cy="769497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직사각형 68">
            <a:extLst>
              <a:ext uri="{FF2B5EF4-FFF2-40B4-BE49-F238E27FC236}">
                <a16:creationId xmlns:a16="http://schemas.microsoft.com/office/drawing/2014/main" id="{0D5AFF56-6273-475C-8203-247337788E0E}"/>
              </a:ext>
            </a:extLst>
          </p:cNvPr>
          <p:cNvSpPr/>
          <p:nvPr/>
        </p:nvSpPr>
        <p:spPr>
          <a:xfrm>
            <a:off x="4445356" y="2511570"/>
            <a:ext cx="1025819" cy="123152"/>
          </a:xfrm>
          <a:prstGeom prst="rect">
            <a:avLst/>
          </a:prstGeom>
          <a:solidFill>
            <a:srgbClr val="C0C0C0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0" name="직사각형 69">
            <a:extLst>
              <a:ext uri="{FF2B5EF4-FFF2-40B4-BE49-F238E27FC236}">
                <a16:creationId xmlns:a16="http://schemas.microsoft.com/office/drawing/2014/main" id="{CC5A93A4-762F-446A-8A83-D5DD00ECAF3E}"/>
              </a:ext>
            </a:extLst>
          </p:cNvPr>
          <p:cNvSpPr/>
          <p:nvPr/>
        </p:nvSpPr>
        <p:spPr>
          <a:xfrm>
            <a:off x="5472895" y="2511570"/>
            <a:ext cx="1441172" cy="118622"/>
          </a:xfrm>
          <a:prstGeom prst="rect">
            <a:avLst/>
          </a:prstGeom>
          <a:solidFill>
            <a:srgbClr val="9CBE4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8D642845-C067-404F-9864-310324C4198F}"/>
              </a:ext>
            </a:extLst>
          </p:cNvPr>
          <p:cNvSpPr/>
          <p:nvPr/>
        </p:nvSpPr>
        <p:spPr>
          <a:xfrm>
            <a:off x="2717408" y="2456581"/>
            <a:ext cx="434029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ko-KR" alt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GCAAAGGGAAGGGGATGCGTCTTGGCGGTGGAGGTTCCATGCGTAAAGGCGAAGAGCTG</a:t>
            </a:r>
            <a:endParaRPr lang="en-US" altLang="ko-K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17FC54BB-C685-4F15-8001-03EF9846CC94}"/>
              </a:ext>
            </a:extLst>
          </p:cNvPr>
          <p:cNvGrpSpPr/>
          <p:nvPr/>
        </p:nvGrpSpPr>
        <p:grpSpPr>
          <a:xfrm>
            <a:off x="2816518" y="2401207"/>
            <a:ext cx="4088228" cy="20532"/>
            <a:chOff x="2446250" y="3316314"/>
            <a:chExt cx="5035638" cy="27302"/>
          </a:xfrm>
        </p:grpSpPr>
        <p:cxnSp>
          <p:nvCxnSpPr>
            <p:cNvPr id="47" name="직선 연결선 46">
              <a:extLst>
                <a:ext uri="{FF2B5EF4-FFF2-40B4-BE49-F238E27FC236}">
                  <a16:creationId xmlns:a16="http://schemas.microsoft.com/office/drawing/2014/main" id="{D01A50FA-60C3-468A-BE5C-A8E28968AC20}"/>
                </a:ext>
              </a:extLst>
            </p:cNvPr>
            <p:cNvCxnSpPr/>
            <p:nvPr/>
          </p:nvCxnSpPr>
          <p:spPr>
            <a:xfrm>
              <a:off x="2446250" y="3316314"/>
              <a:ext cx="5035638" cy="0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직선 연결선 47">
              <a:extLst>
                <a:ext uri="{FF2B5EF4-FFF2-40B4-BE49-F238E27FC236}">
                  <a16:creationId xmlns:a16="http://schemas.microsoft.com/office/drawing/2014/main" id="{6F13E879-A7FE-4171-BC9A-E73338A9908B}"/>
                </a:ext>
              </a:extLst>
            </p:cNvPr>
            <p:cNvCxnSpPr/>
            <p:nvPr/>
          </p:nvCxnSpPr>
          <p:spPr>
            <a:xfrm>
              <a:off x="245135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직선 연결선 48">
              <a:extLst>
                <a:ext uri="{FF2B5EF4-FFF2-40B4-BE49-F238E27FC236}">
                  <a16:creationId xmlns:a16="http://schemas.microsoft.com/office/drawing/2014/main" id="{A4BED23B-0138-416F-8BED-C2DA68C64E23}"/>
                </a:ext>
              </a:extLst>
            </p:cNvPr>
            <p:cNvCxnSpPr/>
            <p:nvPr/>
          </p:nvCxnSpPr>
          <p:spPr>
            <a:xfrm>
              <a:off x="270281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직선 연결선 49">
              <a:extLst>
                <a:ext uri="{FF2B5EF4-FFF2-40B4-BE49-F238E27FC236}">
                  <a16:creationId xmlns:a16="http://schemas.microsoft.com/office/drawing/2014/main" id="{43A4717F-0119-4F07-8A8C-5FA970A2BCD8}"/>
                </a:ext>
              </a:extLst>
            </p:cNvPr>
            <p:cNvCxnSpPr/>
            <p:nvPr/>
          </p:nvCxnSpPr>
          <p:spPr>
            <a:xfrm>
              <a:off x="295427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연결선 50">
              <a:extLst>
                <a:ext uri="{FF2B5EF4-FFF2-40B4-BE49-F238E27FC236}">
                  <a16:creationId xmlns:a16="http://schemas.microsoft.com/office/drawing/2014/main" id="{4BCF4E7B-4CC6-4904-A571-A00F95C0BC6A}"/>
                </a:ext>
              </a:extLst>
            </p:cNvPr>
            <p:cNvCxnSpPr/>
            <p:nvPr/>
          </p:nvCxnSpPr>
          <p:spPr>
            <a:xfrm>
              <a:off x="320573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직선 연결선 51">
              <a:extLst>
                <a:ext uri="{FF2B5EF4-FFF2-40B4-BE49-F238E27FC236}">
                  <a16:creationId xmlns:a16="http://schemas.microsoft.com/office/drawing/2014/main" id="{7FDB8835-ABD6-4122-AE8E-A3AB148DD844}"/>
                </a:ext>
              </a:extLst>
            </p:cNvPr>
            <p:cNvCxnSpPr/>
            <p:nvPr/>
          </p:nvCxnSpPr>
          <p:spPr>
            <a:xfrm>
              <a:off x="345719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연결선 52">
              <a:extLst>
                <a:ext uri="{FF2B5EF4-FFF2-40B4-BE49-F238E27FC236}">
                  <a16:creationId xmlns:a16="http://schemas.microsoft.com/office/drawing/2014/main" id="{2F87932D-E302-43B3-BB78-32E0C4CC3B8D}"/>
                </a:ext>
              </a:extLst>
            </p:cNvPr>
            <p:cNvCxnSpPr/>
            <p:nvPr/>
          </p:nvCxnSpPr>
          <p:spPr>
            <a:xfrm>
              <a:off x="370865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연결선 53">
              <a:extLst>
                <a:ext uri="{FF2B5EF4-FFF2-40B4-BE49-F238E27FC236}">
                  <a16:creationId xmlns:a16="http://schemas.microsoft.com/office/drawing/2014/main" id="{29C55B80-7E9E-4CE3-99AE-F22546E6E193}"/>
                </a:ext>
              </a:extLst>
            </p:cNvPr>
            <p:cNvCxnSpPr/>
            <p:nvPr/>
          </p:nvCxnSpPr>
          <p:spPr>
            <a:xfrm>
              <a:off x="396011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직선 연결선 54">
              <a:extLst>
                <a:ext uri="{FF2B5EF4-FFF2-40B4-BE49-F238E27FC236}">
                  <a16:creationId xmlns:a16="http://schemas.microsoft.com/office/drawing/2014/main" id="{6706A8CC-7F1F-45A4-AAAB-9BF196A8B451}"/>
                </a:ext>
              </a:extLst>
            </p:cNvPr>
            <p:cNvCxnSpPr/>
            <p:nvPr/>
          </p:nvCxnSpPr>
          <p:spPr>
            <a:xfrm>
              <a:off x="421157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7249EF57-5FC5-43D6-AA3C-03B20EE609AC}"/>
                </a:ext>
              </a:extLst>
            </p:cNvPr>
            <p:cNvCxnSpPr/>
            <p:nvPr/>
          </p:nvCxnSpPr>
          <p:spPr>
            <a:xfrm>
              <a:off x="446303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직선 연결선 56">
              <a:extLst>
                <a:ext uri="{FF2B5EF4-FFF2-40B4-BE49-F238E27FC236}">
                  <a16:creationId xmlns:a16="http://schemas.microsoft.com/office/drawing/2014/main" id="{FE94D103-EBC5-4DA9-A5CB-9E1724833082}"/>
                </a:ext>
              </a:extLst>
            </p:cNvPr>
            <p:cNvCxnSpPr/>
            <p:nvPr/>
          </p:nvCxnSpPr>
          <p:spPr>
            <a:xfrm>
              <a:off x="471449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직선 연결선 57">
              <a:extLst>
                <a:ext uri="{FF2B5EF4-FFF2-40B4-BE49-F238E27FC236}">
                  <a16:creationId xmlns:a16="http://schemas.microsoft.com/office/drawing/2014/main" id="{71DA4048-C481-4594-82F5-53E3FF99C975}"/>
                </a:ext>
              </a:extLst>
            </p:cNvPr>
            <p:cNvCxnSpPr/>
            <p:nvPr/>
          </p:nvCxnSpPr>
          <p:spPr>
            <a:xfrm>
              <a:off x="496595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직선 연결선 58">
              <a:extLst>
                <a:ext uri="{FF2B5EF4-FFF2-40B4-BE49-F238E27FC236}">
                  <a16:creationId xmlns:a16="http://schemas.microsoft.com/office/drawing/2014/main" id="{B7E6F6CC-A5BE-4467-A088-4AA1A0BD99BA}"/>
                </a:ext>
              </a:extLst>
            </p:cNvPr>
            <p:cNvCxnSpPr/>
            <p:nvPr/>
          </p:nvCxnSpPr>
          <p:spPr>
            <a:xfrm>
              <a:off x="521741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직선 연결선 59">
              <a:extLst>
                <a:ext uri="{FF2B5EF4-FFF2-40B4-BE49-F238E27FC236}">
                  <a16:creationId xmlns:a16="http://schemas.microsoft.com/office/drawing/2014/main" id="{F6B8613C-7E08-477F-A6DC-A2F7174C4C0A}"/>
                </a:ext>
              </a:extLst>
            </p:cNvPr>
            <p:cNvCxnSpPr/>
            <p:nvPr/>
          </p:nvCxnSpPr>
          <p:spPr>
            <a:xfrm>
              <a:off x="546887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직선 연결선 60">
              <a:extLst>
                <a:ext uri="{FF2B5EF4-FFF2-40B4-BE49-F238E27FC236}">
                  <a16:creationId xmlns:a16="http://schemas.microsoft.com/office/drawing/2014/main" id="{C3DEF150-3022-4618-B4EB-66D409E7B97E}"/>
                </a:ext>
              </a:extLst>
            </p:cNvPr>
            <p:cNvCxnSpPr/>
            <p:nvPr/>
          </p:nvCxnSpPr>
          <p:spPr>
            <a:xfrm>
              <a:off x="572033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직선 연결선 61">
              <a:extLst>
                <a:ext uri="{FF2B5EF4-FFF2-40B4-BE49-F238E27FC236}">
                  <a16:creationId xmlns:a16="http://schemas.microsoft.com/office/drawing/2014/main" id="{5F31AEC7-22AA-4148-B82C-D9E69A262803}"/>
                </a:ext>
              </a:extLst>
            </p:cNvPr>
            <p:cNvCxnSpPr/>
            <p:nvPr/>
          </p:nvCxnSpPr>
          <p:spPr>
            <a:xfrm>
              <a:off x="597179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직선 연결선 62">
              <a:extLst>
                <a:ext uri="{FF2B5EF4-FFF2-40B4-BE49-F238E27FC236}">
                  <a16:creationId xmlns:a16="http://schemas.microsoft.com/office/drawing/2014/main" id="{70CEEF23-4F86-4F7C-9360-C381865077E7}"/>
                </a:ext>
              </a:extLst>
            </p:cNvPr>
            <p:cNvCxnSpPr/>
            <p:nvPr/>
          </p:nvCxnSpPr>
          <p:spPr>
            <a:xfrm>
              <a:off x="622325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직선 연결선 63">
              <a:extLst>
                <a:ext uri="{FF2B5EF4-FFF2-40B4-BE49-F238E27FC236}">
                  <a16:creationId xmlns:a16="http://schemas.microsoft.com/office/drawing/2014/main" id="{FFEEF386-6DB8-41A1-A32B-F8E24DA84C0B}"/>
                </a:ext>
              </a:extLst>
            </p:cNvPr>
            <p:cNvCxnSpPr/>
            <p:nvPr/>
          </p:nvCxnSpPr>
          <p:spPr>
            <a:xfrm>
              <a:off x="647471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직선 연결선 64">
              <a:extLst>
                <a:ext uri="{FF2B5EF4-FFF2-40B4-BE49-F238E27FC236}">
                  <a16:creationId xmlns:a16="http://schemas.microsoft.com/office/drawing/2014/main" id="{8A98FEC6-E506-4271-9593-B39781BF4245}"/>
                </a:ext>
              </a:extLst>
            </p:cNvPr>
            <p:cNvCxnSpPr/>
            <p:nvPr/>
          </p:nvCxnSpPr>
          <p:spPr>
            <a:xfrm>
              <a:off x="672617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직선 연결선 65">
              <a:extLst>
                <a:ext uri="{FF2B5EF4-FFF2-40B4-BE49-F238E27FC236}">
                  <a16:creationId xmlns:a16="http://schemas.microsoft.com/office/drawing/2014/main" id="{2B1B4A8F-952F-4BB8-BDDC-32EB686C3460}"/>
                </a:ext>
              </a:extLst>
            </p:cNvPr>
            <p:cNvCxnSpPr/>
            <p:nvPr/>
          </p:nvCxnSpPr>
          <p:spPr>
            <a:xfrm>
              <a:off x="697763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>
              <a:extLst>
                <a:ext uri="{FF2B5EF4-FFF2-40B4-BE49-F238E27FC236}">
                  <a16:creationId xmlns:a16="http://schemas.microsoft.com/office/drawing/2014/main" id="{7E0499C3-3ABB-4FFF-903C-8A486136CC31}"/>
                </a:ext>
              </a:extLst>
            </p:cNvPr>
            <p:cNvCxnSpPr/>
            <p:nvPr/>
          </p:nvCxnSpPr>
          <p:spPr>
            <a:xfrm>
              <a:off x="722909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>
              <a:extLst>
                <a:ext uri="{FF2B5EF4-FFF2-40B4-BE49-F238E27FC236}">
                  <a16:creationId xmlns:a16="http://schemas.microsoft.com/office/drawing/2014/main" id="{DBC9A661-E955-4E3A-A882-1A431C4C803B}"/>
                </a:ext>
              </a:extLst>
            </p:cNvPr>
            <p:cNvCxnSpPr/>
            <p:nvPr/>
          </p:nvCxnSpPr>
          <p:spPr>
            <a:xfrm>
              <a:off x="7480551" y="3316314"/>
              <a:ext cx="0" cy="27302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그룹 7">
            <a:extLst>
              <a:ext uri="{FF2B5EF4-FFF2-40B4-BE49-F238E27FC236}">
                <a16:creationId xmlns:a16="http://schemas.microsoft.com/office/drawing/2014/main" id="{F4887486-779C-481B-B56C-F262E32D3A3F}"/>
              </a:ext>
            </a:extLst>
          </p:cNvPr>
          <p:cNvGrpSpPr/>
          <p:nvPr/>
        </p:nvGrpSpPr>
        <p:grpSpPr>
          <a:xfrm>
            <a:off x="2896811" y="2396004"/>
            <a:ext cx="3928719" cy="124356"/>
            <a:chOff x="925528" y="2624919"/>
            <a:chExt cx="3928719" cy="124356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3C50EFB-D9B3-48E2-832B-0937DBEF6C79}"/>
                </a:ext>
              </a:extLst>
            </p:cNvPr>
            <p:cNvSpPr txBox="1"/>
            <p:nvPr/>
          </p:nvSpPr>
          <p:spPr>
            <a:xfrm>
              <a:off x="1536236" y="2626164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K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1031225-ACC2-4953-8039-619E670B9390}"/>
                </a:ext>
              </a:extLst>
            </p:cNvPr>
            <p:cNvSpPr txBox="1"/>
            <p:nvPr/>
          </p:nvSpPr>
          <p:spPr>
            <a:xfrm>
              <a:off x="1739805" y="2626164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A75F56B-8613-4F15-B486-620BF0D1CE55}"/>
                </a:ext>
              </a:extLst>
            </p:cNvPr>
            <p:cNvSpPr txBox="1"/>
            <p:nvPr/>
          </p:nvSpPr>
          <p:spPr>
            <a:xfrm>
              <a:off x="1943375" y="2626164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M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217A0F7-EF2E-4A49-BAC6-4C35D49D8F7F}"/>
                </a:ext>
              </a:extLst>
            </p:cNvPr>
            <p:cNvSpPr txBox="1"/>
            <p:nvPr/>
          </p:nvSpPr>
          <p:spPr>
            <a:xfrm>
              <a:off x="2146943" y="2626164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R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F9015F7-9230-419C-99F6-5532F697AF08}"/>
                </a:ext>
              </a:extLst>
            </p:cNvPr>
            <p:cNvSpPr txBox="1"/>
            <p:nvPr/>
          </p:nvSpPr>
          <p:spPr>
            <a:xfrm>
              <a:off x="2350513" y="2626164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F696EEA-1793-4E27-AD12-E663ECF800FC}"/>
                </a:ext>
              </a:extLst>
            </p:cNvPr>
            <p:cNvSpPr txBox="1"/>
            <p:nvPr/>
          </p:nvSpPr>
          <p:spPr>
            <a:xfrm>
              <a:off x="2554083" y="2626164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7A23ECA-992D-416D-9031-94212537825F}"/>
                </a:ext>
              </a:extLst>
            </p:cNvPr>
            <p:cNvSpPr txBox="1"/>
            <p:nvPr/>
          </p:nvSpPr>
          <p:spPr>
            <a:xfrm>
              <a:off x="2757652" y="2626164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B4E0FAC-B5D1-4973-93B8-CC80BAEADC40}"/>
                </a:ext>
              </a:extLst>
            </p:cNvPr>
            <p:cNvSpPr txBox="1"/>
            <p:nvPr/>
          </p:nvSpPr>
          <p:spPr>
            <a:xfrm>
              <a:off x="2961214" y="2626164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737A024-5776-46B0-9C52-F29C518AD64E}"/>
                </a:ext>
              </a:extLst>
            </p:cNvPr>
            <p:cNvSpPr txBox="1"/>
            <p:nvPr/>
          </p:nvSpPr>
          <p:spPr>
            <a:xfrm>
              <a:off x="925528" y="2626164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R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25D3991-5682-4864-9CA6-23F490A91CB6}"/>
                </a:ext>
              </a:extLst>
            </p:cNvPr>
            <p:cNvSpPr txBox="1"/>
            <p:nvPr/>
          </p:nvSpPr>
          <p:spPr>
            <a:xfrm>
              <a:off x="1129096" y="2626164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K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44A9239-5171-4511-8750-4061465103AD}"/>
                </a:ext>
              </a:extLst>
            </p:cNvPr>
            <p:cNvSpPr txBox="1"/>
            <p:nvPr/>
          </p:nvSpPr>
          <p:spPr>
            <a:xfrm>
              <a:off x="1332666" y="2626164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06FE137D-246F-4700-A80B-03473EA8F202}"/>
                </a:ext>
              </a:extLst>
            </p:cNvPr>
            <p:cNvSpPr txBox="1"/>
            <p:nvPr/>
          </p:nvSpPr>
          <p:spPr>
            <a:xfrm>
              <a:off x="3979054" y="2624919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rgbClr val="008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K</a:t>
              </a:r>
              <a:endParaRPr lang="ko-KR" altLang="en-US" sz="8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1FFC90F-E722-4193-9F64-66C2FB3AFC9D}"/>
                </a:ext>
              </a:extLst>
            </p:cNvPr>
            <p:cNvSpPr txBox="1"/>
            <p:nvPr/>
          </p:nvSpPr>
          <p:spPr>
            <a:xfrm>
              <a:off x="4182624" y="2624919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rgbClr val="008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endParaRPr lang="ko-KR" altLang="en-US" sz="8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BDAA4E3-4E33-4DE6-BB1D-B7C4B5016552}"/>
                </a:ext>
              </a:extLst>
            </p:cNvPr>
            <p:cNvSpPr txBox="1"/>
            <p:nvPr/>
          </p:nvSpPr>
          <p:spPr>
            <a:xfrm>
              <a:off x="4386193" y="2624919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rgbClr val="008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E</a:t>
              </a:r>
              <a:endParaRPr lang="ko-KR" altLang="en-US" sz="8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41263EF-6E77-436F-8F49-AC4674EC92DE}"/>
                </a:ext>
              </a:extLst>
            </p:cNvPr>
            <p:cNvSpPr txBox="1"/>
            <p:nvPr/>
          </p:nvSpPr>
          <p:spPr>
            <a:xfrm>
              <a:off x="4589764" y="2624919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rgbClr val="008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E</a:t>
              </a:r>
              <a:endParaRPr lang="ko-KR" altLang="en-US" sz="8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EB5027C-A31F-4819-9601-515310922260}"/>
                </a:ext>
              </a:extLst>
            </p:cNvPr>
            <p:cNvSpPr txBox="1"/>
            <p:nvPr/>
          </p:nvSpPr>
          <p:spPr>
            <a:xfrm>
              <a:off x="4793333" y="2624919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rgbClr val="008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  <a:endParaRPr lang="ko-KR" altLang="en-US" sz="8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B48BB4F-E04D-4488-A2C8-3FBB554F9914}"/>
                </a:ext>
              </a:extLst>
            </p:cNvPr>
            <p:cNvSpPr txBox="1"/>
            <p:nvPr/>
          </p:nvSpPr>
          <p:spPr>
            <a:xfrm>
              <a:off x="3164777" y="2624919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31EC9A4-C49A-4B7C-8411-8135C02506AC}"/>
                </a:ext>
              </a:extLst>
            </p:cNvPr>
            <p:cNvSpPr txBox="1"/>
            <p:nvPr/>
          </p:nvSpPr>
          <p:spPr>
            <a:xfrm>
              <a:off x="3368345" y="2624919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S</a:t>
              </a:r>
              <a:endParaRPr lang="ko-KR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6E56694-C2C1-46B6-B843-373FBB43FBEB}"/>
                </a:ext>
              </a:extLst>
            </p:cNvPr>
            <p:cNvSpPr txBox="1"/>
            <p:nvPr/>
          </p:nvSpPr>
          <p:spPr>
            <a:xfrm>
              <a:off x="3571916" y="2624919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rgbClr val="008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</a:t>
              </a:r>
              <a:endParaRPr lang="ko-KR" altLang="en-US" sz="8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DA89182E-ADCA-4E5A-8E12-14588A6D0E75}"/>
                </a:ext>
              </a:extLst>
            </p:cNvPr>
            <p:cNvSpPr txBox="1"/>
            <p:nvPr/>
          </p:nvSpPr>
          <p:spPr>
            <a:xfrm>
              <a:off x="3775485" y="2624919"/>
              <a:ext cx="6091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rgbClr val="008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R</a:t>
              </a:r>
              <a:endParaRPr lang="ko-KR" altLang="en-US" sz="8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7D19B790-45DE-4874-AAC2-AD5EE2047D41}"/>
              </a:ext>
            </a:extLst>
          </p:cNvPr>
          <p:cNvSpPr txBox="1"/>
          <p:nvPr/>
        </p:nvSpPr>
        <p:spPr>
          <a:xfrm>
            <a:off x="4654397" y="2643749"/>
            <a:ext cx="580287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7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ea typeface="Open Sans Semibold" panose="020B0706030804020204" pitchFamily="34" charset="0"/>
                <a:cs typeface="Arial" panose="020B0604020202020204" pitchFamily="34" charset="0"/>
              </a:rPr>
              <a:t>GGGGS linker</a:t>
            </a:r>
            <a:endParaRPr lang="ko-KR" altLang="en-US" sz="7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100D720-3F75-4518-AEFC-F4D33B3DC301}"/>
              </a:ext>
            </a:extLst>
          </p:cNvPr>
          <p:cNvSpPr txBox="1"/>
          <p:nvPr/>
        </p:nvSpPr>
        <p:spPr>
          <a:xfrm>
            <a:off x="4179812" y="2167693"/>
            <a:ext cx="12907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Open Sans Semibold" panose="020B0706030804020204" pitchFamily="34" charset="0"/>
                <a:cs typeface="Arial" panose="020B0604020202020204" pitchFamily="34" charset="0"/>
              </a:rPr>
              <a:t>Translational fusio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9FDF64C0-16CA-4930-8496-BD19A0EBD088}"/>
              </a:ext>
            </a:extLst>
          </p:cNvPr>
          <p:cNvCxnSpPr>
            <a:cxnSpLocks/>
          </p:cNvCxnSpPr>
          <p:nvPr/>
        </p:nvCxnSpPr>
        <p:spPr>
          <a:xfrm>
            <a:off x="2424950" y="1512375"/>
            <a:ext cx="550747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꺾인 연결선 48">
            <a:extLst>
              <a:ext uri="{FF2B5EF4-FFF2-40B4-BE49-F238E27FC236}">
                <a16:creationId xmlns:a16="http://schemas.microsoft.com/office/drawing/2014/main" id="{DB302375-F452-4D4F-A624-60512B536054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3625943" y="1222566"/>
            <a:ext cx="324304" cy="255320"/>
          </a:xfrm>
          <a:prstGeom prst="bentConnector3">
            <a:avLst>
              <a:gd name="adj1" fmla="val 99930"/>
            </a:avLst>
          </a:prstGeom>
          <a:ln w="19050">
            <a:solidFill>
              <a:schemeClr val="tx1"/>
            </a:solidFill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그룹 15">
            <a:extLst>
              <a:ext uri="{FF2B5EF4-FFF2-40B4-BE49-F238E27FC236}">
                <a16:creationId xmlns:a16="http://schemas.microsoft.com/office/drawing/2014/main" id="{C09FDE7B-E498-47D0-8E22-313CC43C3202}"/>
              </a:ext>
            </a:extLst>
          </p:cNvPr>
          <p:cNvGrpSpPr/>
          <p:nvPr/>
        </p:nvGrpSpPr>
        <p:grpSpPr>
          <a:xfrm>
            <a:off x="3989145" y="1272354"/>
            <a:ext cx="1930828" cy="480040"/>
            <a:chOff x="8533328" y="1805191"/>
            <a:chExt cx="1980715" cy="492443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EC483C7-7891-464B-9F55-4715519FC64B}"/>
                </a:ext>
              </a:extLst>
            </p:cNvPr>
            <p:cNvSpPr txBox="1"/>
            <p:nvPr/>
          </p:nvSpPr>
          <p:spPr>
            <a:xfrm>
              <a:off x="8654098" y="1928303"/>
              <a:ext cx="46358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i="1" dirty="0" err="1">
                  <a:latin typeface="Arial" panose="020B0604020202020204" pitchFamily="34" charset="0"/>
                  <a:ea typeface="Open Sans Semibold" panose="020B0706030804020204" pitchFamily="34" charset="0"/>
                  <a:cs typeface="Arial" panose="020B0604020202020204" pitchFamily="34" charset="0"/>
                </a:rPr>
                <a:t>kgtP</a:t>
              </a:r>
              <a:endParaRPr lang="ko-KR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사각형: 둥근 모서리 4">
              <a:extLst>
                <a:ext uri="{FF2B5EF4-FFF2-40B4-BE49-F238E27FC236}">
                  <a16:creationId xmlns:a16="http://schemas.microsoft.com/office/drawing/2014/main" id="{EAF62F17-FC39-403C-97ED-D89A7DF8B701}"/>
                </a:ext>
              </a:extLst>
            </p:cNvPr>
            <p:cNvSpPr/>
            <p:nvPr/>
          </p:nvSpPr>
          <p:spPr>
            <a:xfrm>
              <a:off x="9459297" y="1805191"/>
              <a:ext cx="1054746" cy="492443"/>
            </a:xfrm>
            <a:prstGeom prst="rightArrow">
              <a:avLst>
                <a:gd name="adj1" fmla="val 50000"/>
                <a:gd name="adj2" fmla="val 76645"/>
              </a:avLst>
            </a:prstGeom>
            <a:solidFill>
              <a:srgbClr val="9CBE4A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5CA38AB-8D5C-4F35-8B0F-3A5DEFC49482}"/>
                </a:ext>
              </a:extLst>
            </p:cNvPr>
            <p:cNvSpPr txBox="1"/>
            <p:nvPr/>
          </p:nvSpPr>
          <p:spPr>
            <a:xfrm>
              <a:off x="9644220" y="1920607"/>
              <a:ext cx="5549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i="1" dirty="0">
                  <a:latin typeface="Arial" panose="020B0604020202020204" pitchFamily="34" charset="0"/>
                  <a:ea typeface="Open Sans Semibold" panose="020B0706030804020204" pitchFamily="34" charset="0"/>
                  <a:cs typeface="Arial" panose="020B0604020202020204" pitchFamily="34" charset="0"/>
                </a:rPr>
                <a:t>sf-</a:t>
              </a:r>
              <a:r>
                <a:rPr lang="en-US" altLang="ko-KR" sz="1100" i="1" dirty="0" err="1">
                  <a:latin typeface="Arial" panose="020B0604020202020204" pitchFamily="34" charset="0"/>
                  <a:ea typeface="Open Sans Semibold" panose="020B0706030804020204" pitchFamily="34" charset="0"/>
                  <a:cs typeface="Arial" panose="020B0604020202020204" pitchFamily="34" charset="0"/>
                </a:rPr>
                <a:t>gfp</a:t>
              </a:r>
              <a:endParaRPr lang="ko-KR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자유형: 도형 23">
              <a:extLst>
                <a:ext uri="{FF2B5EF4-FFF2-40B4-BE49-F238E27FC236}">
                  <a16:creationId xmlns:a16="http://schemas.microsoft.com/office/drawing/2014/main" id="{C55E5077-2452-4D5D-8458-770DF9D0D0B2}"/>
                </a:ext>
              </a:extLst>
            </p:cNvPr>
            <p:cNvSpPr/>
            <p:nvPr/>
          </p:nvSpPr>
          <p:spPr>
            <a:xfrm>
              <a:off x="8533328" y="1928303"/>
              <a:ext cx="787650" cy="246221"/>
            </a:xfrm>
            <a:custGeom>
              <a:avLst/>
              <a:gdLst>
                <a:gd name="connsiteX0" fmla="*/ 0 w 787650"/>
                <a:gd name="connsiteY0" fmla="*/ 0 h 246221"/>
                <a:gd name="connsiteX1" fmla="*/ 787650 w 787650"/>
                <a:gd name="connsiteY1" fmla="*/ 0 h 246221"/>
                <a:gd name="connsiteX2" fmla="*/ 787650 w 787650"/>
                <a:gd name="connsiteY2" fmla="*/ 246221 h 246221"/>
                <a:gd name="connsiteX3" fmla="*/ 0 w 787650"/>
                <a:gd name="connsiteY3" fmla="*/ 246221 h 246221"/>
                <a:gd name="connsiteX4" fmla="*/ 0 w 787650"/>
                <a:gd name="connsiteY4" fmla="*/ 0 h 2462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87650" h="246221">
                  <a:moveTo>
                    <a:pt x="0" y="0"/>
                  </a:moveTo>
                  <a:lnTo>
                    <a:pt x="787650" y="0"/>
                  </a:lnTo>
                  <a:lnTo>
                    <a:pt x="787650" y="246221"/>
                  </a:lnTo>
                  <a:lnTo>
                    <a:pt x="0" y="24622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자유형: 도형 24">
              <a:extLst>
                <a:ext uri="{FF2B5EF4-FFF2-40B4-BE49-F238E27FC236}">
                  <a16:creationId xmlns:a16="http://schemas.microsoft.com/office/drawing/2014/main" id="{822CEDEC-F65A-4D6E-91CB-8FA70805448B}"/>
                </a:ext>
              </a:extLst>
            </p:cNvPr>
            <p:cNvSpPr/>
            <p:nvPr/>
          </p:nvSpPr>
          <p:spPr>
            <a:xfrm>
              <a:off x="9320978" y="1927785"/>
              <a:ext cx="139974" cy="246739"/>
            </a:xfrm>
            <a:custGeom>
              <a:avLst/>
              <a:gdLst>
                <a:gd name="connsiteX0" fmla="*/ 0 w 787650"/>
                <a:gd name="connsiteY0" fmla="*/ 0 h 246221"/>
                <a:gd name="connsiteX1" fmla="*/ 787650 w 787650"/>
                <a:gd name="connsiteY1" fmla="*/ 0 h 246221"/>
                <a:gd name="connsiteX2" fmla="*/ 787650 w 787650"/>
                <a:gd name="connsiteY2" fmla="*/ 246221 h 246221"/>
                <a:gd name="connsiteX3" fmla="*/ 0 w 787650"/>
                <a:gd name="connsiteY3" fmla="*/ 246221 h 246221"/>
                <a:gd name="connsiteX4" fmla="*/ 0 w 787650"/>
                <a:gd name="connsiteY4" fmla="*/ 0 h 2462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87650" h="246221">
                  <a:moveTo>
                    <a:pt x="0" y="0"/>
                  </a:moveTo>
                  <a:lnTo>
                    <a:pt x="787650" y="0"/>
                  </a:lnTo>
                  <a:lnTo>
                    <a:pt x="787650" y="246221"/>
                  </a:lnTo>
                  <a:lnTo>
                    <a:pt x="0" y="24622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1E9CDDC-9F52-40DE-88AC-2DE1EEB3D615}"/>
                </a:ext>
              </a:extLst>
            </p:cNvPr>
            <p:cNvSpPr txBox="1"/>
            <p:nvPr/>
          </p:nvSpPr>
          <p:spPr>
            <a:xfrm>
              <a:off x="8690774" y="1912914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i="1" dirty="0" err="1">
                  <a:latin typeface="Arial" panose="020B0604020202020204" pitchFamily="34" charset="0"/>
                  <a:ea typeface="Open Sans Semibold" panose="020B0706030804020204" pitchFamily="34" charset="0"/>
                  <a:cs typeface="Arial" panose="020B0604020202020204" pitchFamily="34" charset="0"/>
                </a:rPr>
                <a:t>kgtP</a:t>
              </a:r>
              <a:endParaRPr lang="ko-KR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사각형: 둥근 모서리 4">
            <a:extLst>
              <a:ext uri="{FF2B5EF4-FFF2-40B4-BE49-F238E27FC236}">
                <a16:creationId xmlns:a16="http://schemas.microsoft.com/office/drawing/2014/main" id="{7539A8B7-619F-4A3B-9A7A-45BC1C35DE90}"/>
              </a:ext>
            </a:extLst>
          </p:cNvPr>
          <p:cNvSpPr/>
          <p:nvPr/>
        </p:nvSpPr>
        <p:spPr>
          <a:xfrm>
            <a:off x="6096787" y="1270124"/>
            <a:ext cx="664703" cy="480040"/>
          </a:xfrm>
          <a:prstGeom prst="rightArrow">
            <a:avLst>
              <a:gd name="adj1" fmla="val 50000"/>
              <a:gd name="adj2" fmla="val 76645"/>
            </a:avLst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53424D8-9D23-4348-877C-30372063B69E}"/>
              </a:ext>
            </a:extLst>
          </p:cNvPr>
          <p:cNvSpPr txBox="1"/>
          <p:nvPr/>
        </p:nvSpPr>
        <p:spPr>
          <a:xfrm>
            <a:off x="6144351" y="1382892"/>
            <a:ext cx="484728" cy="2550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i="1" dirty="0" err="1">
                <a:latin typeface="Arial" panose="020B0604020202020204" pitchFamily="34" charset="0"/>
                <a:ea typeface="Open Sans Semibold" panose="020B0706030804020204" pitchFamily="34" charset="0"/>
                <a:cs typeface="Arial" panose="020B0604020202020204" pitchFamily="34" charset="0"/>
              </a:rPr>
              <a:t>Cm</a:t>
            </a:r>
            <a:r>
              <a:rPr lang="en-US" altLang="ko-KR" sz="1100" i="1" baseline="30000" dirty="0" err="1">
                <a:latin typeface="Arial" panose="020B0604020202020204" pitchFamily="34" charset="0"/>
                <a:ea typeface="Open Sans Semibold" panose="020B0706030804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1100" i="1" baseline="30000" dirty="0">
                <a:latin typeface="Arial" panose="020B0604020202020204" pitchFamily="34" charset="0"/>
                <a:ea typeface="Open Sans Semibold" panose="020B0706030804020204" pitchFamily="34" charset="0"/>
                <a:cs typeface="Arial" panose="020B0604020202020204" pitchFamily="34" charset="0"/>
              </a:rPr>
              <a:t> </a:t>
            </a:r>
            <a:endParaRPr lang="ko-KR" altLang="en-US" sz="11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BDF3143C-C4D4-45DD-A197-7B2CDEE5DA4A}"/>
              </a:ext>
            </a:extLst>
          </p:cNvPr>
          <p:cNvCxnSpPr>
            <a:cxnSpLocks/>
            <a:stCxn id="21" idx="2"/>
          </p:cNvCxnSpPr>
          <p:nvPr/>
        </p:nvCxnSpPr>
        <p:spPr>
          <a:xfrm flipH="1">
            <a:off x="2816518" y="1647385"/>
            <a:ext cx="1516311" cy="73891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BBFCA3F7-2A02-4699-82CF-4128533267A0}"/>
              </a:ext>
            </a:extLst>
          </p:cNvPr>
          <p:cNvSpPr txBox="1"/>
          <p:nvPr/>
        </p:nvSpPr>
        <p:spPr>
          <a:xfrm>
            <a:off x="1853323" y="63927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313CD48-1AD6-42DC-8828-0AFCF602E218}"/>
              </a:ext>
            </a:extLst>
          </p:cNvPr>
          <p:cNvSpPr txBox="1"/>
          <p:nvPr/>
        </p:nvSpPr>
        <p:spPr>
          <a:xfrm>
            <a:off x="1859280" y="3097326"/>
            <a:ext cx="2602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5" name="그룹 134">
            <a:extLst>
              <a:ext uri="{FF2B5EF4-FFF2-40B4-BE49-F238E27FC236}">
                <a16:creationId xmlns:a16="http://schemas.microsoft.com/office/drawing/2014/main" id="{DC2C4BB0-8F61-4739-AD24-9F1CF836A840}"/>
              </a:ext>
            </a:extLst>
          </p:cNvPr>
          <p:cNvGrpSpPr/>
          <p:nvPr/>
        </p:nvGrpSpPr>
        <p:grpSpPr>
          <a:xfrm>
            <a:off x="5281864" y="3575345"/>
            <a:ext cx="2663647" cy="2024554"/>
            <a:chOff x="992287" y="4161056"/>
            <a:chExt cx="2663647" cy="2024554"/>
          </a:xfrm>
        </p:grpSpPr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5EAEA399-C3C2-471E-9216-3B27D20F819E}"/>
                </a:ext>
              </a:extLst>
            </p:cNvPr>
            <p:cNvSpPr txBox="1"/>
            <p:nvPr/>
          </p:nvSpPr>
          <p:spPr>
            <a:xfrm>
              <a:off x="2498132" y="6019333"/>
              <a:ext cx="477695" cy="166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2" name="그룹 101">
              <a:extLst>
                <a:ext uri="{FF2B5EF4-FFF2-40B4-BE49-F238E27FC236}">
                  <a16:creationId xmlns:a16="http://schemas.microsoft.com/office/drawing/2014/main" id="{C522CBA3-E8AE-4C19-B306-DF4E229D84C7}"/>
                </a:ext>
              </a:extLst>
            </p:cNvPr>
            <p:cNvGrpSpPr/>
            <p:nvPr/>
          </p:nvGrpSpPr>
          <p:grpSpPr>
            <a:xfrm>
              <a:off x="2210268" y="4883510"/>
              <a:ext cx="1445666" cy="277877"/>
              <a:chOff x="3946746" y="2429809"/>
              <a:chExt cx="1445666" cy="257175"/>
            </a:xfrm>
          </p:grpSpPr>
          <p:grpSp>
            <p:nvGrpSpPr>
              <p:cNvPr id="104" name="그룹 103">
                <a:extLst>
                  <a:ext uri="{FF2B5EF4-FFF2-40B4-BE49-F238E27FC236}">
                    <a16:creationId xmlns:a16="http://schemas.microsoft.com/office/drawing/2014/main" id="{8638202C-72F4-413D-A489-E11893CC3EBC}"/>
                  </a:ext>
                </a:extLst>
              </p:cNvPr>
              <p:cNvGrpSpPr/>
              <p:nvPr/>
            </p:nvGrpSpPr>
            <p:grpSpPr>
              <a:xfrm>
                <a:off x="3946746" y="2465767"/>
                <a:ext cx="180000" cy="54424"/>
                <a:chOff x="3946746" y="2465768"/>
                <a:chExt cx="180000" cy="54424"/>
              </a:xfrm>
            </p:grpSpPr>
            <p:cxnSp>
              <p:nvCxnSpPr>
                <p:cNvPr id="110" name="직선 연결선 109">
                  <a:extLst>
                    <a:ext uri="{FF2B5EF4-FFF2-40B4-BE49-F238E27FC236}">
                      <a16:creationId xmlns:a16="http://schemas.microsoft.com/office/drawing/2014/main" id="{0D7AE17E-2A03-4615-ADFF-7D48173DA239}"/>
                    </a:ext>
                  </a:extLst>
                </p:cNvPr>
                <p:cNvCxnSpPr/>
                <p:nvPr/>
              </p:nvCxnSpPr>
              <p:spPr>
                <a:xfrm>
                  <a:off x="3946746" y="2492977"/>
                  <a:ext cx="180000" cy="0"/>
                </a:xfrm>
                <a:prstGeom prst="line">
                  <a:avLst/>
                </a:prstGeom>
                <a:ln w="9525" cap="rnd">
                  <a:solidFill>
                    <a:srgbClr val="008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1" name="타원 110">
                  <a:extLst>
                    <a:ext uri="{FF2B5EF4-FFF2-40B4-BE49-F238E27FC236}">
                      <a16:creationId xmlns:a16="http://schemas.microsoft.com/office/drawing/2014/main" id="{07B487B0-2390-41E8-85B7-E0CD743750F2}"/>
                    </a:ext>
                  </a:extLst>
                </p:cNvPr>
                <p:cNvSpPr/>
                <p:nvPr/>
              </p:nvSpPr>
              <p:spPr>
                <a:xfrm>
                  <a:off x="4009534" y="2465768"/>
                  <a:ext cx="54424" cy="54424"/>
                </a:xfrm>
                <a:prstGeom prst="ellipse">
                  <a:avLst/>
                </a:prstGeom>
                <a:solidFill>
                  <a:schemeClr val="bg1"/>
                </a:solidFill>
                <a:ln w="9525">
                  <a:solidFill>
                    <a:srgbClr val="008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600"/>
                </a:p>
              </p:txBody>
            </p:sp>
          </p:grpSp>
          <p:grpSp>
            <p:nvGrpSpPr>
              <p:cNvPr id="105" name="그룹 104">
                <a:extLst>
                  <a:ext uri="{FF2B5EF4-FFF2-40B4-BE49-F238E27FC236}">
                    <a16:creationId xmlns:a16="http://schemas.microsoft.com/office/drawing/2014/main" id="{07AAD0A6-1E40-4C42-9DC6-AB268F368205}"/>
                  </a:ext>
                </a:extLst>
              </p:cNvPr>
              <p:cNvGrpSpPr/>
              <p:nvPr/>
            </p:nvGrpSpPr>
            <p:grpSpPr>
              <a:xfrm>
                <a:off x="3949320" y="2600174"/>
                <a:ext cx="180000" cy="54424"/>
                <a:chOff x="3949320" y="2584097"/>
                <a:chExt cx="180000" cy="54424"/>
              </a:xfrm>
            </p:grpSpPr>
            <p:cxnSp>
              <p:nvCxnSpPr>
                <p:cNvPr id="108" name="직선 연결선 107">
                  <a:extLst>
                    <a:ext uri="{FF2B5EF4-FFF2-40B4-BE49-F238E27FC236}">
                      <a16:creationId xmlns:a16="http://schemas.microsoft.com/office/drawing/2014/main" id="{E677760E-A939-41AD-8D55-C218A2735B85}"/>
                    </a:ext>
                  </a:extLst>
                </p:cNvPr>
                <p:cNvCxnSpPr/>
                <p:nvPr/>
              </p:nvCxnSpPr>
              <p:spPr>
                <a:xfrm>
                  <a:off x="3949320" y="2611316"/>
                  <a:ext cx="180000" cy="0"/>
                </a:xfrm>
                <a:prstGeom prst="line">
                  <a:avLst/>
                </a:prstGeom>
                <a:ln w="9525" cap="rnd">
                  <a:solidFill>
                    <a:srgbClr val="008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9" name="이등변 삼각형 108">
                  <a:extLst>
                    <a:ext uri="{FF2B5EF4-FFF2-40B4-BE49-F238E27FC236}">
                      <a16:creationId xmlns:a16="http://schemas.microsoft.com/office/drawing/2014/main" id="{B4BC59F4-2122-4ED3-B9B7-B4D015329254}"/>
                    </a:ext>
                  </a:extLst>
                </p:cNvPr>
                <p:cNvSpPr/>
                <p:nvPr/>
              </p:nvSpPr>
              <p:spPr>
                <a:xfrm>
                  <a:off x="4012108" y="2584097"/>
                  <a:ext cx="54424" cy="54424"/>
                </a:xfrm>
                <a:prstGeom prst="triangle">
                  <a:avLst/>
                </a:prstGeom>
                <a:solidFill>
                  <a:srgbClr val="008000"/>
                </a:solidFill>
                <a:ln w="9525">
                  <a:solidFill>
                    <a:srgbClr val="008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600"/>
                </a:p>
              </p:txBody>
            </p:sp>
          </p:grp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E6986D39-CE0E-4FCE-8F82-06312234FADD}"/>
                  </a:ext>
                </a:extLst>
              </p:cNvPr>
              <p:cNvSpPr txBox="1"/>
              <p:nvPr/>
            </p:nvSpPr>
            <p:spPr>
              <a:xfrm>
                <a:off x="4167718" y="2573045"/>
                <a:ext cx="1224694" cy="11393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ko-KR" sz="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gtP</a:t>
                </a:r>
                <a:r>
                  <a:rPr lang="en-US" altLang="ko-KR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(-­­­­8C</a:t>
                </a:r>
                <a:r>
                  <a:rPr lang="en-US" altLang="ko-KR" sz="800" baseline="300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</a:t>
                </a:r>
                <a:r>
                  <a:rPr lang="en-US" altLang="ko-KR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T)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~</a:t>
                </a:r>
                <a:r>
                  <a:rPr lang="en-US" altLang="ko-KR" sz="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fgfp</a:t>
                </a:r>
                <a:r>
                  <a:rPr lang="en-US" altLang="ko-KR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HK1022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BCF6C263-C458-4BF9-9198-1C2080798890}"/>
                  </a:ext>
                </a:extLst>
              </p:cNvPr>
              <p:cNvSpPr txBox="1"/>
              <p:nvPr/>
            </p:nvSpPr>
            <p:spPr>
              <a:xfrm>
                <a:off x="4167718" y="2429809"/>
                <a:ext cx="1065997" cy="11393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ko-KR" sz="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gtP</a:t>
                </a:r>
                <a:r>
                  <a:rPr lang="en-US" altLang="ko-KR" sz="8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altLang="ko-K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~</a:t>
                </a:r>
                <a:r>
                  <a:rPr lang="en-US" altLang="ko-KR" sz="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fgfp</a:t>
                </a:r>
                <a:r>
                  <a:rPr lang="en-US" altLang="ko-KR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HK1020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C0275CF9-4ADC-480B-A16B-0CD1B5D14781}"/>
                </a:ext>
              </a:extLst>
            </p:cNvPr>
            <p:cNvSpPr txBox="1"/>
            <p:nvPr/>
          </p:nvSpPr>
          <p:spPr>
            <a:xfrm rot="16200000">
              <a:off x="383337" y="4770006"/>
              <a:ext cx="1371788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Fluorescence Intensity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3" name="TextBox 112">
            <a:extLst>
              <a:ext uri="{FF2B5EF4-FFF2-40B4-BE49-F238E27FC236}">
                <a16:creationId xmlns:a16="http://schemas.microsoft.com/office/drawing/2014/main" id="{2D84B18A-912B-4FCA-A3DA-28E3B77066F1}"/>
              </a:ext>
            </a:extLst>
          </p:cNvPr>
          <p:cNvSpPr txBox="1"/>
          <p:nvPr/>
        </p:nvSpPr>
        <p:spPr>
          <a:xfrm>
            <a:off x="5020220" y="3026930"/>
            <a:ext cx="332142" cy="3658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C7717B71-F338-43E9-91C2-55763CEEFA36}"/>
              </a:ext>
            </a:extLst>
          </p:cNvPr>
          <p:cNvSpPr txBox="1"/>
          <p:nvPr/>
        </p:nvSpPr>
        <p:spPr>
          <a:xfrm>
            <a:off x="6869308" y="1773053"/>
            <a:ext cx="1063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Open Sans Semibold" panose="020B0706030804020204" pitchFamily="34" charset="0"/>
                <a:cs typeface="Arial" panose="020B0604020202020204" pitchFamily="34" charset="0"/>
              </a:rPr>
              <a:t>Chr. of HK102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2" name="그룹 121">
            <a:extLst>
              <a:ext uri="{FF2B5EF4-FFF2-40B4-BE49-F238E27FC236}">
                <a16:creationId xmlns:a16="http://schemas.microsoft.com/office/drawing/2014/main" id="{886ED663-A702-4405-B970-7EA509EFE9FA}"/>
              </a:ext>
            </a:extLst>
          </p:cNvPr>
          <p:cNvGrpSpPr/>
          <p:nvPr/>
        </p:nvGrpSpPr>
        <p:grpSpPr>
          <a:xfrm>
            <a:off x="2158472" y="3753907"/>
            <a:ext cx="1899631" cy="1825862"/>
            <a:chOff x="7761409" y="830833"/>
            <a:chExt cx="1899631" cy="1825862"/>
          </a:xfrm>
        </p:grpSpPr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7D925AFB-6AD4-470F-8F39-DF6B5B481B79}"/>
                </a:ext>
              </a:extLst>
            </p:cNvPr>
            <p:cNvSpPr txBox="1"/>
            <p:nvPr/>
          </p:nvSpPr>
          <p:spPr>
            <a:xfrm>
              <a:off x="9183345" y="2502807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0C111B88-0C16-49CB-A41E-95B0F12AD068}"/>
                </a:ext>
              </a:extLst>
            </p:cNvPr>
            <p:cNvSpPr txBox="1"/>
            <p:nvPr/>
          </p:nvSpPr>
          <p:spPr>
            <a:xfrm rot="16200000">
              <a:off x="7230013" y="1362229"/>
              <a:ext cx="121668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ell growth 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3" name="그룹 132">
            <a:extLst>
              <a:ext uri="{FF2B5EF4-FFF2-40B4-BE49-F238E27FC236}">
                <a16:creationId xmlns:a16="http://schemas.microsoft.com/office/drawing/2014/main" id="{C8966FE8-17FE-4B7C-8FA2-27ACC9C4906B}"/>
              </a:ext>
            </a:extLst>
          </p:cNvPr>
          <p:cNvGrpSpPr/>
          <p:nvPr/>
        </p:nvGrpSpPr>
        <p:grpSpPr>
          <a:xfrm>
            <a:off x="2626821" y="3489653"/>
            <a:ext cx="722079" cy="466385"/>
            <a:chOff x="9183921" y="3975578"/>
            <a:chExt cx="722079" cy="466385"/>
          </a:xfrm>
        </p:grpSpPr>
        <p:grpSp>
          <p:nvGrpSpPr>
            <p:cNvPr id="79" name="그룹 78">
              <a:extLst>
                <a:ext uri="{FF2B5EF4-FFF2-40B4-BE49-F238E27FC236}">
                  <a16:creationId xmlns:a16="http://schemas.microsoft.com/office/drawing/2014/main" id="{22C1B609-F20E-4005-BACB-C335568994B5}"/>
                </a:ext>
              </a:extLst>
            </p:cNvPr>
            <p:cNvGrpSpPr/>
            <p:nvPr/>
          </p:nvGrpSpPr>
          <p:grpSpPr>
            <a:xfrm>
              <a:off x="9183921" y="4122175"/>
              <a:ext cx="180000" cy="54424"/>
              <a:chOff x="4252839" y="2312540"/>
              <a:chExt cx="180000" cy="54424"/>
            </a:xfrm>
          </p:grpSpPr>
          <p:cxnSp>
            <p:nvCxnSpPr>
              <p:cNvPr id="85" name="직선 연결선 84">
                <a:extLst>
                  <a:ext uri="{FF2B5EF4-FFF2-40B4-BE49-F238E27FC236}">
                    <a16:creationId xmlns:a16="http://schemas.microsoft.com/office/drawing/2014/main" id="{7E35FBF8-2E23-4640-92D0-0318EE72F0DA}"/>
                  </a:ext>
                </a:extLst>
              </p:cNvPr>
              <p:cNvCxnSpPr/>
              <p:nvPr/>
            </p:nvCxnSpPr>
            <p:spPr>
              <a:xfrm>
                <a:off x="4252839" y="2339752"/>
                <a:ext cx="180000" cy="0"/>
              </a:xfrm>
              <a:prstGeom prst="line">
                <a:avLst/>
              </a:prstGeom>
              <a:ln w="9525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타원 85">
                <a:extLst>
                  <a:ext uri="{FF2B5EF4-FFF2-40B4-BE49-F238E27FC236}">
                    <a16:creationId xmlns:a16="http://schemas.microsoft.com/office/drawing/2014/main" id="{78A39699-A249-45F4-95DF-42B244A31953}"/>
                  </a:ext>
                </a:extLst>
              </p:cNvPr>
              <p:cNvSpPr/>
              <p:nvPr/>
            </p:nvSpPr>
            <p:spPr>
              <a:xfrm>
                <a:off x="4315627" y="2312540"/>
                <a:ext cx="54424" cy="54424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grpSp>
          <p:nvGrpSpPr>
            <p:cNvPr id="80" name="그룹 79">
              <a:extLst>
                <a:ext uri="{FF2B5EF4-FFF2-40B4-BE49-F238E27FC236}">
                  <a16:creationId xmlns:a16="http://schemas.microsoft.com/office/drawing/2014/main" id="{50EB3DBF-B7A8-46D0-A4FF-4B7FDD4A0DFE}"/>
                </a:ext>
              </a:extLst>
            </p:cNvPr>
            <p:cNvGrpSpPr/>
            <p:nvPr/>
          </p:nvGrpSpPr>
          <p:grpSpPr>
            <a:xfrm>
              <a:off x="9183921" y="4235596"/>
              <a:ext cx="180000" cy="54424"/>
              <a:chOff x="4255413" y="2439686"/>
              <a:chExt cx="180000" cy="54424"/>
            </a:xfrm>
          </p:grpSpPr>
          <p:cxnSp>
            <p:nvCxnSpPr>
              <p:cNvPr id="83" name="직선 연결선 82">
                <a:extLst>
                  <a:ext uri="{FF2B5EF4-FFF2-40B4-BE49-F238E27FC236}">
                    <a16:creationId xmlns:a16="http://schemas.microsoft.com/office/drawing/2014/main" id="{B1DB7715-FAF0-4B35-AD78-853F99581B8A}"/>
                  </a:ext>
                </a:extLst>
              </p:cNvPr>
              <p:cNvCxnSpPr/>
              <p:nvPr/>
            </p:nvCxnSpPr>
            <p:spPr>
              <a:xfrm>
                <a:off x="4255413" y="2466898"/>
                <a:ext cx="180000" cy="0"/>
              </a:xfrm>
              <a:prstGeom prst="line">
                <a:avLst/>
              </a:prstGeom>
              <a:ln w="9525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이등변 삼각형 83">
                <a:extLst>
                  <a:ext uri="{FF2B5EF4-FFF2-40B4-BE49-F238E27FC236}">
                    <a16:creationId xmlns:a16="http://schemas.microsoft.com/office/drawing/2014/main" id="{36777BB6-E564-4EAE-B8B2-30F197D66E9B}"/>
                  </a:ext>
                </a:extLst>
              </p:cNvPr>
              <p:cNvSpPr/>
              <p:nvPr/>
            </p:nvSpPr>
            <p:spPr>
              <a:xfrm>
                <a:off x="4318201" y="2439686"/>
                <a:ext cx="54424" cy="5442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8834E0F3-DAA5-4413-9B13-C310109FC6EB}"/>
                </a:ext>
              </a:extLst>
            </p:cNvPr>
            <p:cNvSpPr txBox="1"/>
            <p:nvPr/>
          </p:nvSpPr>
          <p:spPr>
            <a:xfrm>
              <a:off x="9396245" y="4202047"/>
              <a:ext cx="31579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K56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B0439054-9626-4C0D-8F0B-8E4445EEF635}"/>
                </a:ext>
              </a:extLst>
            </p:cNvPr>
            <p:cNvSpPr txBox="1"/>
            <p:nvPr/>
          </p:nvSpPr>
          <p:spPr>
            <a:xfrm>
              <a:off x="9396245" y="4085241"/>
              <a:ext cx="37350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K102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3" name="그룹 122">
              <a:extLst>
                <a:ext uri="{FF2B5EF4-FFF2-40B4-BE49-F238E27FC236}">
                  <a16:creationId xmlns:a16="http://schemas.microsoft.com/office/drawing/2014/main" id="{1F9A9863-2857-4D61-B260-67E85FCAFB21}"/>
                </a:ext>
              </a:extLst>
            </p:cNvPr>
            <p:cNvGrpSpPr/>
            <p:nvPr/>
          </p:nvGrpSpPr>
          <p:grpSpPr>
            <a:xfrm>
              <a:off x="9183921" y="4011720"/>
              <a:ext cx="180000" cy="54424"/>
              <a:chOff x="4252839" y="2312540"/>
              <a:chExt cx="180000" cy="54424"/>
            </a:xfrm>
          </p:grpSpPr>
          <p:cxnSp>
            <p:nvCxnSpPr>
              <p:cNvPr id="124" name="직선 연결선 123">
                <a:extLst>
                  <a:ext uri="{FF2B5EF4-FFF2-40B4-BE49-F238E27FC236}">
                    <a16:creationId xmlns:a16="http://schemas.microsoft.com/office/drawing/2014/main" id="{BAC5B0FB-16F0-4A9C-A1EE-0193986B2CC8}"/>
                  </a:ext>
                </a:extLst>
              </p:cNvPr>
              <p:cNvCxnSpPr/>
              <p:nvPr/>
            </p:nvCxnSpPr>
            <p:spPr>
              <a:xfrm>
                <a:off x="4252839" y="2339752"/>
                <a:ext cx="180000" cy="0"/>
              </a:xfrm>
              <a:prstGeom prst="line">
                <a:avLst/>
              </a:prstGeom>
              <a:ln w="9525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5" name="타원 124">
                <a:extLst>
                  <a:ext uri="{FF2B5EF4-FFF2-40B4-BE49-F238E27FC236}">
                    <a16:creationId xmlns:a16="http://schemas.microsoft.com/office/drawing/2014/main" id="{051FE393-835B-4C9B-85B3-39DEF27AA89D}"/>
                  </a:ext>
                </a:extLst>
              </p:cNvPr>
              <p:cNvSpPr/>
              <p:nvPr/>
            </p:nvSpPr>
            <p:spPr>
              <a:xfrm>
                <a:off x="4315627" y="2312540"/>
                <a:ext cx="54424" cy="54424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67800364-B429-46E6-87F1-17090C3545F3}"/>
                </a:ext>
              </a:extLst>
            </p:cNvPr>
            <p:cNvSpPr txBox="1"/>
            <p:nvPr/>
          </p:nvSpPr>
          <p:spPr>
            <a:xfrm>
              <a:off x="9396245" y="3975578"/>
              <a:ext cx="509755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BL21(DE3)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7" name="그룹 126">
              <a:extLst>
                <a:ext uri="{FF2B5EF4-FFF2-40B4-BE49-F238E27FC236}">
                  <a16:creationId xmlns:a16="http://schemas.microsoft.com/office/drawing/2014/main" id="{E2BCF99B-4C48-4B55-8E2B-008FA121F6BF}"/>
                </a:ext>
              </a:extLst>
            </p:cNvPr>
            <p:cNvGrpSpPr/>
            <p:nvPr/>
          </p:nvGrpSpPr>
          <p:grpSpPr>
            <a:xfrm>
              <a:off x="9183921" y="4353195"/>
              <a:ext cx="180000" cy="54424"/>
              <a:chOff x="4255413" y="2439686"/>
              <a:chExt cx="180000" cy="54424"/>
            </a:xfrm>
          </p:grpSpPr>
          <p:cxnSp>
            <p:nvCxnSpPr>
              <p:cNvPr id="128" name="직선 연결선 127">
                <a:extLst>
                  <a:ext uri="{FF2B5EF4-FFF2-40B4-BE49-F238E27FC236}">
                    <a16:creationId xmlns:a16="http://schemas.microsoft.com/office/drawing/2014/main" id="{6B1D330D-D8C1-4EE7-BA00-73528A656781}"/>
                  </a:ext>
                </a:extLst>
              </p:cNvPr>
              <p:cNvCxnSpPr/>
              <p:nvPr/>
            </p:nvCxnSpPr>
            <p:spPr>
              <a:xfrm>
                <a:off x="4255413" y="2466898"/>
                <a:ext cx="180000" cy="0"/>
              </a:xfrm>
              <a:prstGeom prst="line">
                <a:avLst/>
              </a:prstGeom>
              <a:ln w="9525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이등변 삼각형 128">
                <a:extLst>
                  <a:ext uri="{FF2B5EF4-FFF2-40B4-BE49-F238E27FC236}">
                    <a16:creationId xmlns:a16="http://schemas.microsoft.com/office/drawing/2014/main" id="{44C638B1-7072-42C3-BA9B-9907FEECE46A}"/>
                  </a:ext>
                </a:extLst>
              </p:cNvPr>
              <p:cNvSpPr/>
              <p:nvPr/>
            </p:nvSpPr>
            <p:spPr>
              <a:xfrm>
                <a:off x="4318201" y="2439686"/>
                <a:ext cx="54424" cy="54424"/>
              </a:xfrm>
              <a:prstGeom prst="triangl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A2AEAEBD-001A-43A8-BEF8-7EB671B1B66E}"/>
                </a:ext>
              </a:extLst>
            </p:cNvPr>
            <p:cNvSpPr txBox="1"/>
            <p:nvPr/>
          </p:nvSpPr>
          <p:spPr>
            <a:xfrm>
              <a:off x="9396245" y="4318852"/>
              <a:ext cx="37350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K1022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0" name="사각형: 둥근 모서리 4">
            <a:extLst>
              <a:ext uri="{FF2B5EF4-FFF2-40B4-BE49-F238E27FC236}">
                <a16:creationId xmlns:a16="http://schemas.microsoft.com/office/drawing/2014/main" id="{9D560FC9-331B-4000-ADA1-42EA0EF7B314}"/>
              </a:ext>
            </a:extLst>
          </p:cNvPr>
          <p:cNvSpPr/>
          <p:nvPr/>
        </p:nvSpPr>
        <p:spPr>
          <a:xfrm>
            <a:off x="2725010" y="1270124"/>
            <a:ext cx="664703" cy="480040"/>
          </a:xfrm>
          <a:prstGeom prst="rightArrow">
            <a:avLst>
              <a:gd name="adj1" fmla="val 50000"/>
              <a:gd name="adj2" fmla="val 76645"/>
            </a:avLst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188E82F7-A022-4B17-A1BE-F4A58AE600FE}"/>
              </a:ext>
            </a:extLst>
          </p:cNvPr>
          <p:cNvSpPr txBox="1"/>
          <p:nvPr/>
        </p:nvSpPr>
        <p:spPr>
          <a:xfrm>
            <a:off x="2772574" y="1382892"/>
            <a:ext cx="4251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i="1" dirty="0" err="1">
                <a:latin typeface="Arial" panose="020B0604020202020204" pitchFamily="34" charset="0"/>
                <a:ea typeface="Open Sans Semibold" panose="020B0706030804020204" pitchFamily="34" charset="0"/>
                <a:cs typeface="Arial" panose="020B0604020202020204" pitchFamily="34" charset="0"/>
              </a:rPr>
              <a:t>rrfG</a:t>
            </a:r>
            <a:endParaRPr lang="ko-KR" altLang="en-US" sz="11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개체 18">
            <a:extLst>
              <a:ext uri="{FF2B5EF4-FFF2-40B4-BE49-F238E27FC236}">
                <a16:creationId xmlns:a16="http://schemas.microsoft.com/office/drawing/2014/main" id="{EBFEECCB-E140-4FFA-8861-A5EB07E206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9042722"/>
              </p:ext>
            </p:extLst>
          </p:nvPr>
        </p:nvGraphicFramePr>
        <p:xfrm>
          <a:off x="2370542" y="3318036"/>
          <a:ext cx="2753766" cy="21416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25" name="Graph" r:id="rId3" imgW="3291840" imgH="2560320" progId="Origin50.Graph">
                  <p:embed/>
                </p:oleObj>
              </mc:Choice>
              <mc:Fallback>
                <p:oleObj name="Graph" r:id="rId3" imgW="3291840" imgH="2560320" progId="Origin50.Graph">
                  <p:embed/>
                  <p:pic>
                    <p:nvPicPr>
                      <p:cNvPr id="19" name="개체 18">
                        <a:extLst>
                          <a:ext uri="{FF2B5EF4-FFF2-40B4-BE49-F238E27FC236}">
                            <a16:creationId xmlns:a16="http://schemas.microsoft.com/office/drawing/2014/main" id="{EBFEECCB-E140-4FFA-8861-A5EB07E206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70542" y="3318036"/>
                        <a:ext cx="2753766" cy="21416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5" name="개체 74">
            <a:extLst>
              <a:ext uri="{FF2B5EF4-FFF2-40B4-BE49-F238E27FC236}">
                <a16:creationId xmlns:a16="http://schemas.microsoft.com/office/drawing/2014/main" id="{A016FACD-5627-435C-A04F-CD7373D7EF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9606909"/>
              </p:ext>
            </p:extLst>
          </p:nvPr>
        </p:nvGraphicFramePr>
        <p:xfrm>
          <a:off x="5431265" y="3318036"/>
          <a:ext cx="2884807" cy="21257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26" name="Graph" r:id="rId5" imgW="3474720" imgH="2560320" progId="Origin50.Graph">
                  <p:embed/>
                </p:oleObj>
              </mc:Choice>
              <mc:Fallback>
                <p:oleObj name="Graph" r:id="rId5" imgW="3474720" imgH="2560320" progId="Origin50.Graph">
                  <p:embed/>
                  <p:pic>
                    <p:nvPicPr>
                      <p:cNvPr id="75" name="개체 74">
                        <a:extLst>
                          <a:ext uri="{FF2B5EF4-FFF2-40B4-BE49-F238E27FC236}">
                            <a16:creationId xmlns:a16="http://schemas.microsoft.com/office/drawing/2014/main" id="{A016FACD-5627-435C-A04F-CD7373D7EF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431265" y="3318036"/>
                        <a:ext cx="2884807" cy="21257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2" name="사각형: 둥근 모서리 4">
            <a:extLst>
              <a:ext uri="{FF2B5EF4-FFF2-40B4-BE49-F238E27FC236}">
                <a16:creationId xmlns:a16="http://schemas.microsoft.com/office/drawing/2014/main" id="{7539A8B7-619F-4A3B-9A7A-45BC1C35DE90}"/>
              </a:ext>
            </a:extLst>
          </p:cNvPr>
          <p:cNvSpPr/>
          <p:nvPr/>
        </p:nvSpPr>
        <p:spPr>
          <a:xfrm flipH="1">
            <a:off x="6884322" y="1264058"/>
            <a:ext cx="885928" cy="480040"/>
          </a:xfrm>
          <a:prstGeom prst="rightArrow">
            <a:avLst>
              <a:gd name="adj1" fmla="val 50000"/>
              <a:gd name="adj2" fmla="val 76645"/>
            </a:avLst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653424D8-9D23-4348-877C-30372063B69E}"/>
              </a:ext>
            </a:extLst>
          </p:cNvPr>
          <p:cNvSpPr txBox="1"/>
          <p:nvPr/>
        </p:nvSpPr>
        <p:spPr>
          <a:xfrm flipH="1">
            <a:off x="7035342" y="1363715"/>
            <a:ext cx="6601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ssA</a:t>
            </a:r>
            <a:endParaRPr lang="ko-KR" altLang="en-US" sz="11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3115475" y="3218435"/>
            <a:ext cx="1282402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M9 succinate (0.3%)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6348283" y="3218435"/>
            <a:ext cx="1282402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M9 succinate (0.3%)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623139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2B3489F0-86C0-48CF-8D41-77B013D671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5402267"/>
              </p:ext>
            </p:extLst>
          </p:nvPr>
        </p:nvGraphicFramePr>
        <p:xfrm>
          <a:off x="3575905" y="2057717"/>
          <a:ext cx="2754190" cy="214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88" name="Graph" r:id="rId3" imgW="3291840" imgH="2560320" progId="Origin50.Graph">
                  <p:embed/>
                </p:oleObj>
              </mc:Choice>
              <mc:Fallback>
                <p:oleObj name="Graph" r:id="rId3" imgW="3291840" imgH="2560320" progId="Origin50.Graph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8C4020C3-4582-4207-8135-F6DCE8541EE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75905" y="2057717"/>
                        <a:ext cx="2754190" cy="214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" name="그룹 2">
            <a:extLst>
              <a:ext uri="{FF2B5EF4-FFF2-40B4-BE49-F238E27FC236}">
                <a16:creationId xmlns:a16="http://schemas.microsoft.com/office/drawing/2014/main" id="{50EB5589-584E-424D-A1CB-67E34FAB338B}"/>
              </a:ext>
            </a:extLst>
          </p:cNvPr>
          <p:cNvGrpSpPr/>
          <p:nvPr/>
        </p:nvGrpSpPr>
        <p:grpSpPr>
          <a:xfrm>
            <a:off x="3402668" y="2701686"/>
            <a:ext cx="1899631" cy="1594228"/>
            <a:chOff x="7761409" y="1062467"/>
            <a:chExt cx="1899631" cy="1594228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6EA97F9-0F58-42F4-828F-AF7EAB3404F8}"/>
                </a:ext>
              </a:extLst>
            </p:cNvPr>
            <p:cNvSpPr txBox="1"/>
            <p:nvPr/>
          </p:nvSpPr>
          <p:spPr>
            <a:xfrm>
              <a:off x="9183345" y="2502807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513F021-A1F0-484A-A37E-2230168E710A}"/>
                </a:ext>
              </a:extLst>
            </p:cNvPr>
            <p:cNvSpPr txBox="1"/>
            <p:nvPr/>
          </p:nvSpPr>
          <p:spPr>
            <a:xfrm rot="16200000">
              <a:off x="7461647" y="1362229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그룹 5">
            <a:extLst>
              <a:ext uri="{FF2B5EF4-FFF2-40B4-BE49-F238E27FC236}">
                <a16:creationId xmlns:a16="http://schemas.microsoft.com/office/drawing/2014/main" id="{5E57F8D8-DE86-4076-94D1-119AACBC96D2}"/>
              </a:ext>
            </a:extLst>
          </p:cNvPr>
          <p:cNvGrpSpPr/>
          <p:nvPr/>
        </p:nvGrpSpPr>
        <p:grpSpPr>
          <a:xfrm>
            <a:off x="3871017" y="2205798"/>
            <a:ext cx="722079" cy="466385"/>
            <a:chOff x="9183921" y="3975578"/>
            <a:chExt cx="722079" cy="466385"/>
          </a:xfrm>
        </p:grpSpPr>
        <p:grpSp>
          <p:nvGrpSpPr>
            <p:cNvPr id="7" name="그룹 6">
              <a:extLst>
                <a:ext uri="{FF2B5EF4-FFF2-40B4-BE49-F238E27FC236}">
                  <a16:creationId xmlns:a16="http://schemas.microsoft.com/office/drawing/2014/main" id="{6C453F66-550D-4CB5-B8F1-1168ADA29FA3}"/>
                </a:ext>
              </a:extLst>
            </p:cNvPr>
            <p:cNvGrpSpPr/>
            <p:nvPr/>
          </p:nvGrpSpPr>
          <p:grpSpPr>
            <a:xfrm>
              <a:off x="9183921" y="4122175"/>
              <a:ext cx="180000" cy="54424"/>
              <a:chOff x="4252839" y="2312540"/>
              <a:chExt cx="180000" cy="54424"/>
            </a:xfrm>
          </p:grpSpPr>
          <p:cxnSp>
            <p:nvCxnSpPr>
              <p:cNvPr id="21" name="직선 연결선 20">
                <a:extLst>
                  <a:ext uri="{FF2B5EF4-FFF2-40B4-BE49-F238E27FC236}">
                    <a16:creationId xmlns:a16="http://schemas.microsoft.com/office/drawing/2014/main" id="{7E8AEFC4-4C40-4CB1-934D-BADD1C57A676}"/>
                  </a:ext>
                </a:extLst>
              </p:cNvPr>
              <p:cNvCxnSpPr/>
              <p:nvPr/>
            </p:nvCxnSpPr>
            <p:spPr>
              <a:xfrm>
                <a:off x="4252839" y="2339752"/>
                <a:ext cx="180000" cy="0"/>
              </a:xfrm>
              <a:prstGeom prst="line">
                <a:avLst/>
              </a:prstGeom>
              <a:ln w="9525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타원 21">
                <a:extLst>
                  <a:ext uri="{FF2B5EF4-FFF2-40B4-BE49-F238E27FC236}">
                    <a16:creationId xmlns:a16="http://schemas.microsoft.com/office/drawing/2014/main" id="{05398BF7-95BA-48D1-B2A4-1D82B883C67A}"/>
                  </a:ext>
                </a:extLst>
              </p:cNvPr>
              <p:cNvSpPr/>
              <p:nvPr/>
            </p:nvSpPr>
            <p:spPr>
              <a:xfrm>
                <a:off x="4315627" y="2312540"/>
                <a:ext cx="54424" cy="54424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9944E836-1014-4837-A0BE-245974CE0E00}"/>
                </a:ext>
              </a:extLst>
            </p:cNvPr>
            <p:cNvGrpSpPr/>
            <p:nvPr/>
          </p:nvGrpSpPr>
          <p:grpSpPr>
            <a:xfrm>
              <a:off x="9183921" y="4235596"/>
              <a:ext cx="180000" cy="54424"/>
              <a:chOff x="4255413" y="2439686"/>
              <a:chExt cx="180000" cy="54424"/>
            </a:xfrm>
          </p:grpSpPr>
          <p:cxnSp>
            <p:nvCxnSpPr>
              <p:cNvPr id="19" name="직선 연결선 18">
                <a:extLst>
                  <a:ext uri="{FF2B5EF4-FFF2-40B4-BE49-F238E27FC236}">
                    <a16:creationId xmlns:a16="http://schemas.microsoft.com/office/drawing/2014/main" id="{0D147AD7-7A51-4413-8A6B-E2FB331CEA83}"/>
                  </a:ext>
                </a:extLst>
              </p:cNvPr>
              <p:cNvCxnSpPr/>
              <p:nvPr/>
            </p:nvCxnSpPr>
            <p:spPr>
              <a:xfrm>
                <a:off x="4255413" y="2466898"/>
                <a:ext cx="180000" cy="0"/>
              </a:xfrm>
              <a:prstGeom prst="line">
                <a:avLst/>
              </a:prstGeom>
              <a:ln w="9525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이등변 삼각형 19">
                <a:extLst>
                  <a:ext uri="{FF2B5EF4-FFF2-40B4-BE49-F238E27FC236}">
                    <a16:creationId xmlns:a16="http://schemas.microsoft.com/office/drawing/2014/main" id="{348DC970-6206-4717-B193-C01BA7B570C7}"/>
                  </a:ext>
                </a:extLst>
              </p:cNvPr>
              <p:cNvSpPr/>
              <p:nvPr/>
            </p:nvSpPr>
            <p:spPr>
              <a:xfrm>
                <a:off x="4318201" y="2439686"/>
                <a:ext cx="54424" cy="5442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5306010-4320-4650-9D6F-8874AE37B888}"/>
                </a:ext>
              </a:extLst>
            </p:cNvPr>
            <p:cNvSpPr txBox="1"/>
            <p:nvPr/>
          </p:nvSpPr>
          <p:spPr>
            <a:xfrm>
              <a:off x="9396245" y="4202047"/>
              <a:ext cx="31579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K56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182992B-480D-40FD-BBE7-5814B46AA484}"/>
                </a:ext>
              </a:extLst>
            </p:cNvPr>
            <p:cNvSpPr txBox="1"/>
            <p:nvPr/>
          </p:nvSpPr>
          <p:spPr>
            <a:xfrm>
              <a:off x="9396245" y="4085241"/>
              <a:ext cx="37350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K102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그룹 10">
              <a:extLst>
                <a:ext uri="{FF2B5EF4-FFF2-40B4-BE49-F238E27FC236}">
                  <a16:creationId xmlns:a16="http://schemas.microsoft.com/office/drawing/2014/main" id="{2D226607-A8EE-4655-B216-B1E731BD72F5}"/>
                </a:ext>
              </a:extLst>
            </p:cNvPr>
            <p:cNvGrpSpPr/>
            <p:nvPr/>
          </p:nvGrpSpPr>
          <p:grpSpPr>
            <a:xfrm>
              <a:off x="9183921" y="4011720"/>
              <a:ext cx="180000" cy="54424"/>
              <a:chOff x="4252839" y="2312540"/>
              <a:chExt cx="180000" cy="54424"/>
            </a:xfrm>
          </p:grpSpPr>
          <p:cxnSp>
            <p:nvCxnSpPr>
              <p:cNvPr id="17" name="직선 연결선 16">
                <a:extLst>
                  <a:ext uri="{FF2B5EF4-FFF2-40B4-BE49-F238E27FC236}">
                    <a16:creationId xmlns:a16="http://schemas.microsoft.com/office/drawing/2014/main" id="{CE2B57D1-B258-4CE3-BA77-4963871789FF}"/>
                  </a:ext>
                </a:extLst>
              </p:cNvPr>
              <p:cNvCxnSpPr/>
              <p:nvPr/>
            </p:nvCxnSpPr>
            <p:spPr>
              <a:xfrm>
                <a:off x="4252839" y="2339752"/>
                <a:ext cx="180000" cy="0"/>
              </a:xfrm>
              <a:prstGeom prst="line">
                <a:avLst/>
              </a:prstGeom>
              <a:ln w="9525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타원 17">
                <a:extLst>
                  <a:ext uri="{FF2B5EF4-FFF2-40B4-BE49-F238E27FC236}">
                    <a16:creationId xmlns:a16="http://schemas.microsoft.com/office/drawing/2014/main" id="{5A3AAD33-BB0A-468B-8C01-4A3008A9463D}"/>
                  </a:ext>
                </a:extLst>
              </p:cNvPr>
              <p:cNvSpPr/>
              <p:nvPr/>
            </p:nvSpPr>
            <p:spPr>
              <a:xfrm>
                <a:off x="4315627" y="2312540"/>
                <a:ext cx="54424" cy="54424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6042F3D-3043-4929-A468-E40A7E2054B0}"/>
                </a:ext>
              </a:extLst>
            </p:cNvPr>
            <p:cNvSpPr txBox="1"/>
            <p:nvPr/>
          </p:nvSpPr>
          <p:spPr>
            <a:xfrm>
              <a:off x="9396245" y="3975578"/>
              <a:ext cx="509755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BL21(DE3)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그룹 12">
              <a:extLst>
                <a:ext uri="{FF2B5EF4-FFF2-40B4-BE49-F238E27FC236}">
                  <a16:creationId xmlns:a16="http://schemas.microsoft.com/office/drawing/2014/main" id="{7A55EDF1-EF70-467D-9BDD-396EF65691E5}"/>
                </a:ext>
              </a:extLst>
            </p:cNvPr>
            <p:cNvGrpSpPr/>
            <p:nvPr/>
          </p:nvGrpSpPr>
          <p:grpSpPr>
            <a:xfrm>
              <a:off x="9183921" y="4353195"/>
              <a:ext cx="180000" cy="54424"/>
              <a:chOff x="4255413" y="2439686"/>
              <a:chExt cx="180000" cy="54424"/>
            </a:xfrm>
          </p:grpSpPr>
          <p:cxnSp>
            <p:nvCxnSpPr>
              <p:cNvPr id="15" name="직선 연결선 14">
                <a:extLst>
                  <a:ext uri="{FF2B5EF4-FFF2-40B4-BE49-F238E27FC236}">
                    <a16:creationId xmlns:a16="http://schemas.microsoft.com/office/drawing/2014/main" id="{0B46A586-E95D-4D1A-8E79-710947C0F91C}"/>
                  </a:ext>
                </a:extLst>
              </p:cNvPr>
              <p:cNvCxnSpPr/>
              <p:nvPr/>
            </p:nvCxnSpPr>
            <p:spPr>
              <a:xfrm>
                <a:off x="4255413" y="2466898"/>
                <a:ext cx="180000" cy="0"/>
              </a:xfrm>
              <a:prstGeom prst="line">
                <a:avLst/>
              </a:prstGeom>
              <a:ln w="9525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이등변 삼각형 15">
                <a:extLst>
                  <a:ext uri="{FF2B5EF4-FFF2-40B4-BE49-F238E27FC236}">
                    <a16:creationId xmlns:a16="http://schemas.microsoft.com/office/drawing/2014/main" id="{D10703A2-D17D-4601-885A-DAC738F8B6D7}"/>
                  </a:ext>
                </a:extLst>
              </p:cNvPr>
              <p:cNvSpPr/>
              <p:nvPr/>
            </p:nvSpPr>
            <p:spPr>
              <a:xfrm>
                <a:off x="4318201" y="2439686"/>
                <a:ext cx="54424" cy="54424"/>
              </a:xfrm>
              <a:prstGeom prst="triangl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/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67A7FDA-072B-40DA-B6FB-C4137191E1C7}"/>
                </a:ext>
              </a:extLst>
            </p:cNvPr>
            <p:cNvSpPr txBox="1"/>
            <p:nvPr/>
          </p:nvSpPr>
          <p:spPr>
            <a:xfrm>
              <a:off x="9396245" y="4318852"/>
              <a:ext cx="37350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K1022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A47F9B88-13F2-44D4-BE7D-48EC3BDB12C2}"/>
              </a:ext>
            </a:extLst>
          </p:cNvPr>
          <p:cNvSpPr txBox="1"/>
          <p:nvPr/>
        </p:nvSpPr>
        <p:spPr>
          <a:xfrm>
            <a:off x="4359671" y="1934580"/>
            <a:ext cx="1282402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M9 succinate (0.3%)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71A349A8-739B-4697-A819-4B77491A2512}"/>
              </a:ext>
            </a:extLst>
          </p:cNvPr>
          <p:cNvGrpSpPr/>
          <p:nvPr/>
        </p:nvGrpSpPr>
        <p:grpSpPr>
          <a:xfrm>
            <a:off x="3530435" y="2057717"/>
            <a:ext cx="224420" cy="1986223"/>
            <a:chOff x="2231375" y="244499"/>
            <a:chExt cx="224420" cy="1723225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95C1532-D393-401F-9C76-3A1CA9B865DC}"/>
                </a:ext>
              </a:extLst>
            </p:cNvPr>
            <p:cNvSpPr txBox="1"/>
            <p:nvPr/>
          </p:nvSpPr>
          <p:spPr>
            <a:xfrm>
              <a:off x="2306043" y="244499"/>
              <a:ext cx="12824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FB9EA06-9B1D-4E84-8103-B842F5009744}"/>
                </a:ext>
              </a:extLst>
            </p:cNvPr>
            <p:cNvSpPr txBox="1"/>
            <p:nvPr/>
          </p:nvSpPr>
          <p:spPr>
            <a:xfrm>
              <a:off x="2368425" y="778087"/>
              <a:ext cx="641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436B47B-5E7D-4D4D-B1D6-21CC46A1BC4F}"/>
                </a:ext>
              </a:extLst>
            </p:cNvPr>
            <p:cNvSpPr txBox="1"/>
            <p:nvPr/>
          </p:nvSpPr>
          <p:spPr>
            <a:xfrm>
              <a:off x="2291616" y="1310912"/>
              <a:ext cx="16030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7FCF222-9A98-4E10-84CD-079896BF0989}"/>
                </a:ext>
              </a:extLst>
            </p:cNvPr>
            <p:cNvSpPr txBox="1"/>
            <p:nvPr/>
          </p:nvSpPr>
          <p:spPr>
            <a:xfrm>
              <a:off x="2231375" y="1829225"/>
              <a:ext cx="2244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969DC372-09F3-46CE-A8EB-FCA05CAB8EBE}"/>
              </a:ext>
            </a:extLst>
          </p:cNvPr>
          <p:cNvSpPr/>
          <p:nvPr/>
        </p:nvSpPr>
        <p:spPr>
          <a:xfrm>
            <a:off x="0" y="2683"/>
            <a:ext cx="200247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3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030849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>
            <a:extLst>
              <a:ext uri="{FF2B5EF4-FFF2-40B4-BE49-F238E27FC236}">
                <a16:creationId xmlns:a16="http://schemas.microsoft.com/office/drawing/2014/main" id="{357D3649-F0B8-2042-BA6E-2B12F72F63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-23771"/>
            <a:ext cx="3550972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1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</a:t>
            </a:r>
            <a:r>
              <a:rPr kumimoji="0" lang="ko-KR" altLang="ko-KR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ko-KR" altLang="ko-KR" sz="11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able</a:t>
            </a:r>
            <a:r>
              <a:rPr kumimoji="0" lang="ko-KR" altLang="ko-KR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1.</a:t>
            </a:r>
            <a:r>
              <a: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ko-KR" altLang="ko-KR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imers</a:t>
            </a:r>
            <a:r>
              <a: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ko-KR" altLang="ko-KR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sed</a:t>
            </a:r>
            <a:r>
              <a: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ko-KR" altLang="ko-KR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</a:t>
            </a:r>
            <a:r>
              <a: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ko-KR" altLang="ko-KR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is</a:t>
            </a:r>
            <a:r>
              <a: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ko-KR" altLang="ko-KR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udy</a:t>
            </a:r>
            <a:r>
              <a: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endParaRPr kumimoji="0" lang="ko-KR" altLang="ko-KR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ko-KR" altLang="ko-K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1170C464-03CE-0F48-8D1D-BC14657EC5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7903457"/>
              </p:ext>
            </p:extLst>
          </p:nvPr>
        </p:nvGraphicFramePr>
        <p:xfrm>
          <a:off x="1209061" y="801964"/>
          <a:ext cx="7285716" cy="5050189"/>
        </p:xfrm>
        <a:graphic>
          <a:graphicData uri="http://schemas.openxmlformats.org/drawingml/2006/table">
            <a:tbl>
              <a:tblPr firstRow="1" firstCol="1" bandRow="1"/>
              <a:tblGrid>
                <a:gridCol w="1287340">
                  <a:extLst>
                    <a:ext uri="{9D8B030D-6E8A-4147-A177-3AD203B41FA5}">
                      <a16:colId xmlns:a16="http://schemas.microsoft.com/office/drawing/2014/main" val="1787582208"/>
                    </a:ext>
                  </a:extLst>
                </a:gridCol>
                <a:gridCol w="4242912">
                  <a:extLst>
                    <a:ext uri="{9D8B030D-6E8A-4147-A177-3AD203B41FA5}">
                      <a16:colId xmlns:a16="http://schemas.microsoft.com/office/drawing/2014/main" val="907224093"/>
                    </a:ext>
                  </a:extLst>
                </a:gridCol>
                <a:gridCol w="1755464">
                  <a:extLst>
                    <a:ext uri="{9D8B030D-6E8A-4147-A177-3AD203B41FA5}">
                      <a16:colId xmlns:a16="http://schemas.microsoft.com/office/drawing/2014/main" val="481469277"/>
                    </a:ext>
                  </a:extLst>
                </a:gridCol>
              </a:tblGrid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Name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equence (5’</a:t>
                      </a:r>
                      <a:r>
                        <a:rPr lang="ko-KR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→</a:t>
                      </a: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3’)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Description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2034599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kgtP_RTL 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TGTCATATGCGGTCGCTAA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qRT</a:t>
                      </a:r>
                      <a:r>
                        <a:rPr lang="en-US" sz="9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-PCR</a:t>
                      </a:r>
                      <a:endParaRPr lang="ko-KR" sz="800" kern="100" dirty="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2836498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kgtP_RT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CGACAACGCTACGTACTCC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qRT</a:t>
                      </a:r>
                      <a:r>
                        <a:rPr lang="en-US" sz="9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-PCR</a:t>
                      </a:r>
                      <a:endParaRPr lang="ko-KR" sz="800" kern="100" dirty="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9122751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ihfB_RTF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AAGACGGTTGAAGATGCAGT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qRT</a:t>
                      </a:r>
                      <a:r>
                        <a:rPr lang="en-US" sz="9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-PCR</a:t>
                      </a:r>
                      <a:endParaRPr lang="ko-KR" sz="800" kern="100" dirty="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6803894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ihfB_RT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CAAAGAGAAACTGCCGAAA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qRT-PC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9294452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mdh_RTF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ACTCTGGTGTTACCATTCTGC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qRT-PC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7703559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mdh_RT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CACTTCCTGCTCGGTAAAA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qRT-PC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9803303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yoD4_F </a:t>
                      </a:r>
                      <a:endParaRPr lang="ko-KR" sz="800" kern="100" dirty="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GTTCTGGTGCATCTGGT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qRT-PC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612148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yoD4_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TAGCACGGTGAAGACAAAC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qRT-PC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7418700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16S-Fw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AGCAGCCGCGGTAATAC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qRT-PC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6489146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16S-Rev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ACCAGGGTATCTAATCCTGT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qRT-PC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162690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RT_5P_2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[5PHOS]-CCACTCTCTGAGTGC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5’-RACE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8118975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1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GTTATGAAACAATCGGTACGTG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5’-RACE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0211888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A1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GCCTATTGGGCGCATCAGGAATC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5’-RACE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517633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pJET1.2-100up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ATAGTGAATAAAATCAACTGCTTTAAC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equencin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5217264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yfiP_500up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ATACCGGCGTCGTTGCCGATAAGTCTC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enetic complementation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2262326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yfiP_500dn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CGCCCAGTCGAGGATGGTGTTGGAGAC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enetic complementation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5225225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KmR_ATGout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ACCTGCGTGCAATCCATCTTGTTCAATCAT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enetic complementation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3775563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kgtP-F1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CAATCGCCGTGCATTCATCATGGTTCTC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fGFP-CmR cassette taggin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1048991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kgtP-sfG_OR1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CTTTACGCATGGAACCTCCACCGCCAAGACGCATCCCCTTCCCTTTGC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fGFP-CmR cassette taggin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5678796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kgtP-sfG_OF2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CGTCTTGGCGGTGGAGGTTCCATGCGTAAAGGCGAAGAGCTGTTCACT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fGFP-CmR cassette taggin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4313079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mR-pssA-OF3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GCCGCCTGACGGGTCAGTTGCCAGACGGTATAGCCGGTGCTTGCACC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fGFP-CmR cassette taggin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1700496"/>
                  </a:ext>
                </a:extLst>
              </a:tr>
              <a:tr h="21623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mR-pssA-OR2</a:t>
                      </a:r>
                      <a:endParaRPr lang="ko-KR" sz="800" kern="100" dirty="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CCGTCTGGCAACTGACCCGTCAGGCGGCCGCGAATAAAAGAAGAACATCG</a:t>
                      </a:r>
                      <a:endParaRPr lang="ko-KR" sz="800" kern="100" dirty="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fGFP-CmR</a:t>
                      </a:r>
                      <a:r>
                        <a:rPr lang="en-US" sz="9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 cassette tagging</a:t>
                      </a:r>
                      <a:endParaRPr lang="ko-KR" sz="800" kern="100" dirty="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7892012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pssA-R3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AACTGGAGCTGATCCGCGAGCATACCACC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fGFP-CmR cassette taggin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2016253"/>
                  </a:ext>
                </a:extLst>
              </a:tr>
              <a:tr h="194220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fGFP-intR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ACTTATGACCGTTGACATCACCATCCA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fGFP-CmR cassette tagging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8747135"/>
                  </a:ext>
                </a:extLst>
              </a:tr>
              <a:tr h="172673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kgtP_200up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GCCAGATTCAGCAACGGATACGGTTTCC</a:t>
                      </a:r>
                      <a:endParaRPr lang="ko-KR" sz="800" kern="10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  <a:cs typeface="Times New Roman" panose="02020603050405020304" pitchFamily="18" charset="0"/>
                        </a:rPr>
                        <a:t>Sequencing</a:t>
                      </a:r>
                      <a:endParaRPr lang="ko-KR" sz="800" kern="100" dirty="0"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5809" marR="5580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831553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707231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>
            <a:extLst>
              <a:ext uri="{FF2B5EF4-FFF2-40B4-BE49-F238E27FC236}">
                <a16:creationId xmlns:a16="http://schemas.microsoft.com/office/drawing/2014/main" id="{5B86323A-E14C-49A6-B1CB-A63CEACFEA8A}"/>
              </a:ext>
            </a:extLst>
          </p:cNvPr>
          <p:cNvSpPr/>
          <p:nvPr/>
        </p:nvSpPr>
        <p:spPr>
          <a:xfrm>
            <a:off x="0" y="2683"/>
            <a:ext cx="19175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개체 2">
            <a:extLst>
              <a:ext uri="{FF2B5EF4-FFF2-40B4-BE49-F238E27FC236}">
                <a16:creationId xmlns:a16="http://schemas.microsoft.com/office/drawing/2014/main" id="{88E65C60-7188-4B4B-9563-2AF455E78B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7804631"/>
              </p:ext>
            </p:extLst>
          </p:nvPr>
        </p:nvGraphicFramePr>
        <p:xfrm>
          <a:off x="2768643" y="1313925"/>
          <a:ext cx="4165200" cy="16021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5" name="Graph" r:id="rId3" imgW="4754880" imgH="1828800" progId="Origin95.Graph">
                  <p:embed/>
                </p:oleObj>
              </mc:Choice>
              <mc:Fallback>
                <p:oleObj name="Graph" r:id="rId3" imgW="4754880" imgH="1828800" progId="Origin95.Graph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ED184A53-DAD0-4750-B959-C10399D883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68643" y="1313925"/>
                        <a:ext cx="4165200" cy="16021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그룹 3">
            <a:extLst>
              <a:ext uri="{FF2B5EF4-FFF2-40B4-BE49-F238E27FC236}">
                <a16:creationId xmlns:a16="http://schemas.microsoft.com/office/drawing/2014/main" id="{D293E699-48C8-43F1-A038-CC5C961A25B5}"/>
              </a:ext>
            </a:extLst>
          </p:cNvPr>
          <p:cNvGrpSpPr/>
          <p:nvPr/>
        </p:nvGrpSpPr>
        <p:grpSpPr>
          <a:xfrm>
            <a:off x="2602689" y="1632548"/>
            <a:ext cx="3740995" cy="1437372"/>
            <a:chOff x="2172612" y="856812"/>
            <a:chExt cx="3740995" cy="1437372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71A50F0-672F-4F81-AB8C-0E4C492BCE85}"/>
                </a:ext>
              </a:extLst>
            </p:cNvPr>
            <p:cNvSpPr txBox="1"/>
            <p:nvPr/>
          </p:nvSpPr>
          <p:spPr>
            <a:xfrm>
              <a:off x="4174075" y="2140296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B0F585E-61EB-4FE1-881C-DA731A911CA0}"/>
                </a:ext>
              </a:extLst>
            </p:cNvPr>
            <p:cNvSpPr txBox="1"/>
            <p:nvPr/>
          </p:nvSpPr>
          <p:spPr>
            <a:xfrm rot="16200000">
              <a:off x="1872850" y="1156574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EDEFE16-4FB6-417E-B5D4-F43ED8A61971}"/>
                </a:ext>
              </a:extLst>
            </p:cNvPr>
            <p:cNvSpPr txBox="1"/>
            <p:nvPr/>
          </p:nvSpPr>
          <p:spPr>
            <a:xfrm>
              <a:off x="5304007" y="1193686"/>
              <a:ext cx="6096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altLang="ko-KR" sz="800" baseline="300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d</a:t>
              </a:r>
            </a:p>
            <a:p>
              <a:pPr algn="ctr"/>
              <a:r>
                <a:rPr lang="el-GR" altLang="ko-KR" sz="8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8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0.23</a:t>
              </a:r>
              <a:endParaRPr lang="ko-KR" altLang="en-US" sz="8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B15B10A-104A-4C80-A55B-C76448EA3F7E}"/>
                </a:ext>
              </a:extLst>
            </p:cNvPr>
            <p:cNvSpPr txBox="1"/>
            <p:nvPr/>
          </p:nvSpPr>
          <p:spPr>
            <a:xfrm>
              <a:off x="4159229" y="1198550"/>
              <a:ext cx="6096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ko-KR" sz="800" baseline="300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</a:p>
            <a:p>
              <a:pPr algn="ctr"/>
              <a:r>
                <a:rPr lang="el-GR" altLang="ko-KR" sz="8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8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0.14 </a:t>
              </a:r>
              <a:endParaRPr lang="ko-KR" altLang="en-US" sz="8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371EA9E-A721-4D2C-ABBF-5B8CB655573C}"/>
                </a:ext>
              </a:extLst>
            </p:cNvPr>
            <p:cNvSpPr txBox="1"/>
            <p:nvPr/>
          </p:nvSpPr>
          <p:spPr>
            <a:xfrm>
              <a:off x="2891415" y="1198550"/>
              <a:ext cx="6096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altLang="ko-KR" sz="800" baseline="300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</a:p>
            <a:p>
              <a:pPr algn="ctr"/>
              <a:r>
                <a:rPr lang="el-GR" altLang="ko-KR" sz="8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8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0.09</a:t>
              </a:r>
              <a:endParaRPr lang="ko-KR" altLang="en-US" sz="8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C8A66AD1-B965-41CE-849A-E204687BDF60}"/>
              </a:ext>
            </a:extLst>
          </p:cNvPr>
          <p:cNvSpPr txBox="1"/>
          <p:nvPr/>
        </p:nvSpPr>
        <p:spPr>
          <a:xfrm>
            <a:off x="5112752" y="1410930"/>
            <a:ext cx="1641476" cy="12824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9 minimal succinate (0.1%)</a:t>
            </a:r>
          </a:p>
        </p:txBody>
      </p: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FD9D9984-762E-42F1-8EFF-C66A1611B879}"/>
              </a:ext>
            </a:extLst>
          </p:cNvPr>
          <p:cNvGrpSpPr/>
          <p:nvPr/>
        </p:nvGrpSpPr>
        <p:grpSpPr>
          <a:xfrm>
            <a:off x="2741046" y="1327416"/>
            <a:ext cx="186744" cy="1470059"/>
            <a:chOff x="2231375" y="244499"/>
            <a:chExt cx="186744" cy="1710032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5171125-36B8-449D-9864-2CA50C640D1E}"/>
                </a:ext>
              </a:extLst>
            </p:cNvPr>
            <p:cNvSpPr txBox="1"/>
            <p:nvPr/>
          </p:nvSpPr>
          <p:spPr>
            <a:xfrm>
              <a:off x="2306043" y="244499"/>
              <a:ext cx="99386" cy="12530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A4601E0-FF9E-491A-871E-E3EBABB9EAFD}"/>
                </a:ext>
              </a:extLst>
            </p:cNvPr>
            <p:cNvSpPr txBox="1"/>
            <p:nvPr/>
          </p:nvSpPr>
          <p:spPr>
            <a:xfrm>
              <a:off x="2368425" y="778087"/>
              <a:ext cx="49694" cy="12530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8C93812-95D2-4EC2-A76C-4457395BF429}"/>
                </a:ext>
              </a:extLst>
            </p:cNvPr>
            <p:cNvSpPr txBox="1"/>
            <p:nvPr/>
          </p:nvSpPr>
          <p:spPr>
            <a:xfrm>
              <a:off x="2291616" y="1310911"/>
              <a:ext cx="125034" cy="12530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F905DDE-3055-410E-BE0A-D4B31B3B478B}"/>
                </a:ext>
              </a:extLst>
            </p:cNvPr>
            <p:cNvSpPr txBox="1"/>
            <p:nvPr/>
          </p:nvSpPr>
          <p:spPr>
            <a:xfrm>
              <a:off x="2231375" y="1829224"/>
              <a:ext cx="174728" cy="12530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207447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F13AE93-33F0-4F56-86E0-94F932D11620}"/>
              </a:ext>
            </a:extLst>
          </p:cNvPr>
          <p:cNvSpPr txBox="1"/>
          <p:nvPr/>
        </p:nvSpPr>
        <p:spPr>
          <a:xfrm>
            <a:off x="5597894" y="6434457"/>
            <a:ext cx="1931619" cy="12824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9 minimal succinate (0.3%) agar</a:t>
            </a: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BF75B2F3-46A8-4D20-A0F4-65215505144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984" t="48188" r="46422" b="34173"/>
          <a:stretch/>
        </p:blipFill>
        <p:spPr>
          <a:xfrm>
            <a:off x="2441739" y="4514460"/>
            <a:ext cx="2421486" cy="1886659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13B6911E-14E0-45FD-946B-9C0171A6B3A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499" t="21176" r="39138" b="61185"/>
          <a:stretch/>
        </p:blipFill>
        <p:spPr>
          <a:xfrm>
            <a:off x="5108024" y="4514460"/>
            <a:ext cx="2421489" cy="1886659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7841330B-1754-4AAB-80D7-6A0ADBDA622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clrChange>
              <a:clrFrom>
                <a:srgbClr val="E9E9E9"/>
              </a:clrFrom>
              <a:clrTo>
                <a:srgbClr val="E9E9E9">
                  <a:alpha val="0"/>
                </a:srgbClr>
              </a:clrTo>
            </a:clrChange>
          </a:blip>
          <a:srcRect l="38727" t="19869" r="39402" b="62492"/>
          <a:stretch/>
        </p:blipFill>
        <p:spPr>
          <a:xfrm>
            <a:off x="5108024" y="2341633"/>
            <a:ext cx="2421489" cy="1886659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2E8AE9E8-24CB-435A-BF13-A0C3494E82F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6636" t="26299" r="42676" b="56062"/>
          <a:stretch/>
        </p:blipFill>
        <p:spPr>
          <a:xfrm>
            <a:off x="2441739" y="2341629"/>
            <a:ext cx="2421486" cy="1886659"/>
          </a:xfrm>
          <a:prstGeom prst="rect">
            <a:avLst/>
          </a:prstGeom>
        </p:spPr>
      </p:pic>
      <p:grpSp>
        <p:nvGrpSpPr>
          <p:cNvPr id="22" name="그룹 21">
            <a:extLst>
              <a:ext uri="{FF2B5EF4-FFF2-40B4-BE49-F238E27FC236}">
                <a16:creationId xmlns:a16="http://schemas.microsoft.com/office/drawing/2014/main" id="{F08E4121-8233-4D85-BB6C-9AAE70C8FB46}"/>
              </a:ext>
            </a:extLst>
          </p:cNvPr>
          <p:cNvGrpSpPr/>
          <p:nvPr/>
        </p:nvGrpSpPr>
        <p:grpSpPr>
          <a:xfrm>
            <a:off x="4430023" y="3982579"/>
            <a:ext cx="244800" cy="135197"/>
            <a:chOff x="4300477" y="3017518"/>
            <a:chExt cx="244800" cy="135197"/>
          </a:xfrm>
        </p:grpSpPr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F9B42EEA-C5EB-4377-9476-4E0AADFC8649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300477" y="3119378"/>
              <a:ext cx="244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" name="그룹 19">
              <a:extLst>
                <a:ext uri="{FF2B5EF4-FFF2-40B4-BE49-F238E27FC236}">
                  <a16:creationId xmlns:a16="http://schemas.microsoft.com/office/drawing/2014/main" id="{1DEF754A-E211-4210-AED7-574F11A9B8A6}"/>
                </a:ext>
              </a:extLst>
            </p:cNvPr>
            <p:cNvGrpSpPr/>
            <p:nvPr/>
          </p:nvGrpSpPr>
          <p:grpSpPr>
            <a:xfrm>
              <a:off x="4300477" y="3086040"/>
              <a:ext cx="244800" cy="66675"/>
              <a:chOff x="4300477" y="3086040"/>
              <a:chExt cx="244800" cy="66675"/>
            </a:xfrm>
          </p:grpSpPr>
          <p:cxnSp>
            <p:nvCxnSpPr>
              <p:cNvPr id="18" name="직선 연결선 17">
                <a:extLst>
                  <a:ext uri="{FF2B5EF4-FFF2-40B4-BE49-F238E27FC236}">
                    <a16:creationId xmlns:a16="http://schemas.microsoft.com/office/drawing/2014/main" id="{D9430EB0-272C-41E7-9E3A-9DA737394B31}"/>
                  </a:ext>
                </a:extLst>
              </p:cNvPr>
              <p:cNvCxnSpPr/>
              <p:nvPr/>
            </p:nvCxnSpPr>
            <p:spPr>
              <a:xfrm>
                <a:off x="4300477" y="3086040"/>
                <a:ext cx="0" cy="66675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직선 연결선 18">
                <a:extLst>
                  <a:ext uri="{FF2B5EF4-FFF2-40B4-BE49-F238E27FC236}">
                    <a16:creationId xmlns:a16="http://schemas.microsoft.com/office/drawing/2014/main" id="{F0524963-A3DA-43F4-9F83-9E6CBD5C49B3}"/>
                  </a:ext>
                </a:extLst>
              </p:cNvPr>
              <p:cNvCxnSpPr/>
              <p:nvPr/>
            </p:nvCxnSpPr>
            <p:spPr>
              <a:xfrm>
                <a:off x="4545277" y="3086040"/>
                <a:ext cx="0" cy="66675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6C21B6E-F9E3-4F17-A129-5D2620A5431C}"/>
                </a:ext>
              </a:extLst>
            </p:cNvPr>
            <p:cNvSpPr txBox="1"/>
            <p:nvPr/>
          </p:nvSpPr>
          <p:spPr>
            <a:xfrm>
              <a:off x="4320296" y="3017518"/>
              <a:ext cx="192360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mm</a:t>
              </a:r>
              <a:endParaRPr lang="ko-KR" alt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그룹 22">
            <a:extLst>
              <a:ext uri="{FF2B5EF4-FFF2-40B4-BE49-F238E27FC236}">
                <a16:creationId xmlns:a16="http://schemas.microsoft.com/office/drawing/2014/main" id="{1BA8D67E-9F8A-4E0C-8458-F620089D983A}"/>
              </a:ext>
            </a:extLst>
          </p:cNvPr>
          <p:cNvGrpSpPr/>
          <p:nvPr/>
        </p:nvGrpSpPr>
        <p:grpSpPr>
          <a:xfrm>
            <a:off x="7087498" y="3984464"/>
            <a:ext cx="244800" cy="135197"/>
            <a:chOff x="4300477" y="3017518"/>
            <a:chExt cx="244800" cy="135197"/>
          </a:xfrm>
        </p:grpSpPr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BDC5952C-0DC2-4606-B9A5-899E72DD5359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300477" y="3119378"/>
              <a:ext cx="244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5" name="그룹 24">
              <a:extLst>
                <a:ext uri="{FF2B5EF4-FFF2-40B4-BE49-F238E27FC236}">
                  <a16:creationId xmlns:a16="http://schemas.microsoft.com/office/drawing/2014/main" id="{84998CAF-9FE4-4222-96A8-C219659A7904}"/>
                </a:ext>
              </a:extLst>
            </p:cNvPr>
            <p:cNvGrpSpPr/>
            <p:nvPr/>
          </p:nvGrpSpPr>
          <p:grpSpPr>
            <a:xfrm>
              <a:off x="4300477" y="3086040"/>
              <a:ext cx="244800" cy="66675"/>
              <a:chOff x="4300477" y="3086040"/>
              <a:chExt cx="244800" cy="66675"/>
            </a:xfrm>
          </p:grpSpPr>
          <p:cxnSp>
            <p:nvCxnSpPr>
              <p:cNvPr id="27" name="직선 연결선 26">
                <a:extLst>
                  <a:ext uri="{FF2B5EF4-FFF2-40B4-BE49-F238E27FC236}">
                    <a16:creationId xmlns:a16="http://schemas.microsoft.com/office/drawing/2014/main" id="{B4AF18D9-94C1-4C3D-AE25-17BCA94B058A}"/>
                  </a:ext>
                </a:extLst>
              </p:cNvPr>
              <p:cNvCxnSpPr/>
              <p:nvPr/>
            </p:nvCxnSpPr>
            <p:spPr>
              <a:xfrm>
                <a:off x="4300477" y="3086040"/>
                <a:ext cx="0" cy="66675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직선 연결선 27">
                <a:extLst>
                  <a:ext uri="{FF2B5EF4-FFF2-40B4-BE49-F238E27FC236}">
                    <a16:creationId xmlns:a16="http://schemas.microsoft.com/office/drawing/2014/main" id="{9B428578-49C8-437A-B292-E0D477B2662D}"/>
                  </a:ext>
                </a:extLst>
              </p:cNvPr>
              <p:cNvCxnSpPr/>
              <p:nvPr/>
            </p:nvCxnSpPr>
            <p:spPr>
              <a:xfrm>
                <a:off x="4545277" y="3086040"/>
                <a:ext cx="0" cy="66675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A52428C-F266-483E-B6EA-EC2509EB27BD}"/>
                </a:ext>
              </a:extLst>
            </p:cNvPr>
            <p:cNvSpPr txBox="1"/>
            <p:nvPr/>
          </p:nvSpPr>
          <p:spPr>
            <a:xfrm>
              <a:off x="4320296" y="3017518"/>
              <a:ext cx="192360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mm</a:t>
              </a:r>
              <a:endParaRPr lang="ko-KR" alt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그룹 28">
            <a:extLst>
              <a:ext uri="{FF2B5EF4-FFF2-40B4-BE49-F238E27FC236}">
                <a16:creationId xmlns:a16="http://schemas.microsoft.com/office/drawing/2014/main" id="{C99CC96B-079F-4C44-A195-03AF00E5DDC7}"/>
              </a:ext>
            </a:extLst>
          </p:cNvPr>
          <p:cNvGrpSpPr/>
          <p:nvPr/>
        </p:nvGrpSpPr>
        <p:grpSpPr>
          <a:xfrm>
            <a:off x="7107317" y="6146639"/>
            <a:ext cx="244800" cy="135197"/>
            <a:chOff x="4300477" y="3017518"/>
            <a:chExt cx="244800" cy="135197"/>
          </a:xfrm>
        </p:grpSpPr>
        <p:cxnSp>
          <p:nvCxnSpPr>
            <p:cNvPr id="30" name="직선 연결선 29">
              <a:extLst>
                <a:ext uri="{FF2B5EF4-FFF2-40B4-BE49-F238E27FC236}">
                  <a16:creationId xmlns:a16="http://schemas.microsoft.com/office/drawing/2014/main" id="{B25AA848-9491-42BE-B8FD-008DC4183AC4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300477" y="3119378"/>
              <a:ext cx="244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" name="그룹 30">
              <a:extLst>
                <a:ext uri="{FF2B5EF4-FFF2-40B4-BE49-F238E27FC236}">
                  <a16:creationId xmlns:a16="http://schemas.microsoft.com/office/drawing/2014/main" id="{83F422FF-326E-46DC-9DA1-8CB5F081E250}"/>
                </a:ext>
              </a:extLst>
            </p:cNvPr>
            <p:cNvGrpSpPr/>
            <p:nvPr/>
          </p:nvGrpSpPr>
          <p:grpSpPr>
            <a:xfrm>
              <a:off x="4300477" y="3086040"/>
              <a:ext cx="244800" cy="66675"/>
              <a:chOff x="4300477" y="3086040"/>
              <a:chExt cx="244800" cy="66675"/>
            </a:xfrm>
          </p:grpSpPr>
          <p:cxnSp>
            <p:nvCxnSpPr>
              <p:cNvPr id="33" name="직선 연결선 32">
                <a:extLst>
                  <a:ext uri="{FF2B5EF4-FFF2-40B4-BE49-F238E27FC236}">
                    <a16:creationId xmlns:a16="http://schemas.microsoft.com/office/drawing/2014/main" id="{5E4D9CC5-7578-4E5C-A2FF-7A725354B8D5}"/>
                  </a:ext>
                </a:extLst>
              </p:cNvPr>
              <p:cNvCxnSpPr/>
              <p:nvPr/>
            </p:nvCxnSpPr>
            <p:spPr>
              <a:xfrm>
                <a:off x="4300477" y="3086040"/>
                <a:ext cx="0" cy="66675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직선 연결선 33">
                <a:extLst>
                  <a:ext uri="{FF2B5EF4-FFF2-40B4-BE49-F238E27FC236}">
                    <a16:creationId xmlns:a16="http://schemas.microsoft.com/office/drawing/2014/main" id="{689CFAFD-AEDF-41F7-BBE2-F9F9F3886BA8}"/>
                  </a:ext>
                </a:extLst>
              </p:cNvPr>
              <p:cNvCxnSpPr/>
              <p:nvPr/>
            </p:nvCxnSpPr>
            <p:spPr>
              <a:xfrm>
                <a:off x="4545277" y="3086040"/>
                <a:ext cx="0" cy="66675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398C0D6-37C4-4309-A7BE-5AFE315EC289}"/>
                </a:ext>
              </a:extLst>
            </p:cNvPr>
            <p:cNvSpPr txBox="1"/>
            <p:nvPr/>
          </p:nvSpPr>
          <p:spPr>
            <a:xfrm>
              <a:off x="4320296" y="3017518"/>
              <a:ext cx="192360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mm</a:t>
              </a:r>
              <a:endParaRPr lang="ko-KR" alt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그룹 34">
            <a:extLst>
              <a:ext uri="{FF2B5EF4-FFF2-40B4-BE49-F238E27FC236}">
                <a16:creationId xmlns:a16="http://schemas.microsoft.com/office/drawing/2014/main" id="{1B4DD3C5-6895-4E9F-8998-E89F9E79719B}"/>
              </a:ext>
            </a:extLst>
          </p:cNvPr>
          <p:cNvGrpSpPr/>
          <p:nvPr/>
        </p:nvGrpSpPr>
        <p:grpSpPr>
          <a:xfrm>
            <a:off x="4430023" y="6146639"/>
            <a:ext cx="244800" cy="135197"/>
            <a:chOff x="4300477" y="3017518"/>
            <a:chExt cx="244800" cy="135197"/>
          </a:xfrm>
        </p:grpSpPr>
        <p:cxnSp>
          <p:nvCxnSpPr>
            <p:cNvPr id="36" name="직선 연결선 35">
              <a:extLst>
                <a:ext uri="{FF2B5EF4-FFF2-40B4-BE49-F238E27FC236}">
                  <a16:creationId xmlns:a16="http://schemas.microsoft.com/office/drawing/2014/main" id="{7FC04193-75EE-44F4-B7BD-BADB719D1E88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4300477" y="3119378"/>
              <a:ext cx="244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7" name="그룹 36">
              <a:extLst>
                <a:ext uri="{FF2B5EF4-FFF2-40B4-BE49-F238E27FC236}">
                  <a16:creationId xmlns:a16="http://schemas.microsoft.com/office/drawing/2014/main" id="{0588A854-4061-496B-B2EE-77043ACEA1AC}"/>
                </a:ext>
              </a:extLst>
            </p:cNvPr>
            <p:cNvGrpSpPr/>
            <p:nvPr/>
          </p:nvGrpSpPr>
          <p:grpSpPr>
            <a:xfrm>
              <a:off x="4300477" y="3086040"/>
              <a:ext cx="244800" cy="66675"/>
              <a:chOff x="4300477" y="3086040"/>
              <a:chExt cx="244800" cy="66675"/>
            </a:xfrm>
          </p:grpSpPr>
          <p:cxnSp>
            <p:nvCxnSpPr>
              <p:cNvPr id="39" name="직선 연결선 38">
                <a:extLst>
                  <a:ext uri="{FF2B5EF4-FFF2-40B4-BE49-F238E27FC236}">
                    <a16:creationId xmlns:a16="http://schemas.microsoft.com/office/drawing/2014/main" id="{5FE9F0BF-ECBF-440C-A909-328DCBD517CC}"/>
                  </a:ext>
                </a:extLst>
              </p:cNvPr>
              <p:cNvCxnSpPr/>
              <p:nvPr/>
            </p:nvCxnSpPr>
            <p:spPr>
              <a:xfrm>
                <a:off x="4300477" y="3086040"/>
                <a:ext cx="0" cy="66675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직선 연결선 39">
                <a:extLst>
                  <a:ext uri="{FF2B5EF4-FFF2-40B4-BE49-F238E27FC236}">
                    <a16:creationId xmlns:a16="http://schemas.microsoft.com/office/drawing/2014/main" id="{B786EFD7-C097-481C-9E3B-991FA332D3FA}"/>
                  </a:ext>
                </a:extLst>
              </p:cNvPr>
              <p:cNvCxnSpPr/>
              <p:nvPr/>
            </p:nvCxnSpPr>
            <p:spPr>
              <a:xfrm>
                <a:off x="4545277" y="3086040"/>
                <a:ext cx="0" cy="66675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E98A40D-BE5B-4692-B5D5-C644F7B84122}"/>
                </a:ext>
              </a:extLst>
            </p:cNvPr>
            <p:cNvSpPr txBox="1"/>
            <p:nvPr/>
          </p:nvSpPr>
          <p:spPr>
            <a:xfrm>
              <a:off x="4320296" y="3017518"/>
              <a:ext cx="192360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mm</a:t>
              </a:r>
              <a:endParaRPr lang="ko-KR" alt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직사각형 40">
            <a:extLst>
              <a:ext uri="{FF2B5EF4-FFF2-40B4-BE49-F238E27FC236}">
                <a16:creationId xmlns:a16="http://schemas.microsoft.com/office/drawing/2014/main" id="{F0175C1A-1F29-40AA-B52C-64BA3C12B721}"/>
              </a:ext>
            </a:extLst>
          </p:cNvPr>
          <p:cNvSpPr/>
          <p:nvPr/>
        </p:nvSpPr>
        <p:spPr>
          <a:xfrm>
            <a:off x="0" y="2683"/>
            <a:ext cx="19175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83B6776-7599-42D6-9532-57F64320344A}"/>
              </a:ext>
            </a:extLst>
          </p:cNvPr>
          <p:cNvSpPr txBox="1"/>
          <p:nvPr/>
        </p:nvSpPr>
        <p:spPr>
          <a:xfrm>
            <a:off x="1917513" y="65197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F911695-5890-4CE0-B4EA-538CBE75F186}"/>
              </a:ext>
            </a:extLst>
          </p:cNvPr>
          <p:cNvSpPr txBox="1"/>
          <p:nvPr/>
        </p:nvSpPr>
        <p:spPr>
          <a:xfrm>
            <a:off x="1923470" y="2104790"/>
            <a:ext cx="2602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F9BD48E-691B-4680-A83C-65519379EDA7}"/>
              </a:ext>
            </a:extLst>
          </p:cNvPr>
          <p:cNvSpPr txBox="1"/>
          <p:nvPr/>
        </p:nvSpPr>
        <p:spPr>
          <a:xfrm>
            <a:off x="3291778" y="2135948"/>
            <a:ext cx="7072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eed LB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A9F94D0-746E-4567-9FF5-EFCBFF29C0A5}"/>
              </a:ext>
            </a:extLst>
          </p:cNvPr>
          <p:cNvSpPr txBox="1"/>
          <p:nvPr/>
        </p:nvSpPr>
        <p:spPr>
          <a:xfrm>
            <a:off x="5107113" y="2135948"/>
            <a:ext cx="242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M9 minimal succinate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72241A3-2EAB-4301-95AC-995C140A7C67}"/>
              </a:ext>
            </a:extLst>
          </p:cNvPr>
          <p:cNvSpPr txBox="1"/>
          <p:nvPr/>
        </p:nvSpPr>
        <p:spPr>
          <a:xfrm>
            <a:off x="2837330" y="4318364"/>
            <a:ext cx="16161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M9 minimal succinat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EADE909-0C4F-4EC7-818F-E3A6750B5300}"/>
              </a:ext>
            </a:extLst>
          </p:cNvPr>
          <p:cNvSpPr txBox="1"/>
          <p:nvPr/>
        </p:nvSpPr>
        <p:spPr>
          <a:xfrm>
            <a:off x="5107113" y="4318364"/>
            <a:ext cx="242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M9 minimal succinat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25D0EBC4-1FCA-4D75-B512-EC3031C496BC}"/>
              </a:ext>
            </a:extLst>
          </p:cNvPr>
          <p:cNvGrpSpPr/>
          <p:nvPr/>
        </p:nvGrpSpPr>
        <p:grpSpPr>
          <a:xfrm>
            <a:off x="3148657" y="977620"/>
            <a:ext cx="85987" cy="353238"/>
            <a:chOff x="1360527" y="1403956"/>
            <a:chExt cx="162142" cy="666086"/>
          </a:xfrm>
        </p:grpSpPr>
        <p:grpSp>
          <p:nvGrpSpPr>
            <p:cNvPr id="48" name="그룹 47">
              <a:extLst>
                <a:ext uri="{FF2B5EF4-FFF2-40B4-BE49-F238E27FC236}">
                  <a16:creationId xmlns:a16="http://schemas.microsoft.com/office/drawing/2014/main" id="{7738E0F7-09FA-43FB-A277-620CB6901260}"/>
                </a:ext>
              </a:extLst>
            </p:cNvPr>
            <p:cNvGrpSpPr/>
            <p:nvPr/>
          </p:nvGrpSpPr>
          <p:grpSpPr>
            <a:xfrm flipH="1">
              <a:off x="1360528" y="1403956"/>
              <a:ext cx="162141" cy="666086"/>
              <a:chOff x="1139568" y="1057274"/>
              <a:chExt cx="191745" cy="787702"/>
            </a:xfrm>
          </p:grpSpPr>
          <p:grpSp>
            <p:nvGrpSpPr>
              <p:cNvPr id="50" name="그룹 49">
                <a:extLst>
                  <a:ext uri="{FF2B5EF4-FFF2-40B4-BE49-F238E27FC236}">
                    <a16:creationId xmlns:a16="http://schemas.microsoft.com/office/drawing/2014/main" id="{84DEDE58-F9A7-498F-88F9-CFF3F5F782C7}"/>
                  </a:ext>
                </a:extLst>
              </p:cNvPr>
              <p:cNvGrpSpPr/>
              <p:nvPr/>
            </p:nvGrpSpPr>
            <p:grpSpPr>
              <a:xfrm>
                <a:off x="1143981" y="1508724"/>
                <a:ext cx="187330" cy="336252"/>
                <a:chOff x="1143981" y="1508724"/>
                <a:chExt cx="187330" cy="336252"/>
              </a:xfrm>
            </p:grpSpPr>
            <p:sp>
              <p:nvSpPr>
                <p:cNvPr id="55" name="순서도: 지연 54">
                  <a:extLst>
                    <a:ext uri="{FF2B5EF4-FFF2-40B4-BE49-F238E27FC236}">
                      <a16:creationId xmlns:a16="http://schemas.microsoft.com/office/drawing/2014/main" id="{DBCB6D76-9784-4B34-8A48-7AF45CC6FF80}"/>
                    </a:ext>
                  </a:extLst>
                </p:cNvPr>
                <p:cNvSpPr/>
                <p:nvPr/>
              </p:nvSpPr>
              <p:spPr>
                <a:xfrm rot="5400000">
                  <a:off x="1138629" y="1652294"/>
                  <a:ext cx="202447" cy="182917"/>
                </a:xfrm>
                <a:prstGeom prst="flowChartDelay">
                  <a:avLst/>
                </a:prstGeom>
                <a:solidFill>
                  <a:srgbClr val="FFF98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직사각형 55">
                  <a:extLst>
                    <a:ext uri="{FF2B5EF4-FFF2-40B4-BE49-F238E27FC236}">
                      <a16:creationId xmlns:a16="http://schemas.microsoft.com/office/drawing/2014/main" id="{BB74C534-A3A7-4150-A8EB-892CC1958CDF}"/>
                    </a:ext>
                  </a:extLst>
                </p:cNvPr>
                <p:cNvSpPr/>
                <p:nvPr/>
              </p:nvSpPr>
              <p:spPr>
                <a:xfrm rot="5400000">
                  <a:off x="1159690" y="1493015"/>
                  <a:ext cx="151499" cy="182917"/>
                </a:xfrm>
                <a:prstGeom prst="rect">
                  <a:avLst/>
                </a:prstGeom>
                <a:solidFill>
                  <a:srgbClr val="FFF98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1" name="그룹 50">
                <a:extLst>
                  <a:ext uri="{FF2B5EF4-FFF2-40B4-BE49-F238E27FC236}">
                    <a16:creationId xmlns:a16="http://schemas.microsoft.com/office/drawing/2014/main" id="{6A00ABF8-1F73-4FAE-AABE-60E100F3B798}"/>
                  </a:ext>
                </a:extLst>
              </p:cNvPr>
              <p:cNvGrpSpPr/>
              <p:nvPr/>
            </p:nvGrpSpPr>
            <p:grpSpPr>
              <a:xfrm>
                <a:off x="1139568" y="1057274"/>
                <a:ext cx="191745" cy="783431"/>
                <a:chOff x="1148396" y="1050131"/>
                <a:chExt cx="191745" cy="783431"/>
              </a:xfrm>
            </p:grpSpPr>
            <p:cxnSp>
              <p:nvCxnSpPr>
                <p:cNvPr id="52" name="직선 연결선 51">
                  <a:extLst>
                    <a:ext uri="{FF2B5EF4-FFF2-40B4-BE49-F238E27FC236}">
                      <a16:creationId xmlns:a16="http://schemas.microsoft.com/office/drawing/2014/main" id="{76B967AA-D457-4E10-AA56-ABDF483F7C7F}"/>
                    </a:ext>
                  </a:extLst>
                </p:cNvPr>
                <p:cNvCxnSpPr/>
                <p:nvPr/>
              </p:nvCxnSpPr>
              <p:spPr>
                <a:xfrm>
                  <a:off x="1148397" y="1050131"/>
                  <a:ext cx="0" cy="687624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직선 연결선 52">
                  <a:extLst>
                    <a:ext uri="{FF2B5EF4-FFF2-40B4-BE49-F238E27FC236}">
                      <a16:creationId xmlns:a16="http://schemas.microsoft.com/office/drawing/2014/main" id="{0350723B-BCCE-4ADC-A479-3564E6BAFFDD}"/>
                    </a:ext>
                  </a:extLst>
                </p:cNvPr>
                <p:cNvCxnSpPr/>
                <p:nvPr/>
              </p:nvCxnSpPr>
              <p:spPr>
                <a:xfrm>
                  <a:off x="1340141" y="1050131"/>
                  <a:ext cx="0" cy="690006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" name="막힌 원호 53">
                  <a:extLst>
                    <a:ext uri="{FF2B5EF4-FFF2-40B4-BE49-F238E27FC236}">
                      <a16:creationId xmlns:a16="http://schemas.microsoft.com/office/drawing/2014/main" id="{9F1D28EB-FC7C-4DBC-B84B-06152A3C8064}"/>
                    </a:ext>
                  </a:extLst>
                </p:cNvPr>
                <p:cNvSpPr/>
                <p:nvPr/>
              </p:nvSpPr>
              <p:spPr>
                <a:xfrm rot="10800000">
                  <a:off x="1148396" y="1629889"/>
                  <a:ext cx="191745" cy="203673"/>
                </a:xfrm>
                <a:prstGeom prst="blockArc">
                  <a:avLst>
                    <a:gd name="adj1" fmla="val 10800000"/>
                    <a:gd name="adj2" fmla="val 21520872"/>
                    <a:gd name="adj3" fmla="val 0"/>
                  </a:avLst>
                </a:prstGeom>
                <a:noFill/>
                <a:ln w="6350">
                  <a:solidFill>
                    <a:schemeClr val="tx1"/>
                  </a:solidFill>
                  <a:prstDash val="soli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49" name="직선 연결선 48">
              <a:extLst>
                <a:ext uri="{FF2B5EF4-FFF2-40B4-BE49-F238E27FC236}">
                  <a16:creationId xmlns:a16="http://schemas.microsoft.com/office/drawing/2014/main" id="{A1373341-0F89-4D85-8B94-D941E6C60F6E}"/>
                </a:ext>
              </a:extLst>
            </p:cNvPr>
            <p:cNvCxnSpPr/>
            <p:nvPr/>
          </p:nvCxnSpPr>
          <p:spPr>
            <a:xfrm>
              <a:off x="1360527" y="1785937"/>
              <a:ext cx="162141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7D4E8C19-5B03-45B1-9A93-4C8436454BE1}"/>
              </a:ext>
            </a:extLst>
          </p:cNvPr>
          <p:cNvSpPr txBox="1"/>
          <p:nvPr/>
        </p:nvSpPr>
        <p:spPr>
          <a:xfrm>
            <a:off x="2878604" y="1398797"/>
            <a:ext cx="646010" cy="12824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B medium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086C166-8016-470D-8F8D-C9FE51C60AA0}"/>
              </a:ext>
            </a:extLst>
          </p:cNvPr>
          <p:cNvSpPr txBox="1"/>
          <p:nvPr/>
        </p:nvSpPr>
        <p:spPr>
          <a:xfrm>
            <a:off x="2830770" y="764700"/>
            <a:ext cx="739844" cy="12824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L21(DE3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097B1B2-EC0E-4F6E-8E5E-A18E854ACFF9}"/>
              </a:ext>
            </a:extLst>
          </p:cNvPr>
          <p:cNvSpPr txBox="1"/>
          <p:nvPr/>
        </p:nvSpPr>
        <p:spPr>
          <a:xfrm>
            <a:off x="3657255" y="1014904"/>
            <a:ext cx="171522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7E4DD5D7-3673-4113-AACC-06162E8A8BA7}"/>
              </a:ext>
            </a:extLst>
          </p:cNvPr>
          <p:cNvCxnSpPr>
            <a:cxnSpLocks/>
          </p:cNvCxnSpPr>
          <p:nvPr/>
        </p:nvCxnSpPr>
        <p:spPr>
          <a:xfrm>
            <a:off x="3459268" y="1163190"/>
            <a:ext cx="593881" cy="0"/>
          </a:xfrm>
          <a:prstGeom prst="line">
            <a:avLst/>
          </a:prstGeom>
          <a:ln w="127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1" name="그룹 60">
            <a:extLst>
              <a:ext uri="{FF2B5EF4-FFF2-40B4-BE49-F238E27FC236}">
                <a16:creationId xmlns:a16="http://schemas.microsoft.com/office/drawing/2014/main" id="{22CCFFC1-7CC7-49E2-B78C-D64AA74B9648}"/>
              </a:ext>
            </a:extLst>
          </p:cNvPr>
          <p:cNvGrpSpPr/>
          <p:nvPr/>
        </p:nvGrpSpPr>
        <p:grpSpPr>
          <a:xfrm>
            <a:off x="4068098" y="536381"/>
            <a:ext cx="2908910" cy="1053918"/>
            <a:chOff x="4152290" y="2267038"/>
            <a:chExt cx="3249144" cy="1055748"/>
          </a:xfrm>
        </p:grpSpPr>
        <p:pic>
          <p:nvPicPr>
            <p:cNvPr id="62" name="그림 61">
              <a:extLst>
                <a:ext uri="{FF2B5EF4-FFF2-40B4-BE49-F238E27FC236}">
                  <a16:creationId xmlns:a16="http://schemas.microsoft.com/office/drawing/2014/main" id="{E4F4ED6B-32D6-4A33-B705-19C643D5C7A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52290" y="2647994"/>
              <a:ext cx="315627" cy="496008"/>
            </a:xfrm>
            <a:prstGeom prst="rect">
              <a:avLst/>
            </a:prstGeom>
          </p:spPr>
        </p:pic>
        <p:pic>
          <p:nvPicPr>
            <p:cNvPr id="63" name="그림 62">
              <a:extLst>
                <a:ext uri="{FF2B5EF4-FFF2-40B4-BE49-F238E27FC236}">
                  <a16:creationId xmlns:a16="http://schemas.microsoft.com/office/drawing/2014/main" id="{EE7F3116-068C-4725-9CC2-0859B1359B1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92374" y="2647994"/>
              <a:ext cx="315627" cy="496008"/>
            </a:xfrm>
            <a:prstGeom prst="rect">
              <a:avLst/>
            </a:prstGeom>
          </p:spPr>
        </p:pic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D77E7DB-DA36-465C-A293-1592B428EED8}"/>
                </a:ext>
              </a:extLst>
            </p:cNvPr>
            <p:cNvSpPr txBox="1"/>
            <p:nvPr/>
          </p:nvSpPr>
          <p:spPr>
            <a:xfrm>
              <a:off x="4865183" y="2448817"/>
              <a:ext cx="498069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Transfer</a:t>
              </a:r>
              <a:endParaRPr lang="ko-KR" altLang="en-US" sz="8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5" name="자유형 33">
              <a:extLst>
                <a:ext uri="{FF2B5EF4-FFF2-40B4-BE49-F238E27FC236}">
                  <a16:creationId xmlns:a16="http://schemas.microsoft.com/office/drawing/2014/main" id="{A80D9747-3D02-4AF4-AA56-91335900CD78}"/>
                </a:ext>
              </a:extLst>
            </p:cNvPr>
            <p:cNvSpPr/>
            <p:nvPr/>
          </p:nvSpPr>
          <p:spPr>
            <a:xfrm>
              <a:off x="4342735" y="2378756"/>
              <a:ext cx="1189097" cy="243735"/>
            </a:xfrm>
            <a:custGeom>
              <a:avLst/>
              <a:gdLst>
                <a:gd name="connsiteX0" fmla="*/ 0 w 1809750"/>
                <a:gd name="connsiteY0" fmla="*/ 461695 h 461695"/>
                <a:gd name="connsiteX1" fmla="*/ 247650 w 1809750"/>
                <a:gd name="connsiteY1" fmla="*/ 144195 h 461695"/>
                <a:gd name="connsiteX2" fmla="*/ 742950 w 1809750"/>
                <a:gd name="connsiteY2" fmla="*/ 4495 h 461695"/>
                <a:gd name="connsiteX3" fmla="*/ 1257300 w 1809750"/>
                <a:gd name="connsiteY3" fmla="*/ 42595 h 461695"/>
                <a:gd name="connsiteX4" fmla="*/ 1555750 w 1809750"/>
                <a:gd name="connsiteY4" fmla="*/ 125145 h 461695"/>
                <a:gd name="connsiteX5" fmla="*/ 1765300 w 1809750"/>
                <a:gd name="connsiteY5" fmla="*/ 341045 h 461695"/>
                <a:gd name="connsiteX6" fmla="*/ 1809750 w 1809750"/>
                <a:gd name="connsiteY6" fmla="*/ 423595 h 461695"/>
                <a:gd name="connsiteX0" fmla="*/ 0 w 1809750"/>
                <a:gd name="connsiteY0" fmla="*/ 467606 h 467606"/>
                <a:gd name="connsiteX1" fmla="*/ 247650 w 1809750"/>
                <a:gd name="connsiteY1" fmla="*/ 150106 h 467606"/>
                <a:gd name="connsiteX2" fmla="*/ 831850 w 1809750"/>
                <a:gd name="connsiteY2" fmla="*/ 4056 h 467606"/>
                <a:gd name="connsiteX3" fmla="*/ 1257300 w 1809750"/>
                <a:gd name="connsiteY3" fmla="*/ 48506 h 467606"/>
                <a:gd name="connsiteX4" fmla="*/ 1555750 w 1809750"/>
                <a:gd name="connsiteY4" fmla="*/ 131056 h 467606"/>
                <a:gd name="connsiteX5" fmla="*/ 1765300 w 1809750"/>
                <a:gd name="connsiteY5" fmla="*/ 346956 h 467606"/>
                <a:gd name="connsiteX6" fmla="*/ 1809750 w 1809750"/>
                <a:gd name="connsiteY6" fmla="*/ 429506 h 467606"/>
                <a:gd name="connsiteX0" fmla="*/ 0 w 1809750"/>
                <a:gd name="connsiteY0" fmla="*/ 469070 h 469070"/>
                <a:gd name="connsiteX1" fmla="*/ 247650 w 1809750"/>
                <a:gd name="connsiteY1" fmla="*/ 151570 h 469070"/>
                <a:gd name="connsiteX2" fmla="*/ 831850 w 1809750"/>
                <a:gd name="connsiteY2" fmla="*/ 5520 h 469070"/>
                <a:gd name="connsiteX3" fmla="*/ 1282700 w 1809750"/>
                <a:gd name="connsiteY3" fmla="*/ 40445 h 469070"/>
                <a:gd name="connsiteX4" fmla="*/ 1555750 w 1809750"/>
                <a:gd name="connsiteY4" fmla="*/ 132520 h 469070"/>
                <a:gd name="connsiteX5" fmla="*/ 1765300 w 1809750"/>
                <a:gd name="connsiteY5" fmla="*/ 348420 h 469070"/>
                <a:gd name="connsiteX6" fmla="*/ 1809750 w 1809750"/>
                <a:gd name="connsiteY6" fmla="*/ 430970 h 469070"/>
                <a:gd name="connsiteX0" fmla="*/ 0 w 1809750"/>
                <a:gd name="connsiteY0" fmla="*/ 469239 h 469239"/>
                <a:gd name="connsiteX1" fmla="*/ 247650 w 1809750"/>
                <a:gd name="connsiteY1" fmla="*/ 151739 h 469239"/>
                <a:gd name="connsiteX2" fmla="*/ 831850 w 1809750"/>
                <a:gd name="connsiteY2" fmla="*/ 5689 h 469239"/>
                <a:gd name="connsiteX3" fmla="*/ 1282700 w 1809750"/>
                <a:gd name="connsiteY3" fmla="*/ 40614 h 469239"/>
                <a:gd name="connsiteX4" fmla="*/ 1546225 w 1809750"/>
                <a:gd name="connsiteY4" fmla="*/ 142214 h 469239"/>
                <a:gd name="connsiteX5" fmla="*/ 1765300 w 1809750"/>
                <a:gd name="connsiteY5" fmla="*/ 348589 h 469239"/>
                <a:gd name="connsiteX6" fmla="*/ 1809750 w 1809750"/>
                <a:gd name="connsiteY6" fmla="*/ 431139 h 469239"/>
                <a:gd name="connsiteX0" fmla="*/ 0 w 1809750"/>
                <a:gd name="connsiteY0" fmla="*/ 470087 h 470087"/>
                <a:gd name="connsiteX1" fmla="*/ 257175 w 1809750"/>
                <a:gd name="connsiteY1" fmla="*/ 165287 h 470087"/>
                <a:gd name="connsiteX2" fmla="*/ 831850 w 1809750"/>
                <a:gd name="connsiteY2" fmla="*/ 6537 h 470087"/>
                <a:gd name="connsiteX3" fmla="*/ 1282700 w 1809750"/>
                <a:gd name="connsiteY3" fmla="*/ 41462 h 470087"/>
                <a:gd name="connsiteX4" fmla="*/ 1546225 w 1809750"/>
                <a:gd name="connsiteY4" fmla="*/ 143062 h 470087"/>
                <a:gd name="connsiteX5" fmla="*/ 1765300 w 1809750"/>
                <a:gd name="connsiteY5" fmla="*/ 349437 h 470087"/>
                <a:gd name="connsiteX6" fmla="*/ 1809750 w 1809750"/>
                <a:gd name="connsiteY6" fmla="*/ 431987 h 470087"/>
                <a:gd name="connsiteX0" fmla="*/ 0 w 1809750"/>
                <a:gd name="connsiteY0" fmla="*/ 470179 h 470179"/>
                <a:gd name="connsiteX1" fmla="*/ 257175 w 1809750"/>
                <a:gd name="connsiteY1" fmla="*/ 165379 h 470179"/>
                <a:gd name="connsiteX2" fmla="*/ 831850 w 1809750"/>
                <a:gd name="connsiteY2" fmla="*/ 6629 h 470179"/>
                <a:gd name="connsiteX3" fmla="*/ 1282700 w 1809750"/>
                <a:gd name="connsiteY3" fmla="*/ 41554 h 470179"/>
                <a:gd name="connsiteX4" fmla="*/ 1536700 w 1809750"/>
                <a:gd name="connsiteY4" fmla="*/ 147916 h 470179"/>
                <a:gd name="connsiteX5" fmla="*/ 1765300 w 1809750"/>
                <a:gd name="connsiteY5" fmla="*/ 349529 h 470179"/>
                <a:gd name="connsiteX6" fmla="*/ 1809750 w 1809750"/>
                <a:gd name="connsiteY6" fmla="*/ 432079 h 470179"/>
                <a:gd name="connsiteX0" fmla="*/ 0 w 1809750"/>
                <a:gd name="connsiteY0" fmla="*/ 473706 h 473706"/>
                <a:gd name="connsiteX1" fmla="*/ 257175 w 1809750"/>
                <a:gd name="connsiteY1" fmla="*/ 168906 h 473706"/>
                <a:gd name="connsiteX2" fmla="*/ 831850 w 1809750"/>
                <a:gd name="connsiteY2" fmla="*/ 10156 h 473706"/>
                <a:gd name="connsiteX3" fmla="*/ 1220788 w 1809750"/>
                <a:gd name="connsiteY3" fmla="*/ 30794 h 473706"/>
                <a:gd name="connsiteX4" fmla="*/ 1536700 w 1809750"/>
                <a:gd name="connsiteY4" fmla="*/ 151443 h 473706"/>
                <a:gd name="connsiteX5" fmla="*/ 1765300 w 1809750"/>
                <a:gd name="connsiteY5" fmla="*/ 353056 h 473706"/>
                <a:gd name="connsiteX6" fmla="*/ 1809750 w 1809750"/>
                <a:gd name="connsiteY6" fmla="*/ 435606 h 473706"/>
                <a:gd name="connsiteX0" fmla="*/ 0 w 1809750"/>
                <a:gd name="connsiteY0" fmla="*/ 466416 h 466416"/>
                <a:gd name="connsiteX1" fmla="*/ 257175 w 1809750"/>
                <a:gd name="connsiteY1" fmla="*/ 161616 h 466416"/>
                <a:gd name="connsiteX2" fmla="*/ 693738 w 1809750"/>
                <a:gd name="connsiteY2" fmla="*/ 12391 h 466416"/>
                <a:gd name="connsiteX3" fmla="*/ 1220788 w 1809750"/>
                <a:gd name="connsiteY3" fmla="*/ 23504 h 466416"/>
                <a:gd name="connsiteX4" fmla="*/ 1536700 w 1809750"/>
                <a:gd name="connsiteY4" fmla="*/ 144153 h 466416"/>
                <a:gd name="connsiteX5" fmla="*/ 1765300 w 1809750"/>
                <a:gd name="connsiteY5" fmla="*/ 345766 h 466416"/>
                <a:gd name="connsiteX6" fmla="*/ 1809750 w 1809750"/>
                <a:gd name="connsiteY6" fmla="*/ 428316 h 46641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809750" h="466416">
                  <a:moveTo>
                    <a:pt x="0" y="466416"/>
                  </a:moveTo>
                  <a:cubicBezTo>
                    <a:pt x="61912" y="345766"/>
                    <a:pt x="141552" y="237287"/>
                    <a:pt x="257175" y="161616"/>
                  </a:cubicBezTo>
                  <a:cubicBezTo>
                    <a:pt x="372798" y="85945"/>
                    <a:pt x="533136" y="35410"/>
                    <a:pt x="693738" y="12391"/>
                  </a:cubicBezTo>
                  <a:cubicBezTo>
                    <a:pt x="854340" y="-10628"/>
                    <a:pt x="1080294" y="1544"/>
                    <a:pt x="1220788" y="23504"/>
                  </a:cubicBezTo>
                  <a:cubicBezTo>
                    <a:pt x="1361282" y="45464"/>
                    <a:pt x="1445948" y="90443"/>
                    <a:pt x="1536700" y="144153"/>
                  </a:cubicBezTo>
                  <a:cubicBezTo>
                    <a:pt x="1627452" y="197863"/>
                    <a:pt x="1719792" y="298406"/>
                    <a:pt x="1765300" y="345766"/>
                  </a:cubicBezTo>
                  <a:cubicBezTo>
                    <a:pt x="1810808" y="393127"/>
                    <a:pt x="1808691" y="411911"/>
                    <a:pt x="1809750" y="428316"/>
                  </a:cubicBezTo>
                </a:path>
              </a:pathLst>
            </a:custGeom>
            <a:noFill/>
            <a:ln w="12700">
              <a:solidFill>
                <a:schemeClr val="tx1"/>
              </a:solidFill>
              <a:prstDash val="solid"/>
              <a:tailEnd type="triangle" w="sm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E8EE9ACE-A62A-428A-A36A-B2B800CD2423}"/>
                </a:ext>
              </a:extLst>
            </p:cNvPr>
            <p:cNvSpPr txBox="1"/>
            <p:nvPr/>
          </p:nvSpPr>
          <p:spPr>
            <a:xfrm>
              <a:off x="5046975" y="2559477"/>
              <a:ext cx="171522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C7EA6A3A-38B3-4502-B1D5-D1EA4F7ABA0B}"/>
                </a:ext>
              </a:extLst>
            </p:cNvPr>
            <p:cNvSpPr txBox="1"/>
            <p:nvPr/>
          </p:nvSpPr>
          <p:spPr>
            <a:xfrm>
              <a:off x="5416234" y="2267038"/>
              <a:ext cx="200376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ko-KR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  <a:endParaRPr lang="ko-KR" alt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FD45DF0D-77B9-4657-8EF8-11C77384E287}"/>
                </a:ext>
              </a:extLst>
            </p:cNvPr>
            <p:cNvSpPr txBox="1"/>
            <p:nvPr/>
          </p:nvSpPr>
          <p:spPr>
            <a:xfrm>
              <a:off x="4189283" y="2286613"/>
              <a:ext cx="165110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altLang="ko-KR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endParaRPr lang="ko-KR" alt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27B321E-C1D5-404D-A515-2DD8BFFC5E0F}"/>
                </a:ext>
              </a:extLst>
            </p:cNvPr>
            <p:cNvSpPr txBox="1"/>
            <p:nvPr/>
          </p:nvSpPr>
          <p:spPr>
            <a:xfrm>
              <a:off x="6668201" y="2270831"/>
              <a:ext cx="176330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altLang="ko-KR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rd</a:t>
              </a:r>
            </a:p>
          </p:txBody>
        </p:sp>
        <p:sp>
          <p:nvSpPr>
            <p:cNvPr id="70" name="자유형 33">
              <a:extLst>
                <a:ext uri="{FF2B5EF4-FFF2-40B4-BE49-F238E27FC236}">
                  <a16:creationId xmlns:a16="http://schemas.microsoft.com/office/drawing/2014/main" id="{22656773-80D9-4430-A5DA-6FC03B973FFD}"/>
                </a:ext>
              </a:extLst>
            </p:cNvPr>
            <p:cNvSpPr/>
            <p:nvPr/>
          </p:nvSpPr>
          <p:spPr>
            <a:xfrm rot="1396408">
              <a:off x="4280798" y="2488245"/>
              <a:ext cx="657525" cy="834541"/>
            </a:xfrm>
            <a:custGeom>
              <a:avLst/>
              <a:gdLst>
                <a:gd name="connsiteX0" fmla="*/ 0 w 1809750"/>
                <a:gd name="connsiteY0" fmla="*/ 461695 h 461695"/>
                <a:gd name="connsiteX1" fmla="*/ 247650 w 1809750"/>
                <a:gd name="connsiteY1" fmla="*/ 144195 h 461695"/>
                <a:gd name="connsiteX2" fmla="*/ 742950 w 1809750"/>
                <a:gd name="connsiteY2" fmla="*/ 4495 h 461695"/>
                <a:gd name="connsiteX3" fmla="*/ 1257300 w 1809750"/>
                <a:gd name="connsiteY3" fmla="*/ 42595 h 461695"/>
                <a:gd name="connsiteX4" fmla="*/ 1555750 w 1809750"/>
                <a:gd name="connsiteY4" fmla="*/ 125145 h 461695"/>
                <a:gd name="connsiteX5" fmla="*/ 1765300 w 1809750"/>
                <a:gd name="connsiteY5" fmla="*/ 341045 h 461695"/>
                <a:gd name="connsiteX6" fmla="*/ 1809750 w 1809750"/>
                <a:gd name="connsiteY6" fmla="*/ 423595 h 461695"/>
                <a:gd name="connsiteX0" fmla="*/ 0 w 1809750"/>
                <a:gd name="connsiteY0" fmla="*/ 467606 h 467606"/>
                <a:gd name="connsiteX1" fmla="*/ 247650 w 1809750"/>
                <a:gd name="connsiteY1" fmla="*/ 150106 h 467606"/>
                <a:gd name="connsiteX2" fmla="*/ 831850 w 1809750"/>
                <a:gd name="connsiteY2" fmla="*/ 4056 h 467606"/>
                <a:gd name="connsiteX3" fmla="*/ 1257300 w 1809750"/>
                <a:gd name="connsiteY3" fmla="*/ 48506 h 467606"/>
                <a:gd name="connsiteX4" fmla="*/ 1555750 w 1809750"/>
                <a:gd name="connsiteY4" fmla="*/ 131056 h 467606"/>
                <a:gd name="connsiteX5" fmla="*/ 1765300 w 1809750"/>
                <a:gd name="connsiteY5" fmla="*/ 346956 h 467606"/>
                <a:gd name="connsiteX6" fmla="*/ 1809750 w 1809750"/>
                <a:gd name="connsiteY6" fmla="*/ 429506 h 467606"/>
                <a:gd name="connsiteX0" fmla="*/ 0 w 1809750"/>
                <a:gd name="connsiteY0" fmla="*/ 469070 h 469070"/>
                <a:gd name="connsiteX1" fmla="*/ 247650 w 1809750"/>
                <a:gd name="connsiteY1" fmla="*/ 151570 h 469070"/>
                <a:gd name="connsiteX2" fmla="*/ 831850 w 1809750"/>
                <a:gd name="connsiteY2" fmla="*/ 5520 h 469070"/>
                <a:gd name="connsiteX3" fmla="*/ 1282700 w 1809750"/>
                <a:gd name="connsiteY3" fmla="*/ 40445 h 469070"/>
                <a:gd name="connsiteX4" fmla="*/ 1555750 w 1809750"/>
                <a:gd name="connsiteY4" fmla="*/ 132520 h 469070"/>
                <a:gd name="connsiteX5" fmla="*/ 1765300 w 1809750"/>
                <a:gd name="connsiteY5" fmla="*/ 348420 h 469070"/>
                <a:gd name="connsiteX6" fmla="*/ 1809750 w 1809750"/>
                <a:gd name="connsiteY6" fmla="*/ 430970 h 469070"/>
                <a:gd name="connsiteX0" fmla="*/ 0 w 1809750"/>
                <a:gd name="connsiteY0" fmla="*/ 469239 h 469239"/>
                <a:gd name="connsiteX1" fmla="*/ 247650 w 1809750"/>
                <a:gd name="connsiteY1" fmla="*/ 151739 h 469239"/>
                <a:gd name="connsiteX2" fmla="*/ 831850 w 1809750"/>
                <a:gd name="connsiteY2" fmla="*/ 5689 h 469239"/>
                <a:gd name="connsiteX3" fmla="*/ 1282700 w 1809750"/>
                <a:gd name="connsiteY3" fmla="*/ 40614 h 469239"/>
                <a:gd name="connsiteX4" fmla="*/ 1546225 w 1809750"/>
                <a:gd name="connsiteY4" fmla="*/ 142214 h 469239"/>
                <a:gd name="connsiteX5" fmla="*/ 1765300 w 1809750"/>
                <a:gd name="connsiteY5" fmla="*/ 348589 h 469239"/>
                <a:gd name="connsiteX6" fmla="*/ 1809750 w 1809750"/>
                <a:gd name="connsiteY6" fmla="*/ 431139 h 469239"/>
                <a:gd name="connsiteX0" fmla="*/ 0 w 1809750"/>
                <a:gd name="connsiteY0" fmla="*/ 470087 h 470087"/>
                <a:gd name="connsiteX1" fmla="*/ 257175 w 1809750"/>
                <a:gd name="connsiteY1" fmla="*/ 165287 h 470087"/>
                <a:gd name="connsiteX2" fmla="*/ 831850 w 1809750"/>
                <a:gd name="connsiteY2" fmla="*/ 6537 h 470087"/>
                <a:gd name="connsiteX3" fmla="*/ 1282700 w 1809750"/>
                <a:gd name="connsiteY3" fmla="*/ 41462 h 470087"/>
                <a:gd name="connsiteX4" fmla="*/ 1546225 w 1809750"/>
                <a:gd name="connsiteY4" fmla="*/ 143062 h 470087"/>
                <a:gd name="connsiteX5" fmla="*/ 1765300 w 1809750"/>
                <a:gd name="connsiteY5" fmla="*/ 349437 h 470087"/>
                <a:gd name="connsiteX6" fmla="*/ 1809750 w 1809750"/>
                <a:gd name="connsiteY6" fmla="*/ 431987 h 470087"/>
                <a:gd name="connsiteX0" fmla="*/ 0 w 1809750"/>
                <a:gd name="connsiteY0" fmla="*/ 470179 h 470179"/>
                <a:gd name="connsiteX1" fmla="*/ 257175 w 1809750"/>
                <a:gd name="connsiteY1" fmla="*/ 165379 h 470179"/>
                <a:gd name="connsiteX2" fmla="*/ 831850 w 1809750"/>
                <a:gd name="connsiteY2" fmla="*/ 6629 h 470179"/>
                <a:gd name="connsiteX3" fmla="*/ 1282700 w 1809750"/>
                <a:gd name="connsiteY3" fmla="*/ 41554 h 470179"/>
                <a:gd name="connsiteX4" fmla="*/ 1536700 w 1809750"/>
                <a:gd name="connsiteY4" fmla="*/ 147916 h 470179"/>
                <a:gd name="connsiteX5" fmla="*/ 1765300 w 1809750"/>
                <a:gd name="connsiteY5" fmla="*/ 349529 h 470179"/>
                <a:gd name="connsiteX6" fmla="*/ 1809750 w 1809750"/>
                <a:gd name="connsiteY6" fmla="*/ 432079 h 470179"/>
                <a:gd name="connsiteX0" fmla="*/ 0 w 1809750"/>
                <a:gd name="connsiteY0" fmla="*/ 473706 h 473706"/>
                <a:gd name="connsiteX1" fmla="*/ 257175 w 1809750"/>
                <a:gd name="connsiteY1" fmla="*/ 168906 h 473706"/>
                <a:gd name="connsiteX2" fmla="*/ 831850 w 1809750"/>
                <a:gd name="connsiteY2" fmla="*/ 10156 h 473706"/>
                <a:gd name="connsiteX3" fmla="*/ 1220788 w 1809750"/>
                <a:gd name="connsiteY3" fmla="*/ 30794 h 473706"/>
                <a:gd name="connsiteX4" fmla="*/ 1536700 w 1809750"/>
                <a:gd name="connsiteY4" fmla="*/ 151443 h 473706"/>
                <a:gd name="connsiteX5" fmla="*/ 1765300 w 1809750"/>
                <a:gd name="connsiteY5" fmla="*/ 353056 h 473706"/>
                <a:gd name="connsiteX6" fmla="*/ 1809750 w 1809750"/>
                <a:gd name="connsiteY6" fmla="*/ 435606 h 473706"/>
                <a:gd name="connsiteX0" fmla="*/ 0 w 1809750"/>
                <a:gd name="connsiteY0" fmla="*/ 466416 h 466416"/>
                <a:gd name="connsiteX1" fmla="*/ 257175 w 1809750"/>
                <a:gd name="connsiteY1" fmla="*/ 161616 h 466416"/>
                <a:gd name="connsiteX2" fmla="*/ 693738 w 1809750"/>
                <a:gd name="connsiteY2" fmla="*/ 12391 h 466416"/>
                <a:gd name="connsiteX3" fmla="*/ 1220788 w 1809750"/>
                <a:gd name="connsiteY3" fmla="*/ 23504 h 466416"/>
                <a:gd name="connsiteX4" fmla="*/ 1536700 w 1809750"/>
                <a:gd name="connsiteY4" fmla="*/ 144153 h 466416"/>
                <a:gd name="connsiteX5" fmla="*/ 1765300 w 1809750"/>
                <a:gd name="connsiteY5" fmla="*/ 345766 h 466416"/>
                <a:gd name="connsiteX6" fmla="*/ 1809750 w 1809750"/>
                <a:gd name="connsiteY6" fmla="*/ 428316 h 466416"/>
                <a:gd name="connsiteX0" fmla="*/ 0 w 1767026"/>
                <a:gd name="connsiteY0" fmla="*/ 466416 h 1959925"/>
                <a:gd name="connsiteX1" fmla="*/ 257175 w 1767026"/>
                <a:gd name="connsiteY1" fmla="*/ 161616 h 1959925"/>
                <a:gd name="connsiteX2" fmla="*/ 693738 w 1767026"/>
                <a:gd name="connsiteY2" fmla="*/ 12391 h 1959925"/>
                <a:gd name="connsiteX3" fmla="*/ 1220788 w 1767026"/>
                <a:gd name="connsiteY3" fmla="*/ 23504 h 1959925"/>
                <a:gd name="connsiteX4" fmla="*/ 1536700 w 1767026"/>
                <a:gd name="connsiteY4" fmla="*/ 144153 h 1959925"/>
                <a:gd name="connsiteX5" fmla="*/ 1765300 w 1767026"/>
                <a:gd name="connsiteY5" fmla="*/ 345766 h 1959925"/>
                <a:gd name="connsiteX6" fmla="*/ 942412 w 1767026"/>
                <a:gd name="connsiteY6" fmla="*/ 1959925 h 1959925"/>
                <a:gd name="connsiteX0" fmla="*/ 0 w 1537366"/>
                <a:gd name="connsiteY0" fmla="*/ 466416 h 1959925"/>
                <a:gd name="connsiteX1" fmla="*/ 257175 w 1537366"/>
                <a:gd name="connsiteY1" fmla="*/ 161616 h 1959925"/>
                <a:gd name="connsiteX2" fmla="*/ 693738 w 1537366"/>
                <a:gd name="connsiteY2" fmla="*/ 12391 h 1959925"/>
                <a:gd name="connsiteX3" fmla="*/ 1220788 w 1537366"/>
                <a:gd name="connsiteY3" fmla="*/ 23504 h 1959925"/>
                <a:gd name="connsiteX4" fmla="*/ 1536700 w 1537366"/>
                <a:gd name="connsiteY4" fmla="*/ 144153 h 1959925"/>
                <a:gd name="connsiteX5" fmla="*/ 1140910 w 1537366"/>
                <a:gd name="connsiteY5" fmla="*/ 1201757 h 1959925"/>
                <a:gd name="connsiteX6" fmla="*/ 942412 w 1537366"/>
                <a:gd name="connsiteY6" fmla="*/ 1959925 h 1959925"/>
                <a:gd name="connsiteX0" fmla="*/ 0 w 1222460"/>
                <a:gd name="connsiteY0" fmla="*/ 517986 h 2011495"/>
                <a:gd name="connsiteX1" fmla="*/ 257175 w 1222460"/>
                <a:gd name="connsiteY1" fmla="*/ 213186 h 2011495"/>
                <a:gd name="connsiteX2" fmla="*/ 693738 w 1222460"/>
                <a:gd name="connsiteY2" fmla="*/ 63961 h 2011495"/>
                <a:gd name="connsiteX3" fmla="*/ 1220788 w 1222460"/>
                <a:gd name="connsiteY3" fmla="*/ 75074 h 2011495"/>
                <a:gd name="connsiteX4" fmla="*/ 869947 w 1222460"/>
                <a:gd name="connsiteY4" fmla="*/ 958003 h 2011495"/>
                <a:gd name="connsiteX5" fmla="*/ 1140910 w 1222460"/>
                <a:gd name="connsiteY5" fmla="*/ 1253327 h 2011495"/>
                <a:gd name="connsiteX6" fmla="*/ 942412 w 1222460"/>
                <a:gd name="connsiteY6" fmla="*/ 2011495 h 2011495"/>
                <a:gd name="connsiteX0" fmla="*/ 0 w 1246286"/>
                <a:gd name="connsiteY0" fmla="*/ 539641 h 2033150"/>
                <a:gd name="connsiteX1" fmla="*/ 257175 w 1246286"/>
                <a:gd name="connsiteY1" fmla="*/ 234841 h 2033150"/>
                <a:gd name="connsiteX2" fmla="*/ 693738 w 1246286"/>
                <a:gd name="connsiteY2" fmla="*/ 85616 h 2033150"/>
                <a:gd name="connsiteX3" fmla="*/ 1220788 w 1246286"/>
                <a:gd name="connsiteY3" fmla="*/ 96729 h 2033150"/>
                <a:gd name="connsiteX4" fmla="*/ 1140910 w 1246286"/>
                <a:gd name="connsiteY4" fmla="*/ 1274982 h 2033150"/>
                <a:gd name="connsiteX5" fmla="*/ 942412 w 1246286"/>
                <a:gd name="connsiteY5" fmla="*/ 2033150 h 2033150"/>
                <a:gd name="connsiteX0" fmla="*/ 0 w 1149487"/>
                <a:gd name="connsiteY0" fmla="*/ 488553 h 1982062"/>
                <a:gd name="connsiteX1" fmla="*/ 257175 w 1149487"/>
                <a:gd name="connsiteY1" fmla="*/ 183753 h 1982062"/>
                <a:gd name="connsiteX2" fmla="*/ 693738 w 1149487"/>
                <a:gd name="connsiteY2" fmla="*/ 34528 h 1982062"/>
                <a:gd name="connsiteX3" fmla="*/ 959326 w 1149487"/>
                <a:gd name="connsiteY3" fmla="*/ 847892 h 1982062"/>
                <a:gd name="connsiteX4" fmla="*/ 1140910 w 1149487"/>
                <a:gd name="connsiteY4" fmla="*/ 1223894 h 1982062"/>
                <a:gd name="connsiteX5" fmla="*/ 942412 w 1149487"/>
                <a:gd name="connsiteY5" fmla="*/ 1982062 h 1982062"/>
                <a:gd name="connsiteX0" fmla="*/ 0 w 1146545"/>
                <a:gd name="connsiteY0" fmla="*/ 514484 h 2007993"/>
                <a:gd name="connsiteX1" fmla="*/ 257175 w 1146545"/>
                <a:gd name="connsiteY1" fmla="*/ 209684 h 2007993"/>
                <a:gd name="connsiteX2" fmla="*/ 693738 w 1146545"/>
                <a:gd name="connsiteY2" fmla="*/ 60459 h 2007993"/>
                <a:gd name="connsiteX3" fmla="*/ 1140910 w 1146545"/>
                <a:gd name="connsiteY3" fmla="*/ 1249825 h 2007993"/>
                <a:gd name="connsiteX4" fmla="*/ 942412 w 1146545"/>
                <a:gd name="connsiteY4" fmla="*/ 2007993 h 2007993"/>
                <a:gd name="connsiteX0" fmla="*/ 0 w 1146545"/>
                <a:gd name="connsiteY0" fmla="*/ 304801 h 1798310"/>
                <a:gd name="connsiteX1" fmla="*/ 257175 w 1146545"/>
                <a:gd name="connsiteY1" fmla="*/ 1 h 1798310"/>
                <a:gd name="connsiteX2" fmla="*/ 859543 w 1146545"/>
                <a:gd name="connsiteY2" fmla="*/ 305341 h 1798310"/>
                <a:gd name="connsiteX3" fmla="*/ 1140910 w 1146545"/>
                <a:gd name="connsiteY3" fmla="*/ 1040142 h 1798310"/>
                <a:gd name="connsiteX4" fmla="*/ 942412 w 1146545"/>
                <a:gd name="connsiteY4" fmla="*/ 1798310 h 1798310"/>
                <a:gd name="connsiteX0" fmla="*/ 0 w 1146545"/>
                <a:gd name="connsiteY0" fmla="*/ 159707 h 1653216"/>
                <a:gd name="connsiteX1" fmla="*/ 420171 w 1146545"/>
                <a:gd name="connsiteY1" fmla="*/ 1 h 1653216"/>
                <a:gd name="connsiteX2" fmla="*/ 859543 w 1146545"/>
                <a:gd name="connsiteY2" fmla="*/ 160247 h 1653216"/>
                <a:gd name="connsiteX3" fmla="*/ 1140910 w 1146545"/>
                <a:gd name="connsiteY3" fmla="*/ 895048 h 1653216"/>
                <a:gd name="connsiteX4" fmla="*/ 942412 w 1146545"/>
                <a:gd name="connsiteY4" fmla="*/ 1653216 h 1653216"/>
                <a:gd name="connsiteX0" fmla="*/ 0 w 1146545"/>
                <a:gd name="connsiteY0" fmla="*/ 159707 h 1653216"/>
                <a:gd name="connsiteX1" fmla="*/ 420171 w 1146545"/>
                <a:gd name="connsiteY1" fmla="*/ 1 h 1653216"/>
                <a:gd name="connsiteX2" fmla="*/ 859543 w 1146545"/>
                <a:gd name="connsiteY2" fmla="*/ 160247 h 1653216"/>
                <a:gd name="connsiteX3" fmla="*/ 1140910 w 1146545"/>
                <a:gd name="connsiteY3" fmla="*/ 895048 h 1653216"/>
                <a:gd name="connsiteX4" fmla="*/ 942412 w 1146545"/>
                <a:gd name="connsiteY4" fmla="*/ 1653216 h 1653216"/>
                <a:gd name="connsiteX0" fmla="*/ 0 w 1141169"/>
                <a:gd name="connsiteY0" fmla="*/ 159707 h 1653216"/>
                <a:gd name="connsiteX1" fmla="*/ 420171 w 1141169"/>
                <a:gd name="connsiteY1" fmla="*/ 1 h 1653216"/>
                <a:gd name="connsiteX2" fmla="*/ 859543 w 1141169"/>
                <a:gd name="connsiteY2" fmla="*/ 160247 h 1653216"/>
                <a:gd name="connsiteX3" fmla="*/ 1140910 w 1141169"/>
                <a:gd name="connsiteY3" fmla="*/ 895048 h 1653216"/>
                <a:gd name="connsiteX4" fmla="*/ 942412 w 1141169"/>
                <a:gd name="connsiteY4" fmla="*/ 1653216 h 1653216"/>
                <a:gd name="connsiteX0" fmla="*/ 0 w 1141869"/>
                <a:gd name="connsiteY0" fmla="*/ 159707 h 1653216"/>
                <a:gd name="connsiteX1" fmla="*/ 420171 w 1141869"/>
                <a:gd name="connsiteY1" fmla="*/ 1 h 1653216"/>
                <a:gd name="connsiteX2" fmla="*/ 859543 w 1141869"/>
                <a:gd name="connsiteY2" fmla="*/ 160247 h 1653216"/>
                <a:gd name="connsiteX3" fmla="*/ 1140910 w 1141869"/>
                <a:gd name="connsiteY3" fmla="*/ 895048 h 1653216"/>
                <a:gd name="connsiteX4" fmla="*/ 942412 w 1141869"/>
                <a:gd name="connsiteY4" fmla="*/ 1653216 h 1653216"/>
                <a:gd name="connsiteX0" fmla="*/ 0 w 1141869"/>
                <a:gd name="connsiteY0" fmla="*/ 233194 h 1726703"/>
                <a:gd name="connsiteX1" fmla="*/ 436257 w 1141869"/>
                <a:gd name="connsiteY1" fmla="*/ 1 h 1726703"/>
                <a:gd name="connsiteX2" fmla="*/ 859543 w 1141869"/>
                <a:gd name="connsiteY2" fmla="*/ 233734 h 1726703"/>
                <a:gd name="connsiteX3" fmla="*/ 1140910 w 1141869"/>
                <a:gd name="connsiteY3" fmla="*/ 968535 h 1726703"/>
                <a:gd name="connsiteX4" fmla="*/ 942412 w 1141869"/>
                <a:gd name="connsiteY4" fmla="*/ 1726703 h 1726703"/>
                <a:gd name="connsiteX0" fmla="*/ 0 w 1141869"/>
                <a:gd name="connsiteY0" fmla="*/ 233194 h 1726703"/>
                <a:gd name="connsiteX1" fmla="*/ 436257 w 1141869"/>
                <a:gd name="connsiteY1" fmla="*/ 1 h 1726703"/>
                <a:gd name="connsiteX2" fmla="*/ 859543 w 1141869"/>
                <a:gd name="connsiteY2" fmla="*/ 233734 h 1726703"/>
                <a:gd name="connsiteX3" fmla="*/ 1140910 w 1141869"/>
                <a:gd name="connsiteY3" fmla="*/ 968535 h 1726703"/>
                <a:gd name="connsiteX4" fmla="*/ 942412 w 1141869"/>
                <a:gd name="connsiteY4" fmla="*/ 1726703 h 1726703"/>
                <a:gd name="connsiteX0" fmla="*/ 0 w 1141196"/>
                <a:gd name="connsiteY0" fmla="*/ 235957 h 1729466"/>
                <a:gd name="connsiteX1" fmla="*/ 436257 w 1141196"/>
                <a:gd name="connsiteY1" fmla="*/ 2764 h 1729466"/>
                <a:gd name="connsiteX2" fmla="*/ 888064 w 1141196"/>
                <a:gd name="connsiteY2" fmla="*/ 169241 h 1729466"/>
                <a:gd name="connsiteX3" fmla="*/ 1140910 w 1141196"/>
                <a:gd name="connsiteY3" fmla="*/ 971298 h 1729466"/>
                <a:gd name="connsiteX4" fmla="*/ 942412 w 1141196"/>
                <a:gd name="connsiteY4" fmla="*/ 1729466 h 1729466"/>
                <a:gd name="connsiteX0" fmla="*/ 0 w 1107677"/>
                <a:gd name="connsiteY0" fmla="*/ 235882 h 1729391"/>
                <a:gd name="connsiteX1" fmla="*/ 436257 w 1107677"/>
                <a:gd name="connsiteY1" fmla="*/ 2689 h 1729391"/>
                <a:gd name="connsiteX2" fmla="*/ 888064 w 1107677"/>
                <a:gd name="connsiteY2" fmla="*/ 169166 h 1729391"/>
                <a:gd name="connsiteX3" fmla="*/ 1107338 w 1107677"/>
                <a:gd name="connsiteY3" fmla="*/ 963463 h 1729391"/>
                <a:gd name="connsiteX4" fmla="*/ 942412 w 1107677"/>
                <a:gd name="connsiteY4" fmla="*/ 1729391 h 1729391"/>
                <a:gd name="connsiteX0" fmla="*/ 0 w 1107677"/>
                <a:gd name="connsiteY0" fmla="*/ 235882 h 1729391"/>
                <a:gd name="connsiteX1" fmla="*/ 436257 w 1107677"/>
                <a:gd name="connsiteY1" fmla="*/ 2689 h 1729391"/>
                <a:gd name="connsiteX2" fmla="*/ 888064 w 1107677"/>
                <a:gd name="connsiteY2" fmla="*/ 169166 h 1729391"/>
                <a:gd name="connsiteX3" fmla="*/ 1107338 w 1107677"/>
                <a:gd name="connsiteY3" fmla="*/ 963463 h 1729391"/>
                <a:gd name="connsiteX4" fmla="*/ 942412 w 1107677"/>
                <a:gd name="connsiteY4" fmla="*/ 1729391 h 1729391"/>
                <a:gd name="connsiteX0" fmla="*/ 0 w 1107677"/>
                <a:gd name="connsiteY0" fmla="*/ 109422 h 1602931"/>
                <a:gd name="connsiteX1" fmla="*/ 888064 w 1107677"/>
                <a:gd name="connsiteY1" fmla="*/ 42706 h 1602931"/>
                <a:gd name="connsiteX2" fmla="*/ 1107338 w 1107677"/>
                <a:gd name="connsiteY2" fmla="*/ 837003 h 1602931"/>
                <a:gd name="connsiteX3" fmla="*/ 942412 w 1107677"/>
                <a:gd name="connsiteY3" fmla="*/ 1602931 h 1602931"/>
                <a:gd name="connsiteX0" fmla="*/ 0 w 1111835"/>
                <a:gd name="connsiteY0" fmla="*/ 196561 h 1690070"/>
                <a:gd name="connsiteX1" fmla="*/ 888064 w 1111835"/>
                <a:gd name="connsiteY1" fmla="*/ 129845 h 1690070"/>
                <a:gd name="connsiteX2" fmla="*/ 1107338 w 1111835"/>
                <a:gd name="connsiteY2" fmla="*/ 924142 h 1690070"/>
                <a:gd name="connsiteX3" fmla="*/ 942412 w 1111835"/>
                <a:gd name="connsiteY3" fmla="*/ 1690070 h 1690070"/>
                <a:gd name="connsiteX0" fmla="*/ 0 w 1109911"/>
                <a:gd name="connsiteY0" fmla="*/ 331391 h 1824900"/>
                <a:gd name="connsiteX1" fmla="*/ 780988 w 1109911"/>
                <a:gd name="connsiteY1" fmla="*/ 102298 h 1824900"/>
                <a:gd name="connsiteX2" fmla="*/ 1107338 w 1109911"/>
                <a:gd name="connsiteY2" fmla="*/ 1058972 h 1824900"/>
                <a:gd name="connsiteX3" fmla="*/ 942412 w 1109911"/>
                <a:gd name="connsiteY3" fmla="*/ 1824900 h 1824900"/>
                <a:gd name="connsiteX0" fmla="*/ 0 w 1109913"/>
                <a:gd name="connsiteY0" fmla="*/ 351578 h 1845087"/>
                <a:gd name="connsiteX1" fmla="*/ 780988 w 1109913"/>
                <a:gd name="connsiteY1" fmla="*/ 122485 h 1845087"/>
                <a:gd name="connsiteX2" fmla="*/ 1107338 w 1109913"/>
                <a:gd name="connsiteY2" fmla="*/ 1079159 h 1845087"/>
                <a:gd name="connsiteX3" fmla="*/ 942412 w 1109913"/>
                <a:gd name="connsiteY3" fmla="*/ 1845087 h 1845087"/>
                <a:gd name="connsiteX0" fmla="*/ 0 w 1109911"/>
                <a:gd name="connsiteY0" fmla="*/ 275936 h 1769445"/>
                <a:gd name="connsiteX1" fmla="*/ 780988 w 1109911"/>
                <a:gd name="connsiteY1" fmla="*/ 46843 h 1769445"/>
                <a:gd name="connsiteX2" fmla="*/ 1107338 w 1109911"/>
                <a:gd name="connsiteY2" fmla="*/ 1003517 h 1769445"/>
                <a:gd name="connsiteX3" fmla="*/ 942412 w 1109911"/>
                <a:gd name="connsiteY3" fmla="*/ 1769445 h 1769445"/>
                <a:gd name="connsiteX0" fmla="*/ 0 w 1107549"/>
                <a:gd name="connsiteY0" fmla="*/ 275936 h 1769445"/>
                <a:gd name="connsiteX1" fmla="*/ 780988 w 1107549"/>
                <a:gd name="connsiteY1" fmla="*/ 46843 h 1769445"/>
                <a:gd name="connsiteX2" fmla="*/ 1107338 w 1107549"/>
                <a:gd name="connsiteY2" fmla="*/ 1003517 h 1769445"/>
                <a:gd name="connsiteX3" fmla="*/ 942412 w 1107549"/>
                <a:gd name="connsiteY3" fmla="*/ 1769445 h 1769445"/>
                <a:gd name="connsiteX0" fmla="*/ 0 w 1107353"/>
                <a:gd name="connsiteY0" fmla="*/ 275936 h 1769445"/>
                <a:gd name="connsiteX1" fmla="*/ 780988 w 1107353"/>
                <a:gd name="connsiteY1" fmla="*/ 46843 h 1769445"/>
                <a:gd name="connsiteX2" fmla="*/ 1107338 w 1107353"/>
                <a:gd name="connsiteY2" fmla="*/ 1003517 h 1769445"/>
                <a:gd name="connsiteX3" fmla="*/ 942412 w 1107353"/>
                <a:gd name="connsiteY3" fmla="*/ 1769445 h 1769445"/>
                <a:gd name="connsiteX0" fmla="*/ 0 w 1107351"/>
                <a:gd name="connsiteY0" fmla="*/ 314258 h 1807767"/>
                <a:gd name="connsiteX1" fmla="*/ 780988 w 1107351"/>
                <a:gd name="connsiteY1" fmla="*/ 85165 h 1807767"/>
                <a:gd name="connsiteX2" fmla="*/ 1107338 w 1107351"/>
                <a:gd name="connsiteY2" fmla="*/ 1041839 h 1807767"/>
                <a:gd name="connsiteX3" fmla="*/ 942412 w 1107351"/>
                <a:gd name="connsiteY3" fmla="*/ 1807767 h 1807767"/>
                <a:gd name="connsiteX0" fmla="*/ 0 w 1110115"/>
                <a:gd name="connsiteY0" fmla="*/ 314258 h 1701473"/>
                <a:gd name="connsiteX1" fmla="*/ 780988 w 1110115"/>
                <a:gd name="connsiteY1" fmla="*/ 85165 h 1701473"/>
                <a:gd name="connsiteX2" fmla="*/ 1107338 w 1110115"/>
                <a:gd name="connsiteY2" fmla="*/ 1041839 h 1701473"/>
                <a:gd name="connsiteX3" fmla="*/ 947276 w 1110115"/>
                <a:gd name="connsiteY3" fmla="*/ 1701473 h 1701473"/>
                <a:gd name="connsiteX0" fmla="*/ 0 w 1108744"/>
                <a:gd name="connsiteY0" fmla="*/ 314258 h 1701473"/>
                <a:gd name="connsiteX1" fmla="*/ 780988 w 1108744"/>
                <a:gd name="connsiteY1" fmla="*/ 85165 h 1701473"/>
                <a:gd name="connsiteX2" fmla="*/ 1107338 w 1108744"/>
                <a:gd name="connsiteY2" fmla="*/ 1041839 h 1701473"/>
                <a:gd name="connsiteX3" fmla="*/ 947276 w 1108744"/>
                <a:gd name="connsiteY3" fmla="*/ 1701473 h 1701473"/>
                <a:gd name="connsiteX0" fmla="*/ 0 w 1107787"/>
                <a:gd name="connsiteY0" fmla="*/ 314258 h 1701473"/>
                <a:gd name="connsiteX1" fmla="*/ 780988 w 1107787"/>
                <a:gd name="connsiteY1" fmla="*/ 85165 h 1701473"/>
                <a:gd name="connsiteX2" fmla="*/ 1107338 w 1107787"/>
                <a:gd name="connsiteY2" fmla="*/ 1041839 h 1701473"/>
                <a:gd name="connsiteX3" fmla="*/ 947276 w 1107787"/>
                <a:gd name="connsiteY3" fmla="*/ 1701473 h 1701473"/>
                <a:gd name="connsiteX0" fmla="*/ 0 w 1082984"/>
                <a:gd name="connsiteY0" fmla="*/ 303739 h 1690954"/>
                <a:gd name="connsiteX1" fmla="*/ 780988 w 1082984"/>
                <a:gd name="connsiteY1" fmla="*/ 74646 h 1690954"/>
                <a:gd name="connsiteX2" fmla="*/ 1082463 w 1082984"/>
                <a:gd name="connsiteY2" fmla="*/ 1018857 h 1690954"/>
                <a:gd name="connsiteX3" fmla="*/ 947276 w 1082984"/>
                <a:gd name="connsiteY3" fmla="*/ 1690954 h 1690954"/>
                <a:gd name="connsiteX0" fmla="*/ 0 w 1082982"/>
                <a:gd name="connsiteY0" fmla="*/ 303739 h 1690954"/>
                <a:gd name="connsiteX1" fmla="*/ 780988 w 1082982"/>
                <a:gd name="connsiteY1" fmla="*/ 74646 h 1690954"/>
                <a:gd name="connsiteX2" fmla="*/ 1082463 w 1082982"/>
                <a:gd name="connsiteY2" fmla="*/ 1018856 h 1690954"/>
                <a:gd name="connsiteX3" fmla="*/ 947276 w 1082982"/>
                <a:gd name="connsiteY3" fmla="*/ 1690954 h 1690954"/>
                <a:gd name="connsiteX0" fmla="*/ 0 w 1085495"/>
                <a:gd name="connsiteY0" fmla="*/ 296404 h 1683619"/>
                <a:gd name="connsiteX1" fmla="*/ 784730 w 1085495"/>
                <a:gd name="connsiteY1" fmla="*/ 78247 h 1683619"/>
                <a:gd name="connsiteX2" fmla="*/ 1082463 w 1085495"/>
                <a:gd name="connsiteY2" fmla="*/ 1011521 h 1683619"/>
                <a:gd name="connsiteX3" fmla="*/ 947276 w 1085495"/>
                <a:gd name="connsiteY3" fmla="*/ 1683619 h 1683619"/>
                <a:gd name="connsiteX0" fmla="*/ 0 w 1085495"/>
                <a:gd name="connsiteY0" fmla="*/ 324423 h 1711638"/>
                <a:gd name="connsiteX1" fmla="*/ 784730 w 1085495"/>
                <a:gd name="connsiteY1" fmla="*/ 106266 h 1711638"/>
                <a:gd name="connsiteX2" fmla="*/ 1082463 w 1085495"/>
                <a:gd name="connsiteY2" fmla="*/ 1039540 h 1711638"/>
                <a:gd name="connsiteX3" fmla="*/ 947276 w 1085495"/>
                <a:gd name="connsiteY3" fmla="*/ 1711638 h 1711638"/>
                <a:gd name="connsiteX0" fmla="*/ 0 w 1082468"/>
                <a:gd name="connsiteY0" fmla="*/ 324423 h 1711638"/>
                <a:gd name="connsiteX1" fmla="*/ 784730 w 1082468"/>
                <a:gd name="connsiteY1" fmla="*/ 106266 h 1711638"/>
                <a:gd name="connsiteX2" fmla="*/ 1082463 w 1082468"/>
                <a:gd name="connsiteY2" fmla="*/ 1039540 h 1711638"/>
                <a:gd name="connsiteX3" fmla="*/ 947276 w 1082468"/>
                <a:gd name="connsiteY3" fmla="*/ 1711638 h 17116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82468" h="1711638">
                  <a:moveTo>
                    <a:pt x="0" y="324423"/>
                  </a:moveTo>
                  <a:cubicBezTo>
                    <a:pt x="200815" y="-34926"/>
                    <a:pt x="603011" y="-77002"/>
                    <a:pt x="784730" y="106266"/>
                  </a:cubicBezTo>
                  <a:cubicBezTo>
                    <a:pt x="966449" y="289534"/>
                    <a:pt x="1081461" y="757867"/>
                    <a:pt x="1082463" y="1039540"/>
                  </a:cubicBezTo>
                  <a:cubicBezTo>
                    <a:pt x="1083465" y="1321213"/>
                    <a:pt x="946217" y="1695233"/>
                    <a:pt x="947276" y="1711638"/>
                  </a:cubicBezTo>
                </a:path>
              </a:pathLst>
            </a:custGeom>
            <a:noFill/>
            <a:ln w="12700">
              <a:solidFill>
                <a:schemeClr val="tx1"/>
              </a:solidFill>
              <a:prstDash val="solid"/>
              <a:tailEnd type="triangle" w="sm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1" name="그림 70">
              <a:extLst>
                <a:ext uri="{FF2B5EF4-FFF2-40B4-BE49-F238E27FC236}">
                  <a16:creationId xmlns:a16="http://schemas.microsoft.com/office/drawing/2014/main" id="{BDBE8DBA-7173-4E01-89AC-289E4600746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24990" y="2647994"/>
              <a:ext cx="315627" cy="496008"/>
            </a:xfrm>
            <a:prstGeom prst="rect">
              <a:avLst/>
            </a:prstGeom>
          </p:spPr>
        </p:pic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F8CA1DE3-2D00-458D-AF9C-6B2253FE7BF4}"/>
                </a:ext>
              </a:extLst>
            </p:cNvPr>
            <p:cNvSpPr txBox="1"/>
            <p:nvPr/>
          </p:nvSpPr>
          <p:spPr>
            <a:xfrm>
              <a:off x="6093809" y="2471278"/>
              <a:ext cx="502059" cy="12332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Transfer</a:t>
              </a:r>
              <a:endParaRPr lang="ko-KR" altLang="en-US" sz="8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3" name="자유형 33">
              <a:extLst>
                <a:ext uri="{FF2B5EF4-FFF2-40B4-BE49-F238E27FC236}">
                  <a16:creationId xmlns:a16="http://schemas.microsoft.com/office/drawing/2014/main" id="{1B55801D-0465-451F-8748-307E8BA92D83}"/>
                </a:ext>
              </a:extLst>
            </p:cNvPr>
            <p:cNvSpPr/>
            <p:nvPr/>
          </p:nvSpPr>
          <p:spPr>
            <a:xfrm>
              <a:off x="5575351" y="2378756"/>
              <a:ext cx="1189097" cy="243735"/>
            </a:xfrm>
            <a:custGeom>
              <a:avLst/>
              <a:gdLst>
                <a:gd name="connsiteX0" fmla="*/ 0 w 1809750"/>
                <a:gd name="connsiteY0" fmla="*/ 461695 h 461695"/>
                <a:gd name="connsiteX1" fmla="*/ 247650 w 1809750"/>
                <a:gd name="connsiteY1" fmla="*/ 144195 h 461695"/>
                <a:gd name="connsiteX2" fmla="*/ 742950 w 1809750"/>
                <a:gd name="connsiteY2" fmla="*/ 4495 h 461695"/>
                <a:gd name="connsiteX3" fmla="*/ 1257300 w 1809750"/>
                <a:gd name="connsiteY3" fmla="*/ 42595 h 461695"/>
                <a:gd name="connsiteX4" fmla="*/ 1555750 w 1809750"/>
                <a:gd name="connsiteY4" fmla="*/ 125145 h 461695"/>
                <a:gd name="connsiteX5" fmla="*/ 1765300 w 1809750"/>
                <a:gd name="connsiteY5" fmla="*/ 341045 h 461695"/>
                <a:gd name="connsiteX6" fmla="*/ 1809750 w 1809750"/>
                <a:gd name="connsiteY6" fmla="*/ 423595 h 461695"/>
                <a:gd name="connsiteX0" fmla="*/ 0 w 1809750"/>
                <a:gd name="connsiteY0" fmla="*/ 467606 h 467606"/>
                <a:gd name="connsiteX1" fmla="*/ 247650 w 1809750"/>
                <a:gd name="connsiteY1" fmla="*/ 150106 h 467606"/>
                <a:gd name="connsiteX2" fmla="*/ 831850 w 1809750"/>
                <a:gd name="connsiteY2" fmla="*/ 4056 h 467606"/>
                <a:gd name="connsiteX3" fmla="*/ 1257300 w 1809750"/>
                <a:gd name="connsiteY3" fmla="*/ 48506 h 467606"/>
                <a:gd name="connsiteX4" fmla="*/ 1555750 w 1809750"/>
                <a:gd name="connsiteY4" fmla="*/ 131056 h 467606"/>
                <a:gd name="connsiteX5" fmla="*/ 1765300 w 1809750"/>
                <a:gd name="connsiteY5" fmla="*/ 346956 h 467606"/>
                <a:gd name="connsiteX6" fmla="*/ 1809750 w 1809750"/>
                <a:gd name="connsiteY6" fmla="*/ 429506 h 467606"/>
                <a:gd name="connsiteX0" fmla="*/ 0 w 1809750"/>
                <a:gd name="connsiteY0" fmla="*/ 469070 h 469070"/>
                <a:gd name="connsiteX1" fmla="*/ 247650 w 1809750"/>
                <a:gd name="connsiteY1" fmla="*/ 151570 h 469070"/>
                <a:gd name="connsiteX2" fmla="*/ 831850 w 1809750"/>
                <a:gd name="connsiteY2" fmla="*/ 5520 h 469070"/>
                <a:gd name="connsiteX3" fmla="*/ 1282700 w 1809750"/>
                <a:gd name="connsiteY3" fmla="*/ 40445 h 469070"/>
                <a:gd name="connsiteX4" fmla="*/ 1555750 w 1809750"/>
                <a:gd name="connsiteY4" fmla="*/ 132520 h 469070"/>
                <a:gd name="connsiteX5" fmla="*/ 1765300 w 1809750"/>
                <a:gd name="connsiteY5" fmla="*/ 348420 h 469070"/>
                <a:gd name="connsiteX6" fmla="*/ 1809750 w 1809750"/>
                <a:gd name="connsiteY6" fmla="*/ 430970 h 469070"/>
                <a:gd name="connsiteX0" fmla="*/ 0 w 1809750"/>
                <a:gd name="connsiteY0" fmla="*/ 469239 h 469239"/>
                <a:gd name="connsiteX1" fmla="*/ 247650 w 1809750"/>
                <a:gd name="connsiteY1" fmla="*/ 151739 h 469239"/>
                <a:gd name="connsiteX2" fmla="*/ 831850 w 1809750"/>
                <a:gd name="connsiteY2" fmla="*/ 5689 h 469239"/>
                <a:gd name="connsiteX3" fmla="*/ 1282700 w 1809750"/>
                <a:gd name="connsiteY3" fmla="*/ 40614 h 469239"/>
                <a:gd name="connsiteX4" fmla="*/ 1546225 w 1809750"/>
                <a:gd name="connsiteY4" fmla="*/ 142214 h 469239"/>
                <a:gd name="connsiteX5" fmla="*/ 1765300 w 1809750"/>
                <a:gd name="connsiteY5" fmla="*/ 348589 h 469239"/>
                <a:gd name="connsiteX6" fmla="*/ 1809750 w 1809750"/>
                <a:gd name="connsiteY6" fmla="*/ 431139 h 469239"/>
                <a:gd name="connsiteX0" fmla="*/ 0 w 1809750"/>
                <a:gd name="connsiteY0" fmla="*/ 470087 h 470087"/>
                <a:gd name="connsiteX1" fmla="*/ 257175 w 1809750"/>
                <a:gd name="connsiteY1" fmla="*/ 165287 h 470087"/>
                <a:gd name="connsiteX2" fmla="*/ 831850 w 1809750"/>
                <a:gd name="connsiteY2" fmla="*/ 6537 h 470087"/>
                <a:gd name="connsiteX3" fmla="*/ 1282700 w 1809750"/>
                <a:gd name="connsiteY3" fmla="*/ 41462 h 470087"/>
                <a:gd name="connsiteX4" fmla="*/ 1546225 w 1809750"/>
                <a:gd name="connsiteY4" fmla="*/ 143062 h 470087"/>
                <a:gd name="connsiteX5" fmla="*/ 1765300 w 1809750"/>
                <a:gd name="connsiteY5" fmla="*/ 349437 h 470087"/>
                <a:gd name="connsiteX6" fmla="*/ 1809750 w 1809750"/>
                <a:gd name="connsiteY6" fmla="*/ 431987 h 470087"/>
                <a:gd name="connsiteX0" fmla="*/ 0 w 1809750"/>
                <a:gd name="connsiteY0" fmla="*/ 470179 h 470179"/>
                <a:gd name="connsiteX1" fmla="*/ 257175 w 1809750"/>
                <a:gd name="connsiteY1" fmla="*/ 165379 h 470179"/>
                <a:gd name="connsiteX2" fmla="*/ 831850 w 1809750"/>
                <a:gd name="connsiteY2" fmla="*/ 6629 h 470179"/>
                <a:gd name="connsiteX3" fmla="*/ 1282700 w 1809750"/>
                <a:gd name="connsiteY3" fmla="*/ 41554 h 470179"/>
                <a:gd name="connsiteX4" fmla="*/ 1536700 w 1809750"/>
                <a:gd name="connsiteY4" fmla="*/ 147916 h 470179"/>
                <a:gd name="connsiteX5" fmla="*/ 1765300 w 1809750"/>
                <a:gd name="connsiteY5" fmla="*/ 349529 h 470179"/>
                <a:gd name="connsiteX6" fmla="*/ 1809750 w 1809750"/>
                <a:gd name="connsiteY6" fmla="*/ 432079 h 470179"/>
                <a:gd name="connsiteX0" fmla="*/ 0 w 1809750"/>
                <a:gd name="connsiteY0" fmla="*/ 473706 h 473706"/>
                <a:gd name="connsiteX1" fmla="*/ 257175 w 1809750"/>
                <a:gd name="connsiteY1" fmla="*/ 168906 h 473706"/>
                <a:gd name="connsiteX2" fmla="*/ 831850 w 1809750"/>
                <a:gd name="connsiteY2" fmla="*/ 10156 h 473706"/>
                <a:gd name="connsiteX3" fmla="*/ 1220788 w 1809750"/>
                <a:gd name="connsiteY3" fmla="*/ 30794 h 473706"/>
                <a:gd name="connsiteX4" fmla="*/ 1536700 w 1809750"/>
                <a:gd name="connsiteY4" fmla="*/ 151443 h 473706"/>
                <a:gd name="connsiteX5" fmla="*/ 1765300 w 1809750"/>
                <a:gd name="connsiteY5" fmla="*/ 353056 h 473706"/>
                <a:gd name="connsiteX6" fmla="*/ 1809750 w 1809750"/>
                <a:gd name="connsiteY6" fmla="*/ 435606 h 473706"/>
                <a:gd name="connsiteX0" fmla="*/ 0 w 1809750"/>
                <a:gd name="connsiteY0" fmla="*/ 466416 h 466416"/>
                <a:gd name="connsiteX1" fmla="*/ 257175 w 1809750"/>
                <a:gd name="connsiteY1" fmla="*/ 161616 h 466416"/>
                <a:gd name="connsiteX2" fmla="*/ 693738 w 1809750"/>
                <a:gd name="connsiteY2" fmla="*/ 12391 h 466416"/>
                <a:gd name="connsiteX3" fmla="*/ 1220788 w 1809750"/>
                <a:gd name="connsiteY3" fmla="*/ 23504 h 466416"/>
                <a:gd name="connsiteX4" fmla="*/ 1536700 w 1809750"/>
                <a:gd name="connsiteY4" fmla="*/ 144153 h 466416"/>
                <a:gd name="connsiteX5" fmla="*/ 1765300 w 1809750"/>
                <a:gd name="connsiteY5" fmla="*/ 345766 h 466416"/>
                <a:gd name="connsiteX6" fmla="*/ 1809750 w 1809750"/>
                <a:gd name="connsiteY6" fmla="*/ 428316 h 46641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809750" h="466416">
                  <a:moveTo>
                    <a:pt x="0" y="466416"/>
                  </a:moveTo>
                  <a:cubicBezTo>
                    <a:pt x="61912" y="345766"/>
                    <a:pt x="141552" y="237287"/>
                    <a:pt x="257175" y="161616"/>
                  </a:cubicBezTo>
                  <a:cubicBezTo>
                    <a:pt x="372798" y="85945"/>
                    <a:pt x="533136" y="35410"/>
                    <a:pt x="693738" y="12391"/>
                  </a:cubicBezTo>
                  <a:cubicBezTo>
                    <a:pt x="854340" y="-10628"/>
                    <a:pt x="1080294" y="1544"/>
                    <a:pt x="1220788" y="23504"/>
                  </a:cubicBezTo>
                  <a:cubicBezTo>
                    <a:pt x="1361282" y="45464"/>
                    <a:pt x="1445948" y="90443"/>
                    <a:pt x="1536700" y="144153"/>
                  </a:cubicBezTo>
                  <a:cubicBezTo>
                    <a:pt x="1627452" y="197863"/>
                    <a:pt x="1719792" y="298406"/>
                    <a:pt x="1765300" y="345766"/>
                  </a:cubicBezTo>
                  <a:cubicBezTo>
                    <a:pt x="1810808" y="393127"/>
                    <a:pt x="1808691" y="411911"/>
                    <a:pt x="1809750" y="428316"/>
                  </a:cubicBezTo>
                </a:path>
              </a:pathLst>
            </a:custGeom>
            <a:noFill/>
            <a:ln w="12700">
              <a:solidFill>
                <a:schemeClr val="tx1"/>
              </a:solidFill>
              <a:prstDash val="solid"/>
              <a:tailEnd type="triangle" w="sm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8EC8B0F0-7A6E-4E2D-83E9-DA11A4D7CBF1}"/>
                </a:ext>
              </a:extLst>
            </p:cNvPr>
            <p:cNvSpPr txBox="1"/>
            <p:nvPr/>
          </p:nvSpPr>
          <p:spPr>
            <a:xfrm>
              <a:off x="6279591" y="2559477"/>
              <a:ext cx="171522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자유형 33">
              <a:extLst>
                <a:ext uri="{FF2B5EF4-FFF2-40B4-BE49-F238E27FC236}">
                  <a16:creationId xmlns:a16="http://schemas.microsoft.com/office/drawing/2014/main" id="{188115D3-F91D-47A9-A87A-B6144418D662}"/>
                </a:ext>
              </a:extLst>
            </p:cNvPr>
            <p:cNvSpPr/>
            <p:nvPr/>
          </p:nvSpPr>
          <p:spPr>
            <a:xfrm rot="1396408">
              <a:off x="5526623" y="2485377"/>
              <a:ext cx="628786" cy="779882"/>
            </a:xfrm>
            <a:custGeom>
              <a:avLst/>
              <a:gdLst>
                <a:gd name="connsiteX0" fmla="*/ 0 w 1809750"/>
                <a:gd name="connsiteY0" fmla="*/ 461695 h 461695"/>
                <a:gd name="connsiteX1" fmla="*/ 247650 w 1809750"/>
                <a:gd name="connsiteY1" fmla="*/ 144195 h 461695"/>
                <a:gd name="connsiteX2" fmla="*/ 742950 w 1809750"/>
                <a:gd name="connsiteY2" fmla="*/ 4495 h 461695"/>
                <a:gd name="connsiteX3" fmla="*/ 1257300 w 1809750"/>
                <a:gd name="connsiteY3" fmla="*/ 42595 h 461695"/>
                <a:gd name="connsiteX4" fmla="*/ 1555750 w 1809750"/>
                <a:gd name="connsiteY4" fmla="*/ 125145 h 461695"/>
                <a:gd name="connsiteX5" fmla="*/ 1765300 w 1809750"/>
                <a:gd name="connsiteY5" fmla="*/ 341045 h 461695"/>
                <a:gd name="connsiteX6" fmla="*/ 1809750 w 1809750"/>
                <a:gd name="connsiteY6" fmla="*/ 423595 h 461695"/>
                <a:gd name="connsiteX0" fmla="*/ 0 w 1809750"/>
                <a:gd name="connsiteY0" fmla="*/ 467606 h 467606"/>
                <a:gd name="connsiteX1" fmla="*/ 247650 w 1809750"/>
                <a:gd name="connsiteY1" fmla="*/ 150106 h 467606"/>
                <a:gd name="connsiteX2" fmla="*/ 831850 w 1809750"/>
                <a:gd name="connsiteY2" fmla="*/ 4056 h 467606"/>
                <a:gd name="connsiteX3" fmla="*/ 1257300 w 1809750"/>
                <a:gd name="connsiteY3" fmla="*/ 48506 h 467606"/>
                <a:gd name="connsiteX4" fmla="*/ 1555750 w 1809750"/>
                <a:gd name="connsiteY4" fmla="*/ 131056 h 467606"/>
                <a:gd name="connsiteX5" fmla="*/ 1765300 w 1809750"/>
                <a:gd name="connsiteY5" fmla="*/ 346956 h 467606"/>
                <a:gd name="connsiteX6" fmla="*/ 1809750 w 1809750"/>
                <a:gd name="connsiteY6" fmla="*/ 429506 h 467606"/>
                <a:gd name="connsiteX0" fmla="*/ 0 w 1809750"/>
                <a:gd name="connsiteY0" fmla="*/ 469070 h 469070"/>
                <a:gd name="connsiteX1" fmla="*/ 247650 w 1809750"/>
                <a:gd name="connsiteY1" fmla="*/ 151570 h 469070"/>
                <a:gd name="connsiteX2" fmla="*/ 831850 w 1809750"/>
                <a:gd name="connsiteY2" fmla="*/ 5520 h 469070"/>
                <a:gd name="connsiteX3" fmla="*/ 1282700 w 1809750"/>
                <a:gd name="connsiteY3" fmla="*/ 40445 h 469070"/>
                <a:gd name="connsiteX4" fmla="*/ 1555750 w 1809750"/>
                <a:gd name="connsiteY4" fmla="*/ 132520 h 469070"/>
                <a:gd name="connsiteX5" fmla="*/ 1765300 w 1809750"/>
                <a:gd name="connsiteY5" fmla="*/ 348420 h 469070"/>
                <a:gd name="connsiteX6" fmla="*/ 1809750 w 1809750"/>
                <a:gd name="connsiteY6" fmla="*/ 430970 h 469070"/>
                <a:gd name="connsiteX0" fmla="*/ 0 w 1809750"/>
                <a:gd name="connsiteY0" fmla="*/ 469239 h 469239"/>
                <a:gd name="connsiteX1" fmla="*/ 247650 w 1809750"/>
                <a:gd name="connsiteY1" fmla="*/ 151739 h 469239"/>
                <a:gd name="connsiteX2" fmla="*/ 831850 w 1809750"/>
                <a:gd name="connsiteY2" fmla="*/ 5689 h 469239"/>
                <a:gd name="connsiteX3" fmla="*/ 1282700 w 1809750"/>
                <a:gd name="connsiteY3" fmla="*/ 40614 h 469239"/>
                <a:gd name="connsiteX4" fmla="*/ 1546225 w 1809750"/>
                <a:gd name="connsiteY4" fmla="*/ 142214 h 469239"/>
                <a:gd name="connsiteX5" fmla="*/ 1765300 w 1809750"/>
                <a:gd name="connsiteY5" fmla="*/ 348589 h 469239"/>
                <a:gd name="connsiteX6" fmla="*/ 1809750 w 1809750"/>
                <a:gd name="connsiteY6" fmla="*/ 431139 h 469239"/>
                <a:gd name="connsiteX0" fmla="*/ 0 w 1809750"/>
                <a:gd name="connsiteY0" fmla="*/ 470087 h 470087"/>
                <a:gd name="connsiteX1" fmla="*/ 257175 w 1809750"/>
                <a:gd name="connsiteY1" fmla="*/ 165287 h 470087"/>
                <a:gd name="connsiteX2" fmla="*/ 831850 w 1809750"/>
                <a:gd name="connsiteY2" fmla="*/ 6537 h 470087"/>
                <a:gd name="connsiteX3" fmla="*/ 1282700 w 1809750"/>
                <a:gd name="connsiteY3" fmla="*/ 41462 h 470087"/>
                <a:gd name="connsiteX4" fmla="*/ 1546225 w 1809750"/>
                <a:gd name="connsiteY4" fmla="*/ 143062 h 470087"/>
                <a:gd name="connsiteX5" fmla="*/ 1765300 w 1809750"/>
                <a:gd name="connsiteY5" fmla="*/ 349437 h 470087"/>
                <a:gd name="connsiteX6" fmla="*/ 1809750 w 1809750"/>
                <a:gd name="connsiteY6" fmla="*/ 431987 h 470087"/>
                <a:gd name="connsiteX0" fmla="*/ 0 w 1809750"/>
                <a:gd name="connsiteY0" fmla="*/ 470179 h 470179"/>
                <a:gd name="connsiteX1" fmla="*/ 257175 w 1809750"/>
                <a:gd name="connsiteY1" fmla="*/ 165379 h 470179"/>
                <a:gd name="connsiteX2" fmla="*/ 831850 w 1809750"/>
                <a:gd name="connsiteY2" fmla="*/ 6629 h 470179"/>
                <a:gd name="connsiteX3" fmla="*/ 1282700 w 1809750"/>
                <a:gd name="connsiteY3" fmla="*/ 41554 h 470179"/>
                <a:gd name="connsiteX4" fmla="*/ 1536700 w 1809750"/>
                <a:gd name="connsiteY4" fmla="*/ 147916 h 470179"/>
                <a:gd name="connsiteX5" fmla="*/ 1765300 w 1809750"/>
                <a:gd name="connsiteY5" fmla="*/ 349529 h 470179"/>
                <a:gd name="connsiteX6" fmla="*/ 1809750 w 1809750"/>
                <a:gd name="connsiteY6" fmla="*/ 432079 h 470179"/>
                <a:gd name="connsiteX0" fmla="*/ 0 w 1809750"/>
                <a:gd name="connsiteY0" fmla="*/ 473706 h 473706"/>
                <a:gd name="connsiteX1" fmla="*/ 257175 w 1809750"/>
                <a:gd name="connsiteY1" fmla="*/ 168906 h 473706"/>
                <a:gd name="connsiteX2" fmla="*/ 831850 w 1809750"/>
                <a:gd name="connsiteY2" fmla="*/ 10156 h 473706"/>
                <a:gd name="connsiteX3" fmla="*/ 1220788 w 1809750"/>
                <a:gd name="connsiteY3" fmla="*/ 30794 h 473706"/>
                <a:gd name="connsiteX4" fmla="*/ 1536700 w 1809750"/>
                <a:gd name="connsiteY4" fmla="*/ 151443 h 473706"/>
                <a:gd name="connsiteX5" fmla="*/ 1765300 w 1809750"/>
                <a:gd name="connsiteY5" fmla="*/ 353056 h 473706"/>
                <a:gd name="connsiteX6" fmla="*/ 1809750 w 1809750"/>
                <a:gd name="connsiteY6" fmla="*/ 435606 h 473706"/>
                <a:gd name="connsiteX0" fmla="*/ 0 w 1809750"/>
                <a:gd name="connsiteY0" fmla="*/ 466416 h 466416"/>
                <a:gd name="connsiteX1" fmla="*/ 257175 w 1809750"/>
                <a:gd name="connsiteY1" fmla="*/ 161616 h 466416"/>
                <a:gd name="connsiteX2" fmla="*/ 693738 w 1809750"/>
                <a:gd name="connsiteY2" fmla="*/ 12391 h 466416"/>
                <a:gd name="connsiteX3" fmla="*/ 1220788 w 1809750"/>
                <a:gd name="connsiteY3" fmla="*/ 23504 h 466416"/>
                <a:gd name="connsiteX4" fmla="*/ 1536700 w 1809750"/>
                <a:gd name="connsiteY4" fmla="*/ 144153 h 466416"/>
                <a:gd name="connsiteX5" fmla="*/ 1765300 w 1809750"/>
                <a:gd name="connsiteY5" fmla="*/ 345766 h 466416"/>
                <a:gd name="connsiteX6" fmla="*/ 1809750 w 1809750"/>
                <a:gd name="connsiteY6" fmla="*/ 428316 h 466416"/>
                <a:gd name="connsiteX0" fmla="*/ 0 w 1767026"/>
                <a:gd name="connsiteY0" fmla="*/ 466416 h 1959925"/>
                <a:gd name="connsiteX1" fmla="*/ 257175 w 1767026"/>
                <a:gd name="connsiteY1" fmla="*/ 161616 h 1959925"/>
                <a:gd name="connsiteX2" fmla="*/ 693738 w 1767026"/>
                <a:gd name="connsiteY2" fmla="*/ 12391 h 1959925"/>
                <a:gd name="connsiteX3" fmla="*/ 1220788 w 1767026"/>
                <a:gd name="connsiteY3" fmla="*/ 23504 h 1959925"/>
                <a:gd name="connsiteX4" fmla="*/ 1536700 w 1767026"/>
                <a:gd name="connsiteY4" fmla="*/ 144153 h 1959925"/>
                <a:gd name="connsiteX5" fmla="*/ 1765300 w 1767026"/>
                <a:gd name="connsiteY5" fmla="*/ 345766 h 1959925"/>
                <a:gd name="connsiteX6" fmla="*/ 942412 w 1767026"/>
                <a:gd name="connsiteY6" fmla="*/ 1959925 h 1959925"/>
                <a:gd name="connsiteX0" fmla="*/ 0 w 1537366"/>
                <a:gd name="connsiteY0" fmla="*/ 466416 h 1959925"/>
                <a:gd name="connsiteX1" fmla="*/ 257175 w 1537366"/>
                <a:gd name="connsiteY1" fmla="*/ 161616 h 1959925"/>
                <a:gd name="connsiteX2" fmla="*/ 693738 w 1537366"/>
                <a:gd name="connsiteY2" fmla="*/ 12391 h 1959925"/>
                <a:gd name="connsiteX3" fmla="*/ 1220788 w 1537366"/>
                <a:gd name="connsiteY3" fmla="*/ 23504 h 1959925"/>
                <a:gd name="connsiteX4" fmla="*/ 1536700 w 1537366"/>
                <a:gd name="connsiteY4" fmla="*/ 144153 h 1959925"/>
                <a:gd name="connsiteX5" fmla="*/ 1140910 w 1537366"/>
                <a:gd name="connsiteY5" fmla="*/ 1201757 h 1959925"/>
                <a:gd name="connsiteX6" fmla="*/ 942412 w 1537366"/>
                <a:gd name="connsiteY6" fmla="*/ 1959925 h 1959925"/>
                <a:gd name="connsiteX0" fmla="*/ 0 w 1222460"/>
                <a:gd name="connsiteY0" fmla="*/ 517986 h 2011495"/>
                <a:gd name="connsiteX1" fmla="*/ 257175 w 1222460"/>
                <a:gd name="connsiteY1" fmla="*/ 213186 h 2011495"/>
                <a:gd name="connsiteX2" fmla="*/ 693738 w 1222460"/>
                <a:gd name="connsiteY2" fmla="*/ 63961 h 2011495"/>
                <a:gd name="connsiteX3" fmla="*/ 1220788 w 1222460"/>
                <a:gd name="connsiteY3" fmla="*/ 75074 h 2011495"/>
                <a:gd name="connsiteX4" fmla="*/ 869947 w 1222460"/>
                <a:gd name="connsiteY4" fmla="*/ 958003 h 2011495"/>
                <a:gd name="connsiteX5" fmla="*/ 1140910 w 1222460"/>
                <a:gd name="connsiteY5" fmla="*/ 1253327 h 2011495"/>
                <a:gd name="connsiteX6" fmla="*/ 942412 w 1222460"/>
                <a:gd name="connsiteY6" fmla="*/ 2011495 h 2011495"/>
                <a:gd name="connsiteX0" fmla="*/ 0 w 1246286"/>
                <a:gd name="connsiteY0" fmla="*/ 539641 h 2033150"/>
                <a:gd name="connsiteX1" fmla="*/ 257175 w 1246286"/>
                <a:gd name="connsiteY1" fmla="*/ 234841 h 2033150"/>
                <a:gd name="connsiteX2" fmla="*/ 693738 w 1246286"/>
                <a:gd name="connsiteY2" fmla="*/ 85616 h 2033150"/>
                <a:gd name="connsiteX3" fmla="*/ 1220788 w 1246286"/>
                <a:gd name="connsiteY3" fmla="*/ 96729 h 2033150"/>
                <a:gd name="connsiteX4" fmla="*/ 1140910 w 1246286"/>
                <a:gd name="connsiteY4" fmla="*/ 1274982 h 2033150"/>
                <a:gd name="connsiteX5" fmla="*/ 942412 w 1246286"/>
                <a:gd name="connsiteY5" fmla="*/ 2033150 h 2033150"/>
                <a:gd name="connsiteX0" fmla="*/ 0 w 1149487"/>
                <a:gd name="connsiteY0" fmla="*/ 488553 h 1982062"/>
                <a:gd name="connsiteX1" fmla="*/ 257175 w 1149487"/>
                <a:gd name="connsiteY1" fmla="*/ 183753 h 1982062"/>
                <a:gd name="connsiteX2" fmla="*/ 693738 w 1149487"/>
                <a:gd name="connsiteY2" fmla="*/ 34528 h 1982062"/>
                <a:gd name="connsiteX3" fmla="*/ 959326 w 1149487"/>
                <a:gd name="connsiteY3" fmla="*/ 847892 h 1982062"/>
                <a:gd name="connsiteX4" fmla="*/ 1140910 w 1149487"/>
                <a:gd name="connsiteY4" fmla="*/ 1223894 h 1982062"/>
                <a:gd name="connsiteX5" fmla="*/ 942412 w 1149487"/>
                <a:gd name="connsiteY5" fmla="*/ 1982062 h 1982062"/>
                <a:gd name="connsiteX0" fmla="*/ 0 w 1146545"/>
                <a:gd name="connsiteY0" fmla="*/ 514484 h 2007993"/>
                <a:gd name="connsiteX1" fmla="*/ 257175 w 1146545"/>
                <a:gd name="connsiteY1" fmla="*/ 209684 h 2007993"/>
                <a:gd name="connsiteX2" fmla="*/ 693738 w 1146545"/>
                <a:gd name="connsiteY2" fmla="*/ 60459 h 2007993"/>
                <a:gd name="connsiteX3" fmla="*/ 1140910 w 1146545"/>
                <a:gd name="connsiteY3" fmla="*/ 1249825 h 2007993"/>
                <a:gd name="connsiteX4" fmla="*/ 942412 w 1146545"/>
                <a:gd name="connsiteY4" fmla="*/ 2007993 h 2007993"/>
                <a:gd name="connsiteX0" fmla="*/ 0 w 1146545"/>
                <a:gd name="connsiteY0" fmla="*/ 304801 h 1798310"/>
                <a:gd name="connsiteX1" fmla="*/ 257175 w 1146545"/>
                <a:gd name="connsiteY1" fmla="*/ 1 h 1798310"/>
                <a:gd name="connsiteX2" fmla="*/ 859543 w 1146545"/>
                <a:gd name="connsiteY2" fmla="*/ 305341 h 1798310"/>
                <a:gd name="connsiteX3" fmla="*/ 1140910 w 1146545"/>
                <a:gd name="connsiteY3" fmla="*/ 1040142 h 1798310"/>
                <a:gd name="connsiteX4" fmla="*/ 942412 w 1146545"/>
                <a:gd name="connsiteY4" fmla="*/ 1798310 h 1798310"/>
                <a:gd name="connsiteX0" fmla="*/ 0 w 1146545"/>
                <a:gd name="connsiteY0" fmla="*/ 159707 h 1653216"/>
                <a:gd name="connsiteX1" fmla="*/ 420171 w 1146545"/>
                <a:gd name="connsiteY1" fmla="*/ 1 h 1653216"/>
                <a:gd name="connsiteX2" fmla="*/ 859543 w 1146545"/>
                <a:gd name="connsiteY2" fmla="*/ 160247 h 1653216"/>
                <a:gd name="connsiteX3" fmla="*/ 1140910 w 1146545"/>
                <a:gd name="connsiteY3" fmla="*/ 895048 h 1653216"/>
                <a:gd name="connsiteX4" fmla="*/ 942412 w 1146545"/>
                <a:gd name="connsiteY4" fmla="*/ 1653216 h 1653216"/>
                <a:gd name="connsiteX0" fmla="*/ 0 w 1146545"/>
                <a:gd name="connsiteY0" fmla="*/ 159707 h 1653216"/>
                <a:gd name="connsiteX1" fmla="*/ 420171 w 1146545"/>
                <a:gd name="connsiteY1" fmla="*/ 1 h 1653216"/>
                <a:gd name="connsiteX2" fmla="*/ 859543 w 1146545"/>
                <a:gd name="connsiteY2" fmla="*/ 160247 h 1653216"/>
                <a:gd name="connsiteX3" fmla="*/ 1140910 w 1146545"/>
                <a:gd name="connsiteY3" fmla="*/ 895048 h 1653216"/>
                <a:gd name="connsiteX4" fmla="*/ 942412 w 1146545"/>
                <a:gd name="connsiteY4" fmla="*/ 1653216 h 1653216"/>
                <a:gd name="connsiteX0" fmla="*/ 0 w 1141169"/>
                <a:gd name="connsiteY0" fmla="*/ 159707 h 1653216"/>
                <a:gd name="connsiteX1" fmla="*/ 420171 w 1141169"/>
                <a:gd name="connsiteY1" fmla="*/ 1 h 1653216"/>
                <a:gd name="connsiteX2" fmla="*/ 859543 w 1141169"/>
                <a:gd name="connsiteY2" fmla="*/ 160247 h 1653216"/>
                <a:gd name="connsiteX3" fmla="*/ 1140910 w 1141169"/>
                <a:gd name="connsiteY3" fmla="*/ 895048 h 1653216"/>
                <a:gd name="connsiteX4" fmla="*/ 942412 w 1141169"/>
                <a:gd name="connsiteY4" fmla="*/ 1653216 h 1653216"/>
                <a:gd name="connsiteX0" fmla="*/ 0 w 1141869"/>
                <a:gd name="connsiteY0" fmla="*/ 159707 h 1653216"/>
                <a:gd name="connsiteX1" fmla="*/ 420171 w 1141869"/>
                <a:gd name="connsiteY1" fmla="*/ 1 h 1653216"/>
                <a:gd name="connsiteX2" fmla="*/ 859543 w 1141869"/>
                <a:gd name="connsiteY2" fmla="*/ 160247 h 1653216"/>
                <a:gd name="connsiteX3" fmla="*/ 1140910 w 1141869"/>
                <a:gd name="connsiteY3" fmla="*/ 895048 h 1653216"/>
                <a:gd name="connsiteX4" fmla="*/ 942412 w 1141869"/>
                <a:gd name="connsiteY4" fmla="*/ 1653216 h 1653216"/>
                <a:gd name="connsiteX0" fmla="*/ 0 w 1141869"/>
                <a:gd name="connsiteY0" fmla="*/ 233194 h 1726703"/>
                <a:gd name="connsiteX1" fmla="*/ 436257 w 1141869"/>
                <a:gd name="connsiteY1" fmla="*/ 1 h 1726703"/>
                <a:gd name="connsiteX2" fmla="*/ 859543 w 1141869"/>
                <a:gd name="connsiteY2" fmla="*/ 233734 h 1726703"/>
                <a:gd name="connsiteX3" fmla="*/ 1140910 w 1141869"/>
                <a:gd name="connsiteY3" fmla="*/ 968535 h 1726703"/>
                <a:gd name="connsiteX4" fmla="*/ 942412 w 1141869"/>
                <a:gd name="connsiteY4" fmla="*/ 1726703 h 1726703"/>
                <a:gd name="connsiteX0" fmla="*/ 0 w 1141869"/>
                <a:gd name="connsiteY0" fmla="*/ 233194 h 1726703"/>
                <a:gd name="connsiteX1" fmla="*/ 436257 w 1141869"/>
                <a:gd name="connsiteY1" fmla="*/ 1 h 1726703"/>
                <a:gd name="connsiteX2" fmla="*/ 859543 w 1141869"/>
                <a:gd name="connsiteY2" fmla="*/ 233734 h 1726703"/>
                <a:gd name="connsiteX3" fmla="*/ 1140910 w 1141869"/>
                <a:gd name="connsiteY3" fmla="*/ 968535 h 1726703"/>
                <a:gd name="connsiteX4" fmla="*/ 942412 w 1141869"/>
                <a:gd name="connsiteY4" fmla="*/ 1726703 h 1726703"/>
                <a:gd name="connsiteX0" fmla="*/ 0 w 1141196"/>
                <a:gd name="connsiteY0" fmla="*/ 235957 h 1729466"/>
                <a:gd name="connsiteX1" fmla="*/ 436257 w 1141196"/>
                <a:gd name="connsiteY1" fmla="*/ 2764 h 1729466"/>
                <a:gd name="connsiteX2" fmla="*/ 888064 w 1141196"/>
                <a:gd name="connsiteY2" fmla="*/ 169241 h 1729466"/>
                <a:gd name="connsiteX3" fmla="*/ 1140910 w 1141196"/>
                <a:gd name="connsiteY3" fmla="*/ 971298 h 1729466"/>
                <a:gd name="connsiteX4" fmla="*/ 942412 w 1141196"/>
                <a:gd name="connsiteY4" fmla="*/ 1729466 h 1729466"/>
                <a:gd name="connsiteX0" fmla="*/ 0 w 1107677"/>
                <a:gd name="connsiteY0" fmla="*/ 235882 h 1729391"/>
                <a:gd name="connsiteX1" fmla="*/ 436257 w 1107677"/>
                <a:gd name="connsiteY1" fmla="*/ 2689 h 1729391"/>
                <a:gd name="connsiteX2" fmla="*/ 888064 w 1107677"/>
                <a:gd name="connsiteY2" fmla="*/ 169166 h 1729391"/>
                <a:gd name="connsiteX3" fmla="*/ 1107338 w 1107677"/>
                <a:gd name="connsiteY3" fmla="*/ 963463 h 1729391"/>
                <a:gd name="connsiteX4" fmla="*/ 942412 w 1107677"/>
                <a:gd name="connsiteY4" fmla="*/ 1729391 h 1729391"/>
                <a:gd name="connsiteX0" fmla="*/ 0 w 1107677"/>
                <a:gd name="connsiteY0" fmla="*/ 235882 h 1729391"/>
                <a:gd name="connsiteX1" fmla="*/ 436257 w 1107677"/>
                <a:gd name="connsiteY1" fmla="*/ 2689 h 1729391"/>
                <a:gd name="connsiteX2" fmla="*/ 888064 w 1107677"/>
                <a:gd name="connsiteY2" fmla="*/ 169166 h 1729391"/>
                <a:gd name="connsiteX3" fmla="*/ 1107338 w 1107677"/>
                <a:gd name="connsiteY3" fmla="*/ 963463 h 1729391"/>
                <a:gd name="connsiteX4" fmla="*/ 942412 w 1107677"/>
                <a:gd name="connsiteY4" fmla="*/ 1729391 h 1729391"/>
                <a:gd name="connsiteX0" fmla="*/ 0 w 1107677"/>
                <a:gd name="connsiteY0" fmla="*/ 109422 h 1602931"/>
                <a:gd name="connsiteX1" fmla="*/ 888064 w 1107677"/>
                <a:gd name="connsiteY1" fmla="*/ 42706 h 1602931"/>
                <a:gd name="connsiteX2" fmla="*/ 1107338 w 1107677"/>
                <a:gd name="connsiteY2" fmla="*/ 837003 h 1602931"/>
                <a:gd name="connsiteX3" fmla="*/ 942412 w 1107677"/>
                <a:gd name="connsiteY3" fmla="*/ 1602931 h 1602931"/>
                <a:gd name="connsiteX0" fmla="*/ 0 w 1111835"/>
                <a:gd name="connsiteY0" fmla="*/ 196561 h 1690070"/>
                <a:gd name="connsiteX1" fmla="*/ 888064 w 1111835"/>
                <a:gd name="connsiteY1" fmla="*/ 129845 h 1690070"/>
                <a:gd name="connsiteX2" fmla="*/ 1107338 w 1111835"/>
                <a:gd name="connsiteY2" fmla="*/ 924142 h 1690070"/>
                <a:gd name="connsiteX3" fmla="*/ 942412 w 1111835"/>
                <a:gd name="connsiteY3" fmla="*/ 1690070 h 1690070"/>
                <a:gd name="connsiteX0" fmla="*/ 0 w 1109911"/>
                <a:gd name="connsiteY0" fmla="*/ 331391 h 1824900"/>
                <a:gd name="connsiteX1" fmla="*/ 780988 w 1109911"/>
                <a:gd name="connsiteY1" fmla="*/ 102298 h 1824900"/>
                <a:gd name="connsiteX2" fmla="*/ 1107338 w 1109911"/>
                <a:gd name="connsiteY2" fmla="*/ 1058972 h 1824900"/>
                <a:gd name="connsiteX3" fmla="*/ 942412 w 1109911"/>
                <a:gd name="connsiteY3" fmla="*/ 1824900 h 1824900"/>
                <a:gd name="connsiteX0" fmla="*/ 0 w 1109913"/>
                <a:gd name="connsiteY0" fmla="*/ 351578 h 1845087"/>
                <a:gd name="connsiteX1" fmla="*/ 780988 w 1109913"/>
                <a:gd name="connsiteY1" fmla="*/ 122485 h 1845087"/>
                <a:gd name="connsiteX2" fmla="*/ 1107338 w 1109913"/>
                <a:gd name="connsiteY2" fmla="*/ 1079159 h 1845087"/>
                <a:gd name="connsiteX3" fmla="*/ 942412 w 1109913"/>
                <a:gd name="connsiteY3" fmla="*/ 1845087 h 1845087"/>
                <a:gd name="connsiteX0" fmla="*/ 0 w 1109911"/>
                <a:gd name="connsiteY0" fmla="*/ 275936 h 1769445"/>
                <a:gd name="connsiteX1" fmla="*/ 780988 w 1109911"/>
                <a:gd name="connsiteY1" fmla="*/ 46843 h 1769445"/>
                <a:gd name="connsiteX2" fmla="*/ 1107338 w 1109911"/>
                <a:gd name="connsiteY2" fmla="*/ 1003517 h 1769445"/>
                <a:gd name="connsiteX3" fmla="*/ 942412 w 1109911"/>
                <a:gd name="connsiteY3" fmla="*/ 1769445 h 1769445"/>
                <a:gd name="connsiteX0" fmla="*/ 0 w 1107549"/>
                <a:gd name="connsiteY0" fmla="*/ 275936 h 1769445"/>
                <a:gd name="connsiteX1" fmla="*/ 780988 w 1107549"/>
                <a:gd name="connsiteY1" fmla="*/ 46843 h 1769445"/>
                <a:gd name="connsiteX2" fmla="*/ 1107338 w 1107549"/>
                <a:gd name="connsiteY2" fmla="*/ 1003517 h 1769445"/>
                <a:gd name="connsiteX3" fmla="*/ 942412 w 1107549"/>
                <a:gd name="connsiteY3" fmla="*/ 1769445 h 1769445"/>
                <a:gd name="connsiteX0" fmla="*/ 0 w 1107353"/>
                <a:gd name="connsiteY0" fmla="*/ 275936 h 1769445"/>
                <a:gd name="connsiteX1" fmla="*/ 780988 w 1107353"/>
                <a:gd name="connsiteY1" fmla="*/ 46843 h 1769445"/>
                <a:gd name="connsiteX2" fmla="*/ 1107338 w 1107353"/>
                <a:gd name="connsiteY2" fmla="*/ 1003517 h 1769445"/>
                <a:gd name="connsiteX3" fmla="*/ 942412 w 1107353"/>
                <a:gd name="connsiteY3" fmla="*/ 1769445 h 1769445"/>
                <a:gd name="connsiteX0" fmla="*/ 0 w 1107351"/>
                <a:gd name="connsiteY0" fmla="*/ 314258 h 1807767"/>
                <a:gd name="connsiteX1" fmla="*/ 780988 w 1107351"/>
                <a:gd name="connsiteY1" fmla="*/ 85165 h 1807767"/>
                <a:gd name="connsiteX2" fmla="*/ 1107338 w 1107351"/>
                <a:gd name="connsiteY2" fmla="*/ 1041839 h 1807767"/>
                <a:gd name="connsiteX3" fmla="*/ 942412 w 1107351"/>
                <a:gd name="connsiteY3" fmla="*/ 1807767 h 1807767"/>
                <a:gd name="connsiteX0" fmla="*/ 0 w 1110115"/>
                <a:gd name="connsiteY0" fmla="*/ 314258 h 1701473"/>
                <a:gd name="connsiteX1" fmla="*/ 780988 w 1110115"/>
                <a:gd name="connsiteY1" fmla="*/ 85165 h 1701473"/>
                <a:gd name="connsiteX2" fmla="*/ 1107338 w 1110115"/>
                <a:gd name="connsiteY2" fmla="*/ 1041839 h 1701473"/>
                <a:gd name="connsiteX3" fmla="*/ 947276 w 1110115"/>
                <a:gd name="connsiteY3" fmla="*/ 1701473 h 1701473"/>
                <a:gd name="connsiteX0" fmla="*/ 0 w 1108744"/>
                <a:gd name="connsiteY0" fmla="*/ 314258 h 1701473"/>
                <a:gd name="connsiteX1" fmla="*/ 780988 w 1108744"/>
                <a:gd name="connsiteY1" fmla="*/ 85165 h 1701473"/>
                <a:gd name="connsiteX2" fmla="*/ 1107338 w 1108744"/>
                <a:gd name="connsiteY2" fmla="*/ 1041839 h 1701473"/>
                <a:gd name="connsiteX3" fmla="*/ 947276 w 1108744"/>
                <a:gd name="connsiteY3" fmla="*/ 1701473 h 1701473"/>
                <a:gd name="connsiteX0" fmla="*/ 0 w 1107787"/>
                <a:gd name="connsiteY0" fmla="*/ 314258 h 1701473"/>
                <a:gd name="connsiteX1" fmla="*/ 780988 w 1107787"/>
                <a:gd name="connsiteY1" fmla="*/ 85165 h 1701473"/>
                <a:gd name="connsiteX2" fmla="*/ 1107338 w 1107787"/>
                <a:gd name="connsiteY2" fmla="*/ 1041839 h 1701473"/>
                <a:gd name="connsiteX3" fmla="*/ 947276 w 1107787"/>
                <a:gd name="connsiteY3" fmla="*/ 1701473 h 1701473"/>
                <a:gd name="connsiteX0" fmla="*/ 0 w 1082984"/>
                <a:gd name="connsiteY0" fmla="*/ 303739 h 1690954"/>
                <a:gd name="connsiteX1" fmla="*/ 780988 w 1082984"/>
                <a:gd name="connsiteY1" fmla="*/ 74646 h 1690954"/>
                <a:gd name="connsiteX2" fmla="*/ 1082463 w 1082984"/>
                <a:gd name="connsiteY2" fmla="*/ 1018857 h 1690954"/>
                <a:gd name="connsiteX3" fmla="*/ 947276 w 1082984"/>
                <a:gd name="connsiteY3" fmla="*/ 1690954 h 1690954"/>
                <a:gd name="connsiteX0" fmla="*/ 0 w 1082982"/>
                <a:gd name="connsiteY0" fmla="*/ 303739 h 1690954"/>
                <a:gd name="connsiteX1" fmla="*/ 780988 w 1082982"/>
                <a:gd name="connsiteY1" fmla="*/ 74646 h 1690954"/>
                <a:gd name="connsiteX2" fmla="*/ 1082463 w 1082982"/>
                <a:gd name="connsiteY2" fmla="*/ 1018856 h 1690954"/>
                <a:gd name="connsiteX3" fmla="*/ 947276 w 1082982"/>
                <a:gd name="connsiteY3" fmla="*/ 1690954 h 1690954"/>
                <a:gd name="connsiteX0" fmla="*/ 0 w 1085495"/>
                <a:gd name="connsiteY0" fmla="*/ 296404 h 1683619"/>
                <a:gd name="connsiteX1" fmla="*/ 784730 w 1085495"/>
                <a:gd name="connsiteY1" fmla="*/ 78247 h 1683619"/>
                <a:gd name="connsiteX2" fmla="*/ 1082463 w 1085495"/>
                <a:gd name="connsiteY2" fmla="*/ 1011521 h 1683619"/>
                <a:gd name="connsiteX3" fmla="*/ 947276 w 1085495"/>
                <a:gd name="connsiteY3" fmla="*/ 1683619 h 1683619"/>
                <a:gd name="connsiteX0" fmla="*/ 0 w 1085495"/>
                <a:gd name="connsiteY0" fmla="*/ 324423 h 1711638"/>
                <a:gd name="connsiteX1" fmla="*/ 784730 w 1085495"/>
                <a:gd name="connsiteY1" fmla="*/ 106266 h 1711638"/>
                <a:gd name="connsiteX2" fmla="*/ 1082463 w 1085495"/>
                <a:gd name="connsiteY2" fmla="*/ 1039540 h 1711638"/>
                <a:gd name="connsiteX3" fmla="*/ 947276 w 1085495"/>
                <a:gd name="connsiteY3" fmla="*/ 1711638 h 1711638"/>
                <a:gd name="connsiteX0" fmla="*/ 0 w 1082468"/>
                <a:gd name="connsiteY0" fmla="*/ 324423 h 1711638"/>
                <a:gd name="connsiteX1" fmla="*/ 784730 w 1082468"/>
                <a:gd name="connsiteY1" fmla="*/ 106266 h 1711638"/>
                <a:gd name="connsiteX2" fmla="*/ 1082463 w 1082468"/>
                <a:gd name="connsiteY2" fmla="*/ 1039540 h 1711638"/>
                <a:gd name="connsiteX3" fmla="*/ 947276 w 1082468"/>
                <a:gd name="connsiteY3" fmla="*/ 1711638 h 17116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82468" h="1711638">
                  <a:moveTo>
                    <a:pt x="0" y="324423"/>
                  </a:moveTo>
                  <a:cubicBezTo>
                    <a:pt x="200815" y="-34926"/>
                    <a:pt x="603011" y="-77002"/>
                    <a:pt x="784730" y="106266"/>
                  </a:cubicBezTo>
                  <a:cubicBezTo>
                    <a:pt x="966449" y="289534"/>
                    <a:pt x="1081461" y="757867"/>
                    <a:pt x="1082463" y="1039540"/>
                  </a:cubicBezTo>
                  <a:cubicBezTo>
                    <a:pt x="1083465" y="1321213"/>
                    <a:pt x="946217" y="1695233"/>
                    <a:pt x="947276" y="1711638"/>
                  </a:cubicBezTo>
                </a:path>
              </a:pathLst>
            </a:custGeom>
            <a:noFill/>
            <a:ln w="12700">
              <a:solidFill>
                <a:schemeClr val="tx1"/>
              </a:solidFill>
              <a:prstDash val="solid"/>
              <a:tailEnd type="triangle" w="sm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자유형 33">
              <a:extLst>
                <a:ext uri="{FF2B5EF4-FFF2-40B4-BE49-F238E27FC236}">
                  <a16:creationId xmlns:a16="http://schemas.microsoft.com/office/drawing/2014/main" id="{1C5B2905-9F0F-4195-AC52-829EFCB509A7}"/>
                </a:ext>
              </a:extLst>
            </p:cNvPr>
            <p:cNvSpPr/>
            <p:nvPr/>
          </p:nvSpPr>
          <p:spPr>
            <a:xfrm rot="1396408">
              <a:off x="6726975" y="2452887"/>
              <a:ext cx="674459" cy="820323"/>
            </a:xfrm>
            <a:custGeom>
              <a:avLst/>
              <a:gdLst>
                <a:gd name="connsiteX0" fmla="*/ 0 w 1809750"/>
                <a:gd name="connsiteY0" fmla="*/ 461695 h 461695"/>
                <a:gd name="connsiteX1" fmla="*/ 247650 w 1809750"/>
                <a:gd name="connsiteY1" fmla="*/ 144195 h 461695"/>
                <a:gd name="connsiteX2" fmla="*/ 742950 w 1809750"/>
                <a:gd name="connsiteY2" fmla="*/ 4495 h 461695"/>
                <a:gd name="connsiteX3" fmla="*/ 1257300 w 1809750"/>
                <a:gd name="connsiteY3" fmla="*/ 42595 h 461695"/>
                <a:gd name="connsiteX4" fmla="*/ 1555750 w 1809750"/>
                <a:gd name="connsiteY4" fmla="*/ 125145 h 461695"/>
                <a:gd name="connsiteX5" fmla="*/ 1765300 w 1809750"/>
                <a:gd name="connsiteY5" fmla="*/ 341045 h 461695"/>
                <a:gd name="connsiteX6" fmla="*/ 1809750 w 1809750"/>
                <a:gd name="connsiteY6" fmla="*/ 423595 h 461695"/>
                <a:gd name="connsiteX0" fmla="*/ 0 w 1809750"/>
                <a:gd name="connsiteY0" fmla="*/ 467606 h 467606"/>
                <a:gd name="connsiteX1" fmla="*/ 247650 w 1809750"/>
                <a:gd name="connsiteY1" fmla="*/ 150106 h 467606"/>
                <a:gd name="connsiteX2" fmla="*/ 831850 w 1809750"/>
                <a:gd name="connsiteY2" fmla="*/ 4056 h 467606"/>
                <a:gd name="connsiteX3" fmla="*/ 1257300 w 1809750"/>
                <a:gd name="connsiteY3" fmla="*/ 48506 h 467606"/>
                <a:gd name="connsiteX4" fmla="*/ 1555750 w 1809750"/>
                <a:gd name="connsiteY4" fmla="*/ 131056 h 467606"/>
                <a:gd name="connsiteX5" fmla="*/ 1765300 w 1809750"/>
                <a:gd name="connsiteY5" fmla="*/ 346956 h 467606"/>
                <a:gd name="connsiteX6" fmla="*/ 1809750 w 1809750"/>
                <a:gd name="connsiteY6" fmla="*/ 429506 h 467606"/>
                <a:gd name="connsiteX0" fmla="*/ 0 w 1809750"/>
                <a:gd name="connsiteY0" fmla="*/ 469070 h 469070"/>
                <a:gd name="connsiteX1" fmla="*/ 247650 w 1809750"/>
                <a:gd name="connsiteY1" fmla="*/ 151570 h 469070"/>
                <a:gd name="connsiteX2" fmla="*/ 831850 w 1809750"/>
                <a:gd name="connsiteY2" fmla="*/ 5520 h 469070"/>
                <a:gd name="connsiteX3" fmla="*/ 1282700 w 1809750"/>
                <a:gd name="connsiteY3" fmla="*/ 40445 h 469070"/>
                <a:gd name="connsiteX4" fmla="*/ 1555750 w 1809750"/>
                <a:gd name="connsiteY4" fmla="*/ 132520 h 469070"/>
                <a:gd name="connsiteX5" fmla="*/ 1765300 w 1809750"/>
                <a:gd name="connsiteY5" fmla="*/ 348420 h 469070"/>
                <a:gd name="connsiteX6" fmla="*/ 1809750 w 1809750"/>
                <a:gd name="connsiteY6" fmla="*/ 430970 h 469070"/>
                <a:gd name="connsiteX0" fmla="*/ 0 w 1809750"/>
                <a:gd name="connsiteY0" fmla="*/ 469239 h 469239"/>
                <a:gd name="connsiteX1" fmla="*/ 247650 w 1809750"/>
                <a:gd name="connsiteY1" fmla="*/ 151739 h 469239"/>
                <a:gd name="connsiteX2" fmla="*/ 831850 w 1809750"/>
                <a:gd name="connsiteY2" fmla="*/ 5689 h 469239"/>
                <a:gd name="connsiteX3" fmla="*/ 1282700 w 1809750"/>
                <a:gd name="connsiteY3" fmla="*/ 40614 h 469239"/>
                <a:gd name="connsiteX4" fmla="*/ 1546225 w 1809750"/>
                <a:gd name="connsiteY4" fmla="*/ 142214 h 469239"/>
                <a:gd name="connsiteX5" fmla="*/ 1765300 w 1809750"/>
                <a:gd name="connsiteY5" fmla="*/ 348589 h 469239"/>
                <a:gd name="connsiteX6" fmla="*/ 1809750 w 1809750"/>
                <a:gd name="connsiteY6" fmla="*/ 431139 h 469239"/>
                <a:gd name="connsiteX0" fmla="*/ 0 w 1809750"/>
                <a:gd name="connsiteY0" fmla="*/ 470087 h 470087"/>
                <a:gd name="connsiteX1" fmla="*/ 257175 w 1809750"/>
                <a:gd name="connsiteY1" fmla="*/ 165287 h 470087"/>
                <a:gd name="connsiteX2" fmla="*/ 831850 w 1809750"/>
                <a:gd name="connsiteY2" fmla="*/ 6537 h 470087"/>
                <a:gd name="connsiteX3" fmla="*/ 1282700 w 1809750"/>
                <a:gd name="connsiteY3" fmla="*/ 41462 h 470087"/>
                <a:gd name="connsiteX4" fmla="*/ 1546225 w 1809750"/>
                <a:gd name="connsiteY4" fmla="*/ 143062 h 470087"/>
                <a:gd name="connsiteX5" fmla="*/ 1765300 w 1809750"/>
                <a:gd name="connsiteY5" fmla="*/ 349437 h 470087"/>
                <a:gd name="connsiteX6" fmla="*/ 1809750 w 1809750"/>
                <a:gd name="connsiteY6" fmla="*/ 431987 h 470087"/>
                <a:gd name="connsiteX0" fmla="*/ 0 w 1809750"/>
                <a:gd name="connsiteY0" fmla="*/ 470179 h 470179"/>
                <a:gd name="connsiteX1" fmla="*/ 257175 w 1809750"/>
                <a:gd name="connsiteY1" fmla="*/ 165379 h 470179"/>
                <a:gd name="connsiteX2" fmla="*/ 831850 w 1809750"/>
                <a:gd name="connsiteY2" fmla="*/ 6629 h 470179"/>
                <a:gd name="connsiteX3" fmla="*/ 1282700 w 1809750"/>
                <a:gd name="connsiteY3" fmla="*/ 41554 h 470179"/>
                <a:gd name="connsiteX4" fmla="*/ 1536700 w 1809750"/>
                <a:gd name="connsiteY4" fmla="*/ 147916 h 470179"/>
                <a:gd name="connsiteX5" fmla="*/ 1765300 w 1809750"/>
                <a:gd name="connsiteY5" fmla="*/ 349529 h 470179"/>
                <a:gd name="connsiteX6" fmla="*/ 1809750 w 1809750"/>
                <a:gd name="connsiteY6" fmla="*/ 432079 h 470179"/>
                <a:gd name="connsiteX0" fmla="*/ 0 w 1809750"/>
                <a:gd name="connsiteY0" fmla="*/ 473706 h 473706"/>
                <a:gd name="connsiteX1" fmla="*/ 257175 w 1809750"/>
                <a:gd name="connsiteY1" fmla="*/ 168906 h 473706"/>
                <a:gd name="connsiteX2" fmla="*/ 831850 w 1809750"/>
                <a:gd name="connsiteY2" fmla="*/ 10156 h 473706"/>
                <a:gd name="connsiteX3" fmla="*/ 1220788 w 1809750"/>
                <a:gd name="connsiteY3" fmla="*/ 30794 h 473706"/>
                <a:gd name="connsiteX4" fmla="*/ 1536700 w 1809750"/>
                <a:gd name="connsiteY4" fmla="*/ 151443 h 473706"/>
                <a:gd name="connsiteX5" fmla="*/ 1765300 w 1809750"/>
                <a:gd name="connsiteY5" fmla="*/ 353056 h 473706"/>
                <a:gd name="connsiteX6" fmla="*/ 1809750 w 1809750"/>
                <a:gd name="connsiteY6" fmla="*/ 435606 h 473706"/>
                <a:gd name="connsiteX0" fmla="*/ 0 w 1809750"/>
                <a:gd name="connsiteY0" fmla="*/ 466416 h 466416"/>
                <a:gd name="connsiteX1" fmla="*/ 257175 w 1809750"/>
                <a:gd name="connsiteY1" fmla="*/ 161616 h 466416"/>
                <a:gd name="connsiteX2" fmla="*/ 693738 w 1809750"/>
                <a:gd name="connsiteY2" fmla="*/ 12391 h 466416"/>
                <a:gd name="connsiteX3" fmla="*/ 1220788 w 1809750"/>
                <a:gd name="connsiteY3" fmla="*/ 23504 h 466416"/>
                <a:gd name="connsiteX4" fmla="*/ 1536700 w 1809750"/>
                <a:gd name="connsiteY4" fmla="*/ 144153 h 466416"/>
                <a:gd name="connsiteX5" fmla="*/ 1765300 w 1809750"/>
                <a:gd name="connsiteY5" fmla="*/ 345766 h 466416"/>
                <a:gd name="connsiteX6" fmla="*/ 1809750 w 1809750"/>
                <a:gd name="connsiteY6" fmla="*/ 428316 h 466416"/>
                <a:gd name="connsiteX0" fmla="*/ 0 w 1767026"/>
                <a:gd name="connsiteY0" fmla="*/ 466416 h 1959925"/>
                <a:gd name="connsiteX1" fmla="*/ 257175 w 1767026"/>
                <a:gd name="connsiteY1" fmla="*/ 161616 h 1959925"/>
                <a:gd name="connsiteX2" fmla="*/ 693738 w 1767026"/>
                <a:gd name="connsiteY2" fmla="*/ 12391 h 1959925"/>
                <a:gd name="connsiteX3" fmla="*/ 1220788 w 1767026"/>
                <a:gd name="connsiteY3" fmla="*/ 23504 h 1959925"/>
                <a:gd name="connsiteX4" fmla="*/ 1536700 w 1767026"/>
                <a:gd name="connsiteY4" fmla="*/ 144153 h 1959925"/>
                <a:gd name="connsiteX5" fmla="*/ 1765300 w 1767026"/>
                <a:gd name="connsiteY5" fmla="*/ 345766 h 1959925"/>
                <a:gd name="connsiteX6" fmla="*/ 942412 w 1767026"/>
                <a:gd name="connsiteY6" fmla="*/ 1959925 h 1959925"/>
                <a:gd name="connsiteX0" fmla="*/ 0 w 1537366"/>
                <a:gd name="connsiteY0" fmla="*/ 466416 h 1959925"/>
                <a:gd name="connsiteX1" fmla="*/ 257175 w 1537366"/>
                <a:gd name="connsiteY1" fmla="*/ 161616 h 1959925"/>
                <a:gd name="connsiteX2" fmla="*/ 693738 w 1537366"/>
                <a:gd name="connsiteY2" fmla="*/ 12391 h 1959925"/>
                <a:gd name="connsiteX3" fmla="*/ 1220788 w 1537366"/>
                <a:gd name="connsiteY3" fmla="*/ 23504 h 1959925"/>
                <a:gd name="connsiteX4" fmla="*/ 1536700 w 1537366"/>
                <a:gd name="connsiteY4" fmla="*/ 144153 h 1959925"/>
                <a:gd name="connsiteX5" fmla="*/ 1140910 w 1537366"/>
                <a:gd name="connsiteY5" fmla="*/ 1201757 h 1959925"/>
                <a:gd name="connsiteX6" fmla="*/ 942412 w 1537366"/>
                <a:gd name="connsiteY6" fmla="*/ 1959925 h 1959925"/>
                <a:gd name="connsiteX0" fmla="*/ 0 w 1222460"/>
                <a:gd name="connsiteY0" fmla="*/ 517986 h 2011495"/>
                <a:gd name="connsiteX1" fmla="*/ 257175 w 1222460"/>
                <a:gd name="connsiteY1" fmla="*/ 213186 h 2011495"/>
                <a:gd name="connsiteX2" fmla="*/ 693738 w 1222460"/>
                <a:gd name="connsiteY2" fmla="*/ 63961 h 2011495"/>
                <a:gd name="connsiteX3" fmla="*/ 1220788 w 1222460"/>
                <a:gd name="connsiteY3" fmla="*/ 75074 h 2011495"/>
                <a:gd name="connsiteX4" fmla="*/ 869947 w 1222460"/>
                <a:gd name="connsiteY4" fmla="*/ 958003 h 2011495"/>
                <a:gd name="connsiteX5" fmla="*/ 1140910 w 1222460"/>
                <a:gd name="connsiteY5" fmla="*/ 1253327 h 2011495"/>
                <a:gd name="connsiteX6" fmla="*/ 942412 w 1222460"/>
                <a:gd name="connsiteY6" fmla="*/ 2011495 h 2011495"/>
                <a:gd name="connsiteX0" fmla="*/ 0 w 1246286"/>
                <a:gd name="connsiteY0" fmla="*/ 539641 h 2033150"/>
                <a:gd name="connsiteX1" fmla="*/ 257175 w 1246286"/>
                <a:gd name="connsiteY1" fmla="*/ 234841 h 2033150"/>
                <a:gd name="connsiteX2" fmla="*/ 693738 w 1246286"/>
                <a:gd name="connsiteY2" fmla="*/ 85616 h 2033150"/>
                <a:gd name="connsiteX3" fmla="*/ 1220788 w 1246286"/>
                <a:gd name="connsiteY3" fmla="*/ 96729 h 2033150"/>
                <a:gd name="connsiteX4" fmla="*/ 1140910 w 1246286"/>
                <a:gd name="connsiteY4" fmla="*/ 1274982 h 2033150"/>
                <a:gd name="connsiteX5" fmla="*/ 942412 w 1246286"/>
                <a:gd name="connsiteY5" fmla="*/ 2033150 h 2033150"/>
                <a:gd name="connsiteX0" fmla="*/ 0 w 1149487"/>
                <a:gd name="connsiteY0" fmla="*/ 488553 h 1982062"/>
                <a:gd name="connsiteX1" fmla="*/ 257175 w 1149487"/>
                <a:gd name="connsiteY1" fmla="*/ 183753 h 1982062"/>
                <a:gd name="connsiteX2" fmla="*/ 693738 w 1149487"/>
                <a:gd name="connsiteY2" fmla="*/ 34528 h 1982062"/>
                <a:gd name="connsiteX3" fmla="*/ 959326 w 1149487"/>
                <a:gd name="connsiteY3" fmla="*/ 847892 h 1982062"/>
                <a:gd name="connsiteX4" fmla="*/ 1140910 w 1149487"/>
                <a:gd name="connsiteY4" fmla="*/ 1223894 h 1982062"/>
                <a:gd name="connsiteX5" fmla="*/ 942412 w 1149487"/>
                <a:gd name="connsiteY5" fmla="*/ 1982062 h 1982062"/>
                <a:gd name="connsiteX0" fmla="*/ 0 w 1146545"/>
                <a:gd name="connsiteY0" fmla="*/ 514484 h 2007993"/>
                <a:gd name="connsiteX1" fmla="*/ 257175 w 1146545"/>
                <a:gd name="connsiteY1" fmla="*/ 209684 h 2007993"/>
                <a:gd name="connsiteX2" fmla="*/ 693738 w 1146545"/>
                <a:gd name="connsiteY2" fmla="*/ 60459 h 2007993"/>
                <a:gd name="connsiteX3" fmla="*/ 1140910 w 1146545"/>
                <a:gd name="connsiteY3" fmla="*/ 1249825 h 2007993"/>
                <a:gd name="connsiteX4" fmla="*/ 942412 w 1146545"/>
                <a:gd name="connsiteY4" fmla="*/ 2007993 h 2007993"/>
                <a:gd name="connsiteX0" fmla="*/ 0 w 1146545"/>
                <a:gd name="connsiteY0" fmla="*/ 304801 h 1798310"/>
                <a:gd name="connsiteX1" fmla="*/ 257175 w 1146545"/>
                <a:gd name="connsiteY1" fmla="*/ 1 h 1798310"/>
                <a:gd name="connsiteX2" fmla="*/ 859543 w 1146545"/>
                <a:gd name="connsiteY2" fmla="*/ 305341 h 1798310"/>
                <a:gd name="connsiteX3" fmla="*/ 1140910 w 1146545"/>
                <a:gd name="connsiteY3" fmla="*/ 1040142 h 1798310"/>
                <a:gd name="connsiteX4" fmla="*/ 942412 w 1146545"/>
                <a:gd name="connsiteY4" fmla="*/ 1798310 h 1798310"/>
                <a:gd name="connsiteX0" fmla="*/ 0 w 1146545"/>
                <a:gd name="connsiteY0" fmla="*/ 159707 h 1653216"/>
                <a:gd name="connsiteX1" fmla="*/ 420171 w 1146545"/>
                <a:gd name="connsiteY1" fmla="*/ 1 h 1653216"/>
                <a:gd name="connsiteX2" fmla="*/ 859543 w 1146545"/>
                <a:gd name="connsiteY2" fmla="*/ 160247 h 1653216"/>
                <a:gd name="connsiteX3" fmla="*/ 1140910 w 1146545"/>
                <a:gd name="connsiteY3" fmla="*/ 895048 h 1653216"/>
                <a:gd name="connsiteX4" fmla="*/ 942412 w 1146545"/>
                <a:gd name="connsiteY4" fmla="*/ 1653216 h 1653216"/>
                <a:gd name="connsiteX0" fmla="*/ 0 w 1146545"/>
                <a:gd name="connsiteY0" fmla="*/ 159707 h 1653216"/>
                <a:gd name="connsiteX1" fmla="*/ 420171 w 1146545"/>
                <a:gd name="connsiteY1" fmla="*/ 1 h 1653216"/>
                <a:gd name="connsiteX2" fmla="*/ 859543 w 1146545"/>
                <a:gd name="connsiteY2" fmla="*/ 160247 h 1653216"/>
                <a:gd name="connsiteX3" fmla="*/ 1140910 w 1146545"/>
                <a:gd name="connsiteY3" fmla="*/ 895048 h 1653216"/>
                <a:gd name="connsiteX4" fmla="*/ 942412 w 1146545"/>
                <a:gd name="connsiteY4" fmla="*/ 1653216 h 1653216"/>
                <a:gd name="connsiteX0" fmla="*/ 0 w 1141169"/>
                <a:gd name="connsiteY0" fmla="*/ 159707 h 1653216"/>
                <a:gd name="connsiteX1" fmla="*/ 420171 w 1141169"/>
                <a:gd name="connsiteY1" fmla="*/ 1 h 1653216"/>
                <a:gd name="connsiteX2" fmla="*/ 859543 w 1141169"/>
                <a:gd name="connsiteY2" fmla="*/ 160247 h 1653216"/>
                <a:gd name="connsiteX3" fmla="*/ 1140910 w 1141169"/>
                <a:gd name="connsiteY3" fmla="*/ 895048 h 1653216"/>
                <a:gd name="connsiteX4" fmla="*/ 942412 w 1141169"/>
                <a:gd name="connsiteY4" fmla="*/ 1653216 h 1653216"/>
                <a:gd name="connsiteX0" fmla="*/ 0 w 1141869"/>
                <a:gd name="connsiteY0" fmla="*/ 159707 h 1653216"/>
                <a:gd name="connsiteX1" fmla="*/ 420171 w 1141869"/>
                <a:gd name="connsiteY1" fmla="*/ 1 h 1653216"/>
                <a:gd name="connsiteX2" fmla="*/ 859543 w 1141869"/>
                <a:gd name="connsiteY2" fmla="*/ 160247 h 1653216"/>
                <a:gd name="connsiteX3" fmla="*/ 1140910 w 1141869"/>
                <a:gd name="connsiteY3" fmla="*/ 895048 h 1653216"/>
                <a:gd name="connsiteX4" fmla="*/ 942412 w 1141869"/>
                <a:gd name="connsiteY4" fmla="*/ 1653216 h 1653216"/>
                <a:gd name="connsiteX0" fmla="*/ 0 w 1141869"/>
                <a:gd name="connsiteY0" fmla="*/ 233194 h 1726703"/>
                <a:gd name="connsiteX1" fmla="*/ 436257 w 1141869"/>
                <a:gd name="connsiteY1" fmla="*/ 1 h 1726703"/>
                <a:gd name="connsiteX2" fmla="*/ 859543 w 1141869"/>
                <a:gd name="connsiteY2" fmla="*/ 233734 h 1726703"/>
                <a:gd name="connsiteX3" fmla="*/ 1140910 w 1141869"/>
                <a:gd name="connsiteY3" fmla="*/ 968535 h 1726703"/>
                <a:gd name="connsiteX4" fmla="*/ 942412 w 1141869"/>
                <a:gd name="connsiteY4" fmla="*/ 1726703 h 1726703"/>
                <a:gd name="connsiteX0" fmla="*/ 0 w 1141869"/>
                <a:gd name="connsiteY0" fmla="*/ 233194 h 1726703"/>
                <a:gd name="connsiteX1" fmla="*/ 436257 w 1141869"/>
                <a:gd name="connsiteY1" fmla="*/ 1 h 1726703"/>
                <a:gd name="connsiteX2" fmla="*/ 859543 w 1141869"/>
                <a:gd name="connsiteY2" fmla="*/ 233734 h 1726703"/>
                <a:gd name="connsiteX3" fmla="*/ 1140910 w 1141869"/>
                <a:gd name="connsiteY3" fmla="*/ 968535 h 1726703"/>
                <a:gd name="connsiteX4" fmla="*/ 942412 w 1141869"/>
                <a:gd name="connsiteY4" fmla="*/ 1726703 h 1726703"/>
                <a:gd name="connsiteX0" fmla="*/ 0 w 1141196"/>
                <a:gd name="connsiteY0" fmla="*/ 235957 h 1729466"/>
                <a:gd name="connsiteX1" fmla="*/ 436257 w 1141196"/>
                <a:gd name="connsiteY1" fmla="*/ 2764 h 1729466"/>
                <a:gd name="connsiteX2" fmla="*/ 888064 w 1141196"/>
                <a:gd name="connsiteY2" fmla="*/ 169241 h 1729466"/>
                <a:gd name="connsiteX3" fmla="*/ 1140910 w 1141196"/>
                <a:gd name="connsiteY3" fmla="*/ 971298 h 1729466"/>
                <a:gd name="connsiteX4" fmla="*/ 942412 w 1141196"/>
                <a:gd name="connsiteY4" fmla="*/ 1729466 h 1729466"/>
                <a:gd name="connsiteX0" fmla="*/ 0 w 1107677"/>
                <a:gd name="connsiteY0" fmla="*/ 235882 h 1729391"/>
                <a:gd name="connsiteX1" fmla="*/ 436257 w 1107677"/>
                <a:gd name="connsiteY1" fmla="*/ 2689 h 1729391"/>
                <a:gd name="connsiteX2" fmla="*/ 888064 w 1107677"/>
                <a:gd name="connsiteY2" fmla="*/ 169166 h 1729391"/>
                <a:gd name="connsiteX3" fmla="*/ 1107338 w 1107677"/>
                <a:gd name="connsiteY3" fmla="*/ 963463 h 1729391"/>
                <a:gd name="connsiteX4" fmla="*/ 942412 w 1107677"/>
                <a:gd name="connsiteY4" fmla="*/ 1729391 h 1729391"/>
                <a:gd name="connsiteX0" fmla="*/ 0 w 1107677"/>
                <a:gd name="connsiteY0" fmla="*/ 235882 h 1729391"/>
                <a:gd name="connsiteX1" fmla="*/ 436257 w 1107677"/>
                <a:gd name="connsiteY1" fmla="*/ 2689 h 1729391"/>
                <a:gd name="connsiteX2" fmla="*/ 888064 w 1107677"/>
                <a:gd name="connsiteY2" fmla="*/ 169166 h 1729391"/>
                <a:gd name="connsiteX3" fmla="*/ 1107338 w 1107677"/>
                <a:gd name="connsiteY3" fmla="*/ 963463 h 1729391"/>
                <a:gd name="connsiteX4" fmla="*/ 942412 w 1107677"/>
                <a:gd name="connsiteY4" fmla="*/ 1729391 h 1729391"/>
                <a:gd name="connsiteX0" fmla="*/ 0 w 1107677"/>
                <a:gd name="connsiteY0" fmla="*/ 109422 h 1602931"/>
                <a:gd name="connsiteX1" fmla="*/ 888064 w 1107677"/>
                <a:gd name="connsiteY1" fmla="*/ 42706 h 1602931"/>
                <a:gd name="connsiteX2" fmla="*/ 1107338 w 1107677"/>
                <a:gd name="connsiteY2" fmla="*/ 837003 h 1602931"/>
                <a:gd name="connsiteX3" fmla="*/ 942412 w 1107677"/>
                <a:gd name="connsiteY3" fmla="*/ 1602931 h 1602931"/>
                <a:gd name="connsiteX0" fmla="*/ 0 w 1111835"/>
                <a:gd name="connsiteY0" fmla="*/ 196561 h 1690070"/>
                <a:gd name="connsiteX1" fmla="*/ 888064 w 1111835"/>
                <a:gd name="connsiteY1" fmla="*/ 129845 h 1690070"/>
                <a:gd name="connsiteX2" fmla="*/ 1107338 w 1111835"/>
                <a:gd name="connsiteY2" fmla="*/ 924142 h 1690070"/>
                <a:gd name="connsiteX3" fmla="*/ 942412 w 1111835"/>
                <a:gd name="connsiteY3" fmla="*/ 1690070 h 1690070"/>
                <a:gd name="connsiteX0" fmla="*/ 0 w 1109911"/>
                <a:gd name="connsiteY0" fmla="*/ 331391 h 1824900"/>
                <a:gd name="connsiteX1" fmla="*/ 780988 w 1109911"/>
                <a:gd name="connsiteY1" fmla="*/ 102298 h 1824900"/>
                <a:gd name="connsiteX2" fmla="*/ 1107338 w 1109911"/>
                <a:gd name="connsiteY2" fmla="*/ 1058972 h 1824900"/>
                <a:gd name="connsiteX3" fmla="*/ 942412 w 1109911"/>
                <a:gd name="connsiteY3" fmla="*/ 1824900 h 1824900"/>
                <a:gd name="connsiteX0" fmla="*/ 0 w 1109913"/>
                <a:gd name="connsiteY0" fmla="*/ 351578 h 1845087"/>
                <a:gd name="connsiteX1" fmla="*/ 780988 w 1109913"/>
                <a:gd name="connsiteY1" fmla="*/ 122485 h 1845087"/>
                <a:gd name="connsiteX2" fmla="*/ 1107338 w 1109913"/>
                <a:gd name="connsiteY2" fmla="*/ 1079159 h 1845087"/>
                <a:gd name="connsiteX3" fmla="*/ 942412 w 1109913"/>
                <a:gd name="connsiteY3" fmla="*/ 1845087 h 1845087"/>
                <a:gd name="connsiteX0" fmla="*/ 0 w 1109911"/>
                <a:gd name="connsiteY0" fmla="*/ 275936 h 1769445"/>
                <a:gd name="connsiteX1" fmla="*/ 780988 w 1109911"/>
                <a:gd name="connsiteY1" fmla="*/ 46843 h 1769445"/>
                <a:gd name="connsiteX2" fmla="*/ 1107338 w 1109911"/>
                <a:gd name="connsiteY2" fmla="*/ 1003517 h 1769445"/>
                <a:gd name="connsiteX3" fmla="*/ 942412 w 1109911"/>
                <a:gd name="connsiteY3" fmla="*/ 1769445 h 1769445"/>
                <a:gd name="connsiteX0" fmla="*/ 0 w 1107549"/>
                <a:gd name="connsiteY0" fmla="*/ 275936 h 1769445"/>
                <a:gd name="connsiteX1" fmla="*/ 780988 w 1107549"/>
                <a:gd name="connsiteY1" fmla="*/ 46843 h 1769445"/>
                <a:gd name="connsiteX2" fmla="*/ 1107338 w 1107549"/>
                <a:gd name="connsiteY2" fmla="*/ 1003517 h 1769445"/>
                <a:gd name="connsiteX3" fmla="*/ 942412 w 1107549"/>
                <a:gd name="connsiteY3" fmla="*/ 1769445 h 1769445"/>
                <a:gd name="connsiteX0" fmla="*/ 0 w 1107353"/>
                <a:gd name="connsiteY0" fmla="*/ 275936 h 1769445"/>
                <a:gd name="connsiteX1" fmla="*/ 780988 w 1107353"/>
                <a:gd name="connsiteY1" fmla="*/ 46843 h 1769445"/>
                <a:gd name="connsiteX2" fmla="*/ 1107338 w 1107353"/>
                <a:gd name="connsiteY2" fmla="*/ 1003517 h 1769445"/>
                <a:gd name="connsiteX3" fmla="*/ 942412 w 1107353"/>
                <a:gd name="connsiteY3" fmla="*/ 1769445 h 1769445"/>
                <a:gd name="connsiteX0" fmla="*/ 0 w 1107351"/>
                <a:gd name="connsiteY0" fmla="*/ 314258 h 1807767"/>
                <a:gd name="connsiteX1" fmla="*/ 780988 w 1107351"/>
                <a:gd name="connsiteY1" fmla="*/ 85165 h 1807767"/>
                <a:gd name="connsiteX2" fmla="*/ 1107338 w 1107351"/>
                <a:gd name="connsiteY2" fmla="*/ 1041839 h 1807767"/>
                <a:gd name="connsiteX3" fmla="*/ 942412 w 1107351"/>
                <a:gd name="connsiteY3" fmla="*/ 1807767 h 1807767"/>
                <a:gd name="connsiteX0" fmla="*/ 0 w 1110115"/>
                <a:gd name="connsiteY0" fmla="*/ 314258 h 1701473"/>
                <a:gd name="connsiteX1" fmla="*/ 780988 w 1110115"/>
                <a:gd name="connsiteY1" fmla="*/ 85165 h 1701473"/>
                <a:gd name="connsiteX2" fmla="*/ 1107338 w 1110115"/>
                <a:gd name="connsiteY2" fmla="*/ 1041839 h 1701473"/>
                <a:gd name="connsiteX3" fmla="*/ 947276 w 1110115"/>
                <a:gd name="connsiteY3" fmla="*/ 1701473 h 1701473"/>
                <a:gd name="connsiteX0" fmla="*/ 0 w 1108744"/>
                <a:gd name="connsiteY0" fmla="*/ 314258 h 1701473"/>
                <a:gd name="connsiteX1" fmla="*/ 780988 w 1108744"/>
                <a:gd name="connsiteY1" fmla="*/ 85165 h 1701473"/>
                <a:gd name="connsiteX2" fmla="*/ 1107338 w 1108744"/>
                <a:gd name="connsiteY2" fmla="*/ 1041839 h 1701473"/>
                <a:gd name="connsiteX3" fmla="*/ 947276 w 1108744"/>
                <a:gd name="connsiteY3" fmla="*/ 1701473 h 1701473"/>
                <a:gd name="connsiteX0" fmla="*/ 0 w 1107787"/>
                <a:gd name="connsiteY0" fmla="*/ 314258 h 1701473"/>
                <a:gd name="connsiteX1" fmla="*/ 780988 w 1107787"/>
                <a:gd name="connsiteY1" fmla="*/ 85165 h 1701473"/>
                <a:gd name="connsiteX2" fmla="*/ 1107338 w 1107787"/>
                <a:gd name="connsiteY2" fmla="*/ 1041839 h 1701473"/>
                <a:gd name="connsiteX3" fmla="*/ 947276 w 1107787"/>
                <a:gd name="connsiteY3" fmla="*/ 1701473 h 1701473"/>
                <a:gd name="connsiteX0" fmla="*/ 0 w 1082984"/>
                <a:gd name="connsiteY0" fmla="*/ 303739 h 1690954"/>
                <a:gd name="connsiteX1" fmla="*/ 780988 w 1082984"/>
                <a:gd name="connsiteY1" fmla="*/ 74646 h 1690954"/>
                <a:gd name="connsiteX2" fmla="*/ 1082463 w 1082984"/>
                <a:gd name="connsiteY2" fmla="*/ 1018857 h 1690954"/>
                <a:gd name="connsiteX3" fmla="*/ 947276 w 1082984"/>
                <a:gd name="connsiteY3" fmla="*/ 1690954 h 1690954"/>
                <a:gd name="connsiteX0" fmla="*/ 0 w 1082982"/>
                <a:gd name="connsiteY0" fmla="*/ 303739 h 1690954"/>
                <a:gd name="connsiteX1" fmla="*/ 780988 w 1082982"/>
                <a:gd name="connsiteY1" fmla="*/ 74646 h 1690954"/>
                <a:gd name="connsiteX2" fmla="*/ 1082463 w 1082982"/>
                <a:gd name="connsiteY2" fmla="*/ 1018856 h 1690954"/>
                <a:gd name="connsiteX3" fmla="*/ 947276 w 1082982"/>
                <a:gd name="connsiteY3" fmla="*/ 1690954 h 1690954"/>
                <a:gd name="connsiteX0" fmla="*/ 0 w 1085495"/>
                <a:gd name="connsiteY0" fmla="*/ 296404 h 1683619"/>
                <a:gd name="connsiteX1" fmla="*/ 784730 w 1085495"/>
                <a:gd name="connsiteY1" fmla="*/ 78247 h 1683619"/>
                <a:gd name="connsiteX2" fmla="*/ 1082463 w 1085495"/>
                <a:gd name="connsiteY2" fmla="*/ 1011521 h 1683619"/>
                <a:gd name="connsiteX3" fmla="*/ 947276 w 1085495"/>
                <a:gd name="connsiteY3" fmla="*/ 1683619 h 1683619"/>
                <a:gd name="connsiteX0" fmla="*/ 0 w 1085495"/>
                <a:gd name="connsiteY0" fmla="*/ 324423 h 1711638"/>
                <a:gd name="connsiteX1" fmla="*/ 784730 w 1085495"/>
                <a:gd name="connsiteY1" fmla="*/ 106266 h 1711638"/>
                <a:gd name="connsiteX2" fmla="*/ 1082463 w 1085495"/>
                <a:gd name="connsiteY2" fmla="*/ 1039540 h 1711638"/>
                <a:gd name="connsiteX3" fmla="*/ 947276 w 1085495"/>
                <a:gd name="connsiteY3" fmla="*/ 1711638 h 1711638"/>
                <a:gd name="connsiteX0" fmla="*/ 0 w 1082468"/>
                <a:gd name="connsiteY0" fmla="*/ 324423 h 1711638"/>
                <a:gd name="connsiteX1" fmla="*/ 784730 w 1082468"/>
                <a:gd name="connsiteY1" fmla="*/ 106266 h 1711638"/>
                <a:gd name="connsiteX2" fmla="*/ 1082463 w 1082468"/>
                <a:gd name="connsiteY2" fmla="*/ 1039540 h 1711638"/>
                <a:gd name="connsiteX3" fmla="*/ 947276 w 1082468"/>
                <a:gd name="connsiteY3" fmla="*/ 1711638 h 1711638"/>
                <a:gd name="connsiteX0" fmla="*/ 0 w 1110346"/>
                <a:gd name="connsiteY0" fmla="*/ 484533 h 1622885"/>
                <a:gd name="connsiteX1" fmla="*/ 812608 w 1110346"/>
                <a:gd name="connsiteY1" fmla="*/ 17513 h 1622885"/>
                <a:gd name="connsiteX2" fmla="*/ 1110341 w 1110346"/>
                <a:gd name="connsiteY2" fmla="*/ 950787 h 1622885"/>
                <a:gd name="connsiteX3" fmla="*/ 975154 w 1110346"/>
                <a:gd name="connsiteY3" fmla="*/ 1622885 h 1622885"/>
                <a:gd name="connsiteX0" fmla="*/ 0 w 1110346"/>
                <a:gd name="connsiteY0" fmla="*/ 548052 h 1686404"/>
                <a:gd name="connsiteX1" fmla="*/ 812608 w 1110346"/>
                <a:gd name="connsiteY1" fmla="*/ 81032 h 1686404"/>
                <a:gd name="connsiteX2" fmla="*/ 1110341 w 1110346"/>
                <a:gd name="connsiteY2" fmla="*/ 1014306 h 1686404"/>
                <a:gd name="connsiteX3" fmla="*/ 975154 w 1110346"/>
                <a:gd name="connsiteY3" fmla="*/ 1686404 h 1686404"/>
                <a:gd name="connsiteX0" fmla="*/ 0 w 1110346"/>
                <a:gd name="connsiteY0" fmla="*/ 565432 h 1703784"/>
                <a:gd name="connsiteX1" fmla="*/ 812608 w 1110346"/>
                <a:gd name="connsiteY1" fmla="*/ 98412 h 1703784"/>
                <a:gd name="connsiteX2" fmla="*/ 1110341 w 1110346"/>
                <a:gd name="connsiteY2" fmla="*/ 1031686 h 1703784"/>
                <a:gd name="connsiteX3" fmla="*/ 975154 w 1110346"/>
                <a:gd name="connsiteY3" fmla="*/ 1703784 h 1703784"/>
                <a:gd name="connsiteX0" fmla="*/ 0 w 1110346"/>
                <a:gd name="connsiteY0" fmla="*/ 536521 h 1674873"/>
                <a:gd name="connsiteX1" fmla="*/ 812608 w 1110346"/>
                <a:gd name="connsiteY1" fmla="*/ 69501 h 1674873"/>
                <a:gd name="connsiteX2" fmla="*/ 1110341 w 1110346"/>
                <a:gd name="connsiteY2" fmla="*/ 1002775 h 1674873"/>
                <a:gd name="connsiteX3" fmla="*/ 975154 w 1110346"/>
                <a:gd name="connsiteY3" fmla="*/ 1674873 h 1674873"/>
                <a:gd name="connsiteX0" fmla="*/ 0 w 1110346"/>
                <a:gd name="connsiteY0" fmla="*/ 544124 h 1682476"/>
                <a:gd name="connsiteX1" fmla="*/ 812608 w 1110346"/>
                <a:gd name="connsiteY1" fmla="*/ 77104 h 1682476"/>
                <a:gd name="connsiteX2" fmla="*/ 1110341 w 1110346"/>
                <a:gd name="connsiteY2" fmla="*/ 1010378 h 1682476"/>
                <a:gd name="connsiteX3" fmla="*/ 975154 w 1110346"/>
                <a:gd name="connsiteY3" fmla="*/ 1682476 h 16824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10346" h="1682476">
                  <a:moveTo>
                    <a:pt x="0" y="544124"/>
                  </a:moveTo>
                  <a:cubicBezTo>
                    <a:pt x="161417" y="-77663"/>
                    <a:pt x="641903" y="-57918"/>
                    <a:pt x="812608" y="77104"/>
                  </a:cubicBezTo>
                  <a:cubicBezTo>
                    <a:pt x="983313" y="212126"/>
                    <a:pt x="1109339" y="728705"/>
                    <a:pt x="1110341" y="1010378"/>
                  </a:cubicBezTo>
                  <a:cubicBezTo>
                    <a:pt x="1111343" y="1292051"/>
                    <a:pt x="974095" y="1666071"/>
                    <a:pt x="975154" y="1682476"/>
                  </a:cubicBezTo>
                </a:path>
              </a:pathLst>
            </a:custGeom>
            <a:noFill/>
            <a:ln w="12700">
              <a:solidFill>
                <a:schemeClr val="tx1"/>
              </a:solidFill>
              <a:prstDash val="solid"/>
              <a:tailEnd type="triangle" w="sm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7" name="자유형 33">
            <a:extLst>
              <a:ext uri="{FF2B5EF4-FFF2-40B4-BE49-F238E27FC236}">
                <a16:creationId xmlns:a16="http://schemas.microsoft.com/office/drawing/2014/main" id="{705B7155-8186-4BC4-93DD-45E3BB7560A8}"/>
              </a:ext>
            </a:extLst>
          </p:cNvPr>
          <p:cNvSpPr/>
          <p:nvPr/>
        </p:nvSpPr>
        <p:spPr>
          <a:xfrm rot="1396408">
            <a:off x="3470931" y="1194222"/>
            <a:ext cx="288383" cy="522951"/>
          </a:xfrm>
          <a:custGeom>
            <a:avLst/>
            <a:gdLst>
              <a:gd name="connsiteX0" fmla="*/ 0 w 1809750"/>
              <a:gd name="connsiteY0" fmla="*/ 461695 h 461695"/>
              <a:gd name="connsiteX1" fmla="*/ 247650 w 1809750"/>
              <a:gd name="connsiteY1" fmla="*/ 144195 h 461695"/>
              <a:gd name="connsiteX2" fmla="*/ 742950 w 1809750"/>
              <a:gd name="connsiteY2" fmla="*/ 4495 h 461695"/>
              <a:gd name="connsiteX3" fmla="*/ 1257300 w 1809750"/>
              <a:gd name="connsiteY3" fmla="*/ 42595 h 461695"/>
              <a:gd name="connsiteX4" fmla="*/ 1555750 w 1809750"/>
              <a:gd name="connsiteY4" fmla="*/ 125145 h 461695"/>
              <a:gd name="connsiteX5" fmla="*/ 1765300 w 1809750"/>
              <a:gd name="connsiteY5" fmla="*/ 341045 h 461695"/>
              <a:gd name="connsiteX6" fmla="*/ 1809750 w 1809750"/>
              <a:gd name="connsiteY6" fmla="*/ 423595 h 461695"/>
              <a:gd name="connsiteX0" fmla="*/ 0 w 1809750"/>
              <a:gd name="connsiteY0" fmla="*/ 467606 h 467606"/>
              <a:gd name="connsiteX1" fmla="*/ 247650 w 1809750"/>
              <a:gd name="connsiteY1" fmla="*/ 150106 h 467606"/>
              <a:gd name="connsiteX2" fmla="*/ 831850 w 1809750"/>
              <a:gd name="connsiteY2" fmla="*/ 4056 h 467606"/>
              <a:gd name="connsiteX3" fmla="*/ 1257300 w 1809750"/>
              <a:gd name="connsiteY3" fmla="*/ 48506 h 467606"/>
              <a:gd name="connsiteX4" fmla="*/ 1555750 w 1809750"/>
              <a:gd name="connsiteY4" fmla="*/ 131056 h 467606"/>
              <a:gd name="connsiteX5" fmla="*/ 1765300 w 1809750"/>
              <a:gd name="connsiteY5" fmla="*/ 346956 h 467606"/>
              <a:gd name="connsiteX6" fmla="*/ 1809750 w 1809750"/>
              <a:gd name="connsiteY6" fmla="*/ 429506 h 467606"/>
              <a:gd name="connsiteX0" fmla="*/ 0 w 1809750"/>
              <a:gd name="connsiteY0" fmla="*/ 469070 h 469070"/>
              <a:gd name="connsiteX1" fmla="*/ 247650 w 1809750"/>
              <a:gd name="connsiteY1" fmla="*/ 151570 h 469070"/>
              <a:gd name="connsiteX2" fmla="*/ 831850 w 1809750"/>
              <a:gd name="connsiteY2" fmla="*/ 5520 h 469070"/>
              <a:gd name="connsiteX3" fmla="*/ 1282700 w 1809750"/>
              <a:gd name="connsiteY3" fmla="*/ 40445 h 469070"/>
              <a:gd name="connsiteX4" fmla="*/ 1555750 w 1809750"/>
              <a:gd name="connsiteY4" fmla="*/ 132520 h 469070"/>
              <a:gd name="connsiteX5" fmla="*/ 1765300 w 1809750"/>
              <a:gd name="connsiteY5" fmla="*/ 348420 h 469070"/>
              <a:gd name="connsiteX6" fmla="*/ 1809750 w 1809750"/>
              <a:gd name="connsiteY6" fmla="*/ 430970 h 469070"/>
              <a:gd name="connsiteX0" fmla="*/ 0 w 1809750"/>
              <a:gd name="connsiteY0" fmla="*/ 469239 h 469239"/>
              <a:gd name="connsiteX1" fmla="*/ 247650 w 1809750"/>
              <a:gd name="connsiteY1" fmla="*/ 151739 h 469239"/>
              <a:gd name="connsiteX2" fmla="*/ 831850 w 1809750"/>
              <a:gd name="connsiteY2" fmla="*/ 5689 h 469239"/>
              <a:gd name="connsiteX3" fmla="*/ 1282700 w 1809750"/>
              <a:gd name="connsiteY3" fmla="*/ 40614 h 469239"/>
              <a:gd name="connsiteX4" fmla="*/ 1546225 w 1809750"/>
              <a:gd name="connsiteY4" fmla="*/ 142214 h 469239"/>
              <a:gd name="connsiteX5" fmla="*/ 1765300 w 1809750"/>
              <a:gd name="connsiteY5" fmla="*/ 348589 h 469239"/>
              <a:gd name="connsiteX6" fmla="*/ 1809750 w 1809750"/>
              <a:gd name="connsiteY6" fmla="*/ 431139 h 469239"/>
              <a:gd name="connsiteX0" fmla="*/ 0 w 1809750"/>
              <a:gd name="connsiteY0" fmla="*/ 470087 h 470087"/>
              <a:gd name="connsiteX1" fmla="*/ 257175 w 1809750"/>
              <a:gd name="connsiteY1" fmla="*/ 165287 h 470087"/>
              <a:gd name="connsiteX2" fmla="*/ 831850 w 1809750"/>
              <a:gd name="connsiteY2" fmla="*/ 6537 h 470087"/>
              <a:gd name="connsiteX3" fmla="*/ 1282700 w 1809750"/>
              <a:gd name="connsiteY3" fmla="*/ 41462 h 470087"/>
              <a:gd name="connsiteX4" fmla="*/ 1546225 w 1809750"/>
              <a:gd name="connsiteY4" fmla="*/ 143062 h 470087"/>
              <a:gd name="connsiteX5" fmla="*/ 1765300 w 1809750"/>
              <a:gd name="connsiteY5" fmla="*/ 349437 h 470087"/>
              <a:gd name="connsiteX6" fmla="*/ 1809750 w 1809750"/>
              <a:gd name="connsiteY6" fmla="*/ 431987 h 470087"/>
              <a:gd name="connsiteX0" fmla="*/ 0 w 1809750"/>
              <a:gd name="connsiteY0" fmla="*/ 470179 h 470179"/>
              <a:gd name="connsiteX1" fmla="*/ 257175 w 1809750"/>
              <a:gd name="connsiteY1" fmla="*/ 165379 h 470179"/>
              <a:gd name="connsiteX2" fmla="*/ 831850 w 1809750"/>
              <a:gd name="connsiteY2" fmla="*/ 6629 h 470179"/>
              <a:gd name="connsiteX3" fmla="*/ 1282700 w 1809750"/>
              <a:gd name="connsiteY3" fmla="*/ 41554 h 470179"/>
              <a:gd name="connsiteX4" fmla="*/ 1536700 w 1809750"/>
              <a:gd name="connsiteY4" fmla="*/ 147916 h 470179"/>
              <a:gd name="connsiteX5" fmla="*/ 1765300 w 1809750"/>
              <a:gd name="connsiteY5" fmla="*/ 349529 h 470179"/>
              <a:gd name="connsiteX6" fmla="*/ 1809750 w 1809750"/>
              <a:gd name="connsiteY6" fmla="*/ 432079 h 470179"/>
              <a:gd name="connsiteX0" fmla="*/ 0 w 1809750"/>
              <a:gd name="connsiteY0" fmla="*/ 473706 h 473706"/>
              <a:gd name="connsiteX1" fmla="*/ 257175 w 1809750"/>
              <a:gd name="connsiteY1" fmla="*/ 168906 h 473706"/>
              <a:gd name="connsiteX2" fmla="*/ 831850 w 1809750"/>
              <a:gd name="connsiteY2" fmla="*/ 10156 h 473706"/>
              <a:gd name="connsiteX3" fmla="*/ 1220788 w 1809750"/>
              <a:gd name="connsiteY3" fmla="*/ 30794 h 473706"/>
              <a:gd name="connsiteX4" fmla="*/ 1536700 w 1809750"/>
              <a:gd name="connsiteY4" fmla="*/ 151443 h 473706"/>
              <a:gd name="connsiteX5" fmla="*/ 1765300 w 1809750"/>
              <a:gd name="connsiteY5" fmla="*/ 353056 h 473706"/>
              <a:gd name="connsiteX6" fmla="*/ 1809750 w 1809750"/>
              <a:gd name="connsiteY6" fmla="*/ 435606 h 473706"/>
              <a:gd name="connsiteX0" fmla="*/ 0 w 1809750"/>
              <a:gd name="connsiteY0" fmla="*/ 466416 h 466416"/>
              <a:gd name="connsiteX1" fmla="*/ 257175 w 1809750"/>
              <a:gd name="connsiteY1" fmla="*/ 161616 h 466416"/>
              <a:gd name="connsiteX2" fmla="*/ 693738 w 1809750"/>
              <a:gd name="connsiteY2" fmla="*/ 12391 h 466416"/>
              <a:gd name="connsiteX3" fmla="*/ 1220788 w 1809750"/>
              <a:gd name="connsiteY3" fmla="*/ 23504 h 466416"/>
              <a:gd name="connsiteX4" fmla="*/ 1536700 w 1809750"/>
              <a:gd name="connsiteY4" fmla="*/ 144153 h 466416"/>
              <a:gd name="connsiteX5" fmla="*/ 1765300 w 1809750"/>
              <a:gd name="connsiteY5" fmla="*/ 345766 h 466416"/>
              <a:gd name="connsiteX6" fmla="*/ 1809750 w 1809750"/>
              <a:gd name="connsiteY6" fmla="*/ 428316 h 466416"/>
              <a:gd name="connsiteX0" fmla="*/ 0 w 1767026"/>
              <a:gd name="connsiteY0" fmla="*/ 466416 h 1959925"/>
              <a:gd name="connsiteX1" fmla="*/ 257175 w 1767026"/>
              <a:gd name="connsiteY1" fmla="*/ 161616 h 1959925"/>
              <a:gd name="connsiteX2" fmla="*/ 693738 w 1767026"/>
              <a:gd name="connsiteY2" fmla="*/ 12391 h 1959925"/>
              <a:gd name="connsiteX3" fmla="*/ 1220788 w 1767026"/>
              <a:gd name="connsiteY3" fmla="*/ 23504 h 1959925"/>
              <a:gd name="connsiteX4" fmla="*/ 1536700 w 1767026"/>
              <a:gd name="connsiteY4" fmla="*/ 144153 h 1959925"/>
              <a:gd name="connsiteX5" fmla="*/ 1765300 w 1767026"/>
              <a:gd name="connsiteY5" fmla="*/ 345766 h 1959925"/>
              <a:gd name="connsiteX6" fmla="*/ 942412 w 1767026"/>
              <a:gd name="connsiteY6" fmla="*/ 1959925 h 1959925"/>
              <a:gd name="connsiteX0" fmla="*/ 0 w 1537366"/>
              <a:gd name="connsiteY0" fmla="*/ 466416 h 1959925"/>
              <a:gd name="connsiteX1" fmla="*/ 257175 w 1537366"/>
              <a:gd name="connsiteY1" fmla="*/ 161616 h 1959925"/>
              <a:gd name="connsiteX2" fmla="*/ 693738 w 1537366"/>
              <a:gd name="connsiteY2" fmla="*/ 12391 h 1959925"/>
              <a:gd name="connsiteX3" fmla="*/ 1220788 w 1537366"/>
              <a:gd name="connsiteY3" fmla="*/ 23504 h 1959925"/>
              <a:gd name="connsiteX4" fmla="*/ 1536700 w 1537366"/>
              <a:gd name="connsiteY4" fmla="*/ 144153 h 1959925"/>
              <a:gd name="connsiteX5" fmla="*/ 1140910 w 1537366"/>
              <a:gd name="connsiteY5" fmla="*/ 1201757 h 1959925"/>
              <a:gd name="connsiteX6" fmla="*/ 942412 w 1537366"/>
              <a:gd name="connsiteY6" fmla="*/ 1959925 h 1959925"/>
              <a:gd name="connsiteX0" fmla="*/ 0 w 1222460"/>
              <a:gd name="connsiteY0" fmla="*/ 517986 h 2011495"/>
              <a:gd name="connsiteX1" fmla="*/ 257175 w 1222460"/>
              <a:gd name="connsiteY1" fmla="*/ 213186 h 2011495"/>
              <a:gd name="connsiteX2" fmla="*/ 693738 w 1222460"/>
              <a:gd name="connsiteY2" fmla="*/ 63961 h 2011495"/>
              <a:gd name="connsiteX3" fmla="*/ 1220788 w 1222460"/>
              <a:gd name="connsiteY3" fmla="*/ 75074 h 2011495"/>
              <a:gd name="connsiteX4" fmla="*/ 869947 w 1222460"/>
              <a:gd name="connsiteY4" fmla="*/ 958003 h 2011495"/>
              <a:gd name="connsiteX5" fmla="*/ 1140910 w 1222460"/>
              <a:gd name="connsiteY5" fmla="*/ 1253327 h 2011495"/>
              <a:gd name="connsiteX6" fmla="*/ 942412 w 1222460"/>
              <a:gd name="connsiteY6" fmla="*/ 2011495 h 2011495"/>
              <a:gd name="connsiteX0" fmla="*/ 0 w 1246286"/>
              <a:gd name="connsiteY0" fmla="*/ 539641 h 2033150"/>
              <a:gd name="connsiteX1" fmla="*/ 257175 w 1246286"/>
              <a:gd name="connsiteY1" fmla="*/ 234841 h 2033150"/>
              <a:gd name="connsiteX2" fmla="*/ 693738 w 1246286"/>
              <a:gd name="connsiteY2" fmla="*/ 85616 h 2033150"/>
              <a:gd name="connsiteX3" fmla="*/ 1220788 w 1246286"/>
              <a:gd name="connsiteY3" fmla="*/ 96729 h 2033150"/>
              <a:gd name="connsiteX4" fmla="*/ 1140910 w 1246286"/>
              <a:gd name="connsiteY4" fmla="*/ 1274982 h 2033150"/>
              <a:gd name="connsiteX5" fmla="*/ 942412 w 1246286"/>
              <a:gd name="connsiteY5" fmla="*/ 2033150 h 2033150"/>
              <a:gd name="connsiteX0" fmla="*/ 0 w 1149487"/>
              <a:gd name="connsiteY0" fmla="*/ 488553 h 1982062"/>
              <a:gd name="connsiteX1" fmla="*/ 257175 w 1149487"/>
              <a:gd name="connsiteY1" fmla="*/ 183753 h 1982062"/>
              <a:gd name="connsiteX2" fmla="*/ 693738 w 1149487"/>
              <a:gd name="connsiteY2" fmla="*/ 34528 h 1982062"/>
              <a:gd name="connsiteX3" fmla="*/ 959326 w 1149487"/>
              <a:gd name="connsiteY3" fmla="*/ 847892 h 1982062"/>
              <a:gd name="connsiteX4" fmla="*/ 1140910 w 1149487"/>
              <a:gd name="connsiteY4" fmla="*/ 1223894 h 1982062"/>
              <a:gd name="connsiteX5" fmla="*/ 942412 w 1149487"/>
              <a:gd name="connsiteY5" fmla="*/ 1982062 h 1982062"/>
              <a:gd name="connsiteX0" fmla="*/ 0 w 1146545"/>
              <a:gd name="connsiteY0" fmla="*/ 514484 h 2007993"/>
              <a:gd name="connsiteX1" fmla="*/ 257175 w 1146545"/>
              <a:gd name="connsiteY1" fmla="*/ 209684 h 2007993"/>
              <a:gd name="connsiteX2" fmla="*/ 693738 w 1146545"/>
              <a:gd name="connsiteY2" fmla="*/ 60459 h 2007993"/>
              <a:gd name="connsiteX3" fmla="*/ 1140910 w 1146545"/>
              <a:gd name="connsiteY3" fmla="*/ 1249825 h 2007993"/>
              <a:gd name="connsiteX4" fmla="*/ 942412 w 1146545"/>
              <a:gd name="connsiteY4" fmla="*/ 2007993 h 2007993"/>
              <a:gd name="connsiteX0" fmla="*/ 0 w 1146545"/>
              <a:gd name="connsiteY0" fmla="*/ 304801 h 1798310"/>
              <a:gd name="connsiteX1" fmla="*/ 257175 w 1146545"/>
              <a:gd name="connsiteY1" fmla="*/ 1 h 1798310"/>
              <a:gd name="connsiteX2" fmla="*/ 859543 w 1146545"/>
              <a:gd name="connsiteY2" fmla="*/ 305341 h 1798310"/>
              <a:gd name="connsiteX3" fmla="*/ 1140910 w 1146545"/>
              <a:gd name="connsiteY3" fmla="*/ 1040142 h 1798310"/>
              <a:gd name="connsiteX4" fmla="*/ 942412 w 1146545"/>
              <a:gd name="connsiteY4" fmla="*/ 1798310 h 1798310"/>
              <a:gd name="connsiteX0" fmla="*/ 0 w 1146545"/>
              <a:gd name="connsiteY0" fmla="*/ 159707 h 1653216"/>
              <a:gd name="connsiteX1" fmla="*/ 420171 w 1146545"/>
              <a:gd name="connsiteY1" fmla="*/ 1 h 1653216"/>
              <a:gd name="connsiteX2" fmla="*/ 859543 w 1146545"/>
              <a:gd name="connsiteY2" fmla="*/ 160247 h 1653216"/>
              <a:gd name="connsiteX3" fmla="*/ 1140910 w 1146545"/>
              <a:gd name="connsiteY3" fmla="*/ 895048 h 1653216"/>
              <a:gd name="connsiteX4" fmla="*/ 942412 w 1146545"/>
              <a:gd name="connsiteY4" fmla="*/ 1653216 h 1653216"/>
              <a:gd name="connsiteX0" fmla="*/ 0 w 1146545"/>
              <a:gd name="connsiteY0" fmla="*/ 159707 h 1653216"/>
              <a:gd name="connsiteX1" fmla="*/ 420171 w 1146545"/>
              <a:gd name="connsiteY1" fmla="*/ 1 h 1653216"/>
              <a:gd name="connsiteX2" fmla="*/ 859543 w 1146545"/>
              <a:gd name="connsiteY2" fmla="*/ 160247 h 1653216"/>
              <a:gd name="connsiteX3" fmla="*/ 1140910 w 1146545"/>
              <a:gd name="connsiteY3" fmla="*/ 895048 h 1653216"/>
              <a:gd name="connsiteX4" fmla="*/ 942412 w 1146545"/>
              <a:gd name="connsiteY4" fmla="*/ 1653216 h 1653216"/>
              <a:gd name="connsiteX0" fmla="*/ 0 w 1141169"/>
              <a:gd name="connsiteY0" fmla="*/ 159707 h 1653216"/>
              <a:gd name="connsiteX1" fmla="*/ 420171 w 1141169"/>
              <a:gd name="connsiteY1" fmla="*/ 1 h 1653216"/>
              <a:gd name="connsiteX2" fmla="*/ 859543 w 1141169"/>
              <a:gd name="connsiteY2" fmla="*/ 160247 h 1653216"/>
              <a:gd name="connsiteX3" fmla="*/ 1140910 w 1141169"/>
              <a:gd name="connsiteY3" fmla="*/ 895048 h 1653216"/>
              <a:gd name="connsiteX4" fmla="*/ 942412 w 1141169"/>
              <a:gd name="connsiteY4" fmla="*/ 1653216 h 1653216"/>
              <a:gd name="connsiteX0" fmla="*/ 0 w 1141869"/>
              <a:gd name="connsiteY0" fmla="*/ 159707 h 1653216"/>
              <a:gd name="connsiteX1" fmla="*/ 420171 w 1141869"/>
              <a:gd name="connsiteY1" fmla="*/ 1 h 1653216"/>
              <a:gd name="connsiteX2" fmla="*/ 859543 w 1141869"/>
              <a:gd name="connsiteY2" fmla="*/ 160247 h 1653216"/>
              <a:gd name="connsiteX3" fmla="*/ 1140910 w 1141869"/>
              <a:gd name="connsiteY3" fmla="*/ 895048 h 1653216"/>
              <a:gd name="connsiteX4" fmla="*/ 942412 w 1141869"/>
              <a:gd name="connsiteY4" fmla="*/ 1653216 h 1653216"/>
              <a:gd name="connsiteX0" fmla="*/ 0 w 1141869"/>
              <a:gd name="connsiteY0" fmla="*/ 233194 h 1726703"/>
              <a:gd name="connsiteX1" fmla="*/ 436257 w 1141869"/>
              <a:gd name="connsiteY1" fmla="*/ 1 h 1726703"/>
              <a:gd name="connsiteX2" fmla="*/ 859543 w 1141869"/>
              <a:gd name="connsiteY2" fmla="*/ 233734 h 1726703"/>
              <a:gd name="connsiteX3" fmla="*/ 1140910 w 1141869"/>
              <a:gd name="connsiteY3" fmla="*/ 968535 h 1726703"/>
              <a:gd name="connsiteX4" fmla="*/ 942412 w 1141869"/>
              <a:gd name="connsiteY4" fmla="*/ 1726703 h 1726703"/>
              <a:gd name="connsiteX0" fmla="*/ 0 w 1141869"/>
              <a:gd name="connsiteY0" fmla="*/ 233194 h 1726703"/>
              <a:gd name="connsiteX1" fmla="*/ 436257 w 1141869"/>
              <a:gd name="connsiteY1" fmla="*/ 1 h 1726703"/>
              <a:gd name="connsiteX2" fmla="*/ 859543 w 1141869"/>
              <a:gd name="connsiteY2" fmla="*/ 233734 h 1726703"/>
              <a:gd name="connsiteX3" fmla="*/ 1140910 w 1141869"/>
              <a:gd name="connsiteY3" fmla="*/ 968535 h 1726703"/>
              <a:gd name="connsiteX4" fmla="*/ 942412 w 1141869"/>
              <a:gd name="connsiteY4" fmla="*/ 1726703 h 1726703"/>
              <a:gd name="connsiteX0" fmla="*/ 0 w 1141196"/>
              <a:gd name="connsiteY0" fmla="*/ 235957 h 1729466"/>
              <a:gd name="connsiteX1" fmla="*/ 436257 w 1141196"/>
              <a:gd name="connsiteY1" fmla="*/ 2764 h 1729466"/>
              <a:gd name="connsiteX2" fmla="*/ 888064 w 1141196"/>
              <a:gd name="connsiteY2" fmla="*/ 169241 h 1729466"/>
              <a:gd name="connsiteX3" fmla="*/ 1140910 w 1141196"/>
              <a:gd name="connsiteY3" fmla="*/ 971298 h 1729466"/>
              <a:gd name="connsiteX4" fmla="*/ 942412 w 1141196"/>
              <a:gd name="connsiteY4" fmla="*/ 1729466 h 1729466"/>
              <a:gd name="connsiteX0" fmla="*/ 0 w 1107677"/>
              <a:gd name="connsiteY0" fmla="*/ 235882 h 1729391"/>
              <a:gd name="connsiteX1" fmla="*/ 436257 w 1107677"/>
              <a:gd name="connsiteY1" fmla="*/ 2689 h 1729391"/>
              <a:gd name="connsiteX2" fmla="*/ 888064 w 1107677"/>
              <a:gd name="connsiteY2" fmla="*/ 169166 h 1729391"/>
              <a:gd name="connsiteX3" fmla="*/ 1107338 w 1107677"/>
              <a:gd name="connsiteY3" fmla="*/ 963463 h 1729391"/>
              <a:gd name="connsiteX4" fmla="*/ 942412 w 1107677"/>
              <a:gd name="connsiteY4" fmla="*/ 1729391 h 1729391"/>
              <a:gd name="connsiteX0" fmla="*/ 0 w 1107677"/>
              <a:gd name="connsiteY0" fmla="*/ 235882 h 1729391"/>
              <a:gd name="connsiteX1" fmla="*/ 436257 w 1107677"/>
              <a:gd name="connsiteY1" fmla="*/ 2689 h 1729391"/>
              <a:gd name="connsiteX2" fmla="*/ 888064 w 1107677"/>
              <a:gd name="connsiteY2" fmla="*/ 169166 h 1729391"/>
              <a:gd name="connsiteX3" fmla="*/ 1107338 w 1107677"/>
              <a:gd name="connsiteY3" fmla="*/ 963463 h 1729391"/>
              <a:gd name="connsiteX4" fmla="*/ 942412 w 1107677"/>
              <a:gd name="connsiteY4" fmla="*/ 1729391 h 1729391"/>
              <a:gd name="connsiteX0" fmla="*/ 0 w 1107677"/>
              <a:gd name="connsiteY0" fmla="*/ 109422 h 1602931"/>
              <a:gd name="connsiteX1" fmla="*/ 888064 w 1107677"/>
              <a:gd name="connsiteY1" fmla="*/ 42706 h 1602931"/>
              <a:gd name="connsiteX2" fmla="*/ 1107338 w 1107677"/>
              <a:gd name="connsiteY2" fmla="*/ 837003 h 1602931"/>
              <a:gd name="connsiteX3" fmla="*/ 942412 w 1107677"/>
              <a:gd name="connsiteY3" fmla="*/ 1602931 h 1602931"/>
              <a:gd name="connsiteX0" fmla="*/ 0 w 1111835"/>
              <a:gd name="connsiteY0" fmla="*/ 196561 h 1690070"/>
              <a:gd name="connsiteX1" fmla="*/ 888064 w 1111835"/>
              <a:gd name="connsiteY1" fmla="*/ 129845 h 1690070"/>
              <a:gd name="connsiteX2" fmla="*/ 1107338 w 1111835"/>
              <a:gd name="connsiteY2" fmla="*/ 924142 h 1690070"/>
              <a:gd name="connsiteX3" fmla="*/ 942412 w 1111835"/>
              <a:gd name="connsiteY3" fmla="*/ 1690070 h 1690070"/>
              <a:gd name="connsiteX0" fmla="*/ 0 w 1109911"/>
              <a:gd name="connsiteY0" fmla="*/ 331391 h 1824900"/>
              <a:gd name="connsiteX1" fmla="*/ 780988 w 1109911"/>
              <a:gd name="connsiteY1" fmla="*/ 102298 h 1824900"/>
              <a:gd name="connsiteX2" fmla="*/ 1107338 w 1109911"/>
              <a:gd name="connsiteY2" fmla="*/ 1058972 h 1824900"/>
              <a:gd name="connsiteX3" fmla="*/ 942412 w 1109911"/>
              <a:gd name="connsiteY3" fmla="*/ 1824900 h 1824900"/>
              <a:gd name="connsiteX0" fmla="*/ 0 w 1109913"/>
              <a:gd name="connsiteY0" fmla="*/ 351578 h 1845087"/>
              <a:gd name="connsiteX1" fmla="*/ 780988 w 1109913"/>
              <a:gd name="connsiteY1" fmla="*/ 122485 h 1845087"/>
              <a:gd name="connsiteX2" fmla="*/ 1107338 w 1109913"/>
              <a:gd name="connsiteY2" fmla="*/ 1079159 h 1845087"/>
              <a:gd name="connsiteX3" fmla="*/ 942412 w 1109913"/>
              <a:gd name="connsiteY3" fmla="*/ 1845087 h 1845087"/>
              <a:gd name="connsiteX0" fmla="*/ 0 w 1109911"/>
              <a:gd name="connsiteY0" fmla="*/ 275936 h 1769445"/>
              <a:gd name="connsiteX1" fmla="*/ 780988 w 1109911"/>
              <a:gd name="connsiteY1" fmla="*/ 46843 h 1769445"/>
              <a:gd name="connsiteX2" fmla="*/ 1107338 w 1109911"/>
              <a:gd name="connsiteY2" fmla="*/ 1003517 h 1769445"/>
              <a:gd name="connsiteX3" fmla="*/ 942412 w 1109911"/>
              <a:gd name="connsiteY3" fmla="*/ 1769445 h 1769445"/>
              <a:gd name="connsiteX0" fmla="*/ 0 w 1107549"/>
              <a:gd name="connsiteY0" fmla="*/ 275936 h 1769445"/>
              <a:gd name="connsiteX1" fmla="*/ 780988 w 1107549"/>
              <a:gd name="connsiteY1" fmla="*/ 46843 h 1769445"/>
              <a:gd name="connsiteX2" fmla="*/ 1107338 w 1107549"/>
              <a:gd name="connsiteY2" fmla="*/ 1003517 h 1769445"/>
              <a:gd name="connsiteX3" fmla="*/ 942412 w 1107549"/>
              <a:gd name="connsiteY3" fmla="*/ 1769445 h 1769445"/>
              <a:gd name="connsiteX0" fmla="*/ 0 w 1107353"/>
              <a:gd name="connsiteY0" fmla="*/ 275936 h 1769445"/>
              <a:gd name="connsiteX1" fmla="*/ 780988 w 1107353"/>
              <a:gd name="connsiteY1" fmla="*/ 46843 h 1769445"/>
              <a:gd name="connsiteX2" fmla="*/ 1107338 w 1107353"/>
              <a:gd name="connsiteY2" fmla="*/ 1003517 h 1769445"/>
              <a:gd name="connsiteX3" fmla="*/ 942412 w 1107353"/>
              <a:gd name="connsiteY3" fmla="*/ 1769445 h 1769445"/>
              <a:gd name="connsiteX0" fmla="*/ 0 w 1107351"/>
              <a:gd name="connsiteY0" fmla="*/ 314258 h 1807767"/>
              <a:gd name="connsiteX1" fmla="*/ 780988 w 1107351"/>
              <a:gd name="connsiteY1" fmla="*/ 85165 h 1807767"/>
              <a:gd name="connsiteX2" fmla="*/ 1107338 w 1107351"/>
              <a:gd name="connsiteY2" fmla="*/ 1041839 h 1807767"/>
              <a:gd name="connsiteX3" fmla="*/ 942412 w 1107351"/>
              <a:gd name="connsiteY3" fmla="*/ 1807767 h 1807767"/>
              <a:gd name="connsiteX0" fmla="*/ 0 w 1110115"/>
              <a:gd name="connsiteY0" fmla="*/ 314258 h 1701473"/>
              <a:gd name="connsiteX1" fmla="*/ 780988 w 1110115"/>
              <a:gd name="connsiteY1" fmla="*/ 85165 h 1701473"/>
              <a:gd name="connsiteX2" fmla="*/ 1107338 w 1110115"/>
              <a:gd name="connsiteY2" fmla="*/ 1041839 h 1701473"/>
              <a:gd name="connsiteX3" fmla="*/ 947276 w 1110115"/>
              <a:gd name="connsiteY3" fmla="*/ 1701473 h 1701473"/>
              <a:gd name="connsiteX0" fmla="*/ 0 w 1108744"/>
              <a:gd name="connsiteY0" fmla="*/ 314258 h 1701473"/>
              <a:gd name="connsiteX1" fmla="*/ 780988 w 1108744"/>
              <a:gd name="connsiteY1" fmla="*/ 85165 h 1701473"/>
              <a:gd name="connsiteX2" fmla="*/ 1107338 w 1108744"/>
              <a:gd name="connsiteY2" fmla="*/ 1041839 h 1701473"/>
              <a:gd name="connsiteX3" fmla="*/ 947276 w 1108744"/>
              <a:gd name="connsiteY3" fmla="*/ 1701473 h 1701473"/>
              <a:gd name="connsiteX0" fmla="*/ 0 w 1107787"/>
              <a:gd name="connsiteY0" fmla="*/ 314258 h 1701473"/>
              <a:gd name="connsiteX1" fmla="*/ 780988 w 1107787"/>
              <a:gd name="connsiteY1" fmla="*/ 85165 h 1701473"/>
              <a:gd name="connsiteX2" fmla="*/ 1107338 w 1107787"/>
              <a:gd name="connsiteY2" fmla="*/ 1041839 h 1701473"/>
              <a:gd name="connsiteX3" fmla="*/ 947276 w 1107787"/>
              <a:gd name="connsiteY3" fmla="*/ 1701473 h 1701473"/>
              <a:gd name="connsiteX0" fmla="*/ 0 w 1082984"/>
              <a:gd name="connsiteY0" fmla="*/ 303739 h 1690954"/>
              <a:gd name="connsiteX1" fmla="*/ 780988 w 1082984"/>
              <a:gd name="connsiteY1" fmla="*/ 74646 h 1690954"/>
              <a:gd name="connsiteX2" fmla="*/ 1082463 w 1082984"/>
              <a:gd name="connsiteY2" fmla="*/ 1018857 h 1690954"/>
              <a:gd name="connsiteX3" fmla="*/ 947276 w 1082984"/>
              <a:gd name="connsiteY3" fmla="*/ 1690954 h 1690954"/>
              <a:gd name="connsiteX0" fmla="*/ 0 w 1082982"/>
              <a:gd name="connsiteY0" fmla="*/ 303739 h 1690954"/>
              <a:gd name="connsiteX1" fmla="*/ 780988 w 1082982"/>
              <a:gd name="connsiteY1" fmla="*/ 74646 h 1690954"/>
              <a:gd name="connsiteX2" fmla="*/ 1082463 w 1082982"/>
              <a:gd name="connsiteY2" fmla="*/ 1018856 h 1690954"/>
              <a:gd name="connsiteX3" fmla="*/ 947276 w 1082982"/>
              <a:gd name="connsiteY3" fmla="*/ 1690954 h 1690954"/>
              <a:gd name="connsiteX0" fmla="*/ 0 w 1085495"/>
              <a:gd name="connsiteY0" fmla="*/ 296404 h 1683619"/>
              <a:gd name="connsiteX1" fmla="*/ 784730 w 1085495"/>
              <a:gd name="connsiteY1" fmla="*/ 78247 h 1683619"/>
              <a:gd name="connsiteX2" fmla="*/ 1082463 w 1085495"/>
              <a:gd name="connsiteY2" fmla="*/ 1011521 h 1683619"/>
              <a:gd name="connsiteX3" fmla="*/ 947276 w 1085495"/>
              <a:gd name="connsiteY3" fmla="*/ 1683619 h 1683619"/>
              <a:gd name="connsiteX0" fmla="*/ 0 w 1085495"/>
              <a:gd name="connsiteY0" fmla="*/ 324423 h 1711638"/>
              <a:gd name="connsiteX1" fmla="*/ 784730 w 1085495"/>
              <a:gd name="connsiteY1" fmla="*/ 106266 h 1711638"/>
              <a:gd name="connsiteX2" fmla="*/ 1082463 w 1085495"/>
              <a:gd name="connsiteY2" fmla="*/ 1039540 h 1711638"/>
              <a:gd name="connsiteX3" fmla="*/ 947276 w 1085495"/>
              <a:gd name="connsiteY3" fmla="*/ 1711638 h 1711638"/>
              <a:gd name="connsiteX0" fmla="*/ 0 w 1082468"/>
              <a:gd name="connsiteY0" fmla="*/ 324423 h 1711638"/>
              <a:gd name="connsiteX1" fmla="*/ 784730 w 1082468"/>
              <a:gd name="connsiteY1" fmla="*/ 106266 h 1711638"/>
              <a:gd name="connsiteX2" fmla="*/ 1082463 w 1082468"/>
              <a:gd name="connsiteY2" fmla="*/ 1039540 h 1711638"/>
              <a:gd name="connsiteX3" fmla="*/ 947276 w 1082468"/>
              <a:gd name="connsiteY3" fmla="*/ 1711638 h 1711638"/>
              <a:gd name="connsiteX0" fmla="*/ 0 w 562960"/>
              <a:gd name="connsiteY0" fmla="*/ 187627 h 1834742"/>
              <a:gd name="connsiteX1" fmla="*/ 265222 w 562960"/>
              <a:gd name="connsiteY1" fmla="*/ 229370 h 1834742"/>
              <a:gd name="connsiteX2" fmla="*/ 562955 w 562960"/>
              <a:gd name="connsiteY2" fmla="*/ 1162644 h 1834742"/>
              <a:gd name="connsiteX3" fmla="*/ 427768 w 562960"/>
              <a:gd name="connsiteY3" fmla="*/ 1834742 h 1834742"/>
              <a:gd name="connsiteX0" fmla="*/ 0 w 562960"/>
              <a:gd name="connsiteY0" fmla="*/ 68416 h 1715531"/>
              <a:gd name="connsiteX1" fmla="*/ 265222 w 562960"/>
              <a:gd name="connsiteY1" fmla="*/ 110159 h 1715531"/>
              <a:gd name="connsiteX2" fmla="*/ 562955 w 562960"/>
              <a:gd name="connsiteY2" fmla="*/ 1043433 h 1715531"/>
              <a:gd name="connsiteX3" fmla="*/ 427768 w 562960"/>
              <a:gd name="connsiteY3" fmla="*/ 1715531 h 1715531"/>
              <a:gd name="connsiteX0" fmla="*/ 0 w 586633"/>
              <a:gd name="connsiteY0" fmla="*/ 48270 h 1749630"/>
              <a:gd name="connsiteX1" fmla="*/ 288895 w 586633"/>
              <a:gd name="connsiteY1" fmla="*/ 144258 h 1749630"/>
              <a:gd name="connsiteX2" fmla="*/ 586628 w 586633"/>
              <a:gd name="connsiteY2" fmla="*/ 1077532 h 1749630"/>
              <a:gd name="connsiteX3" fmla="*/ 451441 w 586633"/>
              <a:gd name="connsiteY3" fmla="*/ 1749630 h 1749630"/>
              <a:gd name="connsiteX0" fmla="*/ 0 w 586633"/>
              <a:gd name="connsiteY0" fmla="*/ 1 h 1701361"/>
              <a:gd name="connsiteX1" fmla="*/ 586628 w 586633"/>
              <a:gd name="connsiteY1" fmla="*/ 1029263 h 1701361"/>
              <a:gd name="connsiteX2" fmla="*/ 451441 w 586633"/>
              <a:gd name="connsiteY2" fmla="*/ 1701361 h 1701361"/>
              <a:gd name="connsiteX0" fmla="*/ 0 w 586633"/>
              <a:gd name="connsiteY0" fmla="*/ 1 h 1701361"/>
              <a:gd name="connsiteX1" fmla="*/ 586628 w 586633"/>
              <a:gd name="connsiteY1" fmla="*/ 1029263 h 1701361"/>
              <a:gd name="connsiteX2" fmla="*/ 451441 w 586633"/>
              <a:gd name="connsiteY2" fmla="*/ 1701361 h 1701361"/>
              <a:gd name="connsiteX0" fmla="*/ 0 w 586633"/>
              <a:gd name="connsiteY0" fmla="*/ 1 h 1701361"/>
              <a:gd name="connsiteX1" fmla="*/ 586628 w 586633"/>
              <a:gd name="connsiteY1" fmla="*/ 1029263 h 1701361"/>
              <a:gd name="connsiteX2" fmla="*/ 451441 w 586633"/>
              <a:gd name="connsiteY2" fmla="*/ 1701361 h 1701361"/>
              <a:gd name="connsiteX0" fmla="*/ 0 w 606763"/>
              <a:gd name="connsiteY0" fmla="*/ 1 h 1701361"/>
              <a:gd name="connsiteX1" fmla="*/ 586628 w 606763"/>
              <a:gd name="connsiteY1" fmla="*/ 1029263 h 1701361"/>
              <a:gd name="connsiteX2" fmla="*/ 451441 w 606763"/>
              <a:gd name="connsiteY2" fmla="*/ 1701361 h 1701361"/>
              <a:gd name="connsiteX0" fmla="*/ 0 w 587802"/>
              <a:gd name="connsiteY0" fmla="*/ 1 h 1701361"/>
              <a:gd name="connsiteX1" fmla="*/ 355575 w 587802"/>
              <a:gd name="connsiteY1" fmla="*/ 361957 h 1701361"/>
              <a:gd name="connsiteX2" fmla="*/ 586628 w 587802"/>
              <a:gd name="connsiteY2" fmla="*/ 1029263 h 1701361"/>
              <a:gd name="connsiteX3" fmla="*/ 451441 w 587802"/>
              <a:gd name="connsiteY3" fmla="*/ 1701361 h 1701361"/>
              <a:gd name="connsiteX0" fmla="*/ 0 w 587963"/>
              <a:gd name="connsiteY0" fmla="*/ 26190 h 1727550"/>
              <a:gd name="connsiteX1" fmla="*/ 348677 w 587963"/>
              <a:gd name="connsiteY1" fmla="*/ 69405 h 1727550"/>
              <a:gd name="connsiteX2" fmla="*/ 586628 w 587963"/>
              <a:gd name="connsiteY2" fmla="*/ 1055452 h 1727550"/>
              <a:gd name="connsiteX3" fmla="*/ 451441 w 587963"/>
              <a:gd name="connsiteY3" fmla="*/ 1727550 h 1727550"/>
              <a:gd name="connsiteX0" fmla="*/ 0 w 587963"/>
              <a:gd name="connsiteY0" fmla="*/ 64229 h 1765589"/>
              <a:gd name="connsiteX1" fmla="*/ 348677 w 587963"/>
              <a:gd name="connsiteY1" fmla="*/ 107444 h 1765589"/>
              <a:gd name="connsiteX2" fmla="*/ 586628 w 587963"/>
              <a:gd name="connsiteY2" fmla="*/ 1093491 h 1765589"/>
              <a:gd name="connsiteX3" fmla="*/ 451441 w 587963"/>
              <a:gd name="connsiteY3" fmla="*/ 1765589 h 1765589"/>
              <a:gd name="connsiteX0" fmla="*/ 0 w 599319"/>
              <a:gd name="connsiteY0" fmla="*/ 54546 h 1774677"/>
              <a:gd name="connsiteX1" fmla="*/ 360033 w 599319"/>
              <a:gd name="connsiteY1" fmla="*/ 116532 h 1774677"/>
              <a:gd name="connsiteX2" fmla="*/ 597984 w 599319"/>
              <a:gd name="connsiteY2" fmla="*/ 1102579 h 1774677"/>
              <a:gd name="connsiteX3" fmla="*/ 462797 w 599319"/>
              <a:gd name="connsiteY3" fmla="*/ 1774677 h 1774677"/>
              <a:gd name="connsiteX0" fmla="*/ 0 w 598007"/>
              <a:gd name="connsiteY0" fmla="*/ 14527 h 1734658"/>
              <a:gd name="connsiteX1" fmla="*/ 450190 w 598007"/>
              <a:gd name="connsiteY1" fmla="*/ 244413 h 1734658"/>
              <a:gd name="connsiteX2" fmla="*/ 597984 w 598007"/>
              <a:gd name="connsiteY2" fmla="*/ 1062560 h 1734658"/>
              <a:gd name="connsiteX3" fmla="*/ 462797 w 598007"/>
              <a:gd name="connsiteY3" fmla="*/ 1734658 h 1734658"/>
              <a:gd name="connsiteX0" fmla="*/ 0 w 598007"/>
              <a:gd name="connsiteY0" fmla="*/ 17061 h 1737192"/>
              <a:gd name="connsiteX1" fmla="*/ 450190 w 598007"/>
              <a:gd name="connsiteY1" fmla="*/ 246947 h 1737192"/>
              <a:gd name="connsiteX2" fmla="*/ 597984 w 598007"/>
              <a:gd name="connsiteY2" fmla="*/ 1065094 h 1737192"/>
              <a:gd name="connsiteX3" fmla="*/ 462797 w 598007"/>
              <a:gd name="connsiteY3" fmla="*/ 1737192 h 1737192"/>
              <a:gd name="connsiteX0" fmla="*/ 0 w 598007"/>
              <a:gd name="connsiteY0" fmla="*/ 14527 h 1734658"/>
              <a:gd name="connsiteX1" fmla="*/ 450190 w 598007"/>
              <a:gd name="connsiteY1" fmla="*/ 244413 h 1734658"/>
              <a:gd name="connsiteX2" fmla="*/ 597984 w 598007"/>
              <a:gd name="connsiteY2" fmla="*/ 1062560 h 1734658"/>
              <a:gd name="connsiteX3" fmla="*/ 462797 w 598007"/>
              <a:gd name="connsiteY3" fmla="*/ 1734658 h 1734658"/>
              <a:gd name="connsiteX0" fmla="*/ 0 w 600131"/>
              <a:gd name="connsiteY0" fmla="*/ 21341 h 1741472"/>
              <a:gd name="connsiteX1" fmla="*/ 503292 w 600131"/>
              <a:gd name="connsiteY1" fmla="*/ 191623 h 1741472"/>
              <a:gd name="connsiteX2" fmla="*/ 597984 w 600131"/>
              <a:gd name="connsiteY2" fmla="*/ 1069374 h 1741472"/>
              <a:gd name="connsiteX3" fmla="*/ 462797 w 600131"/>
              <a:gd name="connsiteY3" fmla="*/ 1741472 h 1741472"/>
              <a:gd name="connsiteX0" fmla="*/ 0 w 631536"/>
              <a:gd name="connsiteY0" fmla="*/ 22573 h 1742704"/>
              <a:gd name="connsiteX1" fmla="*/ 503292 w 631536"/>
              <a:gd name="connsiteY1" fmla="*/ 192855 h 1742704"/>
              <a:gd name="connsiteX2" fmla="*/ 630613 w 631536"/>
              <a:gd name="connsiteY2" fmla="*/ 1101864 h 1742704"/>
              <a:gd name="connsiteX3" fmla="*/ 462797 w 631536"/>
              <a:gd name="connsiteY3" fmla="*/ 1742704 h 1742704"/>
              <a:gd name="connsiteX0" fmla="*/ 0 w 631536"/>
              <a:gd name="connsiteY0" fmla="*/ 21227 h 1741358"/>
              <a:gd name="connsiteX1" fmla="*/ 503292 w 631536"/>
              <a:gd name="connsiteY1" fmla="*/ 191509 h 1741358"/>
              <a:gd name="connsiteX2" fmla="*/ 630613 w 631536"/>
              <a:gd name="connsiteY2" fmla="*/ 1100518 h 1741358"/>
              <a:gd name="connsiteX3" fmla="*/ 462797 w 631536"/>
              <a:gd name="connsiteY3" fmla="*/ 1741358 h 1741358"/>
              <a:gd name="connsiteX0" fmla="*/ 0 w 633442"/>
              <a:gd name="connsiteY0" fmla="*/ 21227 h 1741358"/>
              <a:gd name="connsiteX1" fmla="*/ 503292 w 633442"/>
              <a:gd name="connsiteY1" fmla="*/ 191509 h 1741358"/>
              <a:gd name="connsiteX2" fmla="*/ 630613 w 633442"/>
              <a:gd name="connsiteY2" fmla="*/ 1100518 h 1741358"/>
              <a:gd name="connsiteX3" fmla="*/ 462797 w 633442"/>
              <a:gd name="connsiteY3" fmla="*/ 1741358 h 1741358"/>
              <a:gd name="connsiteX0" fmla="*/ 0 w 631019"/>
              <a:gd name="connsiteY0" fmla="*/ 15695 h 1735826"/>
              <a:gd name="connsiteX1" fmla="*/ 491988 w 631019"/>
              <a:gd name="connsiteY1" fmla="*/ 227759 h 1735826"/>
              <a:gd name="connsiteX2" fmla="*/ 630613 w 631019"/>
              <a:gd name="connsiteY2" fmla="*/ 1094986 h 1735826"/>
              <a:gd name="connsiteX3" fmla="*/ 462797 w 631019"/>
              <a:gd name="connsiteY3" fmla="*/ 1735826 h 1735826"/>
              <a:gd name="connsiteX0" fmla="*/ 0 w 614137"/>
              <a:gd name="connsiteY0" fmla="*/ 14814 h 1734945"/>
              <a:gd name="connsiteX1" fmla="*/ 491988 w 614137"/>
              <a:gd name="connsiteY1" fmla="*/ 226878 h 1734945"/>
              <a:gd name="connsiteX2" fmla="*/ 613551 w 614137"/>
              <a:gd name="connsiteY2" fmla="*/ 1035674 h 1734945"/>
              <a:gd name="connsiteX3" fmla="*/ 462797 w 614137"/>
              <a:gd name="connsiteY3" fmla="*/ 1734945 h 1734945"/>
              <a:gd name="connsiteX0" fmla="*/ 0 w 615694"/>
              <a:gd name="connsiteY0" fmla="*/ 14814 h 1734945"/>
              <a:gd name="connsiteX1" fmla="*/ 491988 w 615694"/>
              <a:gd name="connsiteY1" fmla="*/ 226878 h 1734945"/>
              <a:gd name="connsiteX2" fmla="*/ 613551 w 615694"/>
              <a:gd name="connsiteY2" fmla="*/ 1035674 h 1734945"/>
              <a:gd name="connsiteX3" fmla="*/ 462797 w 615694"/>
              <a:gd name="connsiteY3" fmla="*/ 1734945 h 1734945"/>
              <a:gd name="connsiteX0" fmla="*/ 0 w 614622"/>
              <a:gd name="connsiteY0" fmla="*/ 14814 h 1734945"/>
              <a:gd name="connsiteX1" fmla="*/ 491988 w 614622"/>
              <a:gd name="connsiteY1" fmla="*/ 226878 h 1734945"/>
              <a:gd name="connsiteX2" fmla="*/ 613551 w 614622"/>
              <a:gd name="connsiteY2" fmla="*/ 1035674 h 1734945"/>
              <a:gd name="connsiteX3" fmla="*/ 462797 w 614622"/>
              <a:gd name="connsiteY3" fmla="*/ 1734945 h 1734945"/>
              <a:gd name="connsiteX0" fmla="*/ 0 w 521028"/>
              <a:gd name="connsiteY0" fmla="*/ 32443 h 1752574"/>
              <a:gd name="connsiteX1" fmla="*/ 491988 w 521028"/>
              <a:gd name="connsiteY1" fmla="*/ 244507 h 1752574"/>
              <a:gd name="connsiteX2" fmla="*/ 462797 w 521028"/>
              <a:gd name="connsiteY2" fmla="*/ 1752574 h 1752574"/>
              <a:gd name="connsiteX0" fmla="*/ 0 w 521028"/>
              <a:gd name="connsiteY0" fmla="*/ 32443 h 1752574"/>
              <a:gd name="connsiteX1" fmla="*/ 491988 w 521028"/>
              <a:gd name="connsiteY1" fmla="*/ 244509 h 1752574"/>
              <a:gd name="connsiteX2" fmla="*/ 462797 w 521028"/>
              <a:gd name="connsiteY2" fmla="*/ 1752574 h 1752574"/>
              <a:gd name="connsiteX0" fmla="*/ 0 w 555271"/>
              <a:gd name="connsiteY0" fmla="*/ 62916 h 1783047"/>
              <a:gd name="connsiteX1" fmla="*/ 491988 w 555271"/>
              <a:gd name="connsiteY1" fmla="*/ 274982 h 1783047"/>
              <a:gd name="connsiteX2" fmla="*/ 462797 w 555271"/>
              <a:gd name="connsiteY2" fmla="*/ 1783047 h 1783047"/>
              <a:gd name="connsiteX0" fmla="*/ 0 w 634052"/>
              <a:gd name="connsiteY0" fmla="*/ 25886 h 1746017"/>
              <a:gd name="connsiteX1" fmla="*/ 586357 w 634052"/>
              <a:gd name="connsiteY1" fmla="*/ 359911 h 1746017"/>
              <a:gd name="connsiteX2" fmla="*/ 462797 w 634052"/>
              <a:gd name="connsiteY2" fmla="*/ 1746017 h 1746017"/>
              <a:gd name="connsiteX0" fmla="*/ 0 w 643701"/>
              <a:gd name="connsiteY0" fmla="*/ 25886 h 1746017"/>
              <a:gd name="connsiteX1" fmla="*/ 586357 w 643701"/>
              <a:gd name="connsiteY1" fmla="*/ 359911 h 1746017"/>
              <a:gd name="connsiteX2" fmla="*/ 462797 w 643701"/>
              <a:gd name="connsiteY2" fmla="*/ 1746017 h 1746017"/>
              <a:gd name="connsiteX0" fmla="*/ 0 w 648389"/>
              <a:gd name="connsiteY0" fmla="*/ 25886 h 1746017"/>
              <a:gd name="connsiteX1" fmla="*/ 586357 w 648389"/>
              <a:gd name="connsiteY1" fmla="*/ 359911 h 1746017"/>
              <a:gd name="connsiteX2" fmla="*/ 462797 w 648389"/>
              <a:gd name="connsiteY2" fmla="*/ 1746017 h 1746017"/>
              <a:gd name="connsiteX0" fmla="*/ 0 w 653675"/>
              <a:gd name="connsiteY0" fmla="*/ 25886 h 1746017"/>
              <a:gd name="connsiteX1" fmla="*/ 586357 w 653675"/>
              <a:gd name="connsiteY1" fmla="*/ 359911 h 1746017"/>
              <a:gd name="connsiteX2" fmla="*/ 462797 w 653675"/>
              <a:gd name="connsiteY2" fmla="*/ 1746017 h 17460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53675" h="1746017">
                <a:moveTo>
                  <a:pt x="0" y="25886"/>
                </a:moveTo>
                <a:cubicBezTo>
                  <a:pt x="170354" y="-27446"/>
                  <a:pt x="431170" y="-33113"/>
                  <a:pt x="586357" y="359911"/>
                </a:cubicBezTo>
                <a:cubicBezTo>
                  <a:pt x="741544" y="752935"/>
                  <a:pt x="597850" y="1410707"/>
                  <a:pt x="462797" y="1746017"/>
                </a:cubicBezTo>
              </a:path>
            </a:pathLst>
          </a:custGeom>
          <a:noFill/>
          <a:ln w="12700">
            <a:solidFill>
              <a:schemeClr val="tx1"/>
            </a:solidFill>
            <a:prstDash val="solid"/>
            <a:tailEnd type="triangle" w="sm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C514E36-BEED-4F2E-AAE6-26548706E863}"/>
              </a:ext>
            </a:extLst>
          </p:cNvPr>
          <p:cNvSpPr txBox="1"/>
          <p:nvPr/>
        </p:nvSpPr>
        <p:spPr>
          <a:xfrm>
            <a:off x="3351148" y="1683327"/>
            <a:ext cx="36728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①          ②                ③             ④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674CF4D-57C1-4770-83E8-34785EB5FDBF}"/>
              </a:ext>
            </a:extLst>
          </p:cNvPr>
          <p:cNvSpPr txBox="1"/>
          <p:nvPr/>
        </p:nvSpPr>
        <p:spPr>
          <a:xfrm>
            <a:off x="2398110" y="2319146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①</a:t>
            </a:r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520F9DC6-0B28-4F29-A53D-1A6273521541}"/>
              </a:ext>
            </a:extLst>
          </p:cNvPr>
          <p:cNvSpPr/>
          <p:nvPr/>
        </p:nvSpPr>
        <p:spPr>
          <a:xfrm>
            <a:off x="5066336" y="2324994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②</a:t>
            </a: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FBD9AA2D-C398-41FC-B7AA-973DA54EA6AD}"/>
              </a:ext>
            </a:extLst>
          </p:cNvPr>
          <p:cNvSpPr/>
          <p:nvPr/>
        </p:nvSpPr>
        <p:spPr>
          <a:xfrm>
            <a:off x="2398110" y="4463733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③</a:t>
            </a: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6C1D9142-274D-4843-A9BF-B5792CE1EE55}"/>
              </a:ext>
            </a:extLst>
          </p:cNvPr>
          <p:cNvSpPr/>
          <p:nvPr/>
        </p:nvSpPr>
        <p:spPr>
          <a:xfrm>
            <a:off x="5066336" y="4463733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④</a:t>
            </a:r>
          </a:p>
        </p:txBody>
      </p:sp>
    </p:spTree>
    <p:extLst>
      <p:ext uri="{BB962C8B-B14F-4D97-AF65-F5344CB8AC3E}">
        <p14:creationId xmlns:p14="http://schemas.microsoft.com/office/powerpoint/2010/main" val="32658072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개체 14">
            <a:extLst>
              <a:ext uri="{FF2B5EF4-FFF2-40B4-BE49-F238E27FC236}">
                <a16:creationId xmlns:a16="http://schemas.microsoft.com/office/drawing/2014/main" id="{BE46C3CE-9239-4DEC-9C62-74A1E0237B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2964551"/>
              </p:ext>
            </p:extLst>
          </p:nvPr>
        </p:nvGraphicFramePr>
        <p:xfrm>
          <a:off x="7679831" y="1904251"/>
          <a:ext cx="1205667" cy="1972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34" name="Graph" r:id="rId3" imgW="1583640" imgH="2592000" progId="Origin95.Graph">
                  <p:embed/>
                </p:oleObj>
              </mc:Choice>
              <mc:Fallback>
                <p:oleObj name="Graph" r:id="rId3" imgW="1583640" imgH="2592000" progId="Origin95.Graph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2865FA6C-762F-4C86-9A70-8ABEA09D32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679831" y="1904251"/>
                        <a:ext cx="1205667" cy="1972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" name="그룹 1">
            <a:extLst>
              <a:ext uri="{FF2B5EF4-FFF2-40B4-BE49-F238E27FC236}">
                <a16:creationId xmlns:a16="http://schemas.microsoft.com/office/drawing/2014/main" id="{3ED04D00-3A77-4790-B621-0BC59858F3CE}"/>
              </a:ext>
            </a:extLst>
          </p:cNvPr>
          <p:cNvGrpSpPr/>
          <p:nvPr/>
        </p:nvGrpSpPr>
        <p:grpSpPr>
          <a:xfrm>
            <a:off x="7288582" y="1941687"/>
            <a:ext cx="1460770" cy="2145126"/>
            <a:chOff x="3526335" y="1747473"/>
            <a:chExt cx="1202825" cy="1766337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A72F25E-06E8-41EC-AACB-ED70B19F81D0}"/>
                </a:ext>
              </a:extLst>
            </p:cNvPr>
            <p:cNvSpPr txBox="1"/>
            <p:nvPr/>
          </p:nvSpPr>
          <p:spPr>
            <a:xfrm>
              <a:off x="3711861" y="1747473"/>
              <a:ext cx="125395" cy="10770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5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ko-KR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57CCE21-78BD-43D1-8579-C39EC9F6FA45}"/>
                </a:ext>
              </a:extLst>
            </p:cNvPr>
            <p:cNvSpPr txBox="1"/>
            <p:nvPr/>
          </p:nvSpPr>
          <p:spPr>
            <a:xfrm>
              <a:off x="3711861" y="2216016"/>
              <a:ext cx="125395" cy="10770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5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ko-KR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2AEAC99-5AD8-4D83-8C17-8D3A7EBF3F8C}"/>
                </a:ext>
              </a:extLst>
            </p:cNvPr>
            <p:cNvSpPr txBox="1"/>
            <p:nvPr/>
          </p:nvSpPr>
          <p:spPr>
            <a:xfrm>
              <a:off x="3711974" y="2681112"/>
              <a:ext cx="125395" cy="10770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5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ko-KR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22A1251-3024-441C-947D-8081FC3A3494}"/>
                </a:ext>
              </a:extLst>
            </p:cNvPr>
            <p:cNvSpPr txBox="1"/>
            <p:nvPr/>
          </p:nvSpPr>
          <p:spPr>
            <a:xfrm>
              <a:off x="3715862" y="3153157"/>
              <a:ext cx="125395" cy="10770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5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ko-KR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ADDC995-D778-4E41-A21C-4407A54712C1}"/>
                </a:ext>
              </a:extLst>
            </p:cNvPr>
            <p:cNvSpPr txBox="1"/>
            <p:nvPr/>
          </p:nvSpPr>
          <p:spPr>
            <a:xfrm>
              <a:off x="3928500" y="3298395"/>
              <a:ext cx="349785" cy="21541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50" dirty="0">
                  <a:latin typeface="Arial" panose="020B0604020202020204" pitchFamily="34" charset="0"/>
                  <a:cs typeface="Arial" panose="020B0604020202020204" pitchFamily="34" charset="0"/>
                </a:rPr>
                <a:t>Small</a:t>
              </a:r>
            </a:p>
            <a:p>
              <a:pPr algn="ctr"/>
              <a:r>
                <a:rPr lang="en-US" altLang="ko-KR" sz="850" dirty="0">
                  <a:latin typeface="Arial" panose="020B0604020202020204" pitchFamily="34" charset="0"/>
                  <a:cs typeface="Arial" panose="020B0604020202020204" pitchFamily="34" charset="0"/>
                </a:rPr>
                <a:t>Colonies</a:t>
              </a:r>
              <a:endParaRPr lang="ko-KR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9FBA906-81B7-46C5-A115-8C7A8A25B884}"/>
                </a:ext>
              </a:extLst>
            </p:cNvPr>
            <p:cNvSpPr txBox="1"/>
            <p:nvPr/>
          </p:nvSpPr>
          <p:spPr>
            <a:xfrm rot="16200000">
              <a:off x="3047855" y="2446941"/>
              <a:ext cx="1083674" cy="12671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pecific growth rate (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2F7CAD7-FC82-46F7-94B3-EB7AF07217D4}"/>
                </a:ext>
              </a:extLst>
            </p:cNvPr>
            <p:cNvSpPr txBox="1"/>
            <p:nvPr/>
          </p:nvSpPr>
          <p:spPr>
            <a:xfrm>
              <a:off x="4379375" y="3298395"/>
              <a:ext cx="349785" cy="21541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850" dirty="0">
                  <a:latin typeface="Arial" panose="020B0604020202020204" pitchFamily="34" charset="0"/>
                  <a:cs typeface="Arial" panose="020B0604020202020204" pitchFamily="34" charset="0"/>
                </a:rPr>
                <a:t>Large</a:t>
              </a:r>
            </a:p>
            <a:p>
              <a:pPr algn="ctr"/>
              <a:r>
                <a:rPr lang="en-US" altLang="ko-KR" sz="850" dirty="0">
                  <a:latin typeface="Arial" panose="020B0604020202020204" pitchFamily="34" charset="0"/>
                  <a:cs typeface="Arial" panose="020B0604020202020204" pitchFamily="34" charset="0"/>
                </a:rPr>
                <a:t>Colonies</a:t>
              </a:r>
              <a:endParaRPr lang="ko-KR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C3B4C8C6-E507-44CB-81FF-997B1CA584DB}"/>
              </a:ext>
            </a:extLst>
          </p:cNvPr>
          <p:cNvSpPr/>
          <p:nvPr/>
        </p:nvSpPr>
        <p:spPr>
          <a:xfrm>
            <a:off x="0" y="2683"/>
            <a:ext cx="19175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개체 15">
            <a:extLst>
              <a:ext uri="{FF2B5EF4-FFF2-40B4-BE49-F238E27FC236}">
                <a16:creationId xmlns:a16="http://schemas.microsoft.com/office/drawing/2014/main" id="{A805F5DB-36D3-4C84-AE8F-E4E3A5C84B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7344702"/>
              </p:ext>
            </p:extLst>
          </p:nvPr>
        </p:nvGraphicFramePr>
        <p:xfrm>
          <a:off x="1135735" y="1879627"/>
          <a:ext cx="2731046" cy="21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35" name="Graph" r:id="rId5" imgW="3291840" imgH="2560320" progId="Origin95.Graph">
                  <p:embed/>
                </p:oleObj>
              </mc:Choice>
              <mc:Fallback>
                <p:oleObj name="Graph" r:id="rId5" imgW="3291840" imgH="256032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35735" y="1879627"/>
                        <a:ext cx="2731046" cy="21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개체 16">
            <a:extLst>
              <a:ext uri="{FF2B5EF4-FFF2-40B4-BE49-F238E27FC236}">
                <a16:creationId xmlns:a16="http://schemas.microsoft.com/office/drawing/2014/main" id="{2410EC82-D3F2-46F6-9AA0-6574CCD20C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8686104"/>
              </p:ext>
            </p:extLst>
          </p:nvPr>
        </p:nvGraphicFramePr>
        <p:xfrm>
          <a:off x="4333552" y="1879627"/>
          <a:ext cx="2731046" cy="21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36" name="Graph" r:id="rId7" imgW="3291840" imgH="2560320" progId="Origin95.Graph">
                  <p:embed/>
                </p:oleObj>
              </mc:Choice>
              <mc:Fallback>
                <p:oleObj name="Graph" r:id="rId7" imgW="3291840" imgH="256032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333552" y="1879627"/>
                        <a:ext cx="2731046" cy="21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771531C6-8CB4-4E56-9D61-93EB60C4D92A}"/>
              </a:ext>
            </a:extLst>
          </p:cNvPr>
          <p:cNvSpPr txBox="1"/>
          <p:nvPr/>
        </p:nvSpPr>
        <p:spPr>
          <a:xfrm>
            <a:off x="2350842" y="3972849"/>
            <a:ext cx="477695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01D1781-7C18-4C01-8CEB-12D18F119A63}"/>
              </a:ext>
            </a:extLst>
          </p:cNvPr>
          <p:cNvSpPr txBox="1"/>
          <p:nvPr/>
        </p:nvSpPr>
        <p:spPr>
          <a:xfrm rot="16200000">
            <a:off x="338460" y="2789083"/>
            <a:ext cx="121668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ell growth (OD</a:t>
            </a:r>
            <a:r>
              <a:rPr lang="en-US" altLang="ko-KR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nm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209722D-EA8B-4ACE-A103-301628FC5991}"/>
              </a:ext>
            </a:extLst>
          </p:cNvPr>
          <p:cNvSpPr txBox="1"/>
          <p:nvPr/>
        </p:nvSpPr>
        <p:spPr>
          <a:xfrm rot="16200000">
            <a:off x="3557302" y="2789083"/>
            <a:ext cx="121668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ell growth (OD</a:t>
            </a:r>
            <a:r>
              <a:rPr lang="en-US" altLang="ko-KR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nm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1C3B48B-D4AC-42D3-92B8-7B77D5FFA678}"/>
              </a:ext>
            </a:extLst>
          </p:cNvPr>
          <p:cNvSpPr txBox="1"/>
          <p:nvPr/>
        </p:nvSpPr>
        <p:spPr>
          <a:xfrm>
            <a:off x="5559402" y="3972849"/>
            <a:ext cx="477695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CF82281-931E-4D63-9258-5621FA49676F}"/>
              </a:ext>
            </a:extLst>
          </p:cNvPr>
          <p:cNvSpPr txBox="1"/>
          <p:nvPr/>
        </p:nvSpPr>
        <p:spPr>
          <a:xfrm>
            <a:off x="713387" y="1632372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7C8A6CA-0172-466F-AB6C-6B51660E0754}"/>
              </a:ext>
            </a:extLst>
          </p:cNvPr>
          <p:cNvSpPr txBox="1"/>
          <p:nvPr/>
        </p:nvSpPr>
        <p:spPr>
          <a:xfrm>
            <a:off x="3928237" y="1632372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F04284E-6BC0-4719-A722-17265FD987FA}"/>
              </a:ext>
            </a:extLst>
          </p:cNvPr>
          <p:cNvSpPr txBox="1"/>
          <p:nvPr/>
        </p:nvSpPr>
        <p:spPr>
          <a:xfrm>
            <a:off x="7128785" y="163237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56531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2FBD4BF2-5EEB-44EA-8759-35A714B502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3075914"/>
              </p:ext>
            </p:extLst>
          </p:nvPr>
        </p:nvGraphicFramePr>
        <p:xfrm>
          <a:off x="5328128" y="1778011"/>
          <a:ext cx="2731046" cy="21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42" name="Graph" r:id="rId3" imgW="3291840" imgH="2560320" progId="Origin95.Graph">
                  <p:embed/>
                </p:oleObj>
              </mc:Choice>
              <mc:Fallback>
                <p:oleObj name="Graph" r:id="rId3" imgW="3291840" imgH="2560320" progId="Origin95.Graph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2538EB58-66F1-48E4-82A1-455980D89DC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28128" y="1778011"/>
                        <a:ext cx="2731046" cy="21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개체 2">
            <a:extLst>
              <a:ext uri="{FF2B5EF4-FFF2-40B4-BE49-F238E27FC236}">
                <a16:creationId xmlns:a16="http://schemas.microsoft.com/office/drawing/2014/main" id="{C04DD34C-B86A-4318-BF94-44E0D8F4F9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2036646"/>
              </p:ext>
            </p:extLst>
          </p:nvPr>
        </p:nvGraphicFramePr>
        <p:xfrm>
          <a:off x="2113278" y="1778011"/>
          <a:ext cx="2731046" cy="21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43" name="Graph" r:id="rId5" imgW="3291840" imgH="2560320" progId="Origin95.Graph">
                  <p:embed/>
                </p:oleObj>
              </mc:Choice>
              <mc:Fallback>
                <p:oleObj name="Graph" r:id="rId5" imgW="3291840" imgH="2560320" progId="Origin95.Graph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99BA9B3F-F3DE-4B13-96F5-E77B2CEDB7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13278" y="1778011"/>
                        <a:ext cx="2731046" cy="21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BC0B874-5333-4EBD-8B5C-256B3E8BD8DA}"/>
              </a:ext>
            </a:extLst>
          </p:cNvPr>
          <p:cNvSpPr txBox="1"/>
          <p:nvPr/>
        </p:nvSpPr>
        <p:spPr>
          <a:xfrm>
            <a:off x="3348370" y="3825067"/>
            <a:ext cx="477695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94813CF-C6E5-4649-93C6-21424C94CE83}"/>
              </a:ext>
            </a:extLst>
          </p:cNvPr>
          <p:cNvSpPr txBox="1"/>
          <p:nvPr/>
        </p:nvSpPr>
        <p:spPr>
          <a:xfrm rot="16200000">
            <a:off x="1567622" y="2641301"/>
            <a:ext cx="75341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og(OD</a:t>
            </a:r>
            <a:r>
              <a:rPr lang="en-US" altLang="ko-KR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nm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00BCA2B-F73E-4EAC-9CBA-1FF8F0312708}"/>
              </a:ext>
            </a:extLst>
          </p:cNvPr>
          <p:cNvSpPr txBox="1"/>
          <p:nvPr/>
        </p:nvSpPr>
        <p:spPr>
          <a:xfrm rot="16200000">
            <a:off x="4786464" y="2641301"/>
            <a:ext cx="75341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og(OD</a:t>
            </a:r>
            <a:r>
              <a:rPr lang="en-US" altLang="ko-KR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nm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EF55D4E-12FC-446C-BB67-E593F7C7BBD3}"/>
              </a:ext>
            </a:extLst>
          </p:cNvPr>
          <p:cNvSpPr txBox="1"/>
          <p:nvPr/>
        </p:nvSpPr>
        <p:spPr>
          <a:xfrm>
            <a:off x="6556930" y="3825067"/>
            <a:ext cx="477695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0CF37B4-219E-4A70-B6F6-63B57F220D08}"/>
              </a:ext>
            </a:extLst>
          </p:cNvPr>
          <p:cNvSpPr txBox="1"/>
          <p:nvPr/>
        </p:nvSpPr>
        <p:spPr>
          <a:xfrm>
            <a:off x="1710915" y="148459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17D1468-B9C4-4E8A-A7FD-54B262AFA596}"/>
              </a:ext>
            </a:extLst>
          </p:cNvPr>
          <p:cNvSpPr txBox="1"/>
          <p:nvPr/>
        </p:nvSpPr>
        <p:spPr>
          <a:xfrm>
            <a:off x="4925765" y="148459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그룹 9">
            <a:extLst>
              <a:ext uri="{FF2B5EF4-FFF2-40B4-BE49-F238E27FC236}">
                <a16:creationId xmlns:a16="http://schemas.microsoft.com/office/drawing/2014/main" id="{E75339C4-907E-45D0-A6DE-D45D911544C5}"/>
              </a:ext>
            </a:extLst>
          </p:cNvPr>
          <p:cNvGrpSpPr/>
          <p:nvPr/>
        </p:nvGrpSpPr>
        <p:grpSpPr>
          <a:xfrm>
            <a:off x="2049319" y="1778011"/>
            <a:ext cx="224420" cy="1986223"/>
            <a:chOff x="2231375" y="244499"/>
            <a:chExt cx="224420" cy="1723225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35FA57B-3911-4852-A13A-EB67D924C570}"/>
                </a:ext>
              </a:extLst>
            </p:cNvPr>
            <p:cNvSpPr txBox="1"/>
            <p:nvPr/>
          </p:nvSpPr>
          <p:spPr>
            <a:xfrm>
              <a:off x="2306043" y="244499"/>
              <a:ext cx="12824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ED7C4F9-0980-4A87-A55B-9CD142E75B68}"/>
                </a:ext>
              </a:extLst>
            </p:cNvPr>
            <p:cNvSpPr txBox="1"/>
            <p:nvPr/>
          </p:nvSpPr>
          <p:spPr>
            <a:xfrm>
              <a:off x="2368425" y="778087"/>
              <a:ext cx="641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D966E8C-FCE0-45F5-A865-00271C48079C}"/>
                </a:ext>
              </a:extLst>
            </p:cNvPr>
            <p:cNvSpPr txBox="1"/>
            <p:nvPr/>
          </p:nvSpPr>
          <p:spPr>
            <a:xfrm>
              <a:off x="2291616" y="1310912"/>
              <a:ext cx="16030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51DC967-5BED-4041-8C3F-8690F247112A}"/>
                </a:ext>
              </a:extLst>
            </p:cNvPr>
            <p:cNvSpPr txBox="1"/>
            <p:nvPr/>
          </p:nvSpPr>
          <p:spPr>
            <a:xfrm>
              <a:off x="2231375" y="1829225"/>
              <a:ext cx="2244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그룹 14">
            <a:extLst>
              <a:ext uri="{FF2B5EF4-FFF2-40B4-BE49-F238E27FC236}">
                <a16:creationId xmlns:a16="http://schemas.microsoft.com/office/drawing/2014/main" id="{7F9F6C93-F444-43CF-9640-3BF95B2A3299}"/>
              </a:ext>
            </a:extLst>
          </p:cNvPr>
          <p:cNvGrpSpPr/>
          <p:nvPr/>
        </p:nvGrpSpPr>
        <p:grpSpPr>
          <a:xfrm>
            <a:off x="5276084" y="1780415"/>
            <a:ext cx="224420" cy="1986223"/>
            <a:chOff x="2231375" y="244499"/>
            <a:chExt cx="224420" cy="1723225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2910101-F8BA-456B-878A-49A1C96697B4}"/>
                </a:ext>
              </a:extLst>
            </p:cNvPr>
            <p:cNvSpPr txBox="1"/>
            <p:nvPr/>
          </p:nvSpPr>
          <p:spPr>
            <a:xfrm>
              <a:off x="2306043" y="244499"/>
              <a:ext cx="12824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A0102BE-5121-499A-AC06-CA5B4BE7D610}"/>
                </a:ext>
              </a:extLst>
            </p:cNvPr>
            <p:cNvSpPr txBox="1"/>
            <p:nvPr/>
          </p:nvSpPr>
          <p:spPr>
            <a:xfrm>
              <a:off x="2368425" y="778087"/>
              <a:ext cx="641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A00FA6A-449C-432E-94E2-9F980E910644}"/>
                </a:ext>
              </a:extLst>
            </p:cNvPr>
            <p:cNvSpPr txBox="1"/>
            <p:nvPr/>
          </p:nvSpPr>
          <p:spPr>
            <a:xfrm>
              <a:off x="2291616" y="1310912"/>
              <a:ext cx="16030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97E683C-E4C0-47E4-9045-02CEA0764AFD}"/>
                </a:ext>
              </a:extLst>
            </p:cNvPr>
            <p:cNvSpPr txBox="1"/>
            <p:nvPr/>
          </p:nvSpPr>
          <p:spPr>
            <a:xfrm>
              <a:off x="2231375" y="1829225"/>
              <a:ext cx="2244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BE2843F5-11C9-4AF6-AD68-E16FF4C1CFD2}"/>
              </a:ext>
            </a:extLst>
          </p:cNvPr>
          <p:cNvSpPr/>
          <p:nvPr/>
        </p:nvSpPr>
        <p:spPr>
          <a:xfrm>
            <a:off x="0" y="2683"/>
            <a:ext cx="19175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85733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9A4D5121-B51B-47BD-9F10-A46A0643FD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164386"/>
              </p:ext>
            </p:extLst>
          </p:nvPr>
        </p:nvGraphicFramePr>
        <p:xfrm>
          <a:off x="3451242" y="1780655"/>
          <a:ext cx="2731046" cy="21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9" name="Graph" r:id="rId3" imgW="3291840" imgH="2560320" progId="Origin95.Graph">
                  <p:embed/>
                </p:oleObj>
              </mc:Choice>
              <mc:Fallback>
                <p:oleObj name="Graph" r:id="rId3" imgW="3291840" imgH="2560320" progId="Origin95.Graph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BDAA9672-EDB8-46D5-B1BF-FE04EC6C6A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51242" y="1780655"/>
                        <a:ext cx="2731046" cy="21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" name="그룹 2">
            <a:extLst>
              <a:ext uri="{FF2B5EF4-FFF2-40B4-BE49-F238E27FC236}">
                <a16:creationId xmlns:a16="http://schemas.microsoft.com/office/drawing/2014/main" id="{CE119027-8BC8-4F71-9102-F5E80947DE04}"/>
              </a:ext>
            </a:extLst>
          </p:cNvPr>
          <p:cNvGrpSpPr/>
          <p:nvPr/>
        </p:nvGrpSpPr>
        <p:grpSpPr>
          <a:xfrm>
            <a:off x="3252904" y="2378205"/>
            <a:ext cx="1902798" cy="1577989"/>
            <a:chOff x="468717" y="2128294"/>
            <a:chExt cx="1902798" cy="157798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1E78F42-6505-480D-ADF8-D3E45BD69BC4}"/>
                </a:ext>
              </a:extLst>
            </p:cNvPr>
            <p:cNvSpPr txBox="1"/>
            <p:nvPr/>
          </p:nvSpPr>
          <p:spPr>
            <a:xfrm>
              <a:off x="1893820" y="3552395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DDA27C3-7B4F-418E-A084-A997F68944E1}"/>
                </a:ext>
              </a:extLst>
            </p:cNvPr>
            <p:cNvSpPr txBox="1"/>
            <p:nvPr/>
          </p:nvSpPr>
          <p:spPr>
            <a:xfrm rot="16200000">
              <a:off x="168955" y="2428056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그룹 5">
            <a:extLst>
              <a:ext uri="{FF2B5EF4-FFF2-40B4-BE49-F238E27FC236}">
                <a16:creationId xmlns:a16="http://schemas.microsoft.com/office/drawing/2014/main" id="{7CBB7D6E-3302-4048-8D25-247052D92855}"/>
              </a:ext>
            </a:extLst>
          </p:cNvPr>
          <p:cNvGrpSpPr/>
          <p:nvPr/>
        </p:nvGrpSpPr>
        <p:grpSpPr>
          <a:xfrm>
            <a:off x="5282859" y="3120319"/>
            <a:ext cx="790372" cy="417711"/>
            <a:chOff x="3838929" y="1156303"/>
            <a:chExt cx="790372" cy="417711"/>
          </a:xfrm>
        </p:grpSpPr>
        <p:cxnSp>
          <p:nvCxnSpPr>
            <p:cNvPr id="7" name="직선 연결선 6">
              <a:extLst>
                <a:ext uri="{FF2B5EF4-FFF2-40B4-BE49-F238E27FC236}">
                  <a16:creationId xmlns:a16="http://schemas.microsoft.com/office/drawing/2014/main" id="{073F1198-F8F1-47C6-ABB1-3F8A65D18589}"/>
                </a:ext>
              </a:extLst>
            </p:cNvPr>
            <p:cNvCxnSpPr/>
            <p:nvPr/>
          </p:nvCxnSpPr>
          <p:spPr>
            <a:xfrm>
              <a:off x="3838929" y="1237094"/>
              <a:ext cx="180000" cy="0"/>
            </a:xfrm>
            <a:prstGeom prst="line">
              <a:avLst/>
            </a:prstGeom>
            <a:ln w="9525" cap="rnd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타원 7">
              <a:extLst>
                <a:ext uri="{FF2B5EF4-FFF2-40B4-BE49-F238E27FC236}">
                  <a16:creationId xmlns:a16="http://schemas.microsoft.com/office/drawing/2014/main" id="{D43007CC-AF3F-4FEC-B54A-551197A07F7F}"/>
                </a:ext>
              </a:extLst>
            </p:cNvPr>
            <p:cNvSpPr/>
            <p:nvPr/>
          </p:nvSpPr>
          <p:spPr>
            <a:xfrm>
              <a:off x="3901717" y="1209882"/>
              <a:ext cx="54424" cy="54424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cxnSp>
          <p:nvCxnSpPr>
            <p:cNvPr id="9" name="직선 연결선 8">
              <a:extLst>
                <a:ext uri="{FF2B5EF4-FFF2-40B4-BE49-F238E27FC236}">
                  <a16:creationId xmlns:a16="http://schemas.microsoft.com/office/drawing/2014/main" id="{85AF849C-8405-4F3B-996A-4E6D8A6B3689}"/>
                </a:ext>
              </a:extLst>
            </p:cNvPr>
            <p:cNvCxnSpPr/>
            <p:nvPr/>
          </p:nvCxnSpPr>
          <p:spPr>
            <a:xfrm>
              <a:off x="3841503" y="1373175"/>
              <a:ext cx="180000" cy="0"/>
            </a:xfrm>
            <a:prstGeom prst="line">
              <a:avLst/>
            </a:prstGeom>
            <a:ln w="9525" cap="rnd"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이등변 삼각형 9">
              <a:extLst>
                <a:ext uri="{FF2B5EF4-FFF2-40B4-BE49-F238E27FC236}">
                  <a16:creationId xmlns:a16="http://schemas.microsoft.com/office/drawing/2014/main" id="{840630A7-14BF-44E4-9DE9-16A5C347409F}"/>
                </a:ext>
              </a:extLst>
            </p:cNvPr>
            <p:cNvSpPr/>
            <p:nvPr/>
          </p:nvSpPr>
          <p:spPr>
            <a:xfrm>
              <a:off x="3904291" y="1345963"/>
              <a:ext cx="54424" cy="54424"/>
            </a:xfrm>
            <a:prstGeom prst="triangle">
              <a:avLst/>
            </a:prstGeom>
            <a:solidFill>
              <a:schemeClr val="bg1"/>
            </a:solidFill>
            <a:ln w="9525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63E77B4-3E57-46E8-8A26-1A8811279784}"/>
                </a:ext>
              </a:extLst>
            </p:cNvPr>
            <p:cNvSpPr txBox="1"/>
            <p:nvPr/>
          </p:nvSpPr>
          <p:spPr>
            <a:xfrm>
              <a:off x="4053827" y="1299527"/>
              <a:ext cx="35266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K565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6207BC2-D4F6-4913-9D63-FB969DEF904A}"/>
                </a:ext>
              </a:extLst>
            </p:cNvPr>
            <p:cNvSpPr txBox="1"/>
            <p:nvPr/>
          </p:nvSpPr>
          <p:spPr>
            <a:xfrm>
              <a:off x="4058632" y="1156303"/>
              <a:ext cx="570669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BL21(DE3)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직선 연결선 12">
              <a:extLst>
                <a:ext uri="{FF2B5EF4-FFF2-40B4-BE49-F238E27FC236}">
                  <a16:creationId xmlns:a16="http://schemas.microsoft.com/office/drawing/2014/main" id="{9CCF183C-328D-4463-9FF4-8DAA62E5FFD6}"/>
                </a:ext>
              </a:extLst>
            </p:cNvPr>
            <p:cNvCxnSpPr/>
            <p:nvPr/>
          </p:nvCxnSpPr>
          <p:spPr>
            <a:xfrm>
              <a:off x="3841503" y="1506782"/>
              <a:ext cx="180000" cy="0"/>
            </a:xfrm>
            <a:prstGeom prst="line">
              <a:avLst/>
            </a:prstGeom>
            <a:ln w="9525" cap="rnd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직사각형 13">
              <a:extLst>
                <a:ext uri="{FF2B5EF4-FFF2-40B4-BE49-F238E27FC236}">
                  <a16:creationId xmlns:a16="http://schemas.microsoft.com/office/drawing/2014/main" id="{0AE254EE-B686-427F-872B-C3F00C863C72}"/>
                </a:ext>
              </a:extLst>
            </p:cNvPr>
            <p:cNvSpPr/>
            <p:nvPr/>
          </p:nvSpPr>
          <p:spPr>
            <a:xfrm>
              <a:off x="3904291" y="1479570"/>
              <a:ext cx="54424" cy="5442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DEEDD24-82A2-4900-A796-5BC4B7AD7536}"/>
                </a:ext>
              </a:extLst>
            </p:cNvPr>
            <p:cNvSpPr txBox="1"/>
            <p:nvPr/>
          </p:nvSpPr>
          <p:spPr>
            <a:xfrm>
              <a:off x="4053827" y="1435515"/>
              <a:ext cx="506549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BW25113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5D839116-B939-4B5C-AB14-182202EA3AE0}"/>
              </a:ext>
            </a:extLst>
          </p:cNvPr>
          <p:cNvSpPr txBox="1"/>
          <p:nvPr/>
        </p:nvSpPr>
        <p:spPr>
          <a:xfrm>
            <a:off x="4383535" y="1591911"/>
            <a:ext cx="12570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ccinate (0.3%)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DF6D98F-C12E-405D-9390-B4C440719210}"/>
              </a:ext>
            </a:extLst>
          </p:cNvPr>
          <p:cNvSpPr txBox="1"/>
          <p:nvPr/>
        </p:nvSpPr>
        <p:spPr>
          <a:xfrm>
            <a:off x="4355463" y="2771931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42</a:t>
            </a:r>
            <a:endParaRPr lang="ko-KR" altLang="en-US" sz="8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255A644-4953-4689-9E58-856A65B3705B}"/>
              </a:ext>
            </a:extLst>
          </p:cNvPr>
          <p:cNvSpPr txBox="1"/>
          <p:nvPr/>
        </p:nvSpPr>
        <p:spPr>
          <a:xfrm>
            <a:off x="5025046" y="2781099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14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3D7D92B-E732-4B3F-B891-92F00CBF4399}"/>
              </a:ext>
            </a:extLst>
          </p:cNvPr>
          <p:cNvSpPr txBox="1"/>
          <p:nvPr/>
        </p:nvSpPr>
        <p:spPr>
          <a:xfrm>
            <a:off x="3750885" y="2754910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7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그룹 19">
            <a:extLst>
              <a:ext uri="{FF2B5EF4-FFF2-40B4-BE49-F238E27FC236}">
                <a16:creationId xmlns:a16="http://schemas.microsoft.com/office/drawing/2014/main" id="{6E7123F6-2CF2-46CF-99C5-E84CC699FFF3}"/>
              </a:ext>
            </a:extLst>
          </p:cNvPr>
          <p:cNvGrpSpPr/>
          <p:nvPr/>
        </p:nvGrpSpPr>
        <p:grpSpPr>
          <a:xfrm>
            <a:off x="3420970" y="1784488"/>
            <a:ext cx="224420" cy="1973702"/>
            <a:chOff x="2231375" y="244499"/>
            <a:chExt cx="224420" cy="1723225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1862323-A9DD-4E48-8F88-3B5226BCC8E8}"/>
                </a:ext>
              </a:extLst>
            </p:cNvPr>
            <p:cNvSpPr txBox="1"/>
            <p:nvPr/>
          </p:nvSpPr>
          <p:spPr>
            <a:xfrm>
              <a:off x="2306043" y="244499"/>
              <a:ext cx="12824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A848A4F-DC17-4A1B-AD8D-58B3BC353B7D}"/>
                </a:ext>
              </a:extLst>
            </p:cNvPr>
            <p:cNvSpPr txBox="1"/>
            <p:nvPr/>
          </p:nvSpPr>
          <p:spPr>
            <a:xfrm>
              <a:off x="2368425" y="778087"/>
              <a:ext cx="641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08B7BA6-3BDE-490D-8F57-793540956591}"/>
                </a:ext>
              </a:extLst>
            </p:cNvPr>
            <p:cNvSpPr txBox="1"/>
            <p:nvPr/>
          </p:nvSpPr>
          <p:spPr>
            <a:xfrm>
              <a:off x="2291616" y="1310912"/>
              <a:ext cx="16030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E683CC5-4310-48ED-87CC-B808A88818B9}"/>
                </a:ext>
              </a:extLst>
            </p:cNvPr>
            <p:cNvSpPr txBox="1"/>
            <p:nvPr/>
          </p:nvSpPr>
          <p:spPr>
            <a:xfrm>
              <a:off x="2231375" y="1829225"/>
              <a:ext cx="2244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22D75B2B-2EF2-4A27-9598-F8D70FEC5B22}"/>
              </a:ext>
            </a:extLst>
          </p:cNvPr>
          <p:cNvSpPr/>
          <p:nvPr/>
        </p:nvSpPr>
        <p:spPr>
          <a:xfrm>
            <a:off x="0" y="2683"/>
            <a:ext cx="19175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20239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개체 9">
            <a:extLst>
              <a:ext uri="{FF2B5EF4-FFF2-40B4-BE49-F238E27FC236}">
                <a16:creationId xmlns:a16="http://schemas.microsoft.com/office/drawing/2014/main" id="{F85C2E76-238A-4B8F-B953-67A599F285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4704481"/>
              </p:ext>
            </p:extLst>
          </p:nvPr>
        </p:nvGraphicFramePr>
        <p:xfrm>
          <a:off x="2268251" y="3647850"/>
          <a:ext cx="2403043" cy="18690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89" name="Graph" r:id="rId3" imgW="3291840" imgH="2560320" progId="Origin50.Graph">
                  <p:embed/>
                </p:oleObj>
              </mc:Choice>
              <mc:Fallback>
                <p:oleObj name="Graph" r:id="rId3" imgW="3291840" imgH="2560320" progId="Origin50.Graph">
                  <p:embed/>
                  <p:pic>
                    <p:nvPicPr>
                      <p:cNvPr id="10" name="개체 9">
                        <a:extLst>
                          <a:ext uri="{FF2B5EF4-FFF2-40B4-BE49-F238E27FC236}">
                            <a16:creationId xmlns:a16="http://schemas.microsoft.com/office/drawing/2014/main" id="{F85C2E76-238A-4B8F-B953-67A599F285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68251" y="3647850"/>
                        <a:ext cx="2403043" cy="18690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개체 10">
            <a:extLst>
              <a:ext uri="{FF2B5EF4-FFF2-40B4-BE49-F238E27FC236}">
                <a16:creationId xmlns:a16="http://schemas.microsoft.com/office/drawing/2014/main" id="{1F33CD74-2E43-498D-B7C6-2D9BE97C78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2932346"/>
              </p:ext>
            </p:extLst>
          </p:nvPr>
        </p:nvGraphicFramePr>
        <p:xfrm>
          <a:off x="5283972" y="3655344"/>
          <a:ext cx="2403043" cy="18690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90" name="Graph" r:id="rId5" imgW="3291840" imgH="2560320" progId="Origin50.Graph">
                  <p:embed/>
                </p:oleObj>
              </mc:Choice>
              <mc:Fallback>
                <p:oleObj name="Graph" r:id="rId5" imgW="3291840" imgH="2560320" progId="Origin50.Graph">
                  <p:embed/>
                  <p:pic>
                    <p:nvPicPr>
                      <p:cNvPr id="11" name="개체 10">
                        <a:extLst>
                          <a:ext uri="{FF2B5EF4-FFF2-40B4-BE49-F238E27FC236}">
                            <a16:creationId xmlns:a16="http://schemas.microsoft.com/office/drawing/2014/main" id="{1F33CD74-2E43-498D-B7C6-2D9BE97C78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283972" y="3655344"/>
                        <a:ext cx="2403043" cy="18690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개체 6">
            <a:extLst>
              <a:ext uri="{FF2B5EF4-FFF2-40B4-BE49-F238E27FC236}">
                <a16:creationId xmlns:a16="http://schemas.microsoft.com/office/drawing/2014/main" id="{686582F6-0BA6-4955-BC15-2177405968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0647310"/>
              </p:ext>
            </p:extLst>
          </p:nvPr>
        </p:nvGraphicFramePr>
        <p:xfrm>
          <a:off x="2268251" y="1290869"/>
          <a:ext cx="2403043" cy="18690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91" name="Graph" r:id="rId7" imgW="3291840" imgH="2560320" progId="Origin95.Graph">
                  <p:embed/>
                </p:oleObj>
              </mc:Choice>
              <mc:Fallback>
                <p:oleObj name="Graph" r:id="rId7" imgW="3291840" imgH="256032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268251" y="1290869"/>
                        <a:ext cx="2403043" cy="18690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A1DBA595-90A8-40A6-BFDE-B0D21DD4A9C1}"/>
              </a:ext>
            </a:extLst>
          </p:cNvPr>
          <p:cNvSpPr txBox="1"/>
          <p:nvPr/>
        </p:nvSpPr>
        <p:spPr>
          <a:xfrm>
            <a:off x="1897272" y="962668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93368CE-1E2E-481B-8673-7C431BF65ECA}"/>
              </a:ext>
            </a:extLst>
          </p:cNvPr>
          <p:cNvSpPr txBox="1"/>
          <p:nvPr/>
        </p:nvSpPr>
        <p:spPr>
          <a:xfrm>
            <a:off x="4823330" y="962668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8FCF33C-F9C0-4839-AC3B-7C78BE3488EC}"/>
              </a:ext>
            </a:extLst>
          </p:cNvPr>
          <p:cNvSpPr txBox="1"/>
          <p:nvPr/>
        </p:nvSpPr>
        <p:spPr>
          <a:xfrm>
            <a:off x="1897272" y="328360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6157802-D55E-4E09-BE02-B611C027B84C}"/>
              </a:ext>
            </a:extLst>
          </p:cNvPr>
          <p:cNvSpPr txBox="1"/>
          <p:nvPr/>
        </p:nvSpPr>
        <p:spPr>
          <a:xfrm>
            <a:off x="4823330" y="328360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15E6C7F2-27DC-4861-850A-57924395B827}"/>
              </a:ext>
            </a:extLst>
          </p:cNvPr>
          <p:cNvGrpSpPr/>
          <p:nvPr/>
        </p:nvGrpSpPr>
        <p:grpSpPr>
          <a:xfrm>
            <a:off x="2084160" y="3536113"/>
            <a:ext cx="1953389" cy="2068431"/>
            <a:chOff x="2075526" y="1101624"/>
            <a:chExt cx="1953389" cy="2068431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F877822-A804-4DBE-BA0F-9D189ACE0E84}"/>
                </a:ext>
              </a:extLst>
            </p:cNvPr>
            <p:cNvSpPr txBox="1"/>
            <p:nvPr/>
          </p:nvSpPr>
          <p:spPr>
            <a:xfrm>
              <a:off x="3012611" y="1101624"/>
              <a:ext cx="1016304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D-Glucose (0.3%)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66F7836-24FE-46A4-A90F-95A1E65DA277}"/>
                </a:ext>
              </a:extLst>
            </p:cNvPr>
            <p:cNvSpPr txBox="1"/>
            <p:nvPr/>
          </p:nvSpPr>
          <p:spPr>
            <a:xfrm>
              <a:off x="3281914" y="3016167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52E6810-FCF9-4E2F-9CDE-C1C7DC1D2E6A}"/>
                </a:ext>
              </a:extLst>
            </p:cNvPr>
            <p:cNvSpPr txBox="1"/>
            <p:nvPr/>
          </p:nvSpPr>
          <p:spPr>
            <a:xfrm rot="16200000">
              <a:off x="1544130" y="1940967"/>
              <a:ext cx="121668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ell growth 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5" name="그룹 54">
              <a:extLst>
                <a:ext uri="{FF2B5EF4-FFF2-40B4-BE49-F238E27FC236}">
                  <a16:creationId xmlns:a16="http://schemas.microsoft.com/office/drawing/2014/main" id="{A49CDD0A-1127-4EF2-8CE0-F53651BC6764}"/>
                </a:ext>
              </a:extLst>
            </p:cNvPr>
            <p:cNvGrpSpPr/>
            <p:nvPr/>
          </p:nvGrpSpPr>
          <p:grpSpPr>
            <a:xfrm>
              <a:off x="2525760" y="1290116"/>
              <a:ext cx="788923" cy="276703"/>
              <a:chOff x="7432736" y="5468641"/>
              <a:chExt cx="788923" cy="276703"/>
            </a:xfrm>
          </p:grpSpPr>
          <p:grpSp>
            <p:nvGrpSpPr>
              <p:cNvPr id="56" name="그룹 55">
                <a:extLst>
                  <a:ext uri="{FF2B5EF4-FFF2-40B4-BE49-F238E27FC236}">
                    <a16:creationId xmlns:a16="http://schemas.microsoft.com/office/drawing/2014/main" id="{F8B37902-4B4C-460A-B221-729AD0636AD9}"/>
                  </a:ext>
                </a:extLst>
              </p:cNvPr>
              <p:cNvGrpSpPr/>
              <p:nvPr/>
            </p:nvGrpSpPr>
            <p:grpSpPr>
              <a:xfrm>
                <a:off x="7432736" y="5606845"/>
                <a:ext cx="570914" cy="138499"/>
                <a:chOff x="7432736" y="5606845"/>
                <a:chExt cx="570914" cy="138499"/>
              </a:xfrm>
            </p:grpSpPr>
            <p:grpSp>
              <p:nvGrpSpPr>
                <p:cNvPr id="62" name="그룹 61">
                  <a:extLst>
                    <a:ext uri="{FF2B5EF4-FFF2-40B4-BE49-F238E27FC236}">
                      <a16:creationId xmlns:a16="http://schemas.microsoft.com/office/drawing/2014/main" id="{8C8DAA81-6A20-4382-943D-2B9D37EC554F}"/>
                    </a:ext>
                  </a:extLst>
                </p:cNvPr>
                <p:cNvGrpSpPr/>
                <p:nvPr/>
              </p:nvGrpSpPr>
              <p:grpSpPr>
                <a:xfrm>
                  <a:off x="7432736" y="5646864"/>
                  <a:ext cx="180000" cy="54424"/>
                  <a:chOff x="4299814" y="2598142"/>
                  <a:chExt cx="180000" cy="54424"/>
                </a:xfrm>
              </p:grpSpPr>
              <p:cxnSp>
                <p:nvCxnSpPr>
                  <p:cNvPr id="64" name="직선 연결선 63">
                    <a:extLst>
                      <a:ext uri="{FF2B5EF4-FFF2-40B4-BE49-F238E27FC236}">
                        <a16:creationId xmlns:a16="http://schemas.microsoft.com/office/drawing/2014/main" id="{1FC928E2-F72B-49C0-8ED2-5D60D3B2D5B4}"/>
                      </a:ext>
                    </a:extLst>
                  </p:cNvPr>
                  <p:cNvCxnSpPr/>
                  <p:nvPr/>
                </p:nvCxnSpPr>
                <p:spPr>
                  <a:xfrm>
                    <a:off x="4299814" y="2625354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5" name="이등변 삼각형 64">
                    <a:extLst>
                      <a:ext uri="{FF2B5EF4-FFF2-40B4-BE49-F238E27FC236}">
                        <a16:creationId xmlns:a16="http://schemas.microsoft.com/office/drawing/2014/main" id="{2E8B69C0-A239-43C8-8604-02D9D4174F13}"/>
                      </a:ext>
                    </a:extLst>
                  </p:cNvPr>
                  <p:cNvSpPr/>
                  <p:nvPr/>
                </p:nvSpPr>
                <p:spPr>
                  <a:xfrm>
                    <a:off x="4362602" y="2598142"/>
                    <a:ext cx="54424" cy="54424"/>
                  </a:xfrm>
                  <a:prstGeom prst="triangl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9F4F1AC0-EC09-4770-B8A4-A7F779A5112F}"/>
                    </a:ext>
                  </a:extLst>
                </p:cNvPr>
                <p:cNvSpPr txBox="1"/>
                <p:nvPr/>
              </p:nvSpPr>
              <p:spPr>
                <a:xfrm>
                  <a:off x="7650989" y="5606845"/>
                  <a:ext cx="352661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K565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7" name="그룹 56">
                <a:extLst>
                  <a:ext uri="{FF2B5EF4-FFF2-40B4-BE49-F238E27FC236}">
                    <a16:creationId xmlns:a16="http://schemas.microsoft.com/office/drawing/2014/main" id="{D7A3637B-A2AB-4E8B-8ADF-F1AE517605A9}"/>
                  </a:ext>
                </a:extLst>
              </p:cNvPr>
              <p:cNvGrpSpPr/>
              <p:nvPr/>
            </p:nvGrpSpPr>
            <p:grpSpPr>
              <a:xfrm>
                <a:off x="7432736" y="5468641"/>
                <a:ext cx="788923" cy="138499"/>
                <a:chOff x="7432736" y="5516261"/>
                <a:chExt cx="788923" cy="138499"/>
              </a:xfrm>
            </p:grpSpPr>
            <p:grpSp>
              <p:nvGrpSpPr>
                <p:cNvPr id="58" name="그룹 57">
                  <a:extLst>
                    <a:ext uri="{FF2B5EF4-FFF2-40B4-BE49-F238E27FC236}">
                      <a16:creationId xmlns:a16="http://schemas.microsoft.com/office/drawing/2014/main" id="{07082B4C-7C7A-4139-884A-01364A9B86F8}"/>
                    </a:ext>
                  </a:extLst>
                </p:cNvPr>
                <p:cNvGrpSpPr/>
                <p:nvPr/>
              </p:nvGrpSpPr>
              <p:grpSpPr>
                <a:xfrm>
                  <a:off x="7432736" y="5555499"/>
                  <a:ext cx="180000" cy="54424"/>
                  <a:chOff x="4299814" y="2310004"/>
                  <a:chExt cx="180000" cy="54424"/>
                </a:xfrm>
              </p:grpSpPr>
              <p:cxnSp>
                <p:nvCxnSpPr>
                  <p:cNvPr id="60" name="직선 연결선 59">
                    <a:extLst>
                      <a:ext uri="{FF2B5EF4-FFF2-40B4-BE49-F238E27FC236}">
                        <a16:creationId xmlns:a16="http://schemas.microsoft.com/office/drawing/2014/main" id="{671629F7-45D9-4DBC-8327-6EA462A69A85}"/>
                      </a:ext>
                    </a:extLst>
                  </p:cNvPr>
                  <p:cNvCxnSpPr/>
                  <p:nvPr/>
                </p:nvCxnSpPr>
                <p:spPr>
                  <a:xfrm>
                    <a:off x="4299814" y="2337216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1" name="타원 60">
                    <a:extLst>
                      <a:ext uri="{FF2B5EF4-FFF2-40B4-BE49-F238E27FC236}">
                        <a16:creationId xmlns:a16="http://schemas.microsoft.com/office/drawing/2014/main" id="{FADA5BEB-C1E5-497B-ABEA-0CC60482975A}"/>
                      </a:ext>
                    </a:extLst>
                  </p:cNvPr>
                  <p:cNvSpPr/>
                  <p:nvPr/>
                </p:nvSpPr>
                <p:spPr>
                  <a:xfrm>
                    <a:off x="4362602" y="2310004"/>
                    <a:ext cx="54424" cy="54424"/>
                  </a:xfrm>
                  <a:prstGeom prst="ellips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94FFBC55-31DF-4650-862B-35C77F6A3EC5}"/>
                    </a:ext>
                  </a:extLst>
                </p:cNvPr>
                <p:cNvSpPr txBox="1"/>
                <p:nvPr/>
              </p:nvSpPr>
              <p:spPr>
                <a:xfrm>
                  <a:off x="7650989" y="5516261"/>
                  <a:ext cx="570670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21(DE3)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F06EA830-2BED-4107-BD10-E3B22D25C8CE}"/>
              </a:ext>
            </a:extLst>
          </p:cNvPr>
          <p:cNvGrpSpPr/>
          <p:nvPr/>
        </p:nvGrpSpPr>
        <p:grpSpPr>
          <a:xfrm>
            <a:off x="5089514" y="3550997"/>
            <a:ext cx="1885119" cy="2050325"/>
            <a:chOff x="4953000" y="1119729"/>
            <a:chExt cx="1885119" cy="2050325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F3625CA-37A5-4F8B-A367-819F8EFD9136}"/>
                </a:ext>
              </a:extLst>
            </p:cNvPr>
            <p:cNvSpPr txBox="1"/>
            <p:nvPr/>
          </p:nvSpPr>
          <p:spPr>
            <a:xfrm>
              <a:off x="5956467" y="1119729"/>
              <a:ext cx="88165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Glycerol (0.3%)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D020503-6B2C-4375-8DB4-B703E3E4ADD8}"/>
                </a:ext>
              </a:extLst>
            </p:cNvPr>
            <p:cNvSpPr txBox="1"/>
            <p:nvPr/>
          </p:nvSpPr>
          <p:spPr>
            <a:xfrm>
              <a:off x="6159388" y="3016166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3CBEF97-9FE0-41A4-915C-273CFE12ABC1}"/>
                </a:ext>
              </a:extLst>
            </p:cNvPr>
            <p:cNvSpPr txBox="1"/>
            <p:nvPr/>
          </p:nvSpPr>
          <p:spPr>
            <a:xfrm rot="16200000">
              <a:off x="4421604" y="1940966"/>
              <a:ext cx="121668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ell growth 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4" name="그룹 53">
              <a:extLst>
                <a:ext uri="{FF2B5EF4-FFF2-40B4-BE49-F238E27FC236}">
                  <a16:creationId xmlns:a16="http://schemas.microsoft.com/office/drawing/2014/main" id="{9B1E3F92-2B88-4506-87DE-884576F2295E}"/>
                </a:ext>
              </a:extLst>
            </p:cNvPr>
            <p:cNvGrpSpPr/>
            <p:nvPr/>
          </p:nvGrpSpPr>
          <p:grpSpPr>
            <a:xfrm>
              <a:off x="5409049" y="1297980"/>
              <a:ext cx="788923" cy="276703"/>
              <a:chOff x="7383380" y="5476653"/>
              <a:chExt cx="788923" cy="276703"/>
            </a:xfrm>
          </p:grpSpPr>
          <p:grpSp>
            <p:nvGrpSpPr>
              <p:cNvPr id="77" name="그룹 76">
                <a:extLst>
                  <a:ext uri="{FF2B5EF4-FFF2-40B4-BE49-F238E27FC236}">
                    <a16:creationId xmlns:a16="http://schemas.microsoft.com/office/drawing/2014/main" id="{DD296CBC-CF8C-4279-8240-2A19E327D134}"/>
                  </a:ext>
                </a:extLst>
              </p:cNvPr>
              <p:cNvGrpSpPr/>
              <p:nvPr/>
            </p:nvGrpSpPr>
            <p:grpSpPr>
              <a:xfrm>
                <a:off x="7383380" y="5614857"/>
                <a:ext cx="570914" cy="138499"/>
                <a:chOff x="7383380" y="5614857"/>
                <a:chExt cx="570914" cy="138499"/>
              </a:xfrm>
            </p:grpSpPr>
            <p:grpSp>
              <p:nvGrpSpPr>
                <p:cNvPr id="83" name="그룹 82">
                  <a:extLst>
                    <a:ext uri="{FF2B5EF4-FFF2-40B4-BE49-F238E27FC236}">
                      <a16:creationId xmlns:a16="http://schemas.microsoft.com/office/drawing/2014/main" id="{381D6CCF-B518-47EC-A945-13F62C9D2DF8}"/>
                    </a:ext>
                  </a:extLst>
                </p:cNvPr>
                <p:cNvGrpSpPr/>
                <p:nvPr/>
              </p:nvGrpSpPr>
              <p:grpSpPr>
                <a:xfrm>
                  <a:off x="7383380" y="5654876"/>
                  <a:ext cx="180000" cy="54424"/>
                  <a:chOff x="4250458" y="2606154"/>
                  <a:chExt cx="180000" cy="54424"/>
                </a:xfrm>
              </p:grpSpPr>
              <p:cxnSp>
                <p:nvCxnSpPr>
                  <p:cNvPr id="85" name="직선 연결선 84">
                    <a:extLst>
                      <a:ext uri="{FF2B5EF4-FFF2-40B4-BE49-F238E27FC236}">
                        <a16:creationId xmlns:a16="http://schemas.microsoft.com/office/drawing/2014/main" id="{DB1360C9-D507-43D8-86CC-173C41579231}"/>
                      </a:ext>
                    </a:extLst>
                  </p:cNvPr>
                  <p:cNvCxnSpPr/>
                  <p:nvPr/>
                </p:nvCxnSpPr>
                <p:spPr>
                  <a:xfrm>
                    <a:off x="4250458" y="2633366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6" name="이등변 삼각형 85">
                    <a:extLst>
                      <a:ext uri="{FF2B5EF4-FFF2-40B4-BE49-F238E27FC236}">
                        <a16:creationId xmlns:a16="http://schemas.microsoft.com/office/drawing/2014/main" id="{46E95949-4359-4E25-94CD-255C421C3D6B}"/>
                      </a:ext>
                    </a:extLst>
                  </p:cNvPr>
                  <p:cNvSpPr/>
                  <p:nvPr/>
                </p:nvSpPr>
                <p:spPr>
                  <a:xfrm>
                    <a:off x="4313246" y="2606154"/>
                    <a:ext cx="54424" cy="54424"/>
                  </a:xfrm>
                  <a:prstGeom prst="triangl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F1AAE6FB-9739-44FC-B100-3744CDE62B9A}"/>
                    </a:ext>
                  </a:extLst>
                </p:cNvPr>
                <p:cNvSpPr txBox="1"/>
                <p:nvPr/>
              </p:nvSpPr>
              <p:spPr>
                <a:xfrm>
                  <a:off x="7601633" y="5614857"/>
                  <a:ext cx="352661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K565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8" name="그룹 77">
                <a:extLst>
                  <a:ext uri="{FF2B5EF4-FFF2-40B4-BE49-F238E27FC236}">
                    <a16:creationId xmlns:a16="http://schemas.microsoft.com/office/drawing/2014/main" id="{C1B55215-3CB8-4782-9E81-F766B63D4B71}"/>
                  </a:ext>
                </a:extLst>
              </p:cNvPr>
              <p:cNvGrpSpPr/>
              <p:nvPr/>
            </p:nvGrpSpPr>
            <p:grpSpPr>
              <a:xfrm>
                <a:off x="7383380" y="5476653"/>
                <a:ext cx="788923" cy="138499"/>
                <a:chOff x="7383380" y="5524273"/>
                <a:chExt cx="788923" cy="138499"/>
              </a:xfrm>
            </p:grpSpPr>
            <p:grpSp>
              <p:nvGrpSpPr>
                <p:cNvPr id="79" name="그룹 78">
                  <a:extLst>
                    <a:ext uri="{FF2B5EF4-FFF2-40B4-BE49-F238E27FC236}">
                      <a16:creationId xmlns:a16="http://schemas.microsoft.com/office/drawing/2014/main" id="{B61F45CD-FD82-4DF8-AC55-4C17FA9BC4B2}"/>
                    </a:ext>
                  </a:extLst>
                </p:cNvPr>
                <p:cNvGrpSpPr/>
                <p:nvPr/>
              </p:nvGrpSpPr>
              <p:grpSpPr>
                <a:xfrm>
                  <a:off x="7383380" y="5563511"/>
                  <a:ext cx="180000" cy="54424"/>
                  <a:chOff x="4250458" y="2318016"/>
                  <a:chExt cx="180000" cy="54424"/>
                </a:xfrm>
              </p:grpSpPr>
              <p:cxnSp>
                <p:nvCxnSpPr>
                  <p:cNvPr id="81" name="직선 연결선 80">
                    <a:extLst>
                      <a:ext uri="{FF2B5EF4-FFF2-40B4-BE49-F238E27FC236}">
                        <a16:creationId xmlns:a16="http://schemas.microsoft.com/office/drawing/2014/main" id="{B859B618-6703-4D12-8CD3-829A9BEAAB46}"/>
                      </a:ext>
                    </a:extLst>
                  </p:cNvPr>
                  <p:cNvCxnSpPr/>
                  <p:nvPr/>
                </p:nvCxnSpPr>
                <p:spPr>
                  <a:xfrm>
                    <a:off x="4250458" y="2345228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2" name="타원 81">
                    <a:extLst>
                      <a:ext uri="{FF2B5EF4-FFF2-40B4-BE49-F238E27FC236}">
                        <a16:creationId xmlns:a16="http://schemas.microsoft.com/office/drawing/2014/main" id="{F985933F-B099-4C75-94DF-E3BAE47CBF12}"/>
                      </a:ext>
                    </a:extLst>
                  </p:cNvPr>
                  <p:cNvSpPr/>
                  <p:nvPr/>
                </p:nvSpPr>
                <p:spPr>
                  <a:xfrm>
                    <a:off x="4313246" y="2318016"/>
                    <a:ext cx="54424" cy="54424"/>
                  </a:xfrm>
                  <a:prstGeom prst="ellips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B9C92F63-3112-45EA-B3E1-E5AD86E8BE03}"/>
                    </a:ext>
                  </a:extLst>
                </p:cNvPr>
                <p:cNvSpPr txBox="1"/>
                <p:nvPr/>
              </p:nvSpPr>
              <p:spPr>
                <a:xfrm>
                  <a:off x="7601633" y="5524273"/>
                  <a:ext cx="570670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21(DE3)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4" name="그룹 3">
            <a:extLst>
              <a:ext uri="{FF2B5EF4-FFF2-40B4-BE49-F238E27FC236}">
                <a16:creationId xmlns:a16="http://schemas.microsoft.com/office/drawing/2014/main" id="{7A9D75FB-0659-488B-B81B-705F33F14EC2}"/>
              </a:ext>
            </a:extLst>
          </p:cNvPr>
          <p:cNvGrpSpPr/>
          <p:nvPr/>
        </p:nvGrpSpPr>
        <p:grpSpPr>
          <a:xfrm>
            <a:off x="2071090" y="1173388"/>
            <a:ext cx="1938312" cy="2100518"/>
            <a:chOff x="4953000" y="3389699"/>
            <a:chExt cx="1938312" cy="2100518"/>
          </a:xfrm>
        </p:grpSpPr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551CC2A-0DFB-4918-8E16-BE346C49E75A}"/>
                </a:ext>
              </a:extLst>
            </p:cNvPr>
            <p:cNvSpPr txBox="1"/>
            <p:nvPr/>
          </p:nvSpPr>
          <p:spPr>
            <a:xfrm>
              <a:off x="6159388" y="5336329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76CD9C1D-F051-4D1C-818B-B096DBD3E8D5}"/>
                </a:ext>
              </a:extLst>
            </p:cNvPr>
            <p:cNvSpPr txBox="1"/>
            <p:nvPr/>
          </p:nvSpPr>
          <p:spPr>
            <a:xfrm rot="16200000">
              <a:off x="4421604" y="4261129"/>
              <a:ext cx="121668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ell growth 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903BD97-49A1-4151-901D-F0ECD9DC4E12}"/>
                </a:ext>
              </a:extLst>
            </p:cNvPr>
            <p:cNvSpPr txBox="1"/>
            <p:nvPr/>
          </p:nvSpPr>
          <p:spPr>
            <a:xfrm>
              <a:off x="5919892" y="3389699"/>
              <a:ext cx="97142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uccinate (0.3%)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7" name="그룹 86">
              <a:extLst>
                <a:ext uri="{FF2B5EF4-FFF2-40B4-BE49-F238E27FC236}">
                  <a16:creationId xmlns:a16="http://schemas.microsoft.com/office/drawing/2014/main" id="{E20DAD90-39A5-459C-91D6-1AB689659750}"/>
                </a:ext>
              </a:extLst>
            </p:cNvPr>
            <p:cNvGrpSpPr/>
            <p:nvPr/>
          </p:nvGrpSpPr>
          <p:grpSpPr>
            <a:xfrm>
              <a:off x="5411551" y="3603057"/>
              <a:ext cx="788923" cy="276703"/>
              <a:chOff x="7385761" y="5449743"/>
              <a:chExt cx="788923" cy="276703"/>
            </a:xfrm>
          </p:grpSpPr>
          <p:grpSp>
            <p:nvGrpSpPr>
              <p:cNvPr id="88" name="그룹 87">
                <a:extLst>
                  <a:ext uri="{FF2B5EF4-FFF2-40B4-BE49-F238E27FC236}">
                    <a16:creationId xmlns:a16="http://schemas.microsoft.com/office/drawing/2014/main" id="{3C7CC090-8404-4F8C-BAFB-714D053510EC}"/>
                  </a:ext>
                </a:extLst>
              </p:cNvPr>
              <p:cNvGrpSpPr/>
              <p:nvPr/>
            </p:nvGrpSpPr>
            <p:grpSpPr>
              <a:xfrm>
                <a:off x="7385761" y="5587947"/>
                <a:ext cx="570914" cy="138499"/>
                <a:chOff x="7385761" y="5587947"/>
                <a:chExt cx="570914" cy="138499"/>
              </a:xfrm>
            </p:grpSpPr>
            <p:grpSp>
              <p:nvGrpSpPr>
                <p:cNvPr id="94" name="그룹 93">
                  <a:extLst>
                    <a:ext uri="{FF2B5EF4-FFF2-40B4-BE49-F238E27FC236}">
                      <a16:creationId xmlns:a16="http://schemas.microsoft.com/office/drawing/2014/main" id="{88C66648-7838-4D92-A1AA-238200DDD04F}"/>
                    </a:ext>
                  </a:extLst>
                </p:cNvPr>
                <p:cNvGrpSpPr/>
                <p:nvPr/>
              </p:nvGrpSpPr>
              <p:grpSpPr>
                <a:xfrm>
                  <a:off x="7385761" y="5627966"/>
                  <a:ext cx="180000" cy="54424"/>
                  <a:chOff x="4252839" y="2579244"/>
                  <a:chExt cx="180000" cy="54424"/>
                </a:xfrm>
              </p:grpSpPr>
              <p:cxnSp>
                <p:nvCxnSpPr>
                  <p:cNvPr id="96" name="직선 연결선 95">
                    <a:extLst>
                      <a:ext uri="{FF2B5EF4-FFF2-40B4-BE49-F238E27FC236}">
                        <a16:creationId xmlns:a16="http://schemas.microsoft.com/office/drawing/2014/main" id="{6ACA591C-D573-4D0C-966C-019B0544D00D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606456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7" name="이등변 삼각형 96">
                    <a:extLst>
                      <a:ext uri="{FF2B5EF4-FFF2-40B4-BE49-F238E27FC236}">
                        <a16:creationId xmlns:a16="http://schemas.microsoft.com/office/drawing/2014/main" id="{A3FAF731-A691-4482-BF43-1ADE55343928}"/>
                      </a:ext>
                    </a:extLst>
                  </p:cNvPr>
                  <p:cNvSpPr/>
                  <p:nvPr/>
                </p:nvSpPr>
                <p:spPr>
                  <a:xfrm>
                    <a:off x="4315627" y="2579244"/>
                    <a:ext cx="54424" cy="54424"/>
                  </a:xfrm>
                  <a:prstGeom prst="triangl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506A0D01-2339-492C-A55D-1FC48E123601}"/>
                    </a:ext>
                  </a:extLst>
                </p:cNvPr>
                <p:cNvSpPr txBox="1"/>
                <p:nvPr/>
              </p:nvSpPr>
              <p:spPr>
                <a:xfrm>
                  <a:off x="7604014" y="5587947"/>
                  <a:ext cx="352661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K565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9" name="그룹 88">
                <a:extLst>
                  <a:ext uri="{FF2B5EF4-FFF2-40B4-BE49-F238E27FC236}">
                    <a16:creationId xmlns:a16="http://schemas.microsoft.com/office/drawing/2014/main" id="{50727192-1127-4000-8419-2FE0F7CB28F2}"/>
                  </a:ext>
                </a:extLst>
              </p:cNvPr>
              <p:cNvGrpSpPr/>
              <p:nvPr/>
            </p:nvGrpSpPr>
            <p:grpSpPr>
              <a:xfrm>
                <a:off x="7385761" y="5449743"/>
                <a:ext cx="788923" cy="138499"/>
                <a:chOff x="7385761" y="5497363"/>
                <a:chExt cx="788923" cy="138499"/>
              </a:xfrm>
            </p:grpSpPr>
            <p:grpSp>
              <p:nvGrpSpPr>
                <p:cNvPr id="90" name="그룹 89">
                  <a:extLst>
                    <a:ext uri="{FF2B5EF4-FFF2-40B4-BE49-F238E27FC236}">
                      <a16:creationId xmlns:a16="http://schemas.microsoft.com/office/drawing/2014/main" id="{36742CC6-A510-4BC3-9E7B-10BD8E092E93}"/>
                    </a:ext>
                  </a:extLst>
                </p:cNvPr>
                <p:cNvGrpSpPr/>
                <p:nvPr/>
              </p:nvGrpSpPr>
              <p:grpSpPr>
                <a:xfrm>
                  <a:off x="7385761" y="5536601"/>
                  <a:ext cx="180000" cy="54424"/>
                  <a:chOff x="4252839" y="2291106"/>
                  <a:chExt cx="180000" cy="54424"/>
                </a:xfrm>
              </p:grpSpPr>
              <p:cxnSp>
                <p:nvCxnSpPr>
                  <p:cNvPr id="92" name="직선 연결선 91">
                    <a:extLst>
                      <a:ext uri="{FF2B5EF4-FFF2-40B4-BE49-F238E27FC236}">
                        <a16:creationId xmlns:a16="http://schemas.microsoft.com/office/drawing/2014/main" id="{01E49553-0BAC-4B06-B309-70FF024C7120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18318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3" name="타원 92">
                    <a:extLst>
                      <a:ext uri="{FF2B5EF4-FFF2-40B4-BE49-F238E27FC236}">
                        <a16:creationId xmlns:a16="http://schemas.microsoft.com/office/drawing/2014/main" id="{E200E117-CA24-43C1-955E-A5C05A4D0499}"/>
                      </a:ext>
                    </a:extLst>
                  </p:cNvPr>
                  <p:cNvSpPr/>
                  <p:nvPr/>
                </p:nvSpPr>
                <p:spPr>
                  <a:xfrm>
                    <a:off x="4315627" y="2291106"/>
                    <a:ext cx="54424" cy="54424"/>
                  </a:xfrm>
                  <a:prstGeom prst="ellips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4866751A-39ED-49BF-8531-8CF12A72F0BB}"/>
                    </a:ext>
                  </a:extLst>
                </p:cNvPr>
                <p:cNvSpPr txBox="1"/>
                <p:nvPr/>
              </p:nvSpPr>
              <p:spPr>
                <a:xfrm>
                  <a:off x="7604014" y="5497363"/>
                  <a:ext cx="570670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21(DE3)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6" name="그룹 5">
            <a:extLst>
              <a:ext uri="{FF2B5EF4-FFF2-40B4-BE49-F238E27FC236}">
                <a16:creationId xmlns:a16="http://schemas.microsoft.com/office/drawing/2014/main" id="{D016E755-6C73-481F-B52D-5AFC2C1B8CAF}"/>
              </a:ext>
            </a:extLst>
          </p:cNvPr>
          <p:cNvGrpSpPr/>
          <p:nvPr/>
        </p:nvGrpSpPr>
        <p:grpSpPr>
          <a:xfrm>
            <a:off x="5102585" y="1182441"/>
            <a:ext cx="2096346" cy="2091465"/>
            <a:chOff x="2075526" y="3398753"/>
            <a:chExt cx="2096346" cy="2091465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D9D7433E-869B-4DDC-BFBA-CF093562F123}"/>
                </a:ext>
              </a:extLst>
            </p:cNvPr>
            <p:cNvSpPr txBox="1"/>
            <p:nvPr/>
          </p:nvSpPr>
          <p:spPr>
            <a:xfrm>
              <a:off x="3281914" y="5336330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D3273F13-604E-4867-B434-C17A113E6DE8}"/>
                </a:ext>
              </a:extLst>
            </p:cNvPr>
            <p:cNvSpPr txBox="1"/>
            <p:nvPr/>
          </p:nvSpPr>
          <p:spPr>
            <a:xfrm rot="16200000">
              <a:off x="1544130" y="4261130"/>
              <a:ext cx="121668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ell growth 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8ED5C7D7-849F-4019-8A27-F8108D173DD2}"/>
                </a:ext>
              </a:extLst>
            </p:cNvPr>
            <p:cNvSpPr txBox="1"/>
            <p:nvPr/>
          </p:nvSpPr>
          <p:spPr>
            <a:xfrm>
              <a:off x="2886264" y="3398753"/>
              <a:ext cx="1285608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etoglutarate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(0.3%)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8" name="그룹 97">
              <a:extLst>
                <a:ext uri="{FF2B5EF4-FFF2-40B4-BE49-F238E27FC236}">
                  <a16:creationId xmlns:a16="http://schemas.microsoft.com/office/drawing/2014/main" id="{08CD70B4-7C6F-4784-B120-EFCC73719F22}"/>
                </a:ext>
              </a:extLst>
            </p:cNvPr>
            <p:cNvGrpSpPr/>
            <p:nvPr/>
          </p:nvGrpSpPr>
          <p:grpSpPr>
            <a:xfrm>
              <a:off x="2492991" y="3591380"/>
              <a:ext cx="788923" cy="276703"/>
              <a:chOff x="7385761" y="5449743"/>
              <a:chExt cx="788923" cy="276703"/>
            </a:xfrm>
          </p:grpSpPr>
          <p:grpSp>
            <p:nvGrpSpPr>
              <p:cNvPr id="99" name="그룹 98">
                <a:extLst>
                  <a:ext uri="{FF2B5EF4-FFF2-40B4-BE49-F238E27FC236}">
                    <a16:creationId xmlns:a16="http://schemas.microsoft.com/office/drawing/2014/main" id="{48752E25-C2BD-487A-A769-6C5FBF13C98E}"/>
                  </a:ext>
                </a:extLst>
              </p:cNvPr>
              <p:cNvGrpSpPr/>
              <p:nvPr/>
            </p:nvGrpSpPr>
            <p:grpSpPr>
              <a:xfrm>
                <a:off x="7385761" y="5587947"/>
                <a:ext cx="570914" cy="138499"/>
                <a:chOff x="7385761" y="5587947"/>
                <a:chExt cx="570914" cy="138499"/>
              </a:xfrm>
            </p:grpSpPr>
            <p:grpSp>
              <p:nvGrpSpPr>
                <p:cNvPr id="105" name="그룹 104">
                  <a:extLst>
                    <a:ext uri="{FF2B5EF4-FFF2-40B4-BE49-F238E27FC236}">
                      <a16:creationId xmlns:a16="http://schemas.microsoft.com/office/drawing/2014/main" id="{130E66CE-8FC5-4FF9-BAEA-84F0AA3166F5}"/>
                    </a:ext>
                  </a:extLst>
                </p:cNvPr>
                <p:cNvGrpSpPr/>
                <p:nvPr/>
              </p:nvGrpSpPr>
              <p:grpSpPr>
                <a:xfrm>
                  <a:off x="7385761" y="5627966"/>
                  <a:ext cx="180000" cy="54424"/>
                  <a:chOff x="4252839" y="2579244"/>
                  <a:chExt cx="180000" cy="54424"/>
                </a:xfrm>
              </p:grpSpPr>
              <p:cxnSp>
                <p:nvCxnSpPr>
                  <p:cNvPr id="107" name="직선 연결선 106">
                    <a:extLst>
                      <a:ext uri="{FF2B5EF4-FFF2-40B4-BE49-F238E27FC236}">
                        <a16:creationId xmlns:a16="http://schemas.microsoft.com/office/drawing/2014/main" id="{2F08F697-DDCD-487F-94D0-D956B1952437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606456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8" name="이등변 삼각형 107">
                    <a:extLst>
                      <a:ext uri="{FF2B5EF4-FFF2-40B4-BE49-F238E27FC236}">
                        <a16:creationId xmlns:a16="http://schemas.microsoft.com/office/drawing/2014/main" id="{0E25B79E-1788-44FE-93FE-1909CB7D7D2D}"/>
                      </a:ext>
                    </a:extLst>
                  </p:cNvPr>
                  <p:cNvSpPr/>
                  <p:nvPr/>
                </p:nvSpPr>
                <p:spPr>
                  <a:xfrm>
                    <a:off x="4315627" y="2579244"/>
                    <a:ext cx="54424" cy="54424"/>
                  </a:xfrm>
                  <a:prstGeom prst="triangl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DB9E73C7-0F41-402A-AA24-BC37D04C21B7}"/>
                    </a:ext>
                  </a:extLst>
                </p:cNvPr>
                <p:cNvSpPr txBox="1"/>
                <p:nvPr/>
              </p:nvSpPr>
              <p:spPr>
                <a:xfrm>
                  <a:off x="7604014" y="5587947"/>
                  <a:ext cx="352661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K565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0" name="그룹 99">
                <a:extLst>
                  <a:ext uri="{FF2B5EF4-FFF2-40B4-BE49-F238E27FC236}">
                    <a16:creationId xmlns:a16="http://schemas.microsoft.com/office/drawing/2014/main" id="{9ACC2EF0-CEC3-410A-A3AE-B4D1464C43B4}"/>
                  </a:ext>
                </a:extLst>
              </p:cNvPr>
              <p:cNvGrpSpPr/>
              <p:nvPr/>
            </p:nvGrpSpPr>
            <p:grpSpPr>
              <a:xfrm>
                <a:off x="7385761" y="5449743"/>
                <a:ext cx="788923" cy="138499"/>
                <a:chOff x="7385761" y="5497363"/>
                <a:chExt cx="788923" cy="138499"/>
              </a:xfrm>
            </p:grpSpPr>
            <p:grpSp>
              <p:nvGrpSpPr>
                <p:cNvPr id="101" name="그룹 100">
                  <a:extLst>
                    <a:ext uri="{FF2B5EF4-FFF2-40B4-BE49-F238E27FC236}">
                      <a16:creationId xmlns:a16="http://schemas.microsoft.com/office/drawing/2014/main" id="{113288A6-2EFD-4DB1-B206-04B9F5DF6E9B}"/>
                    </a:ext>
                  </a:extLst>
                </p:cNvPr>
                <p:cNvGrpSpPr/>
                <p:nvPr/>
              </p:nvGrpSpPr>
              <p:grpSpPr>
                <a:xfrm>
                  <a:off x="7385761" y="5536601"/>
                  <a:ext cx="180000" cy="54424"/>
                  <a:chOff x="4252839" y="2291106"/>
                  <a:chExt cx="180000" cy="54424"/>
                </a:xfrm>
              </p:grpSpPr>
              <p:cxnSp>
                <p:nvCxnSpPr>
                  <p:cNvPr id="103" name="직선 연결선 102">
                    <a:extLst>
                      <a:ext uri="{FF2B5EF4-FFF2-40B4-BE49-F238E27FC236}">
                        <a16:creationId xmlns:a16="http://schemas.microsoft.com/office/drawing/2014/main" id="{825ECBB8-170A-4B62-9140-27083991F482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18318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4" name="타원 103">
                    <a:extLst>
                      <a:ext uri="{FF2B5EF4-FFF2-40B4-BE49-F238E27FC236}">
                        <a16:creationId xmlns:a16="http://schemas.microsoft.com/office/drawing/2014/main" id="{021E269E-59C1-4006-A6E6-58396DC0D933}"/>
                      </a:ext>
                    </a:extLst>
                  </p:cNvPr>
                  <p:cNvSpPr/>
                  <p:nvPr/>
                </p:nvSpPr>
                <p:spPr>
                  <a:xfrm>
                    <a:off x="4315627" y="2291106"/>
                    <a:ext cx="54424" cy="54424"/>
                  </a:xfrm>
                  <a:prstGeom prst="ellips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102" name="TextBox 101">
                  <a:extLst>
                    <a:ext uri="{FF2B5EF4-FFF2-40B4-BE49-F238E27FC236}">
                      <a16:creationId xmlns:a16="http://schemas.microsoft.com/office/drawing/2014/main" id="{6AF52760-B4B6-4058-809F-48DE759FCCB4}"/>
                    </a:ext>
                  </a:extLst>
                </p:cNvPr>
                <p:cNvSpPr txBox="1"/>
                <p:nvPr/>
              </p:nvSpPr>
              <p:spPr>
                <a:xfrm>
                  <a:off x="7604014" y="5497363"/>
                  <a:ext cx="570670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21(DE3)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66" name="직사각형 65">
            <a:extLst>
              <a:ext uri="{FF2B5EF4-FFF2-40B4-BE49-F238E27FC236}">
                <a16:creationId xmlns:a16="http://schemas.microsoft.com/office/drawing/2014/main" id="{C99DE2EC-59FA-46AD-8376-E83393FA0F8C}"/>
              </a:ext>
            </a:extLst>
          </p:cNvPr>
          <p:cNvSpPr/>
          <p:nvPr/>
        </p:nvSpPr>
        <p:spPr>
          <a:xfrm>
            <a:off x="0" y="2683"/>
            <a:ext cx="19175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7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개체 8">
            <a:extLst>
              <a:ext uri="{FF2B5EF4-FFF2-40B4-BE49-F238E27FC236}">
                <a16:creationId xmlns:a16="http://schemas.microsoft.com/office/drawing/2014/main" id="{32E453FE-BB93-4197-9167-D8C5CE2717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142026"/>
              </p:ext>
            </p:extLst>
          </p:nvPr>
        </p:nvGraphicFramePr>
        <p:xfrm>
          <a:off x="5284088" y="1293485"/>
          <a:ext cx="2403043" cy="18690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92" name="Graph" r:id="rId9" imgW="3291840" imgH="2560320" progId="Origin50.Graph">
                  <p:embed/>
                </p:oleObj>
              </mc:Choice>
              <mc:Fallback>
                <p:oleObj name="Graph" r:id="rId9" imgW="3291840" imgH="2560320" progId="Origin50.Graph">
                  <p:embed/>
                  <p:pic>
                    <p:nvPicPr>
                      <p:cNvPr id="9" name="개체 8">
                        <a:extLst>
                          <a:ext uri="{FF2B5EF4-FFF2-40B4-BE49-F238E27FC236}">
                            <a16:creationId xmlns:a16="http://schemas.microsoft.com/office/drawing/2014/main" id="{32E453FE-BB93-4197-9167-D8C5CE2717A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284088" y="1293485"/>
                        <a:ext cx="2403043" cy="18690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1" name="TextBox 70">
            <a:extLst>
              <a:ext uri="{FF2B5EF4-FFF2-40B4-BE49-F238E27FC236}">
                <a16:creationId xmlns:a16="http://schemas.microsoft.com/office/drawing/2014/main" id="{CAA014E6-D31F-4A5F-9084-35C48AA8A173}"/>
              </a:ext>
            </a:extLst>
          </p:cNvPr>
          <p:cNvSpPr txBox="1"/>
          <p:nvPr/>
        </p:nvSpPr>
        <p:spPr>
          <a:xfrm>
            <a:off x="3768409" y="2384186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14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3971CE1-411E-44BE-9326-B26D70D23A87}"/>
              </a:ext>
            </a:extLst>
          </p:cNvPr>
          <p:cNvSpPr txBox="1"/>
          <p:nvPr/>
        </p:nvSpPr>
        <p:spPr>
          <a:xfrm>
            <a:off x="2550037" y="2278282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7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1A454F0-3E4C-4306-A9EC-C77E9B4A3190}"/>
              </a:ext>
            </a:extLst>
          </p:cNvPr>
          <p:cNvSpPr txBox="1"/>
          <p:nvPr/>
        </p:nvSpPr>
        <p:spPr>
          <a:xfrm>
            <a:off x="6699196" y="2285006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45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67F1AD6-4C16-4539-8FAE-06DDDA2033FB}"/>
              </a:ext>
            </a:extLst>
          </p:cNvPr>
          <p:cNvSpPr txBox="1"/>
          <p:nvPr/>
        </p:nvSpPr>
        <p:spPr>
          <a:xfrm>
            <a:off x="5527336" y="2161895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65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0583EA3-C097-454E-B1E3-EB5261B8AA52}"/>
              </a:ext>
            </a:extLst>
          </p:cNvPr>
          <p:cNvSpPr txBox="1"/>
          <p:nvPr/>
        </p:nvSpPr>
        <p:spPr>
          <a:xfrm>
            <a:off x="2690425" y="4387621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2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8D768FEA-6AA0-4016-B5BA-EAF1F69067B6}"/>
              </a:ext>
            </a:extLst>
          </p:cNvPr>
          <p:cNvSpPr txBox="1"/>
          <p:nvPr/>
        </p:nvSpPr>
        <p:spPr>
          <a:xfrm>
            <a:off x="3066959" y="4673191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1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2AED93CF-B910-46C5-807D-5CE642F9A936}"/>
              </a:ext>
            </a:extLst>
          </p:cNvPr>
          <p:cNvSpPr txBox="1"/>
          <p:nvPr/>
        </p:nvSpPr>
        <p:spPr>
          <a:xfrm>
            <a:off x="5806827" y="4679454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47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DDF4CD8B-5A5D-4E18-8AFC-B2AA7DF78B90}"/>
              </a:ext>
            </a:extLst>
          </p:cNvPr>
          <p:cNvSpPr txBox="1"/>
          <p:nvPr/>
        </p:nvSpPr>
        <p:spPr>
          <a:xfrm>
            <a:off x="6235526" y="4796302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51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25544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9937AE30-3071-4EA5-82A0-13E028AE29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5038725"/>
              </p:ext>
            </p:extLst>
          </p:nvPr>
        </p:nvGraphicFramePr>
        <p:xfrm>
          <a:off x="2269782" y="1289447"/>
          <a:ext cx="2402395" cy="186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02" name="Graph" r:id="rId3" imgW="3291840" imgH="2560320" progId="Origin95.Graph">
                  <p:embed/>
                </p:oleObj>
              </mc:Choice>
              <mc:Fallback>
                <p:oleObj name="Graph" r:id="rId3" imgW="3291840" imgH="2560320" progId="Origin95.Graph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2D26E120-3068-4D34-B2D9-1CC54CC256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69782" y="1289447"/>
                        <a:ext cx="2402395" cy="186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개체 2">
            <a:extLst>
              <a:ext uri="{FF2B5EF4-FFF2-40B4-BE49-F238E27FC236}">
                <a16:creationId xmlns:a16="http://schemas.microsoft.com/office/drawing/2014/main" id="{E79B4BC6-81EC-4AA1-B0FB-9381D1DFD5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3356045"/>
              </p:ext>
            </p:extLst>
          </p:nvPr>
        </p:nvGraphicFramePr>
        <p:xfrm>
          <a:off x="5265125" y="1289447"/>
          <a:ext cx="2402395" cy="186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03" name="Graph" r:id="rId5" imgW="3291840" imgH="2560320" progId="Origin95.Graph">
                  <p:embed/>
                </p:oleObj>
              </mc:Choice>
              <mc:Fallback>
                <p:oleObj name="Graph" r:id="rId5" imgW="3291840" imgH="2560320" progId="Origin95.Graph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23D3A88D-F383-4552-824A-F98A856A80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265125" y="1289447"/>
                        <a:ext cx="2402395" cy="186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1E4AD41A-512B-468B-91AF-BF1505C161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8806685"/>
              </p:ext>
            </p:extLst>
          </p:nvPr>
        </p:nvGraphicFramePr>
        <p:xfrm>
          <a:off x="2266010" y="3660353"/>
          <a:ext cx="2402395" cy="186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04" name="Graph" r:id="rId7" imgW="3291840" imgH="2560320" progId="Origin95.Graph">
                  <p:embed/>
                </p:oleObj>
              </mc:Choice>
              <mc:Fallback>
                <p:oleObj name="Graph" r:id="rId7" imgW="3291840" imgH="2560320" progId="Origin95.Graph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E8F67FAB-A041-4562-A8AD-06FFDBC8F3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266010" y="3660353"/>
                        <a:ext cx="2402395" cy="186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AD009C6A-3AAA-49A5-B80A-C9A1687FB4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8422050"/>
              </p:ext>
            </p:extLst>
          </p:nvPr>
        </p:nvGraphicFramePr>
        <p:xfrm>
          <a:off x="5265125" y="3655978"/>
          <a:ext cx="2402395" cy="186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05" name="Graph" r:id="rId9" imgW="3291840" imgH="2560320" progId="Origin95.Graph">
                  <p:embed/>
                </p:oleObj>
              </mc:Choice>
              <mc:Fallback>
                <p:oleObj name="Graph" r:id="rId9" imgW="3291840" imgH="2560320" progId="Origin95.Graph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FDFB3EAA-23FF-4ADD-BAD2-ACE2CC3CAA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265125" y="3655978"/>
                        <a:ext cx="2402395" cy="186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5C6507C-7FED-4C94-A678-D48805ACF927}"/>
              </a:ext>
            </a:extLst>
          </p:cNvPr>
          <p:cNvSpPr txBox="1"/>
          <p:nvPr/>
        </p:nvSpPr>
        <p:spPr>
          <a:xfrm>
            <a:off x="1897272" y="962668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BCC0B3A-A767-4CED-8154-A90797D95FD7}"/>
              </a:ext>
            </a:extLst>
          </p:cNvPr>
          <p:cNvSpPr txBox="1"/>
          <p:nvPr/>
        </p:nvSpPr>
        <p:spPr>
          <a:xfrm>
            <a:off x="4823330" y="962668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7393BA8-8B92-41F9-85A9-48E0C93C1850}"/>
              </a:ext>
            </a:extLst>
          </p:cNvPr>
          <p:cNvSpPr txBox="1"/>
          <p:nvPr/>
        </p:nvSpPr>
        <p:spPr>
          <a:xfrm>
            <a:off x="1897272" y="328360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69A8336-2DAA-4CA8-847E-59A6B3610C1A}"/>
              </a:ext>
            </a:extLst>
          </p:cNvPr>
          <p:cNvSpPr txBox="1"/>
          <p:nvPr/>
        </p:nvSpPr>
        <p:spPr>
          <a:xfrm>
            <a:off x="4823330" y="328360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그룹 9">
            <a:extLst>
              <a:ext uri="{FF2B5EF4-FFF2-40B4-BE49-F238E27FC236}">
                <a16:creationId xmlns:a16="http://schemas.microsoft.com/office/drawing/2014/main" id="{2F3FCFD4-D73D-4751-8FC5-CC21AB336593}"/>
              </a:ext>
            </a:extLst>
          </p:cNvPr>
          <p:cNvGrpSpPr/>
          <p:nvPr/>
        </p:nvGrpSpPr>
        <p:grpSpPr>
          <a:xfrm>
            <a:off x="2084160" y="3536113"/>
            <a:ext cx="1953389" cy="2068431"/>
            <a:chOff x="2075526" y="1101624"/>
            <a:chExt cx="1953389" cy="2068431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047F31B-00A7-4DD5-AF02-7E911A929E5B}"/>
                </a:ext>
              </a:extLst>
            </p:cNvPr>
            <p:cNvSpPr txBox="1"/>
            <p:nvPr/>
          </p:nvSpPr>
          <p:spPr>
            <a:xfrm>
              <a:off x="3012611" y="1101624"/>
              <a:ext cx="1016304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D-Glucose (0.3%)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66BDC1E-59B9-4EB0-A4B1-E4E626CB6773}"/>
                </a:ext>
              </a:extLst>
            </p:cNvPr>
            <p:cNvSpPr txBox="1"/>
            <p:nvPr/>
          </p:nvSpPr>
          <p:spPr>
            <a:xfrm>
              <a:off x="3281914" y="3016167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6BDF4A9-5EEB-436A-9B15-5AC6A8362634}"/>
                </a:ext>
              </a:extLst>
            </p:cNvPr>
            <p:cNvSpPr txBox="1"/>
            <p:nvPr/>
          </p:nvSpPr>
          <p:spPr>
            <a:xfrm rot="16200000">
              <a:off x="1775764" y="1940967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" name="그룹 13">
              <a:extLst>
                <a:ext uri="{FF2B5EF4-FFF2-40B4-BE49-F238E27FC236}">
                  <a16:creationId xmlns:a16="http://schemas.microsoft.com/office/drawing/2014/main" id="{F20A6E79-6829-4172-AA4D-922D2AAD0676}"/>
                </a:ext>
              </a:extLst>
            </p:cNvPr>
            <p:cNvGrpSpPr/>
            <p:nvPr/>
          </p:nvGrpSpPr>
          <p:grpSpPr>
            <a:xfrm>
              <a:off x="2525760" y="1290116"/>
              <a:ext cx="788923" cy="276703"/>
              <a:chOff x="7432736" y="5468641"/>
              <a:chExt cx="788923" cy="276703"/>
            </a:xfrm>
          </p:grpSpPr>
          <p:grpSp>
            <p:nvGrpSpPr>
              <p:cNvPr id="15" name="그룹 14">
                <a:extLst>
                  <a:ext uri="{FF2B5EF4-FFF2-40B4-BE49-F238E27FC236}">
                    <a16:creationId xmlns:a16="http://schemas.microsoft.com/office/drawing/2014/main" id="{0DAC4D5C-A25C-4F0C-9768-CA0A94B3CE0A}"/>
                  </a:ext>
                </a:extLst>
              </p:cNvPr>
              <p:cNvGrpSpPr/>
              <p:nvPr/>
            </p:nvGrpSpPr>
            <p:grpSpPr>
              <a:xfrm>
                <a:off x="7432736" y="5606845"/>
                <a:ext cx="570914" cy="138499"/>
                <a:chOff x="7432736" y="5606845"/>
                <a:chExt cx="570914" cy="138499"/>
              </a:xfrm>
            </p:grpSpPr>
            <p:grpSp>
              <p:nvGrpSpPr>
                <p:cNvPr id="21" name="그룹 20">
                  <a:extLst>
                    <a:ext uri="{FF2B5EF4-FFF2-40B4-BE49-F238E27FC236}">
                      <a16:creationId xmlns:a16="http://schemas.microsoft.com/office/drawing/2014/main" id="{EDA570E5-0F2A-4DB4-AC3D-02CEBDCF92EF}"/>
                    </a:ext>
                  </a:extLst>
                </p:cNvPr>
                <p:cNvGrpSpPr/>
                <p:nvPr/>
              </p:nvGrpSpPr>
              <p:grpSpPr>
                <a:xfrm>
                  <a:off x="7432736" y="5646864"/>
                  <a:ext cx="180000" cy="54424"/>
                  <a:chOff x="4299814" y="2598142"/>
                  <a:chExt cx="180000" cy="54424"/>
                </a:xfrm>
              </p:grpSpPr>
              <p:cxnSp>
                <p:nvCxnSpPr>
                  <p:cNvPr id="23" name="직선 연결선 22">
                    <a:extLst>
                      <a:ext uri="{FF2B5EF4-FFF2-40B4-BE49-F238E27FC236}">
                        <a16:creationId xmlns:a16="http://schemas.microsoft.com/office/drawing/2014/main" id="{225B226B-8122-43E9-9454-E0DB7E087692}"/>
                      </a:ext>
                    </a:extLst>
                  </p:cNvPr>
                  <p:cNvCxnSpPr/>
                  <p:nvPr/>
                </p:nvCxnSpPr>
                <p:spPr>
                  <a:xfrm>
                    <a:off x="4299814" y="2625354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4" name="이등변 삼각형 23">
                    <a:extLst>
                      <a:ext uri="{FF2B5EF4-FFF2-40B4-BE49-F238E27FC236}">
                        <a16:creationId xmlns:a16="http://schemas.microsoft.com/office/drawing/2014/main" id="{FF8B196E-18A7-45CE-8794-CC19AC234FC1}"/>
                      </a:ext>
                    </a:extLst>
                  </p:cNvPr>
                  <p:cNvSpPr/>
                  <p:nvPr/>
                </p:nvSpPr>
                <p:spPr>
                  <a:xfrm>
                    <a:off x="4362602" y="2598142"/>
                    <a:ext cx="54424" cy="54424"/>
                  </a:xfrm>
                  <a:prstGeom prst="triangl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D9D3BCFC-E506-4803-B9C2-67EBF8F9700A}"/>
                    </a:ext>
                  </a:extLst>
                </p:cNvPr>
                <p:cNvSpPr txBox="1"/>
                <p:nvPr/>
              </p:nvSpPr>
              <p:spPr>
                <a:xfrm>
                  <a:off x="7650989" y="5606845"/>
                  <a:ext cx="352661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K565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6" name="그룹 15">
                <a:extLst>
                  <a:ext uri="{FF2B5EF4-FFF2-40B4-BE49-F238E27FC236}">
                    <a16:creationId xmlns:a16="http://schemas.microsoft.com/office/drawing/2014/main" id="{B7789FD4-718E-48B6-BC64-D33271C34519}"/>
                  </a:ext>
                </a:extLst>
              </p:cNvPr>
              <p:cNvGrpSpPr/>
              <p:nvPr/>
            </p:nvGrpSpPr>
            <p:grpSpPr>
              <a:xfrm>
                <a:off x="7432736" y="5468641"/>
                <a:ext cx="788923" cy="138499"/>
                <a:chOff x="7432736" y="5516261"/>
                <a:chExt cx="788923" cy="138499"/>
              </a:xfrm>
            </p:grpSpPr>
            <p:grpSp>
              <p:nvGrpSpPr>
                <p:cNvPr id="17" name="그룹 16">
                  <a:extLst>
                    <a:ext uri="{FF2B5EF4-FFF2-40B4-BE49-F238E27FC236}">
                      <a16:creationId xmlns:a16="http://schemas.microsoft.com/office/drawing/2014/main" id="{D87CF0E4-5364-4A70-9603-75FA48B35CCD}"/>
                    </a:ext>
                  </a:extLst>
                </p:cNvPr>
                <p:cNvGrpSpPr/>
                <p:nvPr/>
              </p:nvGrpSpPr>
              <p:grpSpPr>
                <a:xfrm>
                  <a:off x="7432736" y="5555499"/>
                  <a:ext cx="180000" cy="54424"/>
                  <a:chOff x="4299814" y="2310004"/>
                  <a:chExt cx="180000" cy="54424"/>
                </a:xfrm>
              </p:grpSpPr>
              <p:cxnSp>
                <p:nvCxnSpPr>
                  <p:cNvPr id="19" name="직선 연결선 18">
                    <a:extLst>
                      <a:ext uri="{FF2B5EF4-FFF2-40B4-BE49-F238E27FC236}">
                        <a16:creationId xmlns:a16="http://schemas.microsoft.com/office/drawing/2014/main" id="{F359F01B-89A6-4DAF-9F32-857B333FDD1D}"/>
                      </a:ext>
                    </a:extLst>
                  </p:cNvPr>
                  <p:cNvCxnSpPr/>
                  <p:nvPr/>
                </p:nvCxnSpPr>
                <p:spPr>
                  <a:xfrm>
                    <a:off x="4299814" y="2337216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" name="타원 19">
                    <a:extLst>
                      <a:ext uri="{FF2B5EF4-FFF2-40B4-BE49-F238E27FC236}">
                        <a16:creationId xmlns:a16="http://schemas.microsoft.com/office/drawing/2014/main" id="{4D72268A-3E5E-42F4-B50F-368DE732FEB0}"/>
                      </a:ext>
                    </a:extLst>
                  </p:cNvPr>
                  <p:cNvSpPr/>
                  <p:nvPr/>
                </p:nvSpPr>
                <p:spPr>
                  <a:xfrm>
                    <a:off x="4362602" y="2310004"/>
                    <a:ext cx="54424" cy="54424"/>
                  </a:xfrm>
                  <a:prstGeom prst="ellips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A56E769C-BE82-45E1-B7BB-2B436B818631}"/>
                    </a:ext>
                  </a:extLst>
                </p:cNvPr>
                <p:cNvSpPr txBox="1"/>
                <p:nvPr/>
              </p:nvSpPr>
              <p:spPr>
                <a:xfrm>
                  <a:off x="7650989" y="5516261"/>
                  <a:ext cx="570670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21(DE3)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1598C1B9-24CF-4B70-90A3-E32775E4F18E}"/>
              </a:ext>
            </a:extLst>
          </p:cNvPr>
          <p:cNvGrpSpPr/>
          <p:nvPr/>
        </p:nvGrpSpPr>
        <p:grpSpPr>
          <a:xfrm>
            <a:off x="5089514" y="3550997"/>
            <a:ext cx="1885119" cy="2050325"/>
            <a:chOff x="4953000" y="1119729"/>
            <a:chExt cx="1885119" cy="2050325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0A510C7-B850-4D34-9E38-231078E7A507}"/>
                </a:ext>
              </a:extLst>
            </p:cNvPr>
            <p:cNvSpPr txBox="1"/>
            <p:nvPr/>
          </p:nvSpPr>
          <p:spPr>
            <a:xfrm>
              <a:off x="5956467" y="1119729"/>
              <a:ext cx="88165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Glycerol (0.3%)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BEF5D1F-4DDA-4182-9479-75D1EAF747BE}"/>
                </a:ext>
              </a:extLst>
            </p:cNvPr>
            <p:cNvSpPr txBox="1"/>
            <p:nvPr/>
          </p:nvSpPr>
          <p:spPr>
            <a:xfrm>
              <a:off x="6159388" y="3016166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76BD1BC-EAC5-4089-AC72-45306D3E769D}"/>
                </a:ext>
              </a:extLst>
            </p:cNvPr>
            <p:cNvSpPr txBox="1"/>
            <p:nvPr/>
          </p:nvSpPr>
          <p:spPr>
            <a:xfrm rot="16200000">
              <a:off x="4653238" y="1940966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9" name="그룹 28">
              <a:extLst>
                <a:ext uri="{FF2B5EF4-FFF2-40B4-BE49-F238E27FC236}">
                  <a16:creationId xmlns:a16="http://schemas.microsoft.com/office/drawing/2014/main" id="{A7A0D9F6-81B9-4F8D-BDCD-A5E57A31C03A}"/>
                </a:ext>
              </a:extLst>
            </p:cNvPr>
            <p:cNvGrpSpPr/>
            <p:nvPr/>
          </p:nvGrpSpPr>
          <p:grpSpPr>
            <a:xfrm>
              <a:off x="5409049" y="1297980"/>
              <a:ext cx="788923" cy="276703"/>
              <a:chOff x="7383380" y="5476653"/>
              <a:chExt cx="788923" cy="276703"/>
            </a:xfrm>
          </p:grpSpPr>
          <p:grpSp>
            <p:nvGrpSpPr>
              <p:cNvPr id="30" name="그룹 29">
                <a:extLst>
                  <a:ext uri="{FF2B5EF4-FFF2-40B4-BE49-F238E27FC236}">
                    <a16:creationId xmlns:a16="http://schemas.microsoft.com/office/drawing/2014/main" id="{E6B75D68-7D99-4E88-9077-86E2C7824FC0}"/>
                  </a:ext>
                </a:extLst>
              </p:cNvPr>
              <p:cNvGrpSpPr/>
              <p:nvPr/>
            </p:nvGrpSpPr>
            <p:grpSpPr>
              <a:xfrm>
                <a:off x="7383380" y="5614857"/>
                <a:ext cx="570914" cy="138499"/>
                <a:chOff x="7383380" y="5614857"/>
                <a:chExt cx="570914" cy="138499"/>
              </a:xfrm>
            </p:grpSpPr>
            <p:grpSp>
              <p:nvGrpSpPr>
                <p:cNvPr id="36" name="그룹 35">
                  <a:extLst>
                    <a:ext uri="{FF2B5EF4-FFF2-40B4-BE49-F238E27FC236}">
                      <a16:creationId xmlns:a16="http://schemas.microsoft.com/office/drawing/2014/main" id="{C7330728-903D-4E73-96C2-67574088557F}"/>
                    </a:ext>
                  </a:extLst>
                </p:cNvPr>
                <p:cNvGrpSpPr/>
                <p:nvPr/>
              </p:nvGrpSpPr>
              <p:grpSpPr>
                <a:xfrm>
                  <a:off x="7383380" y="5654876"/>
                  <a:ext cx="180000" cy="54424"/>
                  <a:chOff x="4250458" y="2606154"/>
                  <a:chExt cx="180000" cy="54424"/>
                </a:xfrm>
              </p:grpSpPr>
              <p:cxnSp>
                <p:nvCxnSpPr>
                  <p:cNvPr id="38" name="직선 연결선 37">
                    <a:extLst>
                      <a:ext uri="{FF2B5EF4-FFF2-40B4-BE49-F238E27FC236}">
                        <a16:creationId xmlns:a16="http://schemas.microsoft.com/office/drawing/2014/main" id="{7924CE75-A2F1-4073-8602-D81854D4711C}"/>
                      </a:ext>
                    </a:extLst>
                  </p:cNvPr>
                  <p:cNvCxnSpPr/>
                  <p:nvPr/>
                </p:nvCxnSpPr>
                <p:spPr>
                  <a:xfrm>
                    <a:off x="4250458" y="2633366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9" name="이등변 삼각형 38">
                    <a:extLst>
                      <a:ext uri="{FF2B5EF4-FFF2-40B4-BE49-F238E27FC236}">
                        <a16:creationId xmlns:a16="http://schemas.microsoft.com/office/drawing/2014/main" id="{749CFB80-E2B9-4372-B723-12C1C6447D07}"/>
                      </a:ext>
                    </a:extLst>
                  </p:cNvPr>
                  <p:cNvSpPr/>
                  <p:nvPr/>
                </p:nvSpPr>
                <p:spPr>
                  <a:xfrm>
                    <a:off x="4313246" y="2606154"/>
                    <a:ext cx="54424" cy="54424"/>
                  </a:xfrm>
                  <a:prstGeom prst="triangl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6A2B0442-0F88-4405-913B-4604FC249284}"/>
                    </a:ext>
                  </a:extLst>
                </p:cNvPr>
                <p:cNvSpPr txBox="1"/>
                <p:nvPr/>
              </p:nvSpPr>
              <p:spPr>
                <a:xfrm>
                  <a:off x="7601633" y="5614857"/>
                  <a:ext cx="352661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K565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1" name="그룹 30">
                <a:extLst>
                  <a:ext uri="{FF2B5EF4-FFF2-40B4-BE49-F238E27FC236}">
                    <a16:creationId xmlns:a16="http://schemas.microsoft.com/office/drawing/2014/main" id="{61632734-A32A-431B-8EC4-F8D8855154D6}"/>
                  </a:ext>
                </a:extLst>
              </p:cNvPr>
              <p:cNvGrpSpPr/>
              <p:nvPr/>
            </p:nvGrpSpPr>
            <p:grpSpPr>
              <a:xfrm>
                <a:off x="7383380" y="5476653"/>
                <a:ext cx="788923" cy="138499"/>
                <a:chOff x="7383380" y="5524273"/>
                <a:chExt cx="788923" cy="138499"/>
              </a:xfrm>
            </p:grpSpPr>
            <p:grpSp>
              <p:nvGrpSpPr>
                <p:cNvPr id="32" name="그룹 31">
                  <a:extLst>
                    <a:ext uri="{FF2B5EF4-FFF2-40B4-BE49-F238E27FC236}">
                      <a16:creationId xmlns:a16="http://schemas.microsoft.com/office/drawing/2014/main" id="{76699F58-5A42-4E96-A73A-C5327F7EE375}"/>
                    </a:ext>
                  </a:extLst>
                </p:cNvPr>
                <p:cNvGrpSpPr/>
                <p:nvPr/>
              </p:nvGrpSpPr>
              <p:grpSpPr>
                <a:xfrm>
                  <a:off x="7383380" y="5563511"/>
                  <a:ext cx="180000" cy="54424"/>
                  <a:chOff x="4250458" y="2318016"/>
                  <a:chExt cx="180000" cy="54424"/>
                </a:xfrm>
              </p:grpSpPr>
              <p:cxnSp>
                <p:nvCxnSpPr>
                  <p:cNvPr id="34" name="직선 연결선 33">
                    <a:extLst>
                      <a:ext uri="{FF2B5EF4-FFF2-40B4-BE49-F238E27FC236}">
                        <a16:creationId xmlns:a16="http://schemas.microsoft.com/office/drawing/2014/main" id="{BE73FA9C-4113-4CBB-9C83-A300743ECA7B}"/>
                      </a:ext>
                    </a:extLst>
                  </p:cNvPr>
                  <p:cNvCxnSpPr/>
                  <p:nvPr/>
                </p:nvCxnSpPr>
                <p:spPr>
                  <a:xfrm>
                    <a:off x="4250458" y="2345228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5" name="타원 34">
                    <a:extLst>
                      <a:ext uri="{FF2B5EF4-FFF2-40B4-BE49-F238E27FC236}">
                        <a16:creationId xmlns:a16="http://schemas.microsoft.com/office/drawing/2014/main" id="{3CAC26C3-6309-4E72-92E7-60D482AEAE11}"/>
                      </a:ext>
                    </a:extLst>
                  </p:cNvPr>
                  <p:cNvSpPr/>
                  <p:nvPr/>
                </p:nvSpPr>
                <p:spPr>
                  <a:xfrm>
                    <a:off x="4313246" y="2318016"/>
                    <a:ext cx="54424" cy="54424"/>
                  </a:xfrm>
                  <a:prstGeom prst="ellips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D4BF007F-ABE3-4737-86DF-E48FBB9DCF54}"/>
                    </a:ext>
                  </a:extLst>
                </p:cNvPr>
                <p:cNvSpPr txBox="1"/>
                <p:nvPr/>
              </p:nvSpPr>
              <p:spPr>
                <a:xfrm>
                  <a:off x="7601633" y="5524273"/>
                  <a:ext cx="570670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21(DE3)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40" name="그룹 39">
            <a:extLst>
              <a:ext uri="{FF2B5EF4-FFF2-40B4-BE49-F238E27FC236}">
                <a16:creationId xmlns:a16="http://schemas.microsoft.com/office/drawing/2014/main" id="{4B040CDB-99CD-48FB-BA95-105D145F4D02}"/>
              </a:ext>
            </a:extLst>
          </p:cNvPr>
          <p:cNvGrpSpPr/>
          <p:nvPr/>
        </p:nvGrpSpPr>
        <p:grpSpPr>
          <a:xfrm>
            <a:off x="2071090" y="1173388"/>
            <a:ext cx="1938312" cy="2100518"/>
            <a:chOff x="4953000" y="3389699"/>
            <a:chExt cx="1938312" cy="2100518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657BD7D-DEAF-4808-94EA-D3E29CA1417A}"/>
                </a:ext>
              </a:extLst>
            </p:cNvPr>
            <p:cNvSpPr txBox="1"/>
            <p:nvPr/>
          </p:nvSpPr>
          <p:spPr>
            <a:xfrm>
              <a:off x="6159388" y="5336329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FDA271F-E3AA-492E-9F39-A7BDF66541D0}"/>
                </a:ext>
              </a:extLst>
            </p:cNvPr>
            <p:cNvSpPr txBox="1"/>
            <p:nvPr/>
          </p:nvSpPr>
          <p:spPr>
            <a:xfrm rot="16200000">
              <a:off x="4653238" y="4261129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E806099-86CE-4FC3-8796-A7D6EC7BC693}"/>
                </a:ext>
              </a:extLst>
            </p:cNvPr>
            <p:cNvSpPr txBox="1"/>
            <p:nvPr/>
          </p:nvSpPr>
          <p:spPr>
            <a:xfrm>
              <a:off x="5919892" y="3389699"/>
              <a:ext cx="97142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uccinate (0.3%)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" name="그룹 43">
              <a:extLst>
                <a:ext uri="{FF2B5EF4-FFF2-40B4-BE49-F238E27FC236}">
                  <a16:creationId xmlns:a16="http://schemas.microsoft.com/office/drawing/2014/main" id="{12CC8F84-4024-43F6-902C-66EE74424A2F}"/>
                </a:ext>
              </a:extLst>
            </p:cNvPr>
            <p:cNvGrpSpPr/>
            <p:nvPr/>
          </p:nvGrpSpPr>
          <p:grpSpPr>
            <a:xfrm>
              <a:off x="5411551" y="3603057"/>
              <a:ext cx="788923" cy="276703"/>
              <a:chOff x="7385761" y="5449743"/>
              <a:chExt cx="788923" cy="276703"/>
            </a:xfrm>
          </p:grpSpPr>
          <p:grpSp>
            <p:nvGrpSpPr>
              <p:cNvPr id="45" name="그룹 44">
                <a:extLst>
                  <a:ext uri="{FF2B5EF4-FFF2-40B4-BE49-F238E27FC236}">
                    <a16:creationId xmlns:a16="http://schemas.microsoft.com/office/drawing/2014/main" id="{DF5377EC-66D1-46EB-8BCC-A519C12D9E58}"/>
                  </a:ext>
                </a:extLst>
              </p:cNvPr>
              <p:cNvGrpSpPr/>
              <p:nvPr/>
            </p:nvGrpSpPr>
            <p:grpSpPr>
              <a:xfrm>
                <a:off x="7385761" y="5587947"/>
                <a:ext cx="570914" cy="138499"/>
                <a:chOff x="7385761" y="5587947"/>
                <a:chExt cx="570914" cy="138499"/>
              </a:xfrm>
            </p:grpSpPr>
            <p:grpSp>
              <p:nvGrpSpPr>
                <p:cNvPr id="51" name="그룹 50">
                  <a:extLst>
                    <a:ext uri="{FF2B5EF4-FFF2-40B4-BE49-F238E27FC236}">
                      <a16:creationId xmlns:a16="http://schemas.microsoft.com/office/drawing/2014/main" id="{D06C56E3-B6B9-4E11-8FB9-A89D90455C8C}"/>
                    </a:ext>
                  </a:extLst>
                </p:cNvPr>
                <p:cNvGrpSpPr/>
                <p:nvPr/>
              </p:nvGrpSpPr>
              <p:grpSpPr>
                <a:xfrm>
                  <a:off x="7385761" y="5627966"/>
                  <a:ext cx="180000" cy="54424"/>
                  <a:chOff x="4252839" y="2579244"/>
                  <a:chExt cx="180000" cy="54424"/>
                </a:xfrm>
              </p:grpSpPr>
              <p:cxnSp>
                <p:nvCxnSpPr>
                  <p:cNvPr id="53" name="직선 연결선 52">
                    <a:extLst>
                      <a:ext uri="{FF2B5EF4-FFF2-40B4-BE49-F238E27FC236}">
                        <a16:creationId xmlns:a16="http://schemas.microsoft.com/office/drawing/2014/main" id="{57687BC1-3497-4275-8C81-118D1284F5A6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606456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4" name="이등변 삼각형 53">
                    <a:extLst>
                      <a:ext uri="{FF2B5EF4-FFF2-40B4-BE49-F238E27FC236}">
                        <a16:creationId xmlns:a16="http://schemas.microsoft.com/office/drawing/2014/main" id="{E5520EA9-65C7-4A36-B382-75B1B6FFF40F}"/>
                      </a:ext>
                    </a:extLst>
                  </p:cNvPr>
                  <p:cNvSpPr/>
                  <p:nvPr/>
                </p:nvSpPr>
                <p:spPr>
                  <a:xfrm>
                    <a:off x="4315627" y="2579244"/>
                    <a:ext cx="54424" cy="54424"/>
                  </a:xfrm>
                  <a:prstGeom prst="triangl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BE6162BD-F752-4829-A12D-F6A7E0E7F36B}"/>
                    </a:ext>
                  </a:extLst>
                </p:cNvPr>
                <p:cNvSpPr txBox="1"/>
                <p:nvPr/>
              </p:nvSpPr>
              <p:spPr>
                <a:xfrm>
                  <a:off x="7604014" y="5587947"/>
                  <a:ext cx="352661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K565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6" name="그룹 45">
                <a:extLst>
                  <a:ext uri="{FF2B5EF4-FFF2-40B4-BE49-F238E27FC236}">
                    <a16:creationId xmlns:a16="http://schemas.microsoft.com/office/drawing/2014/main" id="{094F6238-48A4-49C2-822F-DD718A55F9DB}"/>
                  </a:ext>
                </a:extLst>
              </p:cNvPr>
              <p:cNvGrpSpPr/>
              <p:nvPr/>
            </p:nvGrpSpPr>
            <p:grpSpPr>
              <a:xfrm>
                <a:off x="7385761" y="5449743"/>
                <a:ext cx="788923" cy="138499"/>
                <a:chOff x="7385761" y="5497363"/>
                <a:chExt cx="788923" cy="138499"/>
              </a:xfrm>
            </p:grpSpPr>
            <p:grpSp>
              <p:nvGrpSpPr>
                <p:cNvPr id="47" name="그룹 46">
                  <a:extLst>
                    <a:ext uri="{FF2B5EF4-FFF2-40B4-BE49-F238E27FC236}">
                      <a16:creationId xmlns:a16="http://schemas.microsoft.com/office/drawing/2014/main" id="{4BF3DD16-E47E-481D-A42A-B475917E93A7}"/>
                    </a:ext>
                  </a:extLst>
                </p:cNvPr>
                <p:cNvGrpSpPr/>
                <p:nvPr/>
              </p:nvGrpSpPr>
              <p:grpSpPr>
                <a:xfrm>
                  <a:off x="7385761" y="5536601"/>
                  <a:ext cx="180000" cy="54424"/>
                  <a:chOff x="4252839" y="2291106"/>
                  <a:chExt cx="180000" cy="54424"/>
                </a:xfrm>
              </p:grpSpPr>
              <p:cxnSp>
                <p:nvCxnSpPr>
                  <p:cNvPr id="49" name="직선 연결선 48">
                    <a:extLst>
                      <a:ext uri="{FF2B5EF4-FFF2-40B4-BE49-F238E27FC236}">
                        <a16:creationId xmlns:a16="http://schemas.microsoft.com/office/drawing/2014/main" id="{C0D0E45E-86B4-40D3-9B74-6DE2510991F8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18318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0" name="타원 49">
                    <a:extLst>
                      <a:ext uri="{FF2B5EF4-FFF2-40B4-BE49-F238E27FC236}">
                        <a16:creationId xmlns:a16="http://schemas.microsoft.com/office/drawing/2014/main" id="{FE406CD3-F455-4C98-90F0-7AC682C842C8}"/>
                      </a:ext>
                    </a:extLst>
                  </p:cNvPr>
                  <p:cNvSpPr/>
                  <p:nvPr/>
                </p:nvSpPr>
                <p:spPr>
                  <a:xfrm>
                    <a:off x="4315627" y="2291106"/>
                    <a:ext cx="54424" cy="54424"/>
                  </a:xfrm>
                  <a:prstGeom prst="ellips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086F81D2-975B-4587-A47A-B4F9B68F9395}"/>
                    </a:ext>
                  </a:extLst>
                </p:cNvPr>
                <p:cNvSpPr txBox="1"/>
                <p:nvPr/>
              </p:nvSpPr>
              <p:spPr>
                <a:xfrm>
                  <a:off x="7604014" y="5497363"/>
                  <a:ext cx="570670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21(DE3)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55" name="그룹 54">
            <a:extLst>
              <a:ext uri="{FF2B5EF4-FFF2-40B4-BE49-F238E27FC236}">
                <a16:creationId xmlns:a16="http://schemas.microsoft.com/office/drawing/2014/main" id="{66441B00-2D43-46AB-AD71-947AB4F07730}"/>
              </a:ext>
            </a:extLst>
          </p:cNvPr>
          <p:cNvGrpSpPr/>
          <p:nvPr/>
        </p:nvGrpSpPr>
        <p:grpSpPr>
          <a:xfrm>
            <a:off x="5102585" y="1182441"/>
            <a:ext cx="2096346" cy="2091465"/>
            <a:chOff x="2075526" y="3398753"/>
            <a:chExt cx="2096346" cy="2091465"/>
          </a:xfrm>
        </p:grpSpPr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86868088-012E-4C7C-8609-63AC9C2960DE}"/>
                </a:ext>
              </a:extLst>
            </p:cNvPr>
            <p:cNvSpPr txBox="1"/>
            <p:nvPr/>
          </p:nvSpPr>
          <p:spPr>
            <a:xfrm>
              <a:off x="3281914" y="5336330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30B35CD6-A7E1-41BF-8F60-C1977C1D93E5}"/>
                </a:ext>
              </a:extLst>
            </p:cNvPr>
            <p:cNvSpPr txBox="1"/>
            <p:nvPr/>
          </p:nvSpPr>
          <p:spPr>
            <a:xfrm rot="16200000">
              <a:off x="1775764" y="4261130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69D0F5C5-B6B8-4172-B0E8-88E18ADC7382}"/>
                </a:ext>
              </a:extLst>
            </p:cNvPr>
            <p:cNvSpPr txBox="1"/>
            <p:nvPr/>
          </p:nvSpPr>
          <p:spPr>
            <a:xfrm>
              <a:off x="2886264" y="3398753"/>
              <a:ext cx="1285608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etoglutarate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(0.3%)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9" name="그룹 58">
              <a:extLst>
                <a:ext uri="{FF2B5EF4-FFF2-40B4-BE49-F238E27FC236}">
                  <a16:creationId xmlns:a16="http://schemas.microsoft.com/office/drawing/2014/main" id="{9519C4A8-FFCB-44C5-9D43-D3161EEE1401}"/>
                </a:ext>
              </a:extLst>
            </p:cNvPr>
            <p:cNvGrpSpPr/>
            <p:nvPr/>
          </p:nvGrpSpPr>
          <p:grpSpPr>
            <a:xfrm>
              <a:off x="2492991" y="3591380"/>
              <a:ext cx="788923" cy="276703"/>
              <a:chOff x="7385761" y="5449743"/>
              <a:chExt cx="788923" cy="276703"/>
            </a:xfrm>
          </p:grpSpPr>
          <p:grpSp>
            <p:nvGrpSpPr>
              <p:cNvPr id="60" name="그룹 59">
                <a:extLst>
                  <a:ext uri="{FF2B5EF4-FFF2-40B4-BE49-F238E27FC236}">
                    <a16:creationId xmlns:a16="http://schemas.microsoft.com/office/drawing/2014/main" id="{DDCD9752-9B81-4730-A60B-4A80E5F7674E}"/>
                  </a:ext>
                </a:extLst>
              </p:cNvPr>
              <p:cNvGrpSpPr/>
              <p:nvPr/>
            </p:nvGrpSpPr>
            <p:grpSpPr>
              <a:xfrm>
                <a:off x="7385761" y="5587947"/>
                <a:ext cx="570914" cy="138499"/>
                <a:chOff x="7385761" y="5587947"/>
                <a:chExt cx="570914" cy="138499"/>
              </a:xfrm>
            </p:grpSpPr>
            <p:grpSp>
              <p:nvGrpSpPr>
                <p:cNvPr id="66" name="그룹 65">
                  <a:extLst>
                    <a:ext uri="{FF2B5EF4-FFF2-40B4-BE49-F238E27FC236}">
                      <a16:creationId xmlns:a16="http://schemas.microsoft.com/office/drawing/2014/main" id="{707D396E-D5AC-47EB-B030-6682E6E4903E}"/>
                    </a:ext>
                  </a:extLst>
                </p:cNvPr>
                <p:cNvGrpSpPr/>
                <p:nvPr/>
              </p:nvGrpSpPr>
              <p:grpSpPr>
                <a:xfrm>
                  <a:off x="7385761" y="5627966"/>
                  <a:ext cx="180000" cy="54424"/>
                  <a:chOff x="4252839" y="2579244"/>
                  <a:chExt cx="180000" cy="54424"/>
                </a:xfrm>
              </p:grpSpPr>
              <p:cxnSp>
                <p:nvCxnSpPr>
                  <p:cNvPr id="68" name="직선 연결선 67">
                    <a:extLst>
                      <a:ext uri="{FF2B5EF4-FFF2-40B4-BE49-F238E27FC236}">
                        <a16:creationId xmlns:a16="http://schemas.microsoft.com/office/drawing/2014/main" id="{3C73E373-68E2-4E83-B6C6-C81BC4B9936B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606456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9" name="이등변 삼각형 68">
                    <a:extLst>
                      <a:ext uri="{FF2B5EF4-FFF2-40B4-BE49-F238E27FC236}">
                        <a16:creationId xmlns:a16="http://schemas.microsoft.com/office/drawing/2014/main" id="{B7B04394-C071-47C7-A750-8515E341AEE3}"/>
                      </a:ext>
                    </a:extLst>
                  </p:cNvPr>
                  <p:cNvSpPr/>
                  <p:nvPr/>
                </p:nvSpPr>
                <p:spPr>
                  <a:xfrm>
                    <a:off x="4315627" y="2579244"/>
                    <a:ext cx="54424" cy="54424"/>
                  </a:xfrm>
                  <a:prstGeom prst="triangl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1E8901AF-0B1F-48A6-8315-1E21923C9B5B}"/>
                    </a:ext>
                  </a:extLst>
                </p:cNvPr>
                <p:cNvSpPr txBox="1"/>
                <p:nvPr/>
              </p:nvSpPr>
              <p:spPr>
                <a:xfrm>
                  <a:off x="7604014" y="5587947"/>
                  <a:ext cx="352661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K565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1" name="그룹 60">
                <a:extLst>
                  <a:ext uri="{FF2B5EF4-FFF2-40B4-BE49-F238E27FC236}">
                    <a16:creationId xmlns:a16="http://schemas.microsoft.com/office/drawing/2014/main" id="{1A7FCD2C-C0AF-4CE2-8703-E65B148D697D}"/>
                  </a:ext>
                </a:extLst>
              </p:cNvPr>
              <p:cNvGrpSpPr/>
              <p:nvPr/>
            </p:nvGrpSpPr>
            <p:grpSpPr>
              <a:xfrm>
                <a:off x="7385761" y="5449743"/>
                <a:ext cx="788923" cy="138499"/>
                <a:chOff x="7385761" y="5497363"/>
                <a:chExt cx="788923" cy="138499"/>
              </a:xfrm>
            </p:grpSpPr>
            <p:grpSp>
              <p:nvGrpSpPr>
                <p:cNvPr id="62" name="그룹 61">
                  <a:extLst>
                    <a:ext uri="{FF2B5EF4-FFF2-40B4-BE49-F238E27FC236}">
                      <a16:creationId xmlns:a16="http://schemas.microsoft.com/office/drawing/2014/main" id="{95DB9BA3-64B3-418B-B3EB-A2F0396FE6CB}"/>
                    </a:ext>
                  </a:extLst>
                </p:cNvPr>
                <p:cNvGrpSpPr/>
                <p:nvPr/>
              </p:nvGrpSpPr>
              <p:grpSpPr>
                <a:xfrm>
                  <a:off x="7385761" y="5536601"/>
                  <a:ext cx="180000" cy="54424"/>
                  <a:chOff x="4252839" y="2291106"/>
                  <a:chExt cx="180000" cy="54424"/>
                </a:xfrm>
              </p:grpSpPr>
              <p:cxnSp>
                <p:nvCxnSpPr>
                  <p:cNvPr id="64" name="직선 연결선 63">
                    <a:extLst>
                      <a:ext uri="{FF2B5EF4-FFF2-40B4-BE49-F238E27FC236}">
                        <a16:creationId xmlns:a16="http://schemas.microsoft.com/office/drawing/2014/main" id="{B3957353-58B3-45AA-9EB8-B540AC7C9DFD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18318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5" name="타원 64">
                    <a:extLst>
                      <a:ext uri="{FF2B5EF4-FFF2-40B4-BE49-F238E27FC236}">
                        <a16:creationId xmlns:a16="http://schemas.microsoft.com/office/drawing/2014/main" id="{28FB5482-0C49-4774-9529-04B43A69CF31}"/>
                      </a:ext>
                    </a:extLst>
                  </p:cNvPr>
                  <p:cNvSpPr/>
                  <p:nvPr/>
                </p:nvSpPr>
                <p:spPr>
                  <a:xfrm>
                    <a:off x="4315627" y="2291106"/>
                    <a:ext cx="54424" cy="54424"/>
                  </a:xfrm>
                  <a:prstGeom prst="ellipse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/>
                  </a:p>
                </p:txBody>
              </p:sp>
            </p:grp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D54B434F-1A2C-4062-B154-042149806C7E}"/>
                    </a:ext>
                  </a:extLst>
                </p:cNvPr>
                <p:cNvSpPr txBox="1"/>
                <p:nvPr/>
              </p:nvSpPr>
              <p:spPr>
                <a:xfrm>
                  <a:off x="7604014" y="5497363"/>
                  <a:ext cx="570670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21(DE3)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5295326B-BFBA-41E9-91B4-96033C96AE23}"/>
              </a:ext>
            </a:extLst>
          </p:cNvPr>
          <p:cNvSpPr txBox="1"/>
          <p:nvPr/>
        </p:nvSpPr>
        <p:spPr>
          <a:xfrm>
            <a:off x="3569404" y="2295695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14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A4119F6-C0A3-4C4F-A6A8-1210E972045F}"/>
              </a:ext>
            </a:extLst>
          </p:cNvPr>
          <p:cNvSpPr txBox="1"/>
          <p:nvPr/>
        </p:nvSpPr>
        <p:spPr>
          <a:xfrm>
            <a:off x="2504057" y="2081647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7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E798537-5EA3-4F30-84C1-1FE5A71563DB}"/>
              </a:ext>
            </a:extLst>
          </p:cNvPr>
          <p:cNvSpPr txBox="1"/>
          <p:nvPr/>
        </p:nvSpPr>
        <p:spPr>
          <a:xfrm>
            <a:off x="6452996" y="2204758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45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0047173-BD16-457B-AC12-2C15B8D0451E}"/>
              </a:ext>
            </a:extLst>
          </p:cNvPr>
          <p:cNvSpPr txBox="1"/>
          <p:nvPr/>
        </p:nvSpPr>
        <p:spPr>
          <a:xfrm>
            <a:off x="5779845" y="2161895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65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2D2F36CF-F8E6-47AF-A3A5-79EC6D447EB0}"/>
              </a:ext>
            </a:extLst>
          </p:cNvPr>
          <p:cNvSpPr txBox="1"/>
          <p:nvPr/>
        </p:nvSpPr>
        <p:spPr>
          <a:xfrm>
            <a:off x="2552083" y="4380703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2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3A0AD8E-2FF2-41BE-BF6F-99059895EEAE}"/>
              </a:ext>
            </a:extLst>
          </p:cNvPr>
          <p:cNvSpPr txBox="1"/>
          <p:nvPr/>
        </p:nvSpPr>
        <p:spPr>
          <a:xfrm>
            <a:off x="2945513" y="4669193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1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55BD736-EF92-4BBE-86F6-B5B2F51D4C2D}"/>
              </a:ext>
            </a:extLst>
          </p:cNvPr>
          <p:cNvSpPr txBox="1"/>
          <p:nvPr/>
        </p:nvSpPr>
        <p:spPr>
          <a:xfrm>
            <a:off x="5674459" y="4642053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47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322EDB4-7874-4CF5-B1A4-B5D0E2158E98}"/>
              </a:ext>
            </a:extLst>
          </p:cNvPr>
          <p:cNvSpPr txBox="1"/>
          <p:nvPr/>
        </p:nvSpPr>
        <p:spPr>
          <a:xfrm>
            <a:off x="6045298" y="4766599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51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8" name="그룹 77">
            <a:extLst>
              <a:ext uri="{FF2B5EF4-FFF2-40B4-BE49-F238E27FC236}">
                <a16:creationId xmlns:a16="http://schemas.microsoft.com/office/drawing/2014/main" id="{1AE20BA1-5503-426C-808D-CA99A663DECC}"/>
              </a:ext>
            </a:extLst>
          </p:cNvPr>
          <p:cNvGrpSpPr/>
          <p:nvPr/>
        </p:nvGrpSpPr>
        <p:grpSpPr>
          <a:xfrm>
            <a:off x="2229543" y="1290838"/>
            <a:ext cx="204511" cy="1707837"/>
            <a:chOff x="2231375" y="244499"/>
            <a:chExt cx="204511" cy="1707837"/>
          </a:xfrm>
        </p:grpSpPr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60B26B35-CF5F-4191-B697-C89DB009D679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6F90F14C-8F5B-4459-A55C-0B251CB4A427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0D28D44A-45FA-4980-845E-660AF28CDD71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682BC9F3-42B8-46F6-B59E-E171F8381FDD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3" name="그룹 82">
            <a:extLst>
              <a:ext uri="{FF2B5EF4-FFF2-40B4-BE49-F238E27FC236}">
                <a16:creationId xmlns:a16="http://schemas.microsoft.com/office/drawing/2014/main" id="{515F2706-1EAE-4930-9B6B-18DB3F83F4E5}"/>
              </a:ext>
            </a:extLst>
          </p:cNvPr>
          <p:cNvGrpSpPr/>
          <p:nvPr/>
        </p:nvGrpSpPr>
        <p:grpSpPr>
          <a:xfrm>
            <a:off x="5229314" y="1290838"/>
            <a:ext cx="204511" cy="1707837"/>
            <a:chOff x="2231375" y="244499"/>
            <a:chExt cx="204511" cy="1707837"/>
          </a:xfrm>
        </p:grpSpPr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88CE3389-7673-4F54-A849-2811E2667660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BE0B917C-47D9-419B-8754-8D650F9066F8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A001BE6D-5921-445C-B7E6-9911FCF632B8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4DB45723-8766-4287-8BAB-CF7E891A2EE8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8" name="그룹 87">
            <a:extLst>
              <a:ext uri="{FF2B5EF4-FFF2-40B4-BE49-F238E27FC236}">
                <a16:creationId xmlns:a16="http://schemas.microsoft.com/office/drawing/2014/main" id="{CE43FF9B-FA05-4810-9CF4-E44ABEF0228A}"/>
              </a:ext>
            </a:extLst>
          </p:cNvPr>
          <p:cNvGrpSpPr/>
          <p:nvPr/>
        </p:nvGrpSpPr>
        <p:grpSpPr>
          <a:xfrm>
            <a:off x="2215116" y="3657422"/>
            <a:ext cx="204511" cy="1707837"/>
            <a:chOff x="2231375" y="244499"/>
            <a:chExt cx="204511" cy="1707837"/>
          </a:xfrm>
        </p:grpSpPr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8FDEADAF-2073-4AB7-97AB-E22E4AB5FDC7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8D9EA1F-9E3E-4CC4-8FF4-752FBE58C5FD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6B8D6E29-93E3-4F93-8FE5-05F2D3092913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BDFC91F5-6FAA-4474-8888-97C48E5CBBDC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3" name="그룹 92">
            <a:extLst>
              <a:ext uri="{FF2B5EF4-FFF2-40B4-BE49-F238E27FC236}">
                <a16:creationId xmlns:a16="http://schemas.microsoft.com/office/drawing/2014/main" id="{B6F9EE70-503B-4B0D-863F-8858FA7E1EC1}"/>
              </a:ext>
            </a:extLst>
          </p:cNvPr>
          <p:cNvGrpSpPr/>
          <p:nvPr/>
        </p:nvGrpSpPr>
        <p:grpSpPr>
          <a:xfrm>
            <a:off x="5214887" y="3651364"/>
            <a:ext cx="204511" cy="1707837"/>
            <a:chOff x="2231375" y="244499"/>
            <a:chExt cx="204511" cy="1707837"/>
          </a:xfrm>
        </p:grpSpPr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0F4AD450-4375-450A-9C96-EB373DBBD430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E2751254-412F-42C1-BA63-1CA4F261E18E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6C2D7065-CB32-4C43-963E-9EC9FD267BFB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444771DA-7DE0-427B-85EC-2CB4861E949F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8" name="직사각형 97">
            <a:extLst>
              <a:ext uri="{FF2B5EF4-FFF2-40B4-BE49-F238E27FC236}">
                <a16:creationId xmlns:a16="http://schemas.microsoft.com/office/drawing/2014/main" id="{905CFFD0-A1A3-4FFF-A951-07B523ECAC98}"/>
              </a:ext>
            </a:extLst>
          </p:cNvPr>
          <p:cNvSpPr/>
          <p:nvPr/>
        </p:nvSpPr>
        <p:spPr>
          <a:xfrm>
            <a:off x="0" y="2683"/>
            <a:ext cx="19175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8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50750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>
            <a:extLst>
              <a:ext uri="{FF2B5EF4-FFF2-40B4-BE49-F238E27FC236}">
                <a16:creationId xmlns:a16="http://schemas.microsoft.com/office/drawing/2014/main" id="{D1BD6562-28FC-49FB-B00B-B445A4B3D741}"/>
              </a:ext>
            </a:extLst>
          </p:cNvPr>
          <p:cNvSpPr/>
          <p:nvPr/>
        </p:nvSpPr>
        <p:spPr>
          <a:xfrm>
            <a:off x="0" y="2683"/>
            <a:ext cx="19175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9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개체 2">
            <a:extLst>
              <a:ext uri="{FF2B5EF4-FFF2-40B4-BE49-F238E27FC236}">
                <a16:creationId xmlns:a16="http://schemas.microsoft.com/office/drawing/2014/main" id="{83370C40-B27C-4F05-8751-8768473360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5050780"/>
              </p:ext>
            </p:extLst>
          </p:nvPr>
        </p:nvGraphicFramePr>
        <p:xfrm>
          <a:off x="5232718" y="1439361"/>
          <a:ext cx="2404800" cy="1870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6" name="Graph" r:id="rId3" imgW="3291840" imgH="2560320" progId="Origin95.Graph">
                  <p:embed/>
                </p:oleObj>
              </mc:Choice>
              <mc:Fallback>
                <p:oleObj name="Graph" r:id="rId3" imgW="3291840" imgH="2560320" progId="Origin95.Graph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F4703F14-2032-49C7-A918-BDF67C9A69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32718" y="1439361"/>
                        <a:ext cx="2404800" cy="1870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5A3F6E9E-4444-4C4C-A3FF-6A5DF01083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6631567"/>
              </p:ext>
            </p:extLst>
          </p:nvPr>
        </p:nvGraphicFramePr>
        <p:xfrm>
          <a:off x="2270371" y="1435320"/>
          <a:ext cx="2404800" cy="1870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7" name="Graph" r:id="rId5" imgW="3291840" imgH="2560320" progId="Origin95.Graph">
                  <p:embed/>
                </p:oleObj>
              </mc:Choice>
              <mc:Fallback>
                <p:oleObj name="Graph" r:id="rId5" imgW="3291840" imgH="2560320" progId="Origin95.Graph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D76C804C-DC1C-4C09-922A-7A55882568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70371" y="1435320"/>
                        <a:ext cx="2404800" cy="1870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B228DCEB-F1CD-4244-B5F3-6CBA285440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4430686"/>
              </p:ext>
            </p:extLst>
          </p:nvPr>
        </p:nvGraphicFramePr>
        <p:xfrm>
          <a:off x="5228043" y="3878136"/>
          <a:ext cx="2404800" cy="1870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8" name="Graph" r:id="rId7" imgW="3291840" imgH="2560320" progId="Origin95.Graph">
                  <p:embed/>
                </p:oleObj>
              </mc:Choice>
              <mc:Fallback>
                <p:oleObj name="Graph" r:id="rId7" imgW="3291840" imgH="2560320" progId="Origin95.Graph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EE649B1A-2E10-4194-BBC9-A7F629C2D8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228043" y="3878136"/>
                        <a:ext cx="2404800" cy="1870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개체 5">
            <a:extLst>
              <a:ext uri="{FF2B5EF4-FFF2-40B4-BE49-F238E27FC236}">
                <a16:creationId xmlns:a16="http://schemas.microsoft.com/office/drawing/2014/main" id="{099D2C0E-F23F-491C-8D83-8B11589628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2998655"/>
              </p:ext>
            </p:extLst>
          </p:nvPr>
        </p:nvGraphicFramePr>
        <p:xfrm>
          <a:off x="2264780" y="3869244"/>
          <a:ext cx="2404800" cy="1870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9" name="Graph" r:id="rId9" imgW="3291840" imgH="2560320" progId="Origin95.Graph">
                  <p:embed/>
                </p:oleObj>
              </mc:Choice>
              <mc:Fallback>
                <p:oleObj name="Graph" r:id="rId9" imgW="3291840" imgH="2560320" progId="Origin95.Graph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6E07CE2B-F01C-4639-8DCB-9B760D6136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264780" y="3869244"/>
                        <a:ext cx="2404800" cy="1870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7" name="그룹 6">
            <a:extLst>
              <a:ext uri="{FF2B5EF4-FFF2-40B4-BE49-F238E27FC236}">
                <a16:creationId xmlns:a16="http://schemas.microsoft.com/office/drawing/2014/main" id="{9507ED0B-E335-4F44-B561-85BEA51B29A4}"/>
              </a:ext>
            </a:extLst>
          </p:cNvPr>
          <p:cNvGrpSpPr/>
          <p:nvPr/>
        </p:nvGrpSpPr>
        <p:grpSpPr>
          <a:xfrm>
            <a:off x="5042255" y="1285473"/>
            <a:ext cx="2379702" cy="4543668"/>
            <a:chOff x="2100598" y="1311945"/>
            <a:chExt cx="2379702" cy="4543668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CC88538-4858-48B3-B6C1-300B963E8E4D}"/>
                </a:ext>
              </a:extLst>
            </p:cNvPr>
            <p:cNvSpPr txBox="1"/>
            <p:nvPr/>
          </p:nvSpPr>
          <p:spPr>
            <a:xfrm>
              <a:off x="3254614" y="3293618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801BC5D-2CD5-4FCB-9921-AE08E360F7B0}"/>
                </a:ext>
              </a:extLst>
            </p:cNvPr>
            <p:cNvSpPr txBox="1"/>
            <p:nvPr/>
          </p:nvSpPr>
          <p:spPr>
            <a:xfrm rot="16200000">
              <a:off x="1800836" y="2226504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2447D45-B95E-46CB-81D4-95217E22BFC5}"/>
                </a:ext>
              </a:extLst>
            </p:cNvPr>
            <p:cNvSpPr txBox="1"/>
            <p:nvPr/>
          </p:nvSpPr>
          <p:spPr>
            <a:xfrm>
              <a:off x="3254614" y="5701725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89A9030-D382-4034-B35B-D1B2AF7D8641}"/>
                </a:ext>
              </a:extLst>
            </p:cNvPr>
            <p:cNvSpPr txBox="1"/>
            <p:nvPr/>
          </p:nvSpPr>
          <p:spPr>
            <a:xfrm rot="16200000">
              <a:off x="1800836" y="4634611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108152E-3127-4236-9CB4-8D3E0349A559}"/>
                </a:ext>
              </a:extLst>
            </p:cNvPr>
            <p:cNvSpPr txBox="1"/>
            <p:nvPr/>
          </p:nvSpPr>
          <p:spPr>
            <a:xfrm>
              <a:off x="2630435" y="1311945"/>
              <a:ext cx="184986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gtP</a:t>
              </a:r>
              <a:r>
                <a:rPr lang="en-US" altLang="ko-KR" sz="10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yfiP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::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mR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, BL21(DE3) 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D23513C-3412-41C1-A619-1FAEFD24C184}"/>
                </a:ext>
              </a:extLst>
            </p:cNvPr>
            <p:cNvSpPr txBox="1"/>
            <p:nvPr/>
          </p:nvSpPr>
          <p:spPr>
            <a:xfrm>
              <a:off x="2746244" y="3746691"/>
              <a:ext cx="160781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gtP</a:t>
              </a:r>
              <a:r>
                <a:rPr lang="en-US" altLang="ko-KR" sz="10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yfiP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::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mR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, HK565 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" name="그룹 13">
              <a:extLst>
                <a:ext uri="{FF2B5EF4-FFF2-40B4-BE49-F238E27FC236}">
                  <a16:creationId xmlns:a16="http://schemas.microsoft.com/office/drawing/2014/main" id="{F809D9A4-8E37-40A2-8EC9-8263934D24FB}"/>
                </a:ext>
              </a:extLst>
            </p:cNvPr>
            <p:cNvGrpSpPr/>
            <p:nvPr/>
          </p:nvGrpSpPr>
          <p:grpSpPr>
            <a:xfrm>
              <a:off x="2586006" y="4001488"/>
              <a:ext cx="1097400" cy="296923"/>
              <a:chOff x="7385761" y="5355303"/>
              <a:chExt cx="1097400" cy="296923"/>
            </a:xfrm>
          </p:grpSpPr>
          <p:grpSp>
            <p:nvGrpSpPr>
              <p:cNvPr id="26" name="그룹 25">
                <a:extLst>
                  <a:ext uri="{FF2B5EF4-FFF2-40B4-BE49-F238E27FC236}">
                    <a16:creationId xmlns:a16="http://schemas.microsoft.com/office/drawing/2014/main" id="{A5C1EFCC-8C73-4193-97B2-6507F1EC4E9C}"/>
                  </a:ext>
                </a:extLst>
              </p:cNvPr>
              <p:cNvGrpSpPr/>
              <p:nvPr/>
            </p:nvGrpSpPr>
            <p:grpSpPr>
              <a:xfrm>
                <a:off x="7385761" y="5355303"/>
                <a:ext cx="779152" cy="153888"/>
                <a:chOff x="7385761" y="5355303"/>
                <a:chExt cx="779152" cy="153888"/>
              </a:xfrm>
            </p:grpSpPr>
            <p:grpSp>
              <p:nvGrpSpPr>
                <p:cNvPr id="32" name="그룹 31">
                  <a:extLst>
                    <a:ext uri="{FF2B5EF4-FFF2-40B4-BE49-F238E27FC236}">
                      <a16:creationId xmlns:a16="http://schemas.microsoft.com/office/drawing/2014/main" id="{C08D55A7-C452-4459-A0F3-29F12050C1A5}"/>
                    </a:ext>
                  </a:extLst>
                </p:cNvPr>
                <p:cNvGrpSpPr/>
                <p:nvPr/>
              </p:nvGrpSpPr>
              <p:grpSpPr>
                <a:xfrm>
                  <a:off x="7385761" y="5408882"/>
                  <a:ext cx="180000" cy="54424"/>
                  <a:chOff x="4252839" y="2360160"/>
                  <a:chExt cx="180000" cy="54424"/>
                </a:xfrm>
              </p:grpSpPr>
              <p:cxnSp>
                <p:nvCxnSpPr>
                  <p:cNvPr id="34" name="직선 연결선 33">
                    <a:extLst>
                      <a:ext uri="{FF2B5EF4-FFF2-40B4-BE49-F238E27FC236}">
                        <a16:creationId xmlns:a16="http://schemas.microsoft.com/office/drawing/2014/main" id="{B7F42A43-8EE2-452A-A265-42DD5A7F308B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87372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5" name="타원 34">
                    <a:extLst>
                      <a:ext uri="{FF2B5EF4-FFF2-40B4-BE49-F238E27FC236}">
                        <a16:creationId xmlns:a16="http://schemas.microsoft.com/office/drawing/2014/main" id="{1E6A4DFA-6D7F-45A8-9034-A0D9D208B441}"/>
                      </a:ext>
                    </a:extLst>
                  </p:cNvPr>
                  <p:cNvSpPr/>
                  <p:nvPr/>
                </p:nvSpPr>
                <p:spPr>
                  <a:xfrm>
                    <a:off x="4315627" y="2360160"/>
                    <a:ext cx="54424" cy="54424"/>
                  </a:xfrm>
                  <a:prstGeom prst="ellipse">
                    <a:avLst/>
                  </a:prstGeom>
                  <a:solidFill>
                    <a:schemeClr val="bg1"/>
                  </a:solidFill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600"/>
                  </a:p>
                </p:txBody>
              </p:sp>
            </p:grp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419EE1DE-895A-461B-A29F-4E86DF83AB68}"/>
                    </a:ext>
                  </a:extLst>
                </p:cNvPr>
                <p:cNvSpPr txBox="1"/>
                <p:nvPr/>
              </p:nvSpPr>
              <p:spPr>
                <a:xfrm>
                  <a:off x="7605464" y="5355303"/>
                  <a:ext cx="559449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uccinate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" name="그룹 26">
                <a:extLst>
                  <a:ext uri="{FF2B5EF4-FFF2-40B4-BE49-F238E27FC236}">
                    <a16:creationId xmlns:a16="http://schemas.microsoft.com/office/drawing/2014/main" id="{C5C5CE79-31F3-4B26-9026-B8AD5B3F8CEE}"/>
                  </a:ext>
                </a:extLst>
              </p:cNvPr>
              <p:cNvGrpSpPr/>
              <p:nvPr/>
            </p:nvGrpSpPr>
            <p:grpSpPr>
              <a:xfrm>
                <a:off x="7385761" y="5498338"/>
                <a:ext cx="1097400" cy="153888"/>
                <a:chOff x="7385761" y="5545958"/>
                <a:chExt cx="1097400" cy="153888"/>
              </a:xfrm>
            </p:grpSpPr>
            <p:grpSp>
              <p:nvGrpSpPr>
                <p:cNvPr id="28" name="그룹 27">
                  <a:extLst>
                    <a:ext uri="{FF2B5EF4-FFF2-40B4-BE49-F238E27FC236}">
                      <a16:creationId xmlns:a16="http://schemas.microsoft.com/office/drawing/2014/main" id="{6C3CB708-7B5E-495B-B93C-02414B39F186}"/>
                    </a:ext>
                  </a:extLst>
                </p:cNvPr>
                <p:cNvGrpSpPr/>
                <p:nvPr/>
              </p:nvGrpSpPr>
              <p:grpSpPr>
                <a:xfrm>
                  <a:off x="7385761" y="5605655"/>
                  <a:ext cx="180000" cy="54424"/>
                  <a:chOff x="4252839" y="2360160"/>
                  <a:chExt cx="180000" cy="54424"/>
                </a:xfrm>
              </p:grpSpPr>
              <p:cxnSp>
                <p:nvCxnSpPr>
                  <p:cNvPr id="30" name="직선 연결선 29">
                    <a:extLst>
                      <a:ext uri="{FF2B5EF4-FFF2-40B4-BE49-F238E27FC236}">
                        <a16:creationId xmlns:a16="http://schemas.microsoft.com/office/drawing/2014/main" id="{07BDE832-9C56-4CF4-BA8A-6E59B422AA10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87372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" name="타원 30">
                    <a:extLst>
                      <a:ext uri="{FF2B5EF4-FFF2-40B4-BE49-F238E27FC236}">
                        <a16:creationId xmlns:a16="http://schemas.microsoft.com/office/drawing/2014/main" id="{11F58261-F42E-4EFB-884E-D27307DC44CD}"/>
                      </a:ext>
                    </a:extLst>
                  </p:cNvPr>
                  <p:cNvSpPr/>
                  <p:nvPr/>
                </p:nvSpPr>
                <p:spPr>
                  <a:xfrm>
                    <a:off x="4315627" y="2360160"/>
                    <a:ext cx="54424" cy="54424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600"/>
                  </a:p>
                </p:txBody>
              </p:sp>
            </p:grp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16453CAB-9EED-4B4E-8355-2B81EC54CA4E}"/>
                    </a:ext>
                  </a:extLst>
                </p:cNvPr>
                <p:cNvSpPr txBox="1"/>
                <p:nvPr/>
              </p:nvSpPr>
              <p:spPr>
                <a:xfrm>
                  <a:off x="7609525" y="5545958"/>
                  <a:ext cx="87363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l-GR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Ketoglutarate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5" name="그룹 14">
              <a:extLst>
                <a:ext uri="{FF2B5EF4-FFF2-40B4-BE49-F238E27FC236}">
                  <a16:creationId xmlns:a16="http://schemas.microsoft.com/office/drawing/2014/main" id="{0B4E8235-8634-4A18-A514-130D42B1487F}"/>
                </a:ext>
              </a:extLst>
            </p:cNvPr>
            <p:cNvGrpSpPr/>
            <p:nvPr/>
          </p:nvGrpSpPr>
          <p:grpSpPr>
            <a:xfrm>
              <a:off x="2558477" y="1580878"/>
              <a:ext cx="1097400" cy="296923"/>
              <a:chOff x="7385761" y="5307683"/>
              <a:chExt cx="1097400" cy="296923"/>
            </a:xfrm>
          </p:grpSpPr>
          <p:grpSp>
            <p:nvGrpSpPr>
              <p:cNvPr id="16" name="그룹 15">
                <a:extLst>
                  <a:ext uri="{FF2B5EF4-FFF2-40B4-BE49-F238E27FC236}">
                    <a16:creationId xmlns:a16="http://schemas.microsoft.com/office/drawing/2014/main" id="{216EE925-F805-4E3E-A04A-99EBD569EA24}"/>
                  </a:ext>
                </a:extLst>
              </p:cNvPr>
              <p:cNvGrpSpPr/>
              <p:nvPr/>
            </p:nvGrpSpPr>
            <p:grpSpPr>
              <a:xfrm>
                <a:off x="7385761" y="5307683"/>
                <a:ext cx="779152" cy="153888"/>
                <a:chOff x="7385761" y="5307683"/>
                <a:chExt cx="779152" cy="153888"/>
              </a:xfrm>
            </p:grpSpPr>
            <p:grpSp>
              <p:nvGrpSpPr>
                <p:cNvPr id="22" name="그룹 21">
                  <a:extLst>
                    <a:ext uri="{FF2B5EF4-FFF2-40B4-BE49-F238E27FC236}">
                      <a16:creationId xmlns:a16="http://schemas.microsoft.com/office/drawing/2014/main" id="{0E32E432-CF5E-4B6A-AB2E-65CD4721F652}"/>
                    </a:ext>
                  </a:extLst>
                </p:cNvPr>
                <p:cNvGrpSpPr/>
                <p:nvPr/>
              </p:nvGrpSpPr>
              <p:grpSpPr>
                <a:xfrm>
                  <a:off x="7385761" y="5361262"/>
                  <a:ext cx="180000" cy="54424"/>
                  <a:chOff x="4252839" y="2312540"/>
                  <a:chExt cx="180000" cy="54424"/>
                </a:xfrm>
              </p:grpSpPr>
              <p:cxnSp>
                <p:nvCxnSpPr>
                  <p:cNvPr id="24" name="직선 연결선 23">
                    <a:extLst>
                      <a:ext uri="{FF2B5EF4-FFF2-40B4-BE49-F238E27FC236}">
                        <a16:creationId xmlns:a16="http://schemas.microsoft.com/office/drawing/2014/main" id="{82C35110-9D43-4B25-B6EF-B05C33DF40F3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39752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5" name="타원 24">
                    <a:extLst>
                      <a:ext uri="{FF2B5EF4-FFF2-40B4-BE49-F238E27FC236}">
                        <a16:creationId xmlns:a16="http://schemas.microsoft.com/office/drawing/2014/main" id="{2DBDCCE2-5BEF-4015-97DE-C13F891D3546}"/>
                      </a:ext>
                    </a:extLst>
                  </p:cNvPr>
                  <p:cNvSpPr/>
                  <p:nvPr/>
                </p:nvSpPr>
                <p:spPr>
                  <a:xfrm>
                    <a:off x="4315627" y="2312540"/>
                    <a:ext cx="54424" cy="54424"/>
                  </a:xfrm>
                  <a:prstGeom prst="ellipse">
                    <a:avLst/>
                  </a:prstGeom>
                  <a:solidFill>
                    <a:schemeClr val="bg1"/>
                  </a:solidFill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600"/>
                  </a:p>
                </p:txBody>
              </p:sp>
            </p:grp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D0D27CE6-6BE1-4737-AE34-88B6A6E1583D}"/>
                    </a:ext>
                  </a:extLst>
                </p:cNvPr>
                <p:cNvSpPr txBox="1"/>
                <p:nvPr/>
              </p:nvSpPr>
              <p:spPr>
                <a:xfrm>
                  <a:off x="7605464" y="5307683"/>
                  <a:ext cx="559449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uccinate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7" name="그룹 16">
                <a:extLst>
                  <a:ext uri="{FF2B5EF4-FFF2-40B4-BE49-F238E27FC236}">
                    <a16:creationId xmlns:a16="http://schemas.microsoft.com/office/drawing/2014/main" id="{16F72947-845C-4BA7-806A-2CE756B45FCB}"/>
                  </a:ext>
                </a:extLst>
              </p:cNvPr>
              <p:cNvGrpSpPr/>
              <p:nvPr/>
            </p:nvGrpSpPr>
            <p:grpSpPr>
              <a:xfrm>
                <a:off x="7385761" y="5450718"/>
                <a:ext cx="1097400" cy="153888"/>
                <a:chOff x="7385761" y="5498338"/>
                <a:chExt cx="1097400" cy="153888"/>
              </a:xfrm>
            </p:grpSpPr>
            <p:grpSp>
              <p:nvGrpSpPr>
                <p:cNvPr id="18" name="그룹 17">
                  <a:extLst>
                    <a:ext uri="{FF2B5EF4-FFF2-40B4-BE49-F238E27FC236}">
                      <a16:creationId xmlns:a16="http://schemas.microsoft.com/office/drawing/2014/main" id="{AFB9607E-6197-4400-85CF-1D1EBB683053}"/>
                    </a:ext>
                  </a:extLst>
                </p:cNvPr>
                <p:cNvGrpSpPr/>
                <p:nvPr/>
              </p:nvGrpSpPr>
              <p:grpSpPr>
                <a:xfrm>
                  <a:off x="7385761" y="5558035"/>
                  <a:ext cx="180000" cy="54424"/>
                  <a:chOff x="4252839" y="2312540"/>
                  <a:chExt cx="180000" cy="54424"/>
                </a:xfrm>
              </p:grpSpPr>
              <p:cxnSp>
                <p:nvCxnSpPr>
                  <p:cNvPr id="20" name="직선 연결선 19">
                    <a:extLst>
                      <a:ext uri="{FF2B5EF4-FFF2-40B4-BE49-F238E27FC236}">
                        <a16:creationId xmlns:a16="http://schemas.microsoft.com/office/drawing/2014/main" id="{BA4A74CA-B2EF-4790-90AC-A875926F657E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39752"/>
                    <a:ext cx="180000" cy="0"/>
                  </a:xfrm>
                  <a:prstGeom prst="line">
                    <a:avLst/>
                  </a:prstGeom>
                  <a:ln cap="rnd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" name="타원 20">
                    <a:extLst>
                      <a:ext uri="{FF2B5EF4-FFF2-40B4-BE49-F238E27FC236}">
                        <a16:creationId xmlns:a16="http://schemas.microsoft.com/office/drawing/2014/main" id="{3F70185A-96D0-4879-BA32-D8A0DC28FEF6}"/>
                      </a:ext>
                    </a:extLst>
                  </p:cNvPr>
                  <p:cNvSpPr/>
                  <p:nvPr/>
                </p:nvSpPr>
                <p:spPr>
                  <a:xfrm>
                    <a:off x="4315627" y="2312540"/>
                    <a:ext cx="54424" cy="54424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525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600"/>
                  </a:p>
                </p:txBody>
              </p:sp>
            </p:grp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8C959080-CB80-48DB-96B4-67A5C13B4759}"/>
                    </a:ext>
                  </a:extLst>
                </p:cNvPr>
                <p:cNvSpPr txBox="1"/>
                <p:nvPr/>
              </p:nvSpPr>
              <p:spPr>
                <a:xfrm>
                  <a:off x="7609525" y="5498338"/>
                  <a:ext cx="87363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l-GR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Ketoglutarate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36" name="그룹 35">
            <a:extLst>
              <a:ext uri="{FF2B5EF4-FFF2-40B4-BE49-F238E27FC236}">
                <a16:creationId xmlns:a16="http://schemas.microsoft.com/office/drawing/2014/main" id="{F946225C-3DA9-4D4A-8CE9-42C8EE0FC2E8}"/>
              </a:ext>
            </a:extLst>
          </p:cNvPr>
          <p:cNvGrpSpPr/>
          <p:nvPr/>
        </p:nvGrpSpPr>
        <p:grpSpPr>
          <a:xfrm>
            <a:off x="2102751" y="1288345"/>
            <a:ext cx="2472382" cy="4561870"/>
            <a:chOff x="5079283" y="1293743"/>
            <a:chExt cx="2472382" cy="4561870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114A736-CBC8-4747-86A3-EA6CC9032082}"/>
                </a:ext>
              </a:extLst>
            </p:cNvPr>
            <p:cNvSpPr txBox="1"/>
            <p:nvPr/>
          </p:nvSpPr>
          <p:spPr>
            <a:xfrm>
              <a:off x="6208567" y="3295622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6953CC4-6633-455C-9DA4-2AE44DBEA0B7}"/>
                </a:ext>
              </a:extLst>
            </p:cNvPr>
            <p:cNvSpPr txBox="1"/>
            <p:nvPr/>
          </p:nvSpPr>
          <p:spPr>
            <a:xfrm rot="16200000">
              <a:off x="4784581" y="2226504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5AB3E78-4A74-4BE3-9EF3-511DE8C708A4}"/>
                </a:ext>
              </a:extLst>
            </p:cNvPr>
            <p:cNvSpPr txBox="1"/>
            <p:nvPr/>
          </p:nvSpPr>
          <p:spPr>
            <a:xfrm>
              <a:off x="6233299" y="5701725"/>
              <a:ext cx="4776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57D5740-30DA-4D41-8E91-788F28ED9FE2}"/>
                </a:ext>
              </a:extLst>
            </p:cNvPr>
            <p:cNvSpPr txBox="1"/>
            <p:nvPr/>
          </p:nvSpPr>
          <p:spPr>
            <a:xfrm rot="16200000">
              <a:off x="4779521" y="4634611"/>
              <a:ext cx="75341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Log(OD</a:t>
              </a:r>
              <a:r>
                <a:rPr lang="en-US" altLang="ko-KR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00nm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47C91C7-73BA-415A-A437-120080971095}"/>
                </a:ext>
              </a:extLst>
            </p:cNvPr>
            <p:cNvSpPr txBox="1"/>
            <p:nvPr/>
          </p:nvSpPr>
          <p:spPr>
            <a:xfrm>
              <a:off x="5501424" y="1293743"/>
              <a:ext cx="205024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gtP</a:t>
              </a:r>
              <a:r>
                <a:rPr lang="en-US" altLang="ko-KR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(-­­­­8C</a:t>
              </a:r>
              <a:r>
                <a:rPr lang="en-US" altLang="ko-KR" sz="1000" baseline="300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</a:t>
              </a:r>
              <a:r>
                <a:rPr lang="en-US" altLang="ko-KR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T)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yfiP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::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mR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, BL21(DE3) 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FD56C05-A5D9-43C4-8E5B-EC5D21E5639F}"/>
                </a:ext>
              </a:extLst>
            </p:cNvPr>
            <p:cNvSpPr txBox="1"/>
            <p:nvPr/>
          </p:nvSpPr>
          <p:spPr>
            <a:xfrm>
              <a:off x="5614812" y="3723679"/>
              <a:ext cx="1808187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ko-KR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gtP</a:t>
              </a:r>
              <a:r>
                <a:rPr lang="en-US" altLang="ko-KR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(-­­­­8C</a:t>
              </a:r>
              <a:r>
                <a:rPr lang="en-US" altLang="ko-KR" sz="1000" baseline="300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</a:t>
              </a:r>
              <a:r>
                <a:rPr lang="en-US" altLang="ko-KR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T)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yfiP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::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mR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, HK565 </a:t>
              </a:r>
              <a:endParaRPr lang="ko-KR" alt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3" name="그룹 42">
              <a:extLst>
                <a:ext uri="{FF2B5EF4-FFF2-40B4-BE49-F238E27FC236}">
                  <a16:creationId xmlns:a16="http://schemas.microsoft.com/office/drawing/2014/main" id="{88998B78-DC83-471B-AE38-7A4737C3296E}"/>
                </a:ext>
              </a:extLst>
            </p:cNvPr>
            <p:cNvGrpSpPr/>
            <p:nvPr/>
          </p:nvGrpSpPr>
          <p:grpSpPr>
            <a:xfrm>
              <a:off x="6391409" y="4010501"/>
              <a:ext cx="1093339" cy="292197"/>
              <a:chOff x="8841900" y="5307683"/>
              <a:chExt cx="1093339" cy="292197"/>
            </a:xfrm>
          </p:grpSpPr>
          <p:grpSp>
            <p:nvGrpSpPr>
              <p:cNvPr id="55" name="그룹 54">
                <a:extLst>
                  <a:ext uri="{FF2B5EF4-FFF2-40B4-BE49-F238E27FC236}">
                    <a16:creationId xmlns:a16="http://schemas.microsoft.com/office/drawing/2014/main" id="{E3768A9F-8871-49B0-B6B8-246F7ACA62B6}"/>
                  </a:ext>
                </a:extLst>
              </p:cNvPr>
              <p:cNvGrpSpPr/>
              <p:nvPr/>
            </p:nvGrpSpPr>
            <p:grpSpPr>
              <a:xfrm>
                <a:off x="8841900" y="5307683"/>
                <a:ext cx="779152" cy="153888"/>
                <a:chOff x="7385761" y="5307683"/>
                <a:chExt cx="779152" cy="153888"/>
              </a:xfrm>
            </p:grpSpPr>
            <p:grpSp>
              <p:nvGrpSpPr>
                <p:cNvPr id="61" name="그룹 60">
                  <a:extLst>
                    <a:ext uri="{FF2B5EF4-FFF2-40B4-BE49-F238E27FC236}">
                      <a16:creationId xmlns:a16="http://schemas.microsoft.com/office/drawing/2014/main" id="{4BAEE81D-97E1-4571-BA94-C16ACDC9B17B}"/>
                    </a:ext>
                  </a:extLst>
                </p:cNvPr>
                <p:cNvGrpSpPr/>
                <p:nvPr/>
              </p:nvGrpSpPr>
              <p:grpSpPr>
                <a:xfrm>
                  <a:off x="7385761" y="5361262"/>
                  <a:ext cx="180000" cy="54424"/>
                  <a:chOff x="4252839" y="2312540"/>
                  <a:chExt cx="180000" cy="54424"/>
                </a:xfrm>
              </p:grpSpPr>
              <p:cxnSp>
                <p:nvCxnSpPr>
                  <p:cNvPr id="63" name="직선 연결선 62">
                    <a:extLst>
                      <a:ext uri="{FF2B5EF4-FFF2-40B4-BE49-F238E27FC236}">
                        <a16:creationId xmlns:a16="http://schemas.microsoft.com/office/drawing/2014/main" id="{C5972AD8-D0B2-4A73-B857-7B11086A6EA8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39752"/>
                    <a:ext cx="180000" cy="0"/>
                  </a:xfrm>
                  <a:prstGeom prst="line">
                    <a:avLst/>
                  </a:prstGeom>
                  <a:ln w="9525"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4" name="이등변 삼각형 63">
                    <a:extLst>
                      <a:ext uri="{FF2B5EF4-FFF2-40B4-BE49-F238E27FC236}">
                        <a16:creationId xmlns:a16="http://schemas.microsoft.com/office/drawing/2014/main" id="{13314B07-B4FC-4BBA-B501-098CA76A3920}"/>
                      </a:ext>
                    </a:extLst>
                  </p:cNvPr>
                  <p:cNvSpPr/>
                  <p:nvPr/>
                </p:nvSpPr>
                <p:spPr>
                  <a:xfrm>
                    <a:off x="4315627" y="2312540"/>
                    <a:ext cx="54424" cy="54424"/>
                  </a:xfrm>
                  <a:prstGeom prst="triangle">
                    <a:avLst/>
                  </a:prstGeom>
                  <a:solidFill>
                    <a:schemeClr val="bg1"/>
                  </a:solidFill>
                  <a:ln w="9525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600"/>
                  </a:p>
                </p:txBody>
              </p:sp>
            </p:grp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1C03D449-973A-42CE-8A83-348765743AF7}"/>
                    </a:ext>
                  </a:extLst>
                </p:cNvPr>
                <p:cNvSpPr txBox="1"/>
                <p:nvPr/>
              </p:nvSpPr>
              <p:spPr>
                <a:xfrm>
                  <a:off x="7605464" y="5307683"/>
                  <a:ext cx="559449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uccinate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6" name="그룹 55">
                <a:extLst>
                  <a:ext uri="{FF2B5EF4-FFF2-40B4-BE49-F238E27FC236}">
                    <a16:creationId xmlns:a16="http://schemas.microsoft.com/office/drawing/2014/main" id="{B7577CEF-0E37-448B-BBBB-CE0F0DA7BD99}"/>
                  </a:ext>
                </a:extLst>
              </p:cNvPr>
              <p:cNvGrpSpPr/>
              <p:nvPr/>
            </p:nvGrpSpPr>
            <p:grpSpPr>
              <a:xfrm>
                <a:off x="8843908" y="5445992"/>
                <a:ext cx="1091331" cy="153888"/>
                <a:chOff x="7385761" y="5493612"/>
                <a:chExt cx="1091331" cy="153888"/>
              </a:xfrm>
            </p:grpSpPr>
            <p:grpSp>
              <p:nvGrpSpPr>
                <p:cNvPr id="57" name="그룹 56">
                  <a:extLst>
                    <a:ext uri="{FF2B5EF4-FFF2-40B4-BE49-F238E27FC236}">
                      <a16:creationId xmlns:a16="http://schemas.microsoft.com/office/drawing/2014/main" id="{0D86F7D4-2B69-499A-B94A-DD0683CA8B7B}"/>
                    </a:ext>
                  </a:extLst>
                </p:cNvPr>
                <p:cNvGrpSpPr/>
                <p:nvPr/>
              </p:nvGrpSpPr>
              <p:grpSpPr>
                <a:xfrm>
                  <a:off x="7385761" y="5558035"/>
                  <a:ext cx="180000" cy="54424"/>
                  <a:chOff x="4252839" y="2312540"/>
                  <a:chExt cx="180000" cy="54424"/>
                </a:xfrm>
              </p:grpSpPr>
              <p:cxnSp>
                <p:nvCxnSpPr>
                  <p:cNvPr id="59" name="직선 연결선 58">
                    <a:extLst>
                      <a:ext uri="{FF2B5EF4-FFF2-40B4-BE49-F238E27FC236}">
                        <a16:creationId xmlns:a16="http://schemas.microsoft.com/office/drawing/2014/main" id="{8DC4DADF-C93C-47DA-AD87-EDE2DBE12B25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39752"/>
                    <a:ext cx="180000" cy="0"/>
                  </a:xfrm>
                  <a:prstGeom prst="line">
                    <a:avLst/>
                  </a:prstGeom>
                  <a:ln w="9525"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0" name="이등변 삼각형 59">
                    <a:extLst>
                      <a:ext uri="{FF2B5EF4-FFF2-40B4-BE49-F238E27FC236}">
                        <a16:creationId xmlns:a16="http://schemas.microsoft.com/office/drawing/2014/main" id="{4A18C29C-3ADC-4ED8-9585-7CC7383240FB}"/>
                      </a:ext>
                    </a:extLst>
                  </p:cNvPr>
                  <p:cNvSpPr/>
                  <p:nvPr/>
                </p:nvSpPr>
                <p:spPr>
                  <a:xfrm>
                    <a:off x="4315627" y="2312540"/>
                    <a:ext cx="54424" cy="54424"/>
                  </a:xfrm>
                  <a:prstGeom prst="triangle">
                    <a:avLst/>
                  </a:prstGeom>
                  <a:solidFill>
                    <a:srgbClr val="008000"/>
                  </a:solidFill>
                  <a:ln w="9525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600"/>
                  </a:p>
                </p:txBody>
              </p:sp>
            </p:grp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7314D488-2BBA-41A4-9F80-CFFA254D254B}"/>
                    </a:ext>
                  </a:extLst>
                </p:cNvPr>
                <p:cNvSpPr txBox="1"/>
                <p:nvPr/>
              </p:nvSpPr>
              <p:spPr>
                <a:xfrm>
                  <a:off x="7603456" y="5493612"/>
                  <a:ext cx="87363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l-GR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Ketoglutarate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44" name="그룹 43">
              <a:extLst>
                <a:ext uri="{FF2B5EF4-FFF2-40B4-BE49-F238E27FC236}">
                  <a16:creationId xmlns:a16="http://schemas.microsoft.com/office/drawing/2014/main" id="{08EF6E08-81F8-450C-96FC-D52162322C19}"/>
                </a:ext>
              </a:extLst>
            </p:cNvPr>
            <p:cNvGrpSpPr/>
            <p:nvPr/>
          </p:nvGrpSpPr>
          <p:grpSpPr>
            <a:xfrm>
              <a:off x="6396469" y="1552379"/>
              <a:ext cx="1093339" cy="292197"/>
              <a:chOff x="8841900" y="5307683"/>
              <a:chExt cx="1093339" cy="292197"/>
            </a:xfrm>
          </p:grpSpPr>
          <p:grpSp>
            <p:nvGrpSpPr>
              <p:cNvPr id="45" name="그룹 44">
                <a:extLst>
                  <a:ext uri="{FF2B5EF4-FFF2-40B4-BE49-F238E27FC236}">
                    <a16:creationId xmlns:a16="http://schemas.microsoft.com/office/drawing/2014/main" id="{1BE7F945-B19E-4E8E-A881-FD87A1068C68}"/>
                  </a:ext>
                </a:extLst>
              </p:cNvPr>
              <p:cNvGrpSpPr/>
              <p:nvPr/>
            </p:nvGrpSpPr>
            <p:grpSpPr>
              <a:xfrm>
                <a:off x="8841900" y="5307683"/>
                <a:ext cx="779152" cy="153888"/>
                <a:chOff x="7385761" y="5307683"/>
                <a:chExt cx="779152" cy="153888"/>
              </a:xfrm>
            </p:grpSpPr>
            <p:grpSp>
              <p:nvGrpSpPr>
                <p:cNvPr id="51" name="그룹 50">
                  <a:extLst>
                    <a:ext uri="{FF2B5EF4-FFF2-40B4-BE49-F238E27FC236}">
                      <a16:creationId xmlns:a16="http://schemas.microsoft.com/office/drawing/2014/main" id="{A3F5564E-30DC-4C4A-A8C1-9A579238F052}"/>
                    </a:ext>
                  </a:extLst>
                </p:cNvPr>
                <p:cNvGrpSpPr/>
                <p:nvPr/>
              </p:nvGrpSpPr>
              <p:grpSpPr>
                <a:xfrm>
                  <a:off x="7385761" y="5361262"/>
                  <a:ext cx="180000" cy="54424"/>
                  <a:chOff x="4252839" y="2312540"/>
                  <a:chExt cx="180000" cy="54424"/>
                </a:xfrm>
              </p:grpSpPr>
              <p:cxnSp>
                <p:nvCxnSpPr>
                  <p:cNvPr id="53" name="직선 연결선 52">
                    <a:extLst>
                      <a:ext uri="{FF2B5EF4-FFF2-40B4-BE49-F238E27FC236}">
                        <a16:creationId xmlns:a16="http://schemas.microsoft.com/office/drawing/2014/main" id="{D94D7513-FD71-427D-A599-82D515A6F1B0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39752"/>
                    <a:ext cx="180000" cy="0"/>
                  </a:xfrm>
                  <a:prstGeom prst="line">
                    <a:avLst/>
                  </a:prstGeom>
                  <a:ln w="9525"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4" name="이등변 삼각형 53">
                    <a:extLst>
                      <a:ext uri="{FF2B5EF4-FFF2-40B4-BE49-F238E27FC236}">
                        <a16:creationId xmlns:a16="http://schemas.microsoft.com/office/drawing/2014/main" id="{819DA837-3C6D-4DDB-A139-E2A969F245D7}"/>
                      </a:ext>
                    </a:extLst>
                  </p:cNvPr>
                  <p:cNvSpPr/>
                  <p:nvPr/>
                </p:nvSpPr>
                <p:spPr>
                  <a:xfrm>
                    <a:off x="4315627" y="2312540"/>
                    <a:ext cx="54424" cy="54424"/>
                  </a:xfrm>
                  <a:prstGeom prst="triangle">
                    <a:avLst/>
                  </a:prstGeom>
                  <a:solidFill>
                    <a:schemeClr val="bg1"/>
                  </a:solidFill>
                  <a:ln w="9525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600"/>
                  </a:p>
                </p:txBody>
              </p:sp>
            </p:grp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3DF77739-B985-4A90-84B8-7E9C9D4ED32B}"/>
                    </a:ext>
                  </a:extLst>
                </p:cNvPr>
                <p:cNvSpPr txBox="1"/>
                <p:nvPr/>
              </p:nvSpPr>
              <p:spPr>
                <a:xfrm>
                  <a:off x="7605464" y="5307683"/>
                  <a:ext cx="559449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uccinate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6" name="그룹 45">
                <a:extLst>
                  <a:ext uri="{FF2B5EF4-FFF2-40B4-BE49-F238E27FC236}">
                    <a16:creationId xmlns:a16="http://schemas.microsoft.com/office/drawing/2014/main" id="{88C47F7D-A112-47AF-B756-F661CCAA8291}"/>
                  </a:ext>
                </a:extLst>
              </p:cNvPr>
              <p:cNvGrpSpPr/>
              <p:nvPr/>
            </p:nvGrpSpPr>
            <p:grpSpPr>
              <a:xfrm>
                <a:off x="8843908" y="5445992"/>
                <a:ext cx="1091331" cy="153888"/>
                <a:chOff x="7385761" y="5493612"/>
                <a:chExt cx="1091331" cy="153888"/>
              </a:xfrm>
            </p:grpSpPr>
            <p:grpSp>
              <p:nvGrpSpPr>
                <p:cNvPr id="47" name="그룹 46">
                  <a:extLst>
                    <a:ext uri="{FF2B5EF4-FFF2-40B4-BE49-F238E27FC236}">
                      <a16:creationId xmlns:a16="http://schemas.microsoft.com/office/drawing/2014/main" id="{7332D907-D2C7-4D9C-B4AE-850077774F28}"/>
                    </a:ext>
                  </a:extLst>
                </p:cNvPr>
                <p:cNvGrpSpPr/>
                <p:nvPr/>
              </p:nvGrpSpPr>
              <p:grpSpPr>
                <a:xfrm>
                  <a:off x="7385761" y="5558035"/>
                  <a:ext cx="180000" cy="54424"/>
                  <a:chOff x="4252839" y="2312540"/>
                  <a:chExt cx="180000" cy="54424"/>
                </a:xfrm>
              </p:grpSpPr>
              <p:cxnSp>
                <p:nvCxnSpPr>
                  <p:cNvPr id="49" name="직선 연결선 48">
                    <a:extLst>
                      <a:ext uri="{FF2B5EF4-FFF2-40B4-BE49-F238E27FC236}">
                        <a16:creationId xmlns:a16="http://schemas.microsoft.com/office/drawing/2014/main" id="{BF0A90A1-85A0-4E32-8FF7-50663C5AA344}"/>
                      </a:ext>
                    </a:extLst>
                  </p:cNvPr>
                  <p:cNvCxnSpPr/>
                  <p:nvPr/>
                </p:nvCxnSpPr>
                <p:spPr>
                  <a:xfrm>
                    <a:off x="4252839" y="2339752"/>
                    <a:ext cx="180000" cy="0"/>
                  </a:xfrm>
                  <a:prstGeom prst="line">
                    <a:avLst/>
                  </a:prstGeom>
                  <a:ln w="9525" cap="rnd">
                    <a:solidFill>
                      <a:srgbClr val="008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0" name="이등변 삼각형 49">
                    <a:extLst>
                      <a:ext uri="{FF2B5EF4-FFF2-40B4-BE49-F238E27FC236}">
                        <a16:creationId xmlns:a16="http://schemas.microsoft.com/office/drawing/2014/main" id="{DCD1934D-C32C-40B0-8B73-CD4F8EF46E9C}"/>
                      </a:ext>
                    </a:extLst>
                  </p:cNvPr>
                  <p:cNvSpPr/>
                  <p:nvPr/>
                </p:nvSpPr>
                <p:spPr>
                  <a:xfrm>
                    <a:off x="4315627" y="2312540"/>
                    <a:ext cx="54424" cy="54424"/>
                  </a:xfrm>
                  <a:prstGeom prst="triangle">
                    <a:avLst/>
                  </a:prstGeom>
                  <a:solidFill>
                    <a:srgbClr val="008000"/>
                  </a:solidFill>
                  <a:ln w="9525">
                    <a:solidFill>
                      <a:srgbClr val="008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600"/>
                  </a:p>
                </p:txBody>
              </p:sp>
            </p:grp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D9661D99-8CCE-4CD1-8DF1-76153D1C6EFF}"/>
                    </a:ext>
                  </a:extLst>
                </p:cNvPr>
                <p:cNvSpPr txBox="1"/>
                <p:nvPr/>
              </p:nvSpPr>
              <p:spPr>
                <a:xfrm>
                  <a:off x="7603456" y="5493612"/>
                  <a:ext cx="87363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 algn="ctr"/>
                  <a:r>
                    <a:rPr lang="el-GR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Ketoglutarate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65" name="TextBox 64">
            <a:extLst>
              <a:ext uri="{FF2B5EF4-FFF2-40B4-BE49-F238E27FC236}">
                <a16:creationId xmlns:a16="http://schemas.microsoft.com/office/drawing/2014/main" id="{623DC929-72FB-4469-BB98-7F34220AD737}"/>
              </a:ext>
            </a:extLst>
          </p:cNvPr>
          <p:cNvSpPr txBox="1"/>
          <p:nvPr/>
        </p:nvSpPr>
        <p:spPr>
          <a:xfrm>
            <a:off x="1875287" y="91968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AE7AAE7-5710-41BF-AF4E-113EBF01358B}"/>
              </a:ext>
            </a:extLst>
          </p:cNvPr>
          <p:cNvSpPr txBox="1"/>
          <p:nvPr/>
        </p:nvSpPr>
        <p:spPr>
          <a:xfrm>
            <a:off x="4803148" y="934428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4F8E847-DF04-40AF-B320-BE0EADE19574}"/>
              </a:ext>
            </a:extLst>
          </p:cNvPr>
          <p:cNvSpPr txBox="1"/>
          <p:nvPr/>
        </p:nvSpPr>
        <p:spPr>
          <a:xfrm>
            <a:off x="1877090" y="347338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9CDC395-30B1-43F1-A2D0-61F534F19D6D}"/>
              </a:ext>
            </a:extLst>
          </p:cNvPr>
          <p:cNvSpPr txBox="1"/>
          <p:nvPr/>
        </p:nvSpPr>
        <p:spPr>
          <a:xfrm>
            <a:off x="4804951" y="348812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2716E24-F013-49FC-A119-D505B2EE59FC}"/>
              </a:ext>
            </a:extLst>
          </p:cNvPr>
          <p:cNvSpPr txBox="1"/>
          <p:nvPr/>
        </p:nvSpPr>
        <p:spPr>
          <a:xfrm>
            <a:off x="2884301" y="2522263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40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9705F53-6D32-4C11-A910-B92B93019246}"/>
              </a:ext>
            </a:extLst>
          </p:cNvPr>
          <p:cNvSpPr txBox="1"/>
          <p:nvPr/>
        </p:nvSpPr>
        <p:spPr>
          <a:xfrm>
            <a:off x="2490679" y="2235003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57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598795E-63D8-4597-8206-FB46A9621B4F}"/>
              </a:ext>
            </a:extLst>
          </p:cNvPr>
          <p:cNvSpPr txBox="1"/>
          <p:nvPr/>
        </p:nvSpPr>
        <p:spPr>
          <a:xfrm>
            <a:off x="6719131" y="2602269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13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18A307B-5A10-484F-9DDD-79B868500EBB}"/>
              </a:ext>
            </a:extLst>
          </p:cNvPr>
          <p:cNvSpPr txBox="1"/>
          <p:nvPr/>
        </p:nvSpPr>
        <p:spPr>
          <a:xfrm>
            <a:off x="6196271" y="2384752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9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397EB39-7F01-499D-B41D-FC9AB8F69350}"/>
              </a:ext>
            </a:extLst>
          </p:cNvPr>
          <p:cNvSpPr txBox="1"/>
          <p:nvPr/>
        </p:nvSpPr>
        <p:spPr>
          <a:xfrm>
            <a:off x="6656481" y="4983637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15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206E1FC-FD23-4777-8E3A-85C67638EA46}"/>
              </a:ext>
            </a:extLst>
          </p:cNvPr>
          <p:cNvSpPr txBox="1"/>
          <p:nvPr/>
        </p:nvSpPr>
        <p:spPr>
          <a:xfrm>
            <a:off x="6097096" y="4742823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7</a:t>
            </a:r>
            <a:endParaRPr lang="ko-KR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C100E81-574E-484E-984D-8572E42AC749}"/>
              </a:ext>
            </a:extLst>
          </p:cNvPr>
          <p:cNvSpPr txBox="1"/>
          <p:nvPr/>
        </p:nvSpPr>
        <p:spPr>
          <a:xfrm>
            <a:off x="2840822" y="4937239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6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ED69FD0-4E4E-47C9-8E86-0BC4B47CB863}"/>
              </a:ext>
            </a:extLst>
          </p:cNvPr>
          <p:cNvSpPr txBox="1"/>
          <p:nvPr/>
        </p:nvSpPr>
        <p:spPr>
          <a:xfrm>
            <a:off x="2490945" y="4667232"/>
            <a:ext cx="32060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l-GR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59</a:t>
            </a:r>
            <a:endParaRPr lang="ko-KR" altLang="en-US" sz="8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88A81752-1ACC-4C7D-9A25-9471F03F8407}"/>
              </a:ext>
            </a:extLst>
          </p:cNvPr>
          <p:cNvSpPr txBox="1"/>
          <p:nvPr/>
        </p:nvSpPr>
        <p:spPr>
          <a:xfrm>
            <a:off x="3301650" y="1099167"/>
            <a:ext cx="432812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HK652</a:t>
            </a:r>
            <a:endParaRPr lang="ko-KR" alt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A3BBDDB-3413-46AC-AA58-01977F20856E}"/>
              </a:ext>
            </a:extLst>
          </p:cNvPr>
          <p:cNvSpPr txBox="1"/>
          <p:nvPr/>
        </p:nvSpPr>
        <p:spPr>
          <a:xfrm>
            <a:off x="6279286" y="1093453"/>
            <a:ext cx="432812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HK651</a:t>
            </a:r>
            <a:endParaRPr lang="ko-KR" alt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0462F73F-ED00-4F2A-BD3E-BB41646D39E4}"/>
              </a:ext>
            </a:extLst>
          </p:cNvPr>
          <p:cNvSpPr txBox="1"/>
          <p:nvPr/>
        </p:nvSpPr>
        <p:spPr>
          <a:xfrm>
            <a:off x="3315683" y="3545860"/>
            <a:ext cx="432812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HK655</a:t>
            </a:r>
            <a:endParaRPr lang="ko-KR" alt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6770943-7B1E-4434-AD37-9F5902FCE606}"/>
              </a:ext>
            </a:extLst>
          </p:cNvPr>
          <p:cNvSpPr txBox="1"/>
          <p:nvPr/>
        </p:nvSpPr>
        <p:spPr>
          <a:xfrm>
            <a:off x="6279286" y="3546913"/>
            <a:ext cx="432812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HK654</a:t>
            </a:r>
            <a:endParaRPr lang="ko-KR" alt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" name="그룹 80">
            <a:extLst>
              <a:ext uri="{FF2B5EF4-FFF2-40B4-BE49-F238E27FC236}">
                <a16:creationId xmlns:a16="http://schemas.microsoft.com/office/drawing/2014/main" id="{DC59AAE0-1F78-4F95-88E0-CAF436F1EB8D}"/>
              </a:ext>
            </a:extLst>
          </p:cNvPr>
          <p:cNvGrpSpPr/>
          <p:nvPr/>
        </p:nvGrpSpPr>
        <p:grpSpPr>
          <a:xfrm>
            <a:off x="2229543" y="1454345"/>
            <a:ext cx="204511" cy="1707837"/>
            <a:chOff x="2231375" y="244499"/>
            <a:chExt cx="204511" cy="1707837"/>
          </a:xfrm>
        </p:grpSpPr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CC4FBB48-5637-4ED4-9445-0ED9AF0E362D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4670715C-7E8D-485B-B679-5894F8E0595C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B1D4D164-7637-4829-B232-8058BE10A9AD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8337E8B7-8BF5-4E03-9D4E-0F9F6E4AE14C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6" name="그룹 85">
            <a:extLst>
              <a:ext uri="{FF2B5EF4-FFF2-40B4-BE49-F238E27FC236}">
                <a16:creationId xmlns:a16="http://schemas.microsoft.com/office/drawing/2014/main" id="{790E07F4-B9CB-4033-A8FD-6C54FAE92F38}"/>
              </a:ext>
            </a:extLst>
          </p:cNvPr>
          <p:cNvGrpSpPr/>
          <p:nvPr/>
        </p:nvGrpSpPr>
        <p:grpSpPr>
          <a:xfrm>
            <a:off x="5199034" y="1454345"/>
            <a:ext cx="204511" cy="1707837"/>
            <a:chOff x="2231375" y="244499"/>
            <a:chExt cx="204511" cy="1707837"/>
          </a:xfrm>
        </p:grpSpPr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61A687E2-410F-4B9D-9DF5-F2E1CD975A1C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33571A69-69B0-4992-880E-6680F71D49FC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078543FC-EE91-4EA6-8794-16A1D95B6E21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BA61A85D-401D-49CC-B2A4-9ED2AFD75A6B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1" name="그룹 90">
            <a:extLst>
              <a:ext uri="{FF2B5EF4-FFF2-40B4-BE49-F238E27FC236}">
                <a16:creationId xmlns:a16="http://schemas.microsoft.com/office/drawing/2014/main" id="{1E295363-3345-41C0-9F2A-47109AB71AB0}"/>
              </a:ext>
            </a:extLst>
          </p:cNvPr>
          <p:cNvGrpSpPr/>
          <p:nvPr/>
        </p:nvGrpSpPr>
        <p:grpSpPr>
          <a:xfrm>
            <a:off x="2215116" y="3875431"/>
            <a:ext cx="204511" cy="1707837"/>
            <a:chOff x="2231375" y="244499"/>
            <a:chExt cx="204511" cy="1707837"/>
          </a:xfrm>
        </p:grpSpPr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22BECBD6-5BC1-44C1-9104-DE7DABE0A56B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BE5712E6-B25A-4404-B36A-B527E7FDD0BC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D5922A91-0B84-49A2-B050-767DE64ED2EC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CE526A9C-9F14-4D51-A1E4-DDCBE104D358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6" name="그룹 95">
            <a:extLst>
              <a:ext uri="{FF2B5EF4-FFF2-40B4-BE49-F238E27FC236}">
                <a16:creationId xmlns:a16="http://schemas.microsoft.com/office/drawing/2014/main" id="{1DC74A0E-99A4-48C1-853A-5A59BF8FCB07}"/>
              </a:ext>
            </a:extLst>
          </p:cNvPr>
          <p:cNvGrpSpPr/>
          <p:nvPr/>
        </p:nvGrpSpPr>
        <p:grpSpPr>
          <a:xfrm>
            <a:off x="5184607" y="3875431"/>
            <a:ext cx="204511" cy="1707837"/>
            <a:chOff x="2231375" y="244499"/>
            <a:chExt cx="204511" cy="1707837"/>
          </a:xfrm>
        </p:grpSpPr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F26ACE4E-7292-4E34-99B2-03694B77813D}"/>
                </a:ext>
              </a:extLst>
            </p:cNvPr>
            <p:cNvSpPr txBox="1"/>
            <p:nvPr/>
          </p:nvSpPr>
          <p:spPr>
            <a:xfrm>
              <a:off x="2306043" y="244499"/>
              <a:ext cx="11541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7E441579-A3D5-4AE6-88BA-A80B1BA9281D}"/>
                </a:ext>
              </a:extLst>
            </p:cNvPr>
            <p:cNvSpPr txBox="1"/>
            <p:nvPr/>
          </p:nvSpPr>
          <p:spPr>
            <a:xfrm>
              <a:off x="2368425" y="77808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3A5DD6E4-4120-430B-B5C4-0AD7573B6049}"/>
                </a:ext>
              </a:extLst>
            </p:cNvPr>
            <p:cNvSpPr txBox="1"/>
            <p:nvPr/>
          </p:nvSpPr>
          <p:spPr>
            <a:xfrm>
              <a:off x="2291616" y="1310912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D412F3E1-CF36-49CD-9FD8-15185BA4AF15}"/>
                </a:ext>
              </a:extLst>
            </p:cNvPr>
            <p:cNvSpPr txBox="1"/>
            <p:nvPr/>
          </p:nvSpPr>
          <p:spPr>
            <a:xfrm>
              <a:off x="2231375" y="1829225"/>
              <a:ext cx="20197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929543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80</TotalTime>
  <Words>1215</Words>
  <Application>Microsoft Office PowerPoint</Application>
  <PresentationFormat>A4 용지(210x297mm)</PresentationFormat>
  <Paragraphs>541</Paragraphs>
  <Slides>14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4</vt:i4>
      </vt:variant>
    </vt:vector>
  </HeadingPairs>
  <TitlesOfParts>
    <vt:vector size="22" baseType="lpstr">
      <vt:lpstr>맑은 고딕</vt:lpstr>
      <vt:lpstr>Arial</vt:lpstr>
      <vt:lpstr>Calibri</vt:lpstr>
      <vt:lpstr>Calibri Light</vt:lpstr>
      <vt:lpstr>Courier New</vt:lpstr>
      <vt:lpstr>Times New Roman</vt:lpstr>
      <vt:lpstr>Office 테마</vt:lpstr>
      <vt:lpstr>Graph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현주</dc:creator>
  <cp:lastModifiedBy>김현주</cp:lastModifiedBy>
  <cp:revision>152</cp:revision>
  <cp:lastPrinted>2021-05-19T09:35:35Z</cp:lastPrinted>
  <dcterms:created xsi:type="dcterms:W3CDTF">2019-01-04T10:27:48Z</dcterms:created>
  <dcterms:modified xsi:type="dcterms:W3CDTF">2021-06-09T08:37:10Z</dcterms:modified>
</cp:coreProperties>
</file>